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1607" r:id="rId2"/>
    <p:sldId id="1614" r:id="rId3"/>
    <p:sldId id="1613" r:id="rId4"/>
    <p:sldId id="1611" r:id="rId5"/>
    <p:sldId id="1615" r:id="rId6"/>
  </p:sldIdLst>
  <p:sldSz cx="9144000" cy="6858000" type="screen4x3"/>
  <p:notesSz cx="6858000" cy="9144000"/>
  <p:defaultTextStyle>
    <a:defPPr>
      <a:defRPr lang="it-C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28" userDrawn="1">
          <p15:clr>
            <a:srgbClr val="A4A3A4"/>
          </p15:clr>
        </p15:guide>
        <p15:guide id="2" pos="3107" userDrawn="1">
          <p15:clr>
            <a:srgbClr val="A4A3A4"/>
          </p15:clr>
        </p15:guide>
        <p15:guide id="3" pos="5103" userDrawn="1">
          <p15:clr>
            <a:srgbClr val="A4A3A4"/>
          </p15:clr>
        </p15:guide>
        <p15:guide id="4" orient="horz" pos="109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9A6A3"/>
    <a:srgbClr val="33CCCC"/>
    <a:srgbClr val="FF9999"/>
    <a:srgbClr val="FF6600"/>
    <a:srgbClr val="FF9966"/>
    <a:srgbClr val="A3FFFF"/>
    <a:srgbClr val="66FFFF"/>
    <a:srgbClr val="CCFFFF"/>
    <a:srgbClr val="99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997E11D-29CD-4387-AD28-D8541B11CB53}" v="475" dt="2025-03-24T10:56:13.15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93D81CF-94F2-401A-BA57-92F5A7B2D0C5}" styleName="Style moye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133" autoAdjust="0"/>
    <p:restoredTop sz="94651"/>
  </p:normalViewPr>
  <p:slideViewPr>
    <p:cSldViewPr snapToGrid="0">
      <p:cViewPr>
        <p:scale>
          <a:sx n="110" d="100"/>
          <a:sy n="110" d="100"/>
        </p:scale>
        <p:origin x="1424" y="1224"/>
      </p:cViewPr>
      <p:guideLst>
        <p:guide orient="horz" pos="2228"/>
        <p:guide pos="3107"/>
        <p:guide pos="5103"/>
        <p:guide orient="horz" pos="109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olo Paganetti" userId="dcd282f25ae9c4f2" providerId="LiveId" clId="{C997E11D-29CD-4387-AD28-D8541B11CB53}"/>
    <pc:docChg chg="undo custSel addSld delSld modSld sldOrd">
      <pc:chgData name="Paolo Paganetti" userId="dcd282f25ae9c4f2" providerId="LiveId" clId="{C997E11D-29CD-4387-AD28-D8541B11CB53}" dt="2025-03-24T10:57:09.293" v="4523" actId="1037"/>
      <pc:docMkLst>
        <pc:docMk/>
      </pc:docMkLst>
      <pc:sldChg chg="del">
        <pc:chgData name="Paolo Paganetti" userId="dcd282f25ae9c4f2" providerId="LiveId" clId="{C997E11D-29CD-4387-AD28-D8541B11CB53}" dt="2025-03-19T08:50:17.522" v="15" actId="47"/>
        <pc:sldMkLst>
          <pc:docMk/>
          <pc:sldMk cId="1559225015" sldId="1570"/>
        </pc:sldMkLst>
      </pc:sldChg>
      <pc:sldChg chg="del">
        <pc:chgData name="Paolo Paganetti" userId="dcd282f25ae9c4f2" providerId="LiveId" clId="{C997E11D-29CD-4387-AD28-D8541B11CB53}" dt="2025-03-19T08:51:37.183" v="27" actId="47"/>
        <pc:sldMkLst>
          <pc:docMk/>
          <pc:sldMk cId="1986782033" sldId="1597"/>
        </pc:sldMkLst>
      </pc:sldChg>
      <pc:sldChg chg="addSp delSp modSp mod ord">
        <pc:chgData name="Paolo Paganetti" userId="dcd282f25ae9c4f2" providerId="LiveId" clId="{C997E11D-29CD-4387-AD28-D8541B11CB53}" dt="2025-03-24T10:57:09.293" v="4523" actId="1037"/>
        <pc:sldMkLst>
          <pc:docMk/>
          <pc:sldMk cId="1216977762" sldId="1607"/>
        </pc:sldMkLst>
        <pc:spChg chg="add mod ord">
          <ac:chgData name="Paolo Paganetti" userId="dcd282f25ae9c4f2" providerId="LiveId" clId="{C997E11D-29CD-4387-AD28-D8541B11CB53}" dt="2025-03-24T10:56:31.177" v="4512" actId="14100"/>
          <ac:spMkLst>
            <pc:docMk/>
            <pc:sldMk cId="1216977762" sldId="1607"/>
            <ac:spMk id="2" creationId="{EDD94D72-ACF3-F0CC-79B9-BD4407B177ED}"/>
          </ac:spMkLst>
        </pc:spChg>
        <pc:spChg chg="add mod topLvl">
          <ac:chgData name="Paolo Paganetti" userId="dcd282f25ae9c4f2" providerId="LiveId" clId="{C997E11D-29CD-4387-AD28-D8541B11CB53}" dt="2025-03-24T08:19:41.348" v="4318" actId="165"/>
          <ac:spMkLst>
            <pc:docMk/>
            <pc:sldMk cId="1216977762" sldId="1607"/>
            <ac:spMk id="19" creationId="{D04B4750-277D-2970-5857-27105C0E3559}"/>
          </ac:spMkLst>
        </pc:spChg>
        <pc:spChg chg="mod">
          <ac:chgData name="Paolo Paganetti" userId="dcd282f25ae9c4f2" providerId="LiveId" clId="{C997E11D-29CD-4387-AD28-D8541B11CB53}" dt="2025-03-23T12:54:43.434" v="3403"/>
          <ac:spMkLst>
            <pc:docMk/>
            <pc:sldMk cId="1216977762" sldId="1607"/>
            <ac:spMk id="25" creationId="{EA0D7F39-8F80-1AF2-D1A8-BB3FED521859}"/>
          </ac:spMkLst>
        </pc:spChg>
        <pc:spChg chg="mod">
          <ac:chgData name="Paolo Paganetti" userId="dcd282f25ae9c4f2" providerId="LiveId" clId="{C997E11D-29CD-4387-AD28-D8541B11CB53}" dt="2025-03-23T12:54:43.434" v="3403"/>
          <ac:spMkLst>
            <pc:docMk/>
            <pc:sldMk cId="1216977762" sldId="1607"/>
            <ac:spMk id="26" creationId="{BFE2756F-35F5-8F4D-A8B9-D9DFBB5921E7}"/>
          </ac:spMkLst>
        </pc:spChg>
        <pc:spChg chg="mod">
          <ac:chgData name="Paolo Paganetti" userId="dcd282f25ae9c4f2" providerId="LiveId" clId="{C997E11D-29CD-4387-AD28-D8541B11CB53}" dt="2025-03-23T12:54:43.434" v="3403"/>
          <ac:spMkLst>
            <pc:docMk/>
            <pc:sldMk cId="1216977762" sldId="1607"/>
            <ac:spMk id="28" creationId="{579D38A9-A367-6261-CF35-EC34D9F41AF8}"/>
          </ac:spMkLst>
        </pc:spChg>
        <pc:spChg chg="mod">
          <ac:chgData name="Paolo Paganetti" userId="dcd282f25ae9c4f2" providerId="LiveId" clId="{C997E11D-29CD-4387-AD28-D8541B11CB53}" dt="2025-03-23T12:54:43.434" v="3403"/>
          <ac:spMkLst>
            <pc:docMk/>
            <pc:sldMk cId="1216977762" sldId="1607"/>
            <ac:spMk id="37" creationId="{840E5FA5-766D-850A-328D-D502183BE842}"/>
          </ac:spMkLst>
        </pc:spChg>
        <pc:spChg chg="mod">
          <ac:chgData name="Paolo Paganetti" userId="dcd282f25ae9c4f2" providerId="LiveId" clId="{C997E11D-29CD-4387-AD28-D8541B11CB53}" dt="2025-03-23T12:54:43.434" v="3403"/>
          <ac:spMkLst>
            <pc:docMk/>
            <pc:sldMk cId="1216977762" sldId="1607"/>
            <ac:spMk id="38" creationId="{C0D695DB-F56F-DF7C-74AD-6ECA7A7E02BF}"/>
          </ac:spMkLst>
        </pc:spChg>
        <pc:spChg chg="mod topLvl">
          <ac:chgData name="Paolo Paganetti" userId="dcd282f25ae9c4f2" providerId="LiveId" clId="{C997E11D-29CD-4387-AD28-D8541B11CB53}" dt="2025-03-24T10:56:23.875" v="4511" actId="1076"/>
          <ac:spMkLst>
            <pc:docMk/>
            <pc:sldMk cId="1216977762" sldId="1607"/>
            <ac:spMk id="41" creationId="{D1E241AE-349F-FCCE-34DF-04DA796A9DAF}"/>
          </ac:spMkLst>
        </pc:spChg>
        <pc:spChg chg="mod">
          <ac:chgData name="Paolo Paganetti" userId="dcd282f25ae9c4f2" providerId="LiveId" clId="{C997E11D-29CD-4387-AD28-D8541B11CB53}" dt="2025-03-23T12:54:43.434" v="3403"/>
          <ac:spMkLst>
            <pc:docMk/>
            <pc:sldMk cId="1216977762" sldId="1607"/>
            <ac:spMk id="43" creationId="{B53D8C63-0DF9-7D21-C648-DB73D640327D}"/>
          </ac:spMkLst>
        </pc:spChg>
        <pc:spChg chg="mod">
          <ac:chgData name="Paolo Paganetti" userId="dcd282f25ae9c4f2" providerId="LiveId" clId="{C997E11D-29CD-4387-AD28-D8541B11CB53}" dt="2025-03-23T12:54:43.434" v="3403"/>
          <ac:spMkLst>
            <pc:docMk/>
            <pc:sldMk cId="1216977762" sldId="1607"/>
            <ac:spMk id="45" creationId="{95760ECD-F572-B150-CFB1-7BB7ED8B25A0}"/>
          </ac:spMkLst>
        </pc:spChg>
        <pc:spChg chg="mod">
          <ac:chgData name="Paolo Paganetti" userId="dcd282f25ae9c4f2" providerId="LiveId" clId="{C997E11D-29CD-4387-AD28-D8541B11CB53}" dt="2025-03-23T12:54:43.434" v="3403"/>
          <ac:spMkLst>
            <pc:docMk/>
            <pc:sldMk cId="1216977762" sldId="1607"/>
            <ac:spMk id="47" creationId="{2BB9935F-9C03-036C-3501-D35B5813D56E}"/>
          </ac:spMkLst>
        </pc:spChg>
        <pc:spChg chg="mod">
          <ac:chgData name="Paolo Paganetti" userId="dcd282f25ae9c4f2" providerId="LiveId" clId="{C997E11D-29CD-4387-AD28-D8541B11CB53}" dt="2025-03-23T12:54:43.434" v="3403"/>
          <ac:spMkLst>
            <pc:docMk/>
            <pc:sldMk cId="1216977762" sldId="1607"/>
            <ac:spMk id="49" creationId="{C88BAE4F-3BB9-1DCF-A50D-9D3579B99B61}"/>
          </ac:spMkLst>
        </pc:spChg>
        <pc:spChg chg="mod">
          <ac:chgData name="Paolo Paganetti" userId="dcd282f25ae9c4f2" providerId="LiveId" clId="{C997E11D-29CD-4387-AD28-D8541B11CB53}" dt="2025-03-23T12:54:43.434" v="3403"/>
          <ac:spMkLst>
            <pc:docMk/>
            <pc:sldMk cId="1216977762" sldId="1607"/>
            <ac:spMk id="50" creationId="{398B2584-1B6B-5B4C-4792-F99D0079981B}"/>
          </ac:spMkLst>
        </pc:spChg>
        <pc:spChg chg="add mod">
          <ac:chgData name="Paolo Paganetti" userId="dcd282f25ae9c4f2" providerId="LiveId" clId="{C997E11D-29CD-4387-AD28-D8541B11CB53}" dt="2025-03-23T12:57:33.011" v="3485" actId="1038"/>
          <ac:spMkLst>
            <pc:docMk/>
            <pc:sldMk cId="1216977762" sldId="1607"/>
            <ac:spMk id="52" creationId="{5B4B7F1A-11F0-D833-E8CF-45BA0E5C5C71}"/>
          </ac:spMkLst>
        </pc:spChg>
        <pc:spChg chg="add mod">
          <ac:chgData name="Paolo Paganetti" userId="dcd282f25ae9c4f2" providerId="LiveId" clId="{C997E11D-29CD-4387-AD28-D8541B11CB53}" dt="2025-03-23T12:59:49.668" v="3539" actId="164"/>
          <ac:spMkLst>
            <pc:docMk/>
            <pc:sldMk cId="1216977762" sldId="1607"/>
            <ac:spMk id="54" creationId="{2F4349C9-2207-C994-DD85-548831DBB989}"/>
          </ac:spMkLst>
        </pc:spChg>
        <pc:spChg chg="add mod topLvl">
          <ac:chgData name="Paolo Paganetti" userId="dcd282f25ae9c4f2" providerId="LiveId" clId="{C997E11D-29CD-4387-AD28-D8541B11CB53}" dt="2025-03-24T08:19:41.348" v="4318" actId="165"/>
          <ac:spMkLst>
            <pc:docMk/>
            <pc:sldMk cId="1216977762" sldId="1607"/>
            <ac:spMk id="56" creationId="{83E3261D-AAE8-0AE8-FA6E-BBF7951C2328}"/>
          </ac:spMkLst>
        </pc:spChg>
        <pc:spChg chg="add mod">
          <ac:chgData name="Paolo Paganetti" userId="dcd282f25ae9c4f2" providerId="LiveId" clId="{C997E11D-29CD-4387-AD28-D8541B11CB53}" dt="2025-03-23T12:58:03.190" v="3491" actId="571"/>
          <ac:spMkLst>
            <pc:docMk/>
            <pc:sldMk cId="1216977762" sldId="1607"/>
            <ac:spMk id="59" creationId="{FA33C44B-2EDA-DCBD-FBF1-1A3D076533CF}"/>
          </ac:spMkLst>
        </pc:spChg>
        <pc:spChg chg="add mod">
          <ac:chgData name="Paolo Paganetti" userId="dcd282f25ae9c4f2" providerId="LiveId" clId="{C997E11D-29CD-4387-AD28-D8541B11CB53}" dt="2025-03-24T08:20:17.120" v="4321" actId="164"/>
          <ac:spMkLst>
            <pc:docMk/>
            <pc:sldMk cId="1216977762" sldId="1607"/>
            <ac:spMk id="61" creationId="{F29EEB07-9607-C24C-37DD-8EA4C5C66191}"/>
          </ac:spMkLst>
        </pc:spChg>
        <pc:spChg chg="add mod topLvl">
          <ac:chgData name="Paolo Paganetti" userId="dcd282f25ae9c4f2" providerId="LiveId" clId="{C997E11D-29CD-4387-AD28-D8541B11CB53}" dt="2025-03-24T10:49:05.930" v="4414" actId="164"/>
          <ac:spMkLst>
            <pc:docMk/>
            <pc:sldMk cId="1216977762" sldId="1607"/>
            <ac:spMk id="65" creationId="{C5A9ED45-9675-D216-9112-06E7B0833084}"/>
          </ac:spMkLst>
        </pc:spChg>
        <pc:spChg chg="add mod topLvl">
          <ac:chgData name="Paolo Paganetti" userId="dcd282f25ae9c4f2" providerId="LiveId" clId="{C997E11D-29CD-4387-AD28-D8541B11CB53}" dt="2025-03-24T10:49:05.930" v="4414" actId="164"/>
          <ac:spMkLst>
            <pc:docMk/>
            <pc:sldMk cId="1216977762" sldId="1607"/>
            <ac:spMk id="66" creationId="{6084F3A6-6BBE-354E-B414-06B256B4B900}"/>
          </ac:spMkLst>
        </pc:spChg>
        <pc:spChg chg="mod topLvl">
          <ac:chgData name="Paolo Paganetti" userId="dcd282f25ae9c4f2" providerId="LiveId" clId="{C997E11D-29CD-4387-AD28-D8541B11CB53}" dt="2025-03-23T12:56:07.520" v="3416" actId="207"/>
          <ac:spMkLst>
            <pc:docMk/>
            <pc:sldMk cId="1216977762" sldId="1607"/>
            <ac:spMk id="67" creationId="{8968D980-42A3-9809-79A8-D75EFC395954}"/>
          </ac:spMkLst>
        </pc:spChg>
        <pc:spChg chg="mod topLvl">
          <ac:chgData name="Paolo Paganetti" userId="dcd282f25ae9c4f2" providerId="LiveId" clId="{C997E11D-29CD-4387-AD28-D8541B11CB53}" dt="2025-03-24T10:57:09.293" v="4523" actId="1037"/>
          <ac:spMkLst>
            <pc:docMk/>
            <pc:sldMk cId="1216977762" sldId="1607"/>
            <ac:spMk id="68" creationId="{CC26C7B0-8B49-9F72-2ED8-CD115AB8B63D}"/>
          </ac:spMkLst>
        </pc:spChg>
        <pc:spChg chg="del mod topLvl">
          <ac:chgData name="Paolo Paganetti" userId="dcd282f25ae9c4f2" providerId="LiveId" clId="{C997E11D-29CD-4387-AD28-D8541B11CB53}" dt="2025-03-23T12:50:43.213" v="3374" actId="478"/>
          <ac:spMkLst>
            <pc:docMk/>
            <pc:sldMk cId="1216977762" sldId="1607"/>
            <ac:spMk id="69" creationId="{B18891C5-9EEE-B210-4794-E43FC0988686}"/>
          </ac:spMkLst>
        </pc:spChg>
        <pc:spChg chg="mod topLvl">
          <ac:chgData name="Paolo Paganetti" userId="dcd282f25ae9c4f2" providerId="LiveId" clId="{C997E11D-29CD-4387-AD28-D8541B11CB53}" dt="2025-03-24T10:49:05.930" v="4414" actId="164"/>
          <ac:spMkLst>
            <pc:docMk/>
            <pc:sldMk cId="1216977762" sldId="1607"/>
            <ac:spMk id="70" creationId="{E66CC3FC-8628-3DE5-075B-7249192F557C}"/>
          </ac:spMkLst>
        </pc:spChg>
        <pc:spChg chg="mod topLvl">
          <ac:chgData name="Paolo Paganetti" userId="dcd282f25ae9c4f2" providerId="LiveId" clId="{C997E11D-29CD-4387-AD28-D8541B11CB53}" dt="2025-03-24T10:49:05.930" v="4414" actId="164"/>
          <ac:spMkLst>
            <pc:docMk/>
            <pc:sldMk cId="1216977762" sldId="1607"/>
            <ac:spMk id="71" creationId="{9154DC47-5E82-7483-D749-0731EE027024}"/>
          </ac:spMkLst>
        </pc:spChg>
        <pc:spChg chg="mod topLvl">
          <ac:chgData name="Paolo Paganetti" userId="dcd282f25ae9c4f2" providerId="LiveId" clId="{C997E11D-29CD-4387-AD28-D8541B11CB53}" dt="2025-03-23T12:49:23.338" v="3257" actId="1076"/>
          <ac:spMkLst>
            <pc:docMk/>
            <pc:sldMk cId="1216977762" sldId="1607"/>
            <ac:spMk id="72" creationId="{A18E10A0-0442-55B8-5610-9A9B61813B1F}"/>
          </ac:spMkLst>
        </pc:spChg>
        <pc:spChg chg="mod">
          <ac:chgData name="Paolo Paganetti" userId="dcd282f25ae9c4f2" providerId="LiveId" clId="{C997E11D-29CD-4387-AD28-D8541B11CB53}" dt="2025-03-23T12:49:23.338" v="3257" actId="1076"/>
          <ac:spMkLst>
            <pc:docMk/>
            <pc:sldMk cId="1216977762" sldId="1607"/>
            <ac:spMk id="73" creationId="{D6D3FE1C-B34E-2DD2-7460-BC79D99A85F4}"/>
          </ac:spMkLst>
        </pc:spChg>
        <pc:spChg chg="mod topLvl">
          <ac:chgData name="Paolo Paganetti" userId="dcd282f25ae9c4f2" providerId="LiveId" clId="{C997E11D-29CD-4387-AD28-D8541B11CB53}" dt="2025-03-24T10:49:05.930" v="4414" actId="164"/>
          <ac:spMkLst>
            <pc:docMk/>
            <pc:sldMk cId="1216977762" sldId="1607"/>
            <ac:spMk id="74" creationId="{FCB569C5-8ABC-9E80-B8B3-2C026D48AB21}"/>
          </ac:spMkLst>
        </pc:spChg>
        <pc:spChg chg="mod topLvl">
          <ac:chgData name="Paolo Paganetti" userId="dcd282f25ae9c4f2" providerId="LiveId" clId="{C997E11D-29CD-4387-AD28-D8541B11CB53}" dt="2025-03-23T12:59:49.668" v="3539" actId="164"/>
          <ac:spMkLst>
            <pc:docMk/>
            <pc:sldMk cId="1216977762" sldId="1607"/>
            <ac:spMk id="75" creationId="{8606E20F-E8A6-E18A-0BCE-41FB95899E39}"/>
          </ac:spMkLst>
        </pc:spChg>
        <pc:spChg chg="mod topLvl">
          <ac:chgData name="Paolo Paganetti" userId="dcd282f25ae9c4f2" providerId="LiveId" clId="{C997E11D-29CD-4387-AD28-D8541B11CB53}" dt="2025-03-24T10:49:05.930" v="4414" actId="164"/>
          <ac:spMkLst>
            <pc:docMk/>
            <pc:sldMk cId="1216977762" sldId="1607"/>
            <ac:spMk id="76" creationId="{80B20AD5-0447-C223-5D5A-DEEB72D9F025}"/>
          </ac:spMkLst>
        </pc:spChg>
        <pc:spChg chg="mod topLvl">
          <ac:chgData name="Paolo Paganetti" userId="dcd282f25ae9c4f2" providerId="LiveId" clId="{C997E11D-29CD-4387-AD28-D8541B11CB53}" dt="2025-03-24T08:20:17.120" v="4321" actId="164"/>
          <ac:spMkLst>
            <pc:docMk/>
            <pc:sldMk cId="1216977762" sldId="1607"/>
            <ac:spMk id="77" creationId="{EDF15A6C-ABA4-AB43-D6F5-AE9E71CD098B}"/>
          </ac:spMkLst>
        </pc:spChg>
        <pc:spChg chg="mod topLvl">
          <ac:chgData name="Paolo Paganetti" userId="dcd282f25ae9c4f2" providerId="LiveId" clId="{C997E11D-29CD-4387-AD28-D8541B11CB53}" dt="2025-03-24T10:49:05.930" v="4414" actId="164"/>
          <ac:spMkLst>
            <pc:docMk/>
            <pc:sldMk cId="1216977762" sldId="1607"/>
            <ac:spMk id="80" creationId="{A02F3DCB-02BC-A844-57A6-3CDB230F0246}"/>
          </ac:spMkLst>
        </pc:spChg>
        <pc:spChg chg="mod topLvl">
          <ac:chgData name="Paolo Paganetti" userId="dcd282f25ae9c4f2" providerId="LiveId" clId="{C997E11D-29CD-4387-AD28-D8541B11CB53}" dt="2025-03-24T08:20:17.120" v="4321" actId="164"/>
          <ac:spMkLst>
            <pc:docMk/>
            <pc:sldMk cId="1216977762" sldId="1607"/>
            <ac:spMk id="81" creationId="{372D46AC-99B7-B8B7-1E68-E9F1CB10DB89}"/>
          </ac:spMkLst>
        </pc:spChg>
        <pc:spChg chg="mod topLvl">
          <ac:chgData name="Paolo Paganetti" userId="dcd282f25ae9c4f2" providerId="LiveId" clId="{C997E11D-29CD-4387-AD28-D8541B11CB53}" dt="2025-03-24T08:19:41.348" v="4318" actId="165"/>
          <ac:spMkLst>
            <pc:docMk/>
            <pc:sldMk cId="1216977762" sldId="1607"/>
            <ac:spMk id="82" creationId="{8AED5054-BEC9-5B87-4B1A-9329A0F46617}"/>
          </ac:spMkLst>
        </pc:spChg>
        <pc:spChg chg="add del mod">
          <ac:chgData name="Paolo Paganetti" userId="dcd282f25ae9c4f2" providerId="LiveId" clId="{C997E11D-29CD-4387-AD28-D8541B11CB53}" dt="2025-03-23T12:50:43.213" v="3374" actId="478"/>
          <ac:spMkLst>
            <pc:docMk/>
            <pc:sldMk cId="1216977762" sldId="1607"/>
            <ac:spMk id="87" creationId="{83893E44-17BD-B5B1-A2A2-05FAC6ED9D1A}"/>
          </ac:spMkLst>
        </pc:spChg>
        <pc:spChg chg="add del mod">
          <ac:chgData name="Paolo Paganetti" userId="dcd282f25ae9c4f2" providerId="LiveId" clId="{C997E11D-29CD-4387-AD28-D8541B11CB53}" dt="2025-03-23T12:59:34.170" v="3536" actId="478"/>
          <ac:spMkLst>
            <pc:docMk/>
            <pc:sldMk cId="1216977762" sldId="1607"/>
            <ac:spMk id="88" creationId="{E9833A44-9824-82B5-B7F5-DA98C9D2C621}"/>
          </ac:spMkLst>
        </pc:spChg>
        <pc:spChg chg="add del mod topLvl">
          <ac:chgData name="Paolo Paganetti" userId="dcd282f25ae9c4f2" providerId="LiveId" clId="{C997E11D-29CD-4387-AD28-D8541B11CB53}" dt="2025-03-23T12:57:36.608" v="3486" actId="478"/>
          <ac:spMkLst>
            <pc:docMk/>
            <pc:sldMk cId="1216977762" sldId="1607"/>
            <ac:spMk id="92" creationId="{908F1277-F846-2B86-4449-34205D9F2DF3}"/>
          </ac:spMkLst>
        </pc:spChg>
        <pc:spChg chg="add del mod topLvl">
          <ac:chgData name="Paolo Paganetti" userId="dcd282f25ae9c4f2" providerId="LiveId" clId="{C997E11D-29CD-4387-AD28-D8541B11CB53}" dt="2025-03-23T12:57:36.608" v="3486" actId="478"/>
          <ac:spMkLst>
            <pc:docMk/>
            <pc:sldMk cId="1216977762" sldId="1607"/>
            <ac:spMk id="93" creationId="{C4A852C2-67A9-78B0-BE9D-9AE33E2196BC}"/>
          </ac:spMkLst>
        </pc:spChg>
        <pc:spChg chg="add mod">
          <ac:chgData name="Paolo Paganetti" userId="dcd282f25ae9c4f2" providerId="LiveId" clId="{C997E11D-29CD-4387-AD28-D8541B11CB53}" dt="2025-03-24T08:19:51.902" v="4319" actId="555"/>
          <ac:spMkLst>
            <pc:docMk/>
            <pc:sldMk cId="1216977762" sldId="1607"/>
            <ac:spMk id="96" creationId="{EE616B4A-9325-EE7D-2677-34DA52C20B23}"/>
          </ac:spMkLst>
        </pc:spChg>
        <pc:spChg chg="add mod topLvl">
          <ac:chgData name="Paolo Paganetti" userId="dcd282f25ae9c4f2" providerId="LiveId" clId="{C997E11D-29CD-4387-AD28-D8541B11CB53}" dt="2025-03-24T08:20:17.120" v="4321" actId="164"/>
          <ac:spMkLst>
            <pc:docMk/>
            <pc:sldMk cId="1216977762" sldId="1607"/>
            <ac:spMk id="99" creationId="{4A34471C-5CC3-48FE-6686-56A5F191DBAE}"/>
          </ac:spMkLst>
        </pc:spChg>
        <pc:spChg chg="add mod topLvl">
          <ac:chgData name="Paolo Paganetti" userId="dcd282f25ae9c4f2" providerId="LiveId" clId="{C997E11D-29CD-4387-AD28-D8541B11CB53}" dt="2025-03-24T10:49:05.930" v="4414" actId="164"/>
          <ac:spMkLst>
            <pc:docMk/>
            <pc:sldMk cId="1216977762" sldId="1607"/>
            <ac:spMk id="100" creationId="{225972A6-66E3-B84E-AD0F-7EBEE02478F6}"/>
          </ac:spMkLst>
        </pc:spChg>
        <pc:spChg chg="add mod">
          <ac:chgData name="Paolo Paganetti" userId="dcd282f25ae9c4f2" providerId="LiveId" clId="{C997E11D-29CD-4387-AD28-D8541B11CB53}" dt="2025-03-23T14:04:35.057" v="3881" actId="164"/>
          <ac:spMkLst>
            <pc:docMk/>
            <pc:sldMk cId="1216977762" sldId="1607"/>
            <ac:spMk id="114" creationId="{1E831714-95E8-567D-74FD-E84924B204A7}"/>
          </ac:spMkLst>
        </pc:spChg>
        <pc:spChg chg="mod">
          <ac:chgData name="Paolo Paganetti" userId="dcd282f25ae9c4f2" providerId="LiveId" clId="{C997E11D-29CD-4387-AD28-D8541B11CB53}" dt="2025-03-23T14:04:03.133" v="3879"/>
          <ac:spMkLst>
            <pc:docMk/>
            <pc:sldMk cId="1216977762" sldId="1607"/>
            <ac:spMk id="117" creationId="{AAA6DA54-5DB4-C27C-7C13-FC24A0A2792F}"/>
          </ac:spMkLst>
        </pc:spChg>
        <pc:spChg chg="del mod topLvl">
          <ac:chgData name="Paolo Paganetti" userId="dcd282f25ae9c4f2" providerId="LiveId" clId="{C997E11D-29CD-4387-AD28-D8541B11CB53}" dt="2025-03-24T10:48:56.103" v="4412" actId="478"/>
          <ac:spMkLst>
            <pc:docMk/>
            <pc:sldMk cId="1216977762" sldId="1607"/>
            <ac:spMk id="118" creationId="{B03AD087-AC89-07E7-0B3A-C0C6CD0D2306}"/>
          </ac:spMkLst>
        </pc:spChg>
        <pc:spChg chg="mod">
          <ac:chgData name="Paolo Paganetti" userId="dcd282f25ae9c4f2" providerId="LiveId" clId="{C997E11D-29CD-4387-AD28-D8541B11CB53}" dt="2025-03-23T14:04:03.133" v="3879"/>
          <ac:spMkLst>
            <pc:docMk/>
            <pc:sldMk cId="1216977762" sldId="1607"/>
            <ac:spMk id="119" creationId="{EAF3AA42-F7FA-320D-9D02-D56BDD6811BE}"/>
          </ac:spMkLst>
        </pc:spChg>
        <pc:spChg chg="del mod topLvl">
          <ac:chgData name="Paolo Paganetti" userId="dcd282f25ae9c4f2" providerId="LiveId" clId="{C997E11D-29CD-4387-AD28-D8541B11CB53}" dt="2025-03-24T10:48:56.103" v="4412" actId="478"/>
          <ac:spMkLst>
            <pc:docMk/>
            <pc:sldMk cId="1216977762" sldId="1607"/>
            <ac:spMk id="120" creationId="{D4642774-E8A2-B72D-5263-3CA5D904C1B0}"/>
          </ac:spMkLst>
        </pc:spChg>
        <pc:spChg chg="mod topLvl">
          <ac:chgData name="Paolo Paganetti" userId="dcd282f25ae9c4f2" providerId="LiveId" clId="{C997E11D-29CD-4387-AD28-D8541B11CB53}" dt="2025-03-24T08:19:41.348" v="4318" actId="165"/>
          <ac:spMkLst>
            <pc:docMk/>
            <pc:sldMk cId="1216977762" sldId="1607"/>
            <ac:spMk id="121" creationId="{3CA41FF8-CA31-15FA-4A81-04930F2EB9FF}"/>
          </ac:spMkLst>
        </pc:spChg>
        <pc:spChg chg="del mod">
          <ac:chgData name="Paolo Paganetti" userId="dcd282f25ae9c4f2" providerId="LiveId" clId="{C997E11D-29CD-4387-AD28-D8541B11CB53}" dt="2025-03-24T10:48:56.103" v="4412" actId="478"/>
          <ac:spMkLst>
            <pc:docMk/>
            <pc:sldMk cId="1216977762" sldId="1607"/>
            <ac:spMk id="122" creationId="{3DCC9247-2756-7CE9-5AB0-4EFA69D07B73}"/>
          </ac:spMkLst>
        </pc:spChg>
        <pc:spChg chg="del">
          <ac:chgData name="Paolo Paganetti" userId="dcd282f25ae9c4f2" providerId="LiveId" clId="{C997E11D-29CD-4387-AD28-D8541B11CB53}" dt="2025-03-24T10:48:56.103" v="4412" actId="478"/>
          <ac:spMkLst>
            <pc:docMk/>
            <pc:sldMk cId="1216977762" sldId="1607"/>
            <ac:spMk id="123" creationId="{A815A3D5-54F8-0B3F-420F-09D545E953D7}"/>
          </ac:spMkLst>
        </pc:spChg>
        <pc:spChg chg="del mod topLvl">
          <ac:chgData name="Paolo Paganetti" userId="dcd282f25ae9c4f2" providerId="LiveId" clId="{C997E11D-29CD-4387-AD28-D8541B11CB53}" dt="2025-03-24T10:48:56.103" v="4412" actId="478"/>
          <ac:spMkLst>
            <pc:docMk/>
            <pc:sldMk cId="1216977762" sldId="1607"/>
            <ac:spMk id="124" creationId="{436C60E8-AF19-041E-058F-26455C4CC9AA}"/>
          </ac:spMkLst>
        </pc:spChg>
        <pc:spChg chg="mod">
          <ac:chgData name="Paolo Paganetti" userId="dcd282f25ae9c4f2" providerId="LiveId" clId="{C997E11D-29CD-4387-AD28-D8541B11CB53}" dt="2025-03-24T08:20:17.120" v="4321" actId="164"/>
          <ac:spMkLst>
            <pc:docMk/>
            <pc:sldMk cId="1216977762" sldId="1607"/>
            <ac:spMk id="125" creationId="{24334F57-C91B-10BC-4A5B-9DDFDE0D1CD8}"/>
          </ac:spMkLst>
        </pc:spChg>
        <pc:spChg chg="del mod">
          <ac:chgData name="Paolo Paganetti" userId="dcd282f25ae9c4f2" providerId="LiveId" clId="{C997E11D-29CD-4387-AD28-D8541B11CB53}" dt="2025-03-24T10:48:56.103" v="4412" actId="478"/>
          <ac:spMkLst>
            <pc:docMk/>
            <pc:sldMk cId="1216977762" sldId="1607"/>
            <ac:spMk id="126" creationId="{2312A1DE-2505-24AE-0FD0-2BF81271E521}"/>
          </ac:spMkLst>
        </pc:spChg>
        <pc:spChg chg="del mod">
          <ac:chgData name="Paolo Paganetti" userId="dcd282f25ae9c4f2" providerId="LiveId" clId="{C997E11D-29CD-4387-AD28-D8541B11CB53}" dt="2025-03-24T10:48:56.103" v="4412" actId="478"/>
          <ac:spMkLst>
            <pc:docMk/>
            <pc:sldMk cId="1216977762" sldId="1607"/>
            <ac:spMk id="127" creationId="{60634B57-5331-E1C5-5FF0-FF14FF6A4C1B}"/>
          </ac:spMkLst>
        </pc:spChg>
        <pc:spChg chg="del mod topLvl">
          <ac:chgData name="Paolo Paganetti" userId="dcd282f25ae9c4f2" providerId="LiveId" clId="{C997E11D-29CD-4387-AD28-D8541B11CB53}" dt="2025-03-24T10:48:56.103" v="4412" actId="478"/>
          <ac:spMkLst>
            <pc:docMk/>
            <pc:sldMk cId="1216977762" sldId="1607"/>
            <ac:spMk id="130" creationId="{22B9658D-427F-F825-053E-C665CA80D5AA}"/>
          </ac:spMkLst>
        </pc:spChg>
        <pc:spChg chg="del mod topLvl">
          <ac:chgData name="Paolo Paganetti" userId="dcd282f25ae9c4f2" providerId="LiveId" clId="{C997E11D-29CD-4387-AD28-D8541B11CB53}" dt="2025-03-24T10:48:56.103" v="4412" actId="478"/>
          <ac:spMkLst>
            <pc:docMk/>
            <pc:sldMk cId="1216977762" sldId="1607"/>
            <ac:spMk id="131" creationId="{0E820697-4D54-44FB-63A0-483328B83678}"/>
          </ac:spMkLst>
        </pc:spChg>
        <pc:spChg chg="del">
          <ac:chgData name="Paolo Paganetti" userId="dcd282f25ae9c4f2" providerId="LiveId" clId="{C997E11D-29CD-4387-AD28-D8541B11CB53}" dt="2025-03-24T10:48:56.103" v="4412" actId="478"/>
          <ac:spMkLst>
            <pc:docMk/>
            <pc:sldMk cId="1216977762" sldId="1607"/>
            <ac:spMk id="132" creationId="{254BD277-1F0F-B5D4-E653-CDCF1C084645}"/>
          </ac:spMkLst>
        </pc:spChg>
        <pc:grpChg chg="mod">
          <ac:chgData name="Paolo Paganetti" userId="dcd282f25ae9c4f2" providerId="LiveId" clId="{C997E11D-29CD-4387-AD28-D8541B11CB53}" dt="2025-03-23T12:48:46.667" v="3252" actId="1076"/>
          <ac:grpSpMkLst>
            <pc:docMk/>
            <pc:sldMk cId="1216977762" sldId="1607"/>
            <ac:grpSpMk id="2" creationId="{C2E3C82B-84DB-566B-74E8-F3527CEE7301}"/>
          </ac:grpSpMkLst>
        </pc:grpChg>
        <pc:grpChg chg="mod">
          <ac:chgData name="Paolo Paganetti" userId="dcd282f25ae9c4f2" providerId="LiveId" clId="{C997E11D-29CD-4387-AD28-D8541B11CB53}" dt="2025-03-24T10:48:48.501" v="4410" actId="1076"/>
          <ac:grpSpMkLst>
            <pc:docMk/>
            <pc:sldMk cId="1216977762" sldId="1607"/>
            <ac:grpSpMk id="3" creationId="{AF1E085D-B4CD-B92E-FFE4-19352A8B499B}"/>
          </ac:grpSpMkLst>
        </pc:grpChg>
        <pc:grpChg chg="mod">
          <ac:chgData name="Paolo Paganetti" userId="dcd282f25ae9c4f2" providerId="LiveId" clId="{C997E11D-29CD-4387-AD28-D8541B11CB53}" dt="2025-03-24T10:56:47.476" v="4514" actId="1076"/>
          <ac:grpSpMkLst>
            <pc:docMk/>
            <pc:sldMk cId="1216977762" sldId="1607"/>
            <ac:grpSpMk id="4" creationId="{A8A62E67-031B-94F8-C1FD-6F652E620364}"/>
          </ac:grpSpMkLst>
        </pc:grpChg>
        <pc:grpChg chg="del mod">
          <ac:chgData name="Paolo Paganetti" userId="dcd282f25ae9c4f2" providerId="LiveId" clId="{C997E11D-29CD-4387-AD28-D8541B11CB53}" dt="2025-03-23T12:59:40.887" v="3537" actId="478"/>
          <ac:grpSpMkLst>
            <pc:docMk/>
            <pc:sldMk cId="1216977762" sldId="1607"/>
            <ac:grpSpMk id="23" creationId="{978F3D7A-D1B3-7C79-04F6-561724CFB724}"/>
          </ac:grpSpMkLst>
        </pc:grpChg>
        <pc:grpChg chg="mod">
          <ac:chgData name="Paolo Paganetti" userId="dcd282f25ae9c4f2" providerId="LiveId" clId="{C997E11D-29CD-4387-AD28-D8541B11CB53}" dt="2025-03-23T14:04:35.057" v="3881" actId="164"/>
          <ac:grpSpMkLst>
            <pc:docMk/>
            <pc:sldMk cId="1216977762" sldId="1607"/>
            <ac:grpSpMk id="102" creationId="{7543C9CE-43F0-67BE-0E49-5EC3C4AAD9CC}"/>
          </ac:grpSpMkLst>
        </pc:grpChg>
        <pc:grpChg chg="mod">
          <ac:chgData name="Paolo Paganetti" userId="dcd282f25ae9c4f2" providerId="LiveId" clId="{C997E11D-29CD-4387-AD28-D8541B11CB53}" dt="2025-03-23T14:04:35.057" v="3881" actId="164"/>
          <ac:grpSpMkLst>
            <pc:docMk/>
            <pc:sldMk cId="1216977762" sldId="1607"/>
            <ac:grpSpMk id="115" creationId="{D2FE8191-3B58-7E28-6E99-F5890282645F}"/>
          </ac:grpSpMkLst>
        </pc:grpChg>
        <pc:grpChg chg="add mod">
          <ac:chgData name="Paolo Paganetti" userId="dcd282f25ae9c4f2" providerId="LiveId" clId="{C997E11D-29CD-4387-AD28-D8541B11CB53}" dt="2025-03-23T14:04:38.073" v="3882" actId="1076"/>
          <ac:grpSpMkLst>
            <pc:docMk/>
            <pc:sldMk cId="1216977762" sldId="1607"/>
            <ac:grpSpMk id="137" creationId="{D434BE7A-079C-DBEC-D2F7-EF537D5B9A5C}"/>
          </ac:grpSpMkLst>
        </pc:grpChg>
        <pc:picChg chg="add del mod">
          <ac:chgData name="Paolo Paganetti" userId="dcd282f25ae9c4f2" providerId="LiveId" clId="{C997E11D-29CD-4387-AD28-D8541B11CB53}" dt="2025-03-23T11:46:43.458" v="2329" actId="21"/>
          <ac:picMkLst>
            <pc:docMk/>
            <pc:sldMk cId="1216977762" sldId="1607"/>
            <ac:picMk id="3" creationId="{B491D3FA-A341-61FD-B89C-FB389136D819}"/>
          </ac:picMkLst>
        </pc:picChg>
        <pc:picChg chg="add del mod">
          <ac:chgData name="Paolo Paganetti" userId="dcd282f25ae9c4f2" providerId="LiveId" clId="{C997E11D-29CD-4387-AD28-D8541B11CB53}" dt="2025-03-23T11:46:43.458" v="2329" actId="21"/>
          <ac:picMkLst>
            <pc:docMk/>
            <pc:sldMk cId="1216977762" sldId="1607"/>
            <ac:picMk id="4" creationId="{C78F9E26-C757-6CF5-AE67-443E7ED26379}"/>
          </ac:picMkLst>
        </pc:picChg>
        <pc:picChg chg="add del mod">
          <ac:chgData name="Paolo Paganetti" userId="dcd282f25ae9c4f2" providerId="LiveId" clId="{C997E11D-29CD-4387-AD28-D8541B11CB53}" dt="2025-03-23T11:46:43.458" v="2329" actId="21"/>
          <ac:picMkLst>
            <pc:docMk/>
            <pc:sldMk cId="1216977762" sldId="1607"/>
            <ac:picMk id="5" creationId="{9C2EFF55-130D-3AC5-2201-25BB0A73DB56}"/>
          </ac:picMkLst>
        </pc:picChg>
        <pc:picChg chg="add del mod">
          <ac:chgData name="Paolo Paganetti" userId="dcd282f25ae9c4f2" providerId="LiveId" clId="{C997E11D-29CD-4387-AD28-D8541B11CB53}" dt="2025-03-23T11:47:51.987" v="2334" actId="478"/>
          <ac:picMkLst>
            <pc:docMk/>
            <pc:sldMk cId="1216977762" sldId="1607"/>
            <ac:picMk id="6" creationId="{24FFAB16-C76B-668D-F0D1-63A543FFE67D}"/>
          </ac:picMkLst>
        </pc:picChg>
        <pc:picChg chg="add del mod">
          <ac:chgData name="Paolo Paganetti" userId="dcd282f25ae9c4f2" providerId="LiveId" clId="{C997E11D-29CD-4387-AD28-D8541B11CB53}" dt="2025-03-23T11:47:51.987" v="2334" actId="478"/>
          <ac:picMkLst>
            <pc:docMk/>
            <pc:sldMk cId="1216977762" sldId="1607"/>
            <ac:picMk id="7" creationId="{B22468BE-E23B-AFCB-93BC-29C788007146}"/>
          </ac:picMkLst>
        </pc:picChg>
        <pc:picChg chg="add del mod">
          <ac:chgData name="Paolo Paganetti" userId="dcd282f25ae9c4f2" providerId="LiveId" clId="{C997E11D-29CD-4387-AD28-D8541B11CB53}" dt="2025-03-23T11:47:51.987" v="2334" actId="478"/>
          <ac:picMkLst>
            <pc:docMk/>
            <pc:sldMk cId="1216977762" sldId="1607"/>
            <ac:picMk id="8" creationId="{B5058FDE-E703-CB35-9E24-7E45503AD0BF}"/>
          </ac:picMkLst>
        </pc:picChg>
        <pc:picChg chg="add del mod modCrop">
          <ac:chgData name="Paolo Paganetti" userId="dcd282f25ae9c4f2" providerId="LiveId" clId="{C997E11D-29CD-4387-AD28-D8541B11CB53}" dt="2025-03-23T12:57:33.011" v="3485" actId="1038"/>
          <ac:picMkLst>
            <pc:docMk/>
            <pc:sldMk cId="1216977762" sldId="1607"/>
            <ac:picMk id="9" creationId="{8675D2AA-A012-DBC5-8E0B-9DCB1D38C131}"/>
          </ac:picMkLst>
        </pc:picChg>
        <pc:picChg chg="add mod modCrop">
          <ac:chgData name="Paolo Paganetti" userId="dcd282f25ae9c4f2" providerId="LiveId" clId="{C997E11D-29CD-4387-AD28-D8541B11CB53}" dt="2025-03-23T12:50:25.486" v="3371" actId="1036"/>
          <ac:picMkLst>
            <pc:docMk/>
            <pc:sldMk cId="1216977762" sldId="1607"/>
            <ac:picMk id="10" creationId="{3FA18C46-B7CE-B503-E8D5-9B1407F5025F}"/>
          </ac:picMkLst>
        </pc:picChg>
        <pc:picChg chg="add mod modCrop">
          <ac:chgData name="Paolo Paganetti" userId="dcd282f25ae9c4f2" providerId="LiveId" clId="{C997E11D-29CD-4387-AD28-D8541B11CB53}" dt="2025-03-23T12:57:33.011" v="3485" actId="1038"/>
          <ac:picMkLst>
            <pc:docMk/>
            <pc:sldMk cId="1216977762" sldId="1607"/>
            <ac:picMk id="11" creationId="{D2E1E3C1-05E7-1D3F-35DD-8DCFB812D611}"/>
          </ac:picMkLst>
        </pc:picChg>
        <pc:picChg chg="add del mod">
          <ac:chgData name="Paolo Paganetti" userId="dcd282f25ae9c4f2" providerId="LiveId" clId="{C997E11D-29CD-4387-AD28-D8541B11CB53}" dt="2025-03-23T12:47:03.547" v="3198" actId="478"/>
          <ac:picMkLst>
            <pc:docMk/>
            <pc:sldMk cId="1216977762" sldId="1607"/>
            <ac:picMk id="12" creationId="{D121037F-33B8-F56D-E0C0-1510EE1926DD}"/>
          </ac:picMkLst>
        </pc:picChg>
        <pc:picChg chg="add del mod">
          <ac:chgData name="Paolo Paganetti" userId="dcd282f25ae9c4f2" providerId="LiveId" clId="{C997E11D-29CD-4387-AD28-D8541B11CB53}" dt="2025-03-23T12:47:26.286" v="3226" actId="478"/>
          <ac:picMkLst>
            <pc:docMk/>
            <pc:sldMk cId="1216977762" sldId="1607"/>
            <ac:picMk id="13" creationId="{6E9C9B9A-1B03-02CA-CC2C-8149F757DA2B}"/>
          </ac:picMkLst>
        </pc:picChg>
        <pc:picChg chg="add del mod">
          <ac:chgData name="Paolo Paganetti" userId="dcd282f25ae9c4f2" providerId="LiveId" clId="{C997E11D-29CD-4387-AD28-D8541B11CB53}" dt="2025-03-23T12:47:36.352" v="3228" actId="478"/>
          <ac:picMkLst>
            <pc:docMk/>
            <pc:sldMk cId="1216977762" sldId="1607"/>
            <ac:picMk id="14" creationId="{2AAD695E-E9CF-FC34-38FE-88F4DD93606A}"/>
          </ac:picMkLst>
        </pc:picChg>
        <pc:picChg chg="add mod">
          <ac:chgData name="Paolo Paganetti" userId="dcd282f25ae9c4f2" providerId="LiveId" clId="{C997E11D-29CD-4387-AD28-D8541B11CB53}" dt="2025-03-23T12:48:07.486" v="3231" actId="571"/>
          <ac:picMkLst>
            <pc:docMk/>
            <pc:sldMk cId="1216977762" sldId="1607"/>
            <ac:picMk id="15" creationId="{F9E6C51F-3529-9C4D-ACB5-19488DC24FA8}"/>
          </ac:picMkLst>
        </pc:picChg>
        <pc:picChg chg="add del mod">
          <ac:chgData name="Paolo Paganetti" userId="dcd282f25ae9c4f2" providerId="LiveId" clId="{C997E11D-29CD-4387-AD28-D8541B11CB53}" dt="2025-03-23T12:48:31.513" v="3249" actId="478"/>
          <ac:picMkLst>
            <pc:docMk/>
            <pc:sldMk cId="1216977762" sldId="1607"/>
            <ac:picMk id="16" creationId="{7060CBA0-5453-3E23-25BB-C73F72867AAF}"/>
          </ac:picMkLst>
        </pc:picChg>
        <pc:picChg chg="add mod">
          <ac:chgData name="Paolo Paganetti" userId="dcd282f25ae9c4f2" providerId="LiveId" clId="{C997E11D-29CD-4387-AD28-D8541B11CB53}" dt="2025-03-23T12:48:45.891" v="3251" actId="571"/>
          <ac:picMkLst>
            <pc:docMk/>
            <pc:sldMk cId="1216977762" sldId="1607"/>
            <ac:picMk id="17" creationId="{D6F6F280-94D7-4B35-2BAF-3B94B5CFBC98}"/>
          </ac:picMkLst>
        </pc:picChg>
        <pc:picChg chg="add del mod">
          <ac:chgData name="Paolo Paganetti" userId="dcd282f25ae9c4f2" providerId="LiveId" clId="{C997E11D-29CD-4387-AD28-D8541B11CB53}" dt="2025-03-23T12:49:03.351" v="3255" actId="478"/>
          <ac:picMkLst>
            <pc:docMk/>
            <pc:sldMk cId="1216977762" sldId="1607"/>
            <ac:picMk id="18" creationId="{3AD38A23-CAFA-0852-52F5-94441D03A7A8}"/>
          </ac:picMkLst>
        </pc:picChg>
        <pc:picChg chg="add del mod">
          <ac:chgData name="Paolo Paganetti" userId="dcd282f25ae9c4f2" providerId="LiveId" clId="{C997E11D-29CD-4387-AD28-D8541B11CB53}" dt="2025-03-23T12:52:42.299" v="3385" actId="478"/>
          <ac:picMkLst>
            <pc:docMk/>
            <pc:sldMk cId="1216977762" sldId="1607"/>
            <ac:picMk id="20" creationId="{5A438915-F088-BDDE-69B1-8F5E9193A7DF}"/>
          </ac:picMkLst>
        </pc:picChg>
        <pc:picChg chg="add mod">
          <ac:chgData name="Paolo Paganetti" userId="dcd282f25ae9c4f2" providerId="LiveId" clId="{C997E11D-29CD-4387-AD28-D8541B11CB53}" dt="2025-03-23T12:53:23.154" v="3396" actId="571"/>
          <ac:picMkLst>
            <pc:docMk/>
            <pc:sldMk cId="1216977762" sldId="1607"/>
            <ac:picMk id="21" creationId="{603211BC-036F-A2F7-8D20-57FFE8650517}"/>
          </ac:picMkLst>
        </pc:picChg>
        <pc:picChg chg="add del mod">
          <ac:chgData name="Paolo Paganetti" userId="dcd282f25ae9c4f2" providerId="LiveId" clId="{C997E11D-29CD-4387-AD28-D8541B11CB53}" dt="2025-03-23T12:53:22.483" v="3395" actId="571"/>
          <ac:picMkLst>
            <pc:docMk/>
            <pc:sldMk cId="1216977762" sldId="1607"/>
            <ac:picMk id="22" creationId="{C9544B26-23E2-17EB-7098-D370747B676A}"/>
          </ac:picMkLst>
        </pc:picChg>
        <pc:picChg chg="add del mod modCrop">
          <ac:chgData name="Paolo Paganetti" userId="dcd282f25ae9c4f2" providerId="LiveId" clId="{C997E11D-29CD-4387-AD28-D8541B11CB53}" dt="2025-03-23T12:52:17.428" v="3380" actId="478"/>
          <ac:picMkLst>
            <pc:docMk/>
            <pc:sldMk cId="1216977762" sldId="1607"/>
            <ac:picMk id="60" creationId="{365D9233-FF9C-04D3-5F9E-1B618C3BED66}"/>
          </ac:picMkLst>
        </pc:picChg>
        <pc:picChg chg="add del mod modCrop">
          <ac:chgData name="Paolo Paganetti" userId="dcd282f25ae9c4f2" providerId="LiveId" clId="{C997E11D-29CD-4387-AD28-D8541B11CB53}" dt="2025-03-23T12:52:18.512" v="3381" actId="478"/>
          <ac:picMkLst>
            <pc:docMk/>
            <pc:sldMk cId="1216977762" sldId="1607"/>
            <ac:picMk id="63" creationId="{CBE9FECF-DC38-3A69-9895-6B17721118FC}"/>
          </ac:picMkLst>
        </pc:picChg>
        <pc:picChg chg="add del mod">
          <ac:chgData name="Paolo Paganetti" userId="dcd282f25ae9c4f2" providerId="LiveId" clId="{C997E11D-29CD-4387-AD28-D8541B11CB53}" dt="2025-03-23T13:04:41.289" v="3543" actId="478"/>
          <ac:picMkLst>
            <pc:docMk/>
            <pc:sldMk cId="1216977762" sldId="1607"/>
            <ac:picMk id="103" creationId="{042D7A83-A6B0-0386-B3A2-F7BD02F5F23E}"/>
          </ac:picMkLst>
        </pc:picChg>
        <pc:picChg chg="add del mod">
          <ac:chgData name="Paolo Paganetti" userId="dcd282f25ae9c4f2" providerId="LiveId" clId="{C997E11D-29CD-4387-AD28-D8541B11CB53}" dt="2025-03-23T13:04:41.289" v="3543" actId="478"/>
          <ac:picMkLst>
            <pc:docMk/>
            <pc:sldMk cId="1216977762" sldId="1607"/>
            <ac:picMk id="104" creationId="{AD1C1B91-8366-A0C7-CD71-F9D811962F2D}"/>
          </ac:picMkLst>
        </pc:picChg>
        <pc:picChg chg="add del mod">
          <ac:chgData name="Paolo Paganetti" userId="dcd282f25ae9c4f2" providerId="LiveId" clId="{C997E11D-29CD-4387-AD28-D8541B11CB53}" dt="2025-03-23T13:04:41.289" v="3543" actId="478"/>
          <ac:picMkLst>
            <pc:docMk/>
            <pc:sldMk cId="1216977762" sldId="1607"/>
            <ac:picMk id="105" creationId="{ECF0EF9F-C4F6-BA6F-146B-EF55B8EC141B}"/>
          </ac:picMkLst>
        </pc:picChg>
        <pc:picChg chg="add del mod">
          <ac:chgData name="Paolo Paganetti" userId="dcd282f25ae9c4f2" providerId="LiveId" clId="{C997E11D-29CD-4387-AD28-D8541B11CB53}" dt="2025-03-23T13:11:02.912" v="3566" actId="478"/>
          <ac:picMkLst>
            <pc:docMk/>
            <pc:sldMk cId="1216977762" sldId="1607"/>
            <ac:picMk id="107" creationId="{2DE20D48-6F1A-BDD6-C638-661CD028C9BE}"/>
          </ac:picMkLst>
        </pc:picChg>
        <pc:picChg chg="add del mod">
          <ac:chgData name="Paolo Paganetti" userId="dcd282f25ae9c4f2" providerId="LiveId" clId="{C997E11D-29CD-4387-AD28-D8541B11CB53}" dt="2025-03-23T13:11:01.284" v="3564" actId="478"/>
          <ac:picMkLst>
            <pc:docMk/>
            <pc:sldMk cId="1216977762" sldId="1607"/>
            <ac:picMk id="109" creationId="{7B115AEE-E95C-A21F-34DE-4ED2B32DA7FB}"/>
          </ac:picMkLst>
        </pc:picChg>
        <pc:picChg chg="add del mod">
          <ac:chgData name="Paolo Paganetti" userId="dcd282f25ae9c4f2" providerId="LiveId" clId="{C997E11D-29CD-4387-AD28-D8541B11CB53}" dt="2025-03-23T13:11:02.099" v="3565" actId="478"/>
          <ac:picMkLst>
            <pc:docMk/>
            <pc:sldMk cId="1216977762" sldId="1607"/>
            <ac:picMk id="111" creationId="{A6F4BCA3-F3D5-9B7D-A98E-ECDA68D1A936}"/>
          </ac:picMkLst>
        </pc:picChg>
        <pc:picChg chg="add del mod">
          <ac:chgData name="Paolo Paganetti" userId="dcd282f25ae9c4f2" providerId="LiveId" clId="{C997E11D-29CD-4387-AD28-D8541B11CB53}" dt="2025-03-23T13:10:59.865" v="3563" actId="478"/>
          <ac:picMkLst>
            <pc:docMk/>
            <pc:sldMk cId="1216977762" sldId="1607"/>
            <ac:picMk id="113" creationId="{49F7C4C8-E34E-3BE8-DAC1-89D971AE8436}"/>
          </ac:picMkLst>
        </pc:picChg>
        <pc:cxnChg chg="add mod">
          <ac:chgData name="Paolo Paganetti" userId="dcd282f25ae9c4f2" providerId="LiveId" clId="{C997E11D-29CD-4387-AD28-D8541B11CB53}" dt="2025-03-23T12:57:33.011" v="3485" actId="1038"/>
          <ac:cxnSpMkLst>
            <pc:docMk/>
            <pc:sldMk cId="1216977762" sldId="1607"/>
            <ac:cxnSpMk id="53" creationId="{A344D3EF-5E15-5607-76BC-46D09DEDE875}"/>
          </ac:cxnSpMkLst>
        </pc:cxnChg>
        <pc:cxnChg chg="add mod">
          <ac:chgData name="Paolo Paganetti" userId="dcd282f25ae9c4f2" providerId="LiveId" clId="{C997E11D-29CD-4387-AD28-D8541B11CB53}" dt="2025-03-23T12:57:33.011" v="3485" actId="1038"/>
          <ac:cxnSpMkLst>
            <pc:docMk/>
            <pc:sldMk cId="1216977762" sldId="1607"/>
            <ac:cxnSpMk id="55" creationId="{11E2C5E7-1D50-3266-2E21-799CEFEEDBB1}"/>
          </ac:cxnSpMkLst>
        </pc:cxnChg>
        <pc:cxnChg chg="add mod">
          <ac:chgData name="Paolo Paganetti" userId="dcd282f25ae9c4f2" providerId="LiveId" clId="{C997E11D-29CD-4387-AD28-D8541B11CB53}" dt="2025-03-23T12:58:03.190" v="3491" actId="571"/>
          <ac:cxnSpMkLst>
            <pc:docMk/>
            <pc:sldMk cId="1216977762" sldId="1607"/>
            <ac:cxnSpMk id="62" creationId="{347E8E8C-D923-AC13-3EF6-41FBB11E3B3E}"/>
          </ac:cxnSpMkLst>
        </pc:cxnChg>
        <pc:cxnChg chg="add mod">
          <ac:chgData name="Paolo Paganetti" userId="dcd282f25ae9c4f2" providerId="LiveId" clId="{C997E11D-29CD-4387-AD28-D8541B11CB53}" dt="2025-03-23T12:58:03.190" v="3491" actId="571"/>
          <ac:cxnSpMkLst>
            <pc:docMk/>
            <pc:sldMk cId="1216977762" sldId="1607"/>
            <ac:cxnSpMk id="64" creationId="{515353E9-5754-A73E-5666-2BEE7118C1BC}"/>
          </ac:cxnSpMkLst>
        </pc:cxnChg>
        <pc:cxnChg chg="mod">
          <ac:chgData name="Paolo Paganetti" userId="dcd282f25ae9c4f2" providerId="LiveId" clId="{C997E11D-29CD-4387-AD28-D8541B11CB53}" dt="2025-03-23T12:57:55.751" v="3490" actId="14100"/>
          <ac:cxnSpMkLst>
            <pc:docMk/>
            <pc:sldMk cId="1216977762" sldId="1607"/>
            <ac:cxnSpMk id="78" creationId="{276FD3D9-6BA3-FD9B-04AB-818137F93E8B}"/>
          </ac:cxnSpMkLst>
        </pc:cxnChg>
        <pc:cxnChg chg="mod">
          <ac:chgData name="Paolo Paganetti" userId="dcd282f25ae9c4f2" providerId="LiveId" clId="{C997E11D-29CD-4387-AD28-D8541B11CB53}" dt="2025-03-23T12:57:55.751" v="3490" actId="14100"/>
          <ac:cxnSpMkLst>
            <pc:docMk/>
            <pc:sldMk cId="1216977762" sldId="1607"/>
            <ac:cxnSpMk id="79" creationId="{5E54BD99-C7AD-CA65-EB37-7971EEBB7EDD}"/>
          </ac:cxnSpMkLst>
        </pc:cxnChg>
        <pc:cxnChg chg="mod">
          <ac:chgData name="Paolo Paganetti" userId="dcd282f25ae9c4f2" providerId="LiveId" clId="{C997E11D-29CD-4387-AD28-D8541B11CB53}" dt="2025-03-24T10:57:09.293" v="4523" actId="1037"/>
          <ac:cxnSpMkLst>
            <pc:docMk/>
            <pc:sldMk cId="1216977762" sldId="1607"/>
            <ac:cxnSpMk id="83" creationId="{EF0403AF-07DD-DE18-585D-E407BFF6D6A3}"/>
          </ac:cxnSpMkLst>
        </pc:cxnChg>
        <pc:cxnChg chg="mod ord">
          <ac:chgData name="Paolo Paganetti" userId="dcd282f25ae9c4f2" providerId="LiveId" clId="{C997E11D-29CD-4387-AD28-D8541B11CB53}" dt="2025-03-23T12:57:33.011" v="3485" actId="1038"/>
          <ac:cxnSpMkLst>
            <pc:docMk/>
            <pc:sldMk cId="1216977762" sldId="1607"/>
            <ac:cxnSpMk id="84" creationId="{F61C8070-5A04-07B8-2BA7-B866A23F4DB1}"/>
          </ac:cxnSpMkLst>
        </pc:cxnChg>
        <pc:cxnChg chg="mod ord">
          <ac:chgData name="Paolo Paganetti" userId="dcd282f25ae9c4f2" providerId="LiveId" clId="{C997E11D-29CD-4387-AD28-D8541B11CB53}" dt="2025-03-23T12:57:33.011" v="3485" actId="1038"/>
          <ac:cxnSpMkLst>
            <pc:docMk/>
            <pc:sldMk cId="1216977762" sldId="1607"/>
            <ac:cxnSpMk id="85" creationId="{7959BA16-C40F-FECD-F528-BB9B67B733F2}"/>
          </ac:cxnSpMkLst>
        </pc:cxnChg>
        <pc:cxnChg chg="del mod">
          <ac:chgData name="Paolo Paganetti" userId="dcd282f25ae9c4f2" providerId="LiveId" clId="{C997E11D-29CD-4387-AD28-D8541B11CB53}" dt="2025-03-23T12:56:00.528" v="3414" actId="478"/>
          <ac:cxnSpMkLst>
            <pc:docMk/>
            <pc:sldMk cId="1216977762" sldId="1607"/>
            <ac:cxnSpMk id="86" creationId="{66F5078F-62CB-3FE2-20C6-DC4E08DD1B19}"/>
          </ac:cxnSpMkLst>
        </pc:cxnChg>
        <pc:cxnChg chg="add del mod">
          <ac:chgData name="Paolo Paganetti" userId="dcd282f25ae9c4f2" providerId="LiveId" clId="{C997E11D-29CD-4387-AD28-D8541B11CB53}" dt="2025-03-23T12:59:06.412" v="3515" actId="478"/>
          <ac:cxnSpMkLst>
            <pc:docMk/>
            <pc:sldMk cId="1216977762" sldId="1607"/>
            <ac:cxnSpMk id="89" creationId="{0C3DC3CF-7CE7-78D4-FAF3-234F91856D16}"/>
          </ac:cxnSpMkLst>
        </pc:cxnChg>
        <pc:cxnChg chg="add mod ord">
          <ac:chgData name="Paolo Paganetti" userId="dcd282f25ae9c4f2" providerId="LiveId" clId="{C997E11D-29CD-4387-AD28-D8541B11CB53}" dt="2025-03-23T12:58:57.632" v="3512" actId="1036"/>
          <ac:cxnSpMkLst>
            <pc:docMk/>
            <pc:sldMk cId="1216977762" sldId="1607"/>
            <ac:cxnSpMk id="90" creationId="{C420D90A-9CB6-429B-7EAC-AA200405317E}"/>
          </ac:cxnSpMkLst>
        </pc:cxnChg>
        <pc:cxnChg chg="add mod ord">
          <ac:chgData name="Paolo Paganetti" userId="dcd282f25ae9c4f2" providerId="LiveId" clId="{C997E11D-29CD-4387-AD28-D8541B11CB53}" dt="2025-03-23T12:58:42.472" v="3496" actId="1076"/>
          <ac:cxnSpMkLst>
            <pc:docMk/>
            <pc:sldMk cId="1216977762" sldId="1607"/>
            <ac:cxnSpMk id="91" creationId="{37970CD3-1F1A-BDB6-A9AB-E06F96DCEC66}"/>
          </ac:cxnSpMkLst>
        </pc:cxnChg>
        <pc:cxnChg chg="add del mod">
          <ac:chgData name="Paolo Paganetti" userId="dcd282f25ae9c4f2" providerId="LiveId" clId="{C997E11D-29CD-4387-AD28-D8541B11CB53}" dt="2025-03-23T12:57:36.608" v="3486" actId="478"/>
          <ac:cxnSpMkLst>
            <pc:docMk/>
            <pc:sldMk cId="1216977762" sldId="1607"/>
            <ac:cxnSpMk id="94" creationId="{D27EB2B7-D468-5268-26D8-C42B44C964A3}"/>
          </ac:cxnSpMkLst>
        </pc:cxnChg>
        <pc:cxnChg chg="add del mod">
          <ac:chgData name="Paolo Paganetti" userId="dcd282f25ae9c4f2" providerId="LiveId" clId="{C997E11D-29CD-4387-AD28-D8541B11CB53}" dt="2025-03-23T12:57:36.608" v="3486" actId="478"/>
          <ac:cxnSpMkLst>
            <pc:docMk/>
            <pc:sldMk cId="1216977762" sldId="1607"/>
            <ac:cxnSpMk id="95" creationId="{04D309CE-F84F-C1F0-B3F7-4580893D9755}"/>
          </ac:cxnSpMkLst>
        </pc:cxnChg>
        <pc:cxnChg chg="add mod">
          <ac:chgData name="Paolo Paganetti" userId="dcd282f25ae9c4f2" providerId="LiveId" clId="{C997E11D-29CD-4387-AD28-D8541B11CB53}" dt="2025-03-23T12:58:07.410" v="3492" actId="571"/>
          <ac:cxnSpMkLst>
            <pc:docMk/>
            <pc:sldMk cId="1216977762" sldId="1607"/>
            <ac:cxnSpMk id="97" creationId="{DA77BA12-653A-7967-C637-C9D605A7DE7D}"/>
          </ac:cxnSpMkLst>
        </pc:cxnChg>
        <pc:cxnChg chg="add mod">
          <ac:chgData name="Paolo Paganetti" userId="dcd282f25ae9c4f2" providerId="LiveId" clId="{C997E11D-29CD-4387-AD28-D8541B11CB53}" dt="2025-03-24T08:20:03.508" v="4320" actId="555"/>
          <ac:cxnSpMkLst>
            <pc:docMk/>
            <pc:sldMk cId="1216977762" sldId="1607"/>
            <ac:cxnSpMk id="98" creationId="{C5FB8F3A-6CC4-2B0B-6F8D-E16527D87B0C}"/>
          </ac:cxnSpMkLst>
        </pc:cxnChg>
        <pc:cxnChg chg="add mod">
          <ac:chgData name="Paolo Paganetti" userId="dcd282f25ae9c4f2" providerId="LiveId" clId="{C997E11D-29CD-4387-AD28-D8541B11CB53}" dt="2025-03-23T12:59:23.704" v="3529" actId="1036"/>
          <ac:cxnSpMkLst>
            <pc:docMk/>
            <pc:sldMk cId="1216977762" sldId="1607"/>
            <ac:cxnSpMk id="101" creationId="{CFD490EF-FA2C-BEBD-07BF-9F797E570D14}"/>
          </ac:cxnSpMkLst>
        </pc:cxnChg>
        <pc:cxnChg chg="mod">
          <ac:chgData name="Paolo Paganetti" userId="dcd282f25ae9c4f2" providerId="LiveId" clId="{C997E11D-29CD-4387-AD28-D8541B11CB53}" dt="2025-03-24T08:20:03.508" v="4320" actId="555"/>
          <ac:cxnSpMkLst>
            <pc:docMk/>
            <pc:sldMk cId="1216977762" sldId="1607"/>
            <ac:cxnSpMk id="128" creationId="{A86C4DD4-ADE1-61DF-7CA1-B81F94C154B3}"/>
          </ac:cxnSpMkLst>
        </pc:cxnChg>
        <pc:cxnChg chg="mod">
          <ac:chgData name="Paolo Paganetti" userId="dcd282f25ae9c4f2" providerId="LiveId" clId="{C997E11D-29CD-4387-AD28-D8541B11CB53}" dt="2025-03-24T08:20:03.508" v="4320" actId="555"/>
          <ac:cxnSpMkLst>
            <pc:docMk/>
            <pc:sldMk cId="1216977762" sldId="1607"/>
            <ac:cxnSpMk id="129" creationId="{5873449F-8AB3-109A-4E70-2485307B477E}"/>
          </ac:cxnSpMkLst>
        </pc:cxnChg>
      </pc:sldChg>
      <pc:sldChg chg="del">
        <pc:chgData name="Paolo Paganetti" userId="dcd282f25ae9c4f2" providerId="LiveId" clId="{C997E11D-29CD-4387-AD28-D8541B11CB53}" dt="2025-03-19T08:50:12.302" v="12" actId="47"/>
        <pc:sldMkLst>
          <pc:docMk/>
          <pc:sldMk cId="1248745093" sldId="1608"/>
        </pc:sldMkLst>
      </pc:sldChg>
      <pc:sldChg chg="addSp delSp modSp mod">
        <pc:chgData name="Paolo Paganetti" userId="dcd282f25ae9c4f2" providerId="LiveId" clId="{C997E11D-29CD-4387-AD28-D8541B11CB53}" dt="2025-03-24T08:28:48.337" v="4398" actId="164"/>
        <pc:sldMkLst>
          <pc:docMk/>
          <pc:sldMk cId="4282942959" sldId="1611"/>
        </pc:sldMkLst>
        <pc:spChg chg="add mod ord">
          <ac:chgData name="Paolo Paganetti" userId="dcd282f25ae9c4f2" providerId="LiveId" clId="{C997E11D-29CD-4387-AD28-D8541B11CB53}" dt="2025-03-24T08:28:48.337" v="4398" actId="164"/>
          <ac:spMkLst>
            <pc:docMk/>
            <pc:sldMk cId="4282942959" sldId="1611"/>
            <ac:spMk id="2" creationId="{0E35D1A9-2DF5-429E-90B7-441E57DBFE9F}"/>
          </ac:spMkLst>
        </pc:spChg>
        <pc:spChg chg="add mod">
          <ac:chgData name="Paolo Paganetti" userId="dcd282f25ae9c4f2" providerId="LiveId" clId="{C997E11D-29CD-4387-AD28-D8541B11CB53}" dt="2025-03-24T08:28:48.337" v="4398" actId="164"/>
          <ac:spMkLst>
            <pc:docMk/>
            <pc:sldMk cId="4282942959" sldId="1611"/>
            <ac:spMk id="4" creationId="{C6061853-291C-0387-F8C8-2014544DDB83}"/>
          </ac:spMkLst>
        </pc:spChg>
        <pc:spChg chg="add del mod">
          <ac:chgData name="Paolo Paganetti" userId="dcd282f25ae9c4f2" providerId="LiveId" clId="{C997E11D-29CD-4387-AD28-D8541B11CB53}" dt="2025-03-23T12:36:18.118" v="3021" actId="478"/>
          <ac:spMkLst>
            <pc:docMk/>
            <pc:sldMk cId="4282942959" sldId="1611"/>
            <ac:spMk id="8" creationId="{45140CD0-3C34-FB6D-D70F-903D51B983B8}"/>
          </ac:spMkLst>
        </pc:spChg>
        <pc:spChg chg="add mod">
          <ac:chgData name="Paolo Paganetti" userId="dcd282f25ae9c4f2" providerId="LiveId" clId="{C997E11D-29CD-4387-AD28-D8541B11CB53}" dt="2025-03-23T12:41:32.270" v="3143" actId="164"/>
          <ac:spMkLst>
            <pc:docMk/>
            <pc:sldMk cId="4282942959" sldId="1611"/>
            <ac:spMk id="9" creationId="{40A22D7D-E755-7F91-2970-05ACA534013D}"/>
          </ac:spMkLst>
        </pc:spChg>
        <pc:spChg chg="add mod">
          <ac:chgData name="Paolo Paganetti" userId="dcd282f25ae9c4f2" providerId="LiveId" clId="{C997E11D-29CD-4387-AD28-D8541B11CB53}" dt="2025-03-23T12:41:32.270" v="3143" actId="164"/>
          <ac:spMkLst>
            <pc:docMk/>
            <pc:sldMk cId="4282942959" sldId="1611"/>
            <ac:spMk id="10" creationId="{B5C7A86F-6310-A7E6-3CE1-264192A141E7}"/>
          </ac:spMkLst>
        </pc:spChg>
        <pc:spChg chg="mod">
          <ac:chgData name="Paolo Paganetti" userId="dcd282f25ae9c4f2" providerId="LiveId" clId="{C997E11D-29CD-4387-AD28-D8541B11CB53}" dt="2025-03-23T12:41:32.270" v="3143" actId="164"/>
          <ac:spMkLst>
            <pc:docMk/>
            <pc:sldMk cId="4282942959" sldId="1611"/>
            <ac:spMk id="12" creationId="{B6A08515-F524-05F0-15E0-FD4D5C7797D2}"/>
          </ac:spMkLst>
        </pc:spChg>
        <pc:spChg chg="mod">
          <ac:chgData name="Paolo Paganetti" userId="dcd282f25ae9c4f2" providerId="LiveId" clId="{C997E11D-29CD-4387-AD28-D8541B11CB53}" dt="2025-03-23T12:41:36.917" v="3144" actId="164"/>
          <ac:spMkLst>
            <pc:docMk/>
            <pc:sldMk cId="4282942959" sldId="1611"/>
            <ac:spMk id="13" creationId="{46BEDBA9-FF66-0027-036A-161DDA909EE7}"/>
          </ac:spMkLst>
        </pc:spChg>
        <pc:spChg chg="mod">
          <ac:chgData name="Paolo Paganetti" userId="dcd282f25ae9c4f2" providerId="LiveId" clId="{C997E11D-29CD-4387-AD28-D8541B11CB53}" dt="2025-03-23T12:41:32.270" v="3143" actId="164"/>
          <ac:spMkLst>
            <pc:docMk/>
            <pc:sldMk cId="4282942959" sldId="1611"/>
            <ac:spMk id="14" creationId="{DA891110-7C7E-A644-6B4B-DAA3E0E11D24}"/>
          </ac:spMkLst>
        </pc:spChg>
        <pc:spChg chg="mod">
          <ac:chgData name="Paolo Paganetti" userId="dcd282f25ae9c4f2" providerId="LiveId" clId="{C997E11D-29CD-4387-AD28-D8541B11CB53}" dt="2025-03-23T12:34:45.863" v="3011" actId="1038"/>
          <ac:spMkLst>
            <pc:docMk/>
            <pc:sldMk cId="4282942959" sldId="1611"/>
            <ac:spMk id="15" creationId="{53029F72-D711-D4B4-5E87-4D7E3AA403C5}"/>
          </ac:spMkLst>
        </pc:spChg>
        <pc:spChg chg="add mod">
          <ac:chgData name="Paolo Paganetti" userId="dcd282f25ae9c4f2" providerId="LiveId" clId="{C997E11D-29CD-4387-AD28-D8541B11CB53}" dt="2025-03-23T12:34:53.506" v="3012" actId="1076"/>
          <ac:spMkLst>
            <pc:docMk/>
            <pc:sldMk cId="4282942959" sldId="1611"/>
            <ac:spMk id="16" creationId="{BEFC125E-7CE3-8813-16C2-A8D1DDB82C99}"/>
          </ac:spMkLst>
        </pc:spChg>
        <pc:spChg chg="add del mod">
          <ac:chgData name="Paolo Paganetti" userId="dcd282f25ae9c4f2" providerId="LiveId" clId="{C997E11D-29CD-4387-AD28-D8541B11CB53}" dt="2025-03-23T12:35:55.847" v="3019" actId="478"/>
          <ac:spMkLst>
            <pc:docMk/>
            <pc:sldMk cId="4282942959" sldId="1611"/>
            <ac:spMk id="17" creationId="{946BD976-0579-7969-C27E-FD006C9B7B7E}"/>
          </ac:spMkLst>
        </pc:spChg>
        <pc:spChg chg="add mod">
          <ac:chgData name="Paolo Paganetti" userId="dcd282f25ae9c4f2" providerId="LiveId" clId="{C997E11D-29CD-4387-AD28-D8541B11CB53}" dt="2025-03-23T12:34:45.863" v="3011" actId="1038"/>
          <ac:spMkLst>
            <pc:docMk/>
            <pc:sldMk cId="4282942959" sldId="1611"/>
            <ac:spMk id="18" creationId="{1E907F25-3A7D-0FB8-B124-1BFD105C229A}"/>
          </ac:spMkLst>
        </pc:spChg>
        <pc:spChg chg="add del mod">
          <ac:chgData name="Paolo Paganetti" userId="dcd282f25ae9c4f2" providerId="LiveId" clId="{C997E11D-29CD-4387-AD28-D8541B11CB53}" dt="2025-03-23T12:35:55.847" v="3019" actId="478"/>
          <ac:spMkLst>
            <pc:docMk/>
            <pc:sldMk cId="4282942959" sldId="1611"/>
            <ac:spMk id="19" creationId="{4FCA1B99-48A9-2651-5FE9-77B01ED3B84E}"/>
          </ac:spMkLst>
        </pc:spChg>
        <pc:spChg chg="add mod">
          <ac:chgData name="Paolo Paganetti" userId="dcd282f25ae9c4f2" providerId="LiveId" clId="{C997E11D-29CD-4387-AD28-D8541B11CB53}" dt="2025-03-23T12:34:45.863" v="3011" actId="1038"/>
          <ac:spMkLst>
            <pc:docMk/>
            <pc:sldMk cId="4282942959" sldId="1611"/>
            <ac:spMk id="20" creationId="{2FB12205-A63C-14CD-CE15-874197C048B0}"/>
          </ac:spMkLst>
        </pc:spChg>
        <pc:spChg chg="add mod">
          <ac:chgData name="Paolo Paganetti" userId="dcd282f25ae9c4f2" providerId="LiveId" clId="{C997E11D-29CD-4387-AD28-D8541B11CB53}" dt="2025-03-23T12:41:32.270" v="3143" actId="164"/>
          <ac:spMkLst>
            <pc:docMk/>
            <pc:sldMk cId="4282942959" sldId="1611"/>
            <ac:spMk id="21" creationId="{DB583B02-65F0-81DB-38CA-BBC20E2972B2}"/>
          </ac:spMkLst>
        </pc:spChg>
        <pc:spChg chg="del mod">
          <ac:chgData name="Paolo Paganetti" userId="dcd282f25ae9c4f2" providerId="LiveId" clId="{C997E11D-29CD-4387-AD28-D8541B11CB53}" dt="2025-03-23T12:35:55.847" v="3019" actId="478"/>
          <ac:spMkLst>
            <pc:docMk/>
            <pc:sldMk cId="4282942959" sldId="1611"/>
            <ac:spMk id="22" creationId="{FCF1F527-17AA-8686-D0E4-733C2314D2F6}"/>
          </ac:spMkLst>
        </pc:spChg>
        <pc:spChg chg="add del mod">
          <ac:chgData name="Paolo Paganetti" userId="dcd282f25ae9c4f2" providerId="LiveId" clId="{C997E11D-29CD-4387-AD28-D8541B11CB53}" dt="2025-03-23T12:35:55.847" v="3019" actId="478"/>
          <ac:spMkLst>
            <pc:docMk/>
            <pc:sldMk cId="4282942959" sldId="1611"/>
            <ac:spMk id="23" creationId="{4BB3E2C5-3603-476D-52CD-76FA1B1E1AE7}"/>
          </ac:spMkLst>
        </pc:spChg>
        <pc:spChg chg="add del mod">
          <ac:chgData name="Paolo Paganetti" userId="dcd282f25ae9c4f2" providerId="LiveId" clId="{C997E11D-29CD-4387-AD28-D8541B11CB53}" dt="2025-03-23T12:35:55.847" v="3019" actId="478"/>
          <ac:spMkLst>
            <pc:docMk/>
            <pc:sldMk cId="4282942959" sldId="1611"/>
            <ac:spMk id="24" creationId="{07862F39-0A2C-0B50-017A-5F51DB0DA555}"/>
          </ac:spMkLst>
        </pc:spChg>
        <pc:spChg chg="add mod">
          <ac:chgData name="Paolo Paganetti" userId="dcd282f25ae9c4f2" providerId="LiveId" clId="{C997E11D-29CD-4387-AD28-D8541B11CB53}" dt="2025-03-23T12:41:36.917" v="3144" actId="164"/>
          <ac:spMkLst>
            <pc:docMk/>
            <pc:sldMk cId="4282942959" sldId="1611"/>
            <ac:spMk id="25" creationId="{CB22425F-5615-1D78-001E-D87D1C4E3363}"/>
          </ac:spMkLst>
        </pc:spChg>
        <pc:spChg chg="mod">
          <ac:chgData name="Paolo Paganetti" userId="dcd282f25ae9c4f2" providerId="LiveId" clId="{C997E11D-29CD-4387-AD28-D8541B11CB53}" dt="2025-03-23T12:41:36.917" v="3144" actId="164"/>
          <ac:spMkLst>
            <pc:docMk/>
            <pc:sldMk cId="4282942959" sldId="1611"/>
            <ac:spMk id="26" creationId="{7D368ACC-00C3-FB53-9321-65F4DCFE90AF}"/>
          </ac:spMkLst>
        </pc:spChg>
        <pc:spChg chg="add mod">
          <ac:chgData name="Paolo Paganetti" userId="dcd282f25ae9c4f2" providerId="LiveId" clId="{C997E11D-29CD-4387-AD28-D8541B11CB53}" dt="2025-03-23T12:41:32.270" v="3143" actId="164"/>
          <ac:spMkLst>
            <pc:docMk/>
            <pc:sldMk cId="4282942959" sldId="1611"/>
            <ac:spMk id="28" creationId="{3AF0E19A-EF0D-3076-7D31-E95DEA1006E2}"/>
          </ac:spMkLst>
        </pc:spChg>
        <pc:spChg chg="add mod">
          <ac:chgData name="Paolo Paganetti" userId="dcd282f25ae9c4f2" providerId="LiveId" clId="{C997E11D-29CD-4387-AD28-D8541B11CB53}" dt="2025-03-23T12:34:00.108" v="2987" actId="1038"/>
          <ac:spMkLst>
            <pc:docMk/>
            <pc:sldMk cId="4282942959" sldId="1611"/>
            <ac:spMk id="29" creationId="{B1BBCC83-FB09-B69C-4F6A-1439CD43CCAB}"/>
          </ac:spMkLst>
        </pc:spChg>
        <pc:spChg chg="add mod">
          <ac:chgData name="Paolo Paganetti" userId="dcd282f25ae9c4f2" providerId="LiveId" clId="{C997E11D-29CD-4387-AD28-D8541B11CB53}" dt="2025-03-23T12:41:32.270" v="3143" actId="164"/>
          <ac:spMkLst>
            <pc:docMk/>
            <pc:sldMk cId="4282942959" sldId="1611"/>
            <ac:spMk id="32" creationId="{6CCDFCED-2CAD-A7B5-9F49-FAE5B1A9DB51}"/>
          </ac:spMkLst>
        </pc:spChg>
        <pc:spChg chg="add mod">
          <ac:chgData name="Paolo Paganetti" userId="dcd282f25ae9c4f2" providerId="LiveId" clId="{C997E11D-29CD-4387-AD28-D8541B11CB53}" dt="2025-03-23T12:41:32.270" v="3143" actId="164"/>
          <ac:spMkLst>
            <pc:docMk/>
            <pc:sldMk cId="4282942959" sldId="1611"/>
            <ac:spMk id="33" creationId="{E17ED80E-E32C-E7C0-EFB3-EAECF0674C2D}"/>
          </ac:spMkLst>
        </pc:spChg>
        <pc:spChg chg="add del mod">
          <ac:chgData name="Paolo Paganetti" userId="dcd282f25ae9c4f2" providerId="LiveId" clId="{C997E11D-29CD-4387-AD28-D8541B11CB53}" dt="2025-03-23T12:35:55.847" v="3019" actId="478"/>
          <ac:spMkLst>
            <pc:docMk/>
            <pc:sldMk cId="4282942959" sldId="1611"/>
            <ac:spMk id="35" creationId="{96DBE785-858F-3E70-9CB6-5562D7113BBA}"/>
          </ac:spMkLst>
        </pc:spChg>
        <pc:spChg chg="add mod">
          <ac:chgData name="Paolo Paganetti" userId="dcd282f25ae9c4f2" providerId="LiveId" clId="{C997E11D-29CD-4387-AD28-D8541B11CB53}" dt="2025-03-23T12:41:32.270" v="3143" actId="164"/>
          <ac:spMkLst>
            <pc:docMk/>
            <pc:sldMk cId="4282942959" sldId="1611"/>
            <ac:spMk id="36" creationId="{E3E4D384-0886-FDEE-04BE-936B95AE0681}"/>
          </ac:spMkLst>
        </pc:spChg>
        <pc:spChg chg="add del mod">
          <ac:chgData name="Paolo Paganetti" userId="dcd282f25ae9c4f2" providerId="LiveId" clId="{C997E11D-29CD-4387-AD28-D8541B11CB53}" dt="2025-03-23T12:35:55.847" v="3019" actId="478"/>
          <ac:spMkLst>
            <pc:docMk/>
            <pc:sldMk cId="4282942959" sldId="1611"/>
            <ac:spMk id="37" creationId="{2E8504BF-33E6-BC1C-241A-A1CDBA1FEB9D}"/>
          </ac:spMkLst>
        </pc:spChg>
        <pc:spChg chg="del mod">
          <ac:chgData name="Paolo Paganetti" userId="dcd282f25ae9c4f2" providerId="LiveId" clId="{C997E11D-29CD-4387-AD28-D8541B11CB53}" dt="2025-03-23T12:35:55.847" v="3019" actId="478"/>
          <ac:spMkLst>
            <pc:docMk/>
            <pc:sldMk cId="4282942959" sldId="1611"/>
            <ac:spMk id="38" creationId="{ED6B3BFD-7F90-FD35-2353-46B27ABCF738}"/>
          </ac:spMkLst>
        </pc:spChg>
        <pc:spChg chg="add del mod">
          <ac:chgData name="Paolo Paganetti" userId="dcd282f25ae9c4f2" providerId="LiveId" clId="{C997E11D-29CD-4387-AD28-D8541B11CB53}" dt="2025-03-23T12:33:49.162" v="2975" actId="478"/>
          <ac:spMkLst>
            <pc:docMk/>
            <pc:sldMk cId="4282942959" sldId="1611"/>
            <ac:spMk id="43" creationId="{A49A6480-34D9-3064-3EBC-E0DDAA3FD342}"/>
          </ac:spMkLst>
        </pc:spChg>
        <pc:spChg chg="mod">
          <ac:chgData name="Paolo Paganetti" userId="dcd282f25ae9c4f2" providerId="LiveId" clId="{C997E11D-29CD-4387-AD28-D8541B11CB53}" dt="2025-03-23T12:41:40.875" v="3145" actId="164"/>
          <ac:spMkLst>
            <pc:docMk/>
            <pc:sldMk cId="4282942959" sldId="1611"/>
            <ac:spMk id="44" creationId="{9FA0BCA5-1D4F-2F5B-2367-E29478EC21D1}"/>
          </ac:spMkLst>
        </pc:spChg>
        <pc:spChg chg="mod">
          <ac:chgData name="Paolo Paganetti" userId="dcd282f25ae9c4f2" providerId="LiveId" clId="{C997E11D-29CD-4387-AD28-D8541B11CB53}" dt="2025-03-23T12:38:45.178" v="3060" actId="207"/>
          <ac:spMkLst>
            <pc:docMk/>
            <pc:sldMk cId="4282942959" sldId="1611"/>
            <ac:spMk id="45" creationId="{D901F1B0-EFEF-3E54-AF79-A6CE2363EB83}"/>
          </ac:spMkLst>
        </pc:spChg>
        <pc:spChg chg="add del mod">
          <ac:chgData name="Paolo Paganetti" userId="dcd282f25ae9c4f2" providerId="LiveId" clId="{C997E11D-29CD-4387-AD28-D8541B11CB53}" dt="2025-03-23T12:34:08.310" v="2988" actId="478"/>
          <ac:spMkLst>
            <pc:docMk/>
            <pc:sldMk cId="4282942959" sldId="1611"/>
            <ac:spMk id="47" creationId="{07422F97-7B3D-2B10-CCD2-2A5D5F66785F}"/>
          </ac:spMkLst>
        </pc:spChg>
        <pc:spChg chg="add del mod">
          <ac:chgData name="Paolo Paganetti" userId="dcd282f25ae9c4f2" providerId="LiveId" clId="{C997E11D-29CD-4387-AD28-D8541B11CB53}" dt="2025-03-23T12:34:30.022" v="3000" actId="478"/>
          <ac:spMkLst>
            <pc:docMk/>
            <pc:sldMk cId="4282942959" sldId="1611"/>
            <ac:spMk id="51" creationId="{79AEB8F1-E84E-2604-3CE5-CD17D6A12D95}"/>
          </ac:spMkLst>
        </pc:spChg>
        <pc:spChg chg="add mod">
          <ac:chgData name="Paolo Paganetti" userId="dcd282f25ae9c4f2" providerId="LiveId" clId="{C997E11D-29CD-4387-AD28-D8541B11CB53}" dt="2025-03-23T12:41:32.270" v="3143" actId="164"/>
          <ac:spMkLst>
            <pc:docMk/>
            <pc:sldMk cId="4282942959" sldId="1611"/>
            <ac:spMk id="53" creationId="{10677203-306D-47DE-7E66-AC22761342B5}"/>
          </ac:spMkLst>
        </pc:spChg>
        <pc:spChg chg="mod">
          <ac:chgData name="Paolo Paganetti" userId="dcd282f25ae9c4f2" providerId="LiveId" clId="{C997E11D-29CD-4387-AD28-D8541B11CB53}" dt="2025-03-23T12:37:56.898" v="3054"/>
          <ac:spMkLst>
            <pc:docMk/>
            <pc:sldMk cId="4282942959" sldId="1611"/>
            <ac:spMk id="57" creationId="{AC7468B9-FF25-4209-4256-4011AE986B69}"/>
          </ac:spMkLst>
        </pc:spChg>
        <pc:spChg chg="mod">
          <ac:chgData name="Paolo Paganetti" userId="dcd282f25ae9c4f2" providerId="LiveId" clId="{C997E11D-29CD-4387-AD28-D8541B11CB53}" dt="2025-03-23T12:37:56.898" v="3054"/>
          <ac:spMkLst>
            <pc:docMk/>
            <pc:sldMk cId="4282942959" sldId="1611"/>
            <ac:spMk id="60" creationId="{6AC2E7C3-E6A6-774F-F602-2033E836F7ED}"/>
          </ac:spMkLst>
        </pc:spChg>
        <pc:spChg chg="add mod">
          <ac:chgData name="Paolo Paganetti" userId="dcd282f25ae9c4f2" providerId="LiveId" clId="{C997E11D-29CD-4387-AD28-D8541B11CB53}" dt="2025-03-23T12:41:40.875" v="3145" actId="164"/>
          <ac:spMkLst>
            <pc:docMk/>
            <pc:sldMk cId="4282942959" sldId="1611"/>
            <ac:spMk id="61" creationId="{66C893E4-1BF5-72C8-42D5-C106E5C17804}"/>
          </ac:spMkLst>
        </pc:spChg>
        <pc:spChg chg="add mod">
          <ac:chgData name="Paolo Paganetti" userId="dcd282f25ae9c4f2" providerId="LiveId" clId="{C997E11D-29CD-4387-AD28-D8541B11CB53}" dt="2025-03-23T12:41:40.875" v="3145" actId="164"/>
          <ac:spMkLst>
            <pc:docMk/>
            <pc:sldMk cId="4282942959" sldId="1611"/>
            <ac:spMk id="62" creationId="{4200A200-5022-662B-3EB1-E7539B4FCC8F}"/>
          </ac:spMkLst>
        </pc:spChg>
        <pc:spChg chg="mod">
          <ac:chgData name="Paolo Paganetti" userId="dcd282f25ae9c4f2" providerId="LiveId" clId="{C997E11D-29CD-4387-AD28-D8541B11CB53}" dt="2025-03-23T12:37:56.898" v="3054"/>
          <ac:spMkLst>
            <pc:docMk/>
            <pc:sldMk cId="4282942959" sldId="1611"/>
            <ac:spMk id="67" creationId="{589003E5-40CC-A910-0CBB-231CC770549B}"/>
          </ac:spMkLst>
        </pc:spChg>
        <pc:spChg chg="mod">
          <ac:chgData name="Paolo Paganetti" userId="dcd282f25ae9c4f2" providerId="LiveId" clId="{C997E11D-29CD-4387-AD28-D8541B11CB53}" dt="2025-03-23T12:37:56.898" v="3054"/>
          <ac:spMkLst>
            <pc:docMk/>
            <pc:sldMk cId="4282942959" sldId="1611"/>
            <ac:spMk id="68" creationId="{FEB4E2BD-4C54-B0AE-AB33-6454F983C42A}"/>
          </ac:spMkLst>
        </pc:spChg>
        <pc:spChg chg="mod">
          <ac:chgData name="Paolo Paganetti" userId="dcd282f25ae9c4f2" providerId="LiveId" clId="{C997E11D-29CD-4387-AD28-D8541B11CB53}" dt="2025-03-23T12:37:56.898" v="3054"/>
          <ac:spMkLst>
            <pc:docMk/>
            <pc:sldMk cId="4282942959" sldId="1611"/>
            <ac:spMk id="69" creationId="{C25C4BD5-DF7F-6E55-EAC5-0D08122F3223}"/>
          </ac:spMkLst>
        </pc:spChg>
        <pc:spChg chg="mod">
          <ac:chgData name="Paolo Paganetti" userId="dcd282f25ae9c4f2" providerId="LiveId" clId="{C997E11D-29CD-4387-AD28-D8541B11CB53}" dt="2025-03-23T12:37:56.898" v="3054"/>
          <ac:spMkLst>
            <pc:docMk/>
            <pc:sldMk cId="4282942959" sldId="1611"/>
            <ac:spMk id="70" creationId="{3AE9EB78-FA33-7459-A902-8C25B29C2E4F}"/>
          </ac:spMkLst>
        </pc:spChg>
        <pc:spChg chg="mod">
          <ac:chgData name="Paolo Paganetti" userId="dcd282f25ae9c4f2" providerId="LiveId" clId="{C997E11D-29CD-4387-AD28-D8541B11CB53}" dt="2025-03-23T12:37:56.898" v="3054"/>
          <ac:spMkLst>
            <pc:docMk/>
            <pc:sldMk cId="4282942959" sldId="1611"/>
            <ac:spMk id="72" creationId="{1EAED4F9-637E-6BEF-3426-62AE05863BAD}"/>
          </ac:spMkLst>
        </pc:spChg>
        <pc:spChg chg="mod">
          <ac:chgData name="Paolo Paganetti" userId="dcd282f25ae9c4f2" providerId="LiveId" clId="{C997E11D-29CD-4387-AD28-D8541B11CB53}" dt="2025-03-23T12:37:56.898" v="3054"/>
          <ac:spMkLst>
            <pc:docMk/>
            <pc:sldMk cId="4282942959" sldId="1611"/>
            <ac:spMk id="74" creationId="{05EF7A49-E17B-D527-C060-BAA03A683ABB}"/>
          </ac:spMkLst>
        </pc:spChg>
        <pc:spChg chg="mod">
          <ac:chgData name="Paolo Paganetti" userId="dcd282f25ae9c4f2" providerId="LiveId" clId="{C997E11D-29CD-4387-AD28-D8541B11CB53}" dt="2025-03-23T12:37:56.898" v="3054"/>
          <ac:spMkLst>
            <pc:docMk/>
            <pc:sldMk cId="4282942959" sldId="1611"/>
            <ac:spMk id="79" creationId="{800D1153-AC4E-1D26-140F-ECBFEB0BA31C}"/>
          </ac:spMkLst>
        </pc:spChg>
        <pc:spChg chg="mod">
          <ac:chgData name="Paolo Paganetti" userId="dcd282f25ae9c4f2" providerId="LiveId" clId="{C997E11D-29CD-4387-AD28-D8541B11CB53}" dt="2025-03-23T12:37:56.898" v="3054"/>
          <ac:spMkLst>
            <pc:docMk/>
            <pc:sldMk cId="4282942959" sldId="1611"/>
            <ac:spMk id="80" creationId="{4DCDF660-3E18-261A-4555-31F838C1399E}"/>
          </ac:spMkLst>
        </pc:spChg>
        <pc:spChg chg="add mod">
          <ac:chgData name="Paolo Paganetti" userId="dcd282f25ae9c4f2" providerId="LiveId" clId="{C997E11D-29CD-4387-AD28-D8541B11CB53}" dt="2025-03-23T12:41:36.917" v="3144" actId="164"/>
          <ac:spMkLst>
            <pc:docMk/>
            <pc:sldMk cId="4282942959" sldId="1611"/>
            <ac:spMk id="83" creationId="{0DE7DA38-A53B-5289-3FA5-9D74200844C7}"/>
          </ac:spMkLst>
        </pc:spChg>
        <pc:spChg chg="add mod">
          <ac:chgData name="Paolo Paganetti" userId="dcd282f25ae9c4f2" providerId="LiveId" clId="{C997E11D-29CD-4387-AD28-D8541B11CB53}" dt="2025-03-23T12:41:40.875" v="3145" actId="164"/>
          <ac:spMkLst>
            <pc:docMk/>
            <pc:sldMk cId="4282942959" sldId="1611"/>
            <ac:spMk id="84" creationId="{F024E611-ADA9-B610-06F2-F779BC9A9981}"/>
          </ac:spMkLst>
        </pc:spChg>
        <pc:grpChg chg="add mod">
          <ac:chgData name="Paolo Paganetti" userId="dcd282f25ae9c4f2" providerId="LiveId" clId="{C997E11D-29CD-4387-AD28-D8541B11CB53}" dt="2025-03-24T08:28:48.337" v="4398" actId="164"/>
          <ac:grpSpMkLst>
            <pc:docMk/>
            <pc:sldMk cId="4282942959" sldId="1611"/>
            <ac:grpSpMk id="6" creationId="{0655331B-8831-F855-9381-F3EE0FD8E112}"/>
          </ac:grpSpMkLst>
        </pc:grpChg>
        <pc:grpChg chg="del mod">
          <ac:chgData name="Paolo Paganetti" userId="dcd282f25ae9c4f2" providerId="LiveId" clId="{C997E11D-29CD-4387-AD28-D8541B11CB53}" dt="2025-03-23T12:41:22.768" v="3142" actId="478"/>
          <ac:grpSpMkLst>
            <pc:docMk/>
            <pc:sldMk cId="4282942959" sldId="1611"/>
            <ac:grpSpMk id="54" creationId="{8659F69E-852D-2E60-5B9C-1B1867AA60D6}"/>
          </ac:grpSpMkLst>
        </pc:grpChg>
        <pc:grpChg chg="mod">
          <ac:chgData name="Paolo Paganetti" userId="dcd282f25ae9c4f2" providerId="LiveId" clId="{C997E11D-29CD-4387-AD28-D8541B11CB53}" dt="2025-03-23T12:42:07.237" v="3149" actId="164"/>
          <ac:grpSpMkLst>
            <pc:docMk/>
            <pc:sldMk cId="4282942959" sldId="1611"/>
            <ac:grpSpMk id="86" creationId="{DDEA45CF-6C03-2545-701E-0DF2A8ABD692}"/>
          </ac:grpSpMkLst>
        </pc:grpChg>
        <pc:grpChg chg="add mod">
          <ac:chgData name="Paolo Paganetti" userId="dcd282f25ae9c4f2" providerId="LiveId" clId="{C997E11D-29CD-4387-AD28-D8541B11CB53}" dt="2025-03-23T12:42:07.237" v="3149" actId="164"/>
          <ac:grpSpMkLst>
            <pc:docMk/>
            <pc:sldMk cId="4282942959" sldId="1611"/>
            <ac:grpSpMk id="87" creationId="{87D71D90-6AF2-F232-3CFF-946367689851}"/>
          </ac:grpSpMkLst>
        </pc:grpChg>
        <pc:grpChg chg="add mod">
          <ac:chgData name="Paolo Paganetti" userId="dcd282f25ae9c4f2" providerId="LiveId" clId="{C997E11D-29CD-4387-AD28-D8541B11CB53}" dt="2025-03-23T12:42:07.237" v="3149" actId="164"/>
          <ac:grpSpMkLst>
            <pc:docMk/>
            <pc:sldMk cId="4282942959" sldId="1611"/>
            <ac:grpSpMk id="88" creationId="{F33066A5-C1F4-B291-A09D-E39FD4A10C34}"/>
          </ac:grpSpMkLst>
        </pc:grpChg>
        <pc:grpChg chg="add mod">
          <ac:chgData name="Paolo Paganetti" userId="dcd282f25ae9c4f2" providerId="LiveId" clId="{C997E11D-29CD-4387-AD28-D8541B11CB53}" dt="2025-03-24T08:28:48.337" v="4398" actId="164"/>
          <ac:grpSpMkLst>
            <pc:docMk/>
            <pc:sldMk cId="4282942959" sldId="1611"/>
            <ac:grpSpMk id="89" creationId="{F2B05A2B-E531-E2C5-6790-88D956ABC69D}"/>
          </ac:grpSpMkLst>
        </pc:grpChg>
        <pc:picChg chg="del">
          <ac:chgData name="Paolo Paganetti" userId="dcd282f25ae9c4f2" providerId="LiveId" clId="{C997E11D-29CD-4387-AD28-D8541B11CB53}" dt="2025-03-23T12:33:09.171" v="2971" actId="478"/>
          <ac:picMkLst>
            <pc:docMk/>
            <pc:sldMk cId="4282942959" sldId="1611"/>
            <ac:picMk id="2" creationId="{6AE42E11-3A0D-E569-3BC7-54BC85B3866E}"/>
          </ac:picMkLst>
        </pc:picChg>
        <pc:picChg chg="add mod modCrop">
          <ac:chgData name="Paolo Paganetti" userId="dcd282f25ae9c4f2" providerId="LiveId" clId="{C997E11D-29CD-4387-AD28-D8541B11CB53}" dt="2025-03-23T12:40:43.716" v="3106" actId="1076"/>
          <ac:picMkLst>
            <pc:docMk/>
            <pc:sldMk cId="4282942959" sldId="1611"/>
            <ac:picMk id="3" creationId="{985889F2-9248-26C6-4042-B38D244CCF10}"/>
          </ac:picMkLst>
        </pc:picChg>
        <pc:picChg chg="add mod modCrop">
          <ac:chgData name="Paolo Paganetti" userId="dcd282f25ae9c4f2" providerId="LiveId" clId="{C997E11D-29CD-4387-AD28-D8541B11CB53}" dt="2025-03-23T12:41:36.917" v="3144" actId="164"/>
          <ac:picMkLst>
            <pc:docMk/>
            <pc:sldMk cId="4282942959" sldId="1611"/>
            <ac:picMk id="5" creationId="{0CD442DC-7C3C-39B2-D5F9-085B2D8FE707}"/>
          </ac:picMkLst>
        </pc:picChg>
        <pc:picChg chg="add del mod modCrop">
          <ac:chgData name="Paolo Paganetti" userId="dcd282f25ae9c4f2" providerId="LiveId" clId="{C997E11D-29CD-4387-AD28-D8541B11CB53}" dt="2025-03-23T12:38:53.131" v="3061" actId="478"/>
          <ac:picMkLst>
            <pc:docMk/>
            <pc:sldMk cId="4282942959" sldId="1611"/>
            <ac:picMk id="6" creationId="{DD41165C-70E2-9534-8851-75134D36C6DF}"/>
          </ac:picMkLst>
        </pc:picChg>
        <pc:picChg chg="add del mod modCrop">
          <ac:chgData name="Paolo Paganetti" userId="dcd282f25ae9c4f2" providerId="LiveId" clId="{C997E11D-29CD-4387-AD28-D8541B11CB53}" dt="2025-03-23T12:38:55.008" v="3062" actId="478"/>
          <ac:picMkLst>
            <pc:docMk/>
            <pc:sldMk cId="4282942959" sldId="1611"/>
            <ac:picMk id="7" creationId="{B9EA6D6E-F4D6-1F0C-BD83-BB29727458B2}"/>
          </ac:picMkLst>
        </pc:picChg>
        <pc:picChg chg="add mod modCrop">
          <ac:chgData name="Paolo Paganetti" userId="dcd282f25ae9c4f2" providerId="LiveId" clId="{C997E11D-29CD-4387-AD28-D8541B11CB53}" dt="2025-03-23T12:41:40.875" v="3145" actId="164"/>
          <ac:picMkLst>
            <pc:docMk/>
            <pc:sldMk cId="4282942959" sldId="1611"/>
            <ac:picMk id="11" creationId="{6B665F3D-5697-2864-CB1D-3F40B6A239EB}"/>
          </ac:picMkLst>
        </pc:picChg>
        <pc:picChg chg="add del mod">
          <ac:chgData name="Paolo Paganetti" userId="dcd282f25ae9c4f2" providerId="LiveId" clId="{C997E11D-29CD-4387-AD28-D8541B11CB53}" dt="2025-03-23T13:12:49.117" v="3570" actId="478"/>
          <ac:picMkLst>
            <pc:docMk/>
            <pc:sldMk cId="4282942959" sldId="1611"/>
            <ac:picMk id="91" creationId="{BA9AFE71-9A76-B323-7DD5-C507266BF3D7}"/>
          </ac:picMkLst>
        </pc:picChg>
        <pc:picChg chg="add mod">
          <ac:chgData name="Paolo Paganetti" userId="dcd282f25ae9c4f2" providerId="LiveId" clId="{C997E11D-29CD-4387-AD28-D8541B11CB53}" dt="2025-03-23T13:13:49.972" v="3575"/>
          <ac:picMkLst>
            <pc:docMk/>
            <pc:sldMk cId="4282942959" sldId="1611"/>
            <ac:picMk id="93" creationId="{41DB69F4-971D-FCD9-6434-BA2081CE251F}"/>
          </ac:picMkLst>
        </pc:picChg>
        <pc:picChg chg="add del mod">
          <ac:chgData name="Paolo Paganetti" userId="dcd282f25ae9c4f2" providerId="LiveId" clId="{C997E11D-29CD-4387-AD28-D8541B11CB53}" dt="2025-03-23T13:14:05.573" v="3579" actId="478"/>
          <ac:picMkLst>
            <pc:docMk/>
            <pc:sldMk cId="4282942959" sldId="1611"/>
            <ac:picMk id="95" creationId="{13DFA29C-33CC-3859-33DF-2265A6D4217E}"/>
          </ac:picMkLst>
        </pc:picChg>
        <pc:picChg chg="add del mod">
          <ac:chgData name="Paolo Paganetti" userId="dcd282f25ae9c4f2" providerId="LiveId" clId="{C997E11D-29CD-4387-AD28-D8541B11CB53}" dt="2025-03-23T13:14:30.734" v="3583" actId="478"/>
          <ac:picMkLst>
            <pc:docMk/>
            <pc:sldMk cId="4282942959" sldId="1611"/>
            <ac:picMk id="97" creationId="{2331E735-5301-4703-8A85-F723D0CD64BC}"/>
          </ac:picMkLst>
        </pc:picChg>
        <pc:cxnChg chg="mod">
          <ac:chgData name="Paolo Paganetti" userId="dcd282f25ae9c4f2" providerId="LiveId" clId="{C997E11D-29CD-4387-AD28-D8541B11CB53}" dt="2025-03-23T12:41:36.917" v="3144" actId="164"/>
          <ac:cxnSpMkLst>
            <pc:docMk/>
            <pc:sldMk cId="4282942959" sldId="1611"/>
            <ac:cxnSpMk id="27" creationId="{9A92D741-4E60-AB2B-07CC-811E0FCD51AC}"/>
          </ac:cxnSpMkLst>
        </pc:cxnChg>
        <pc:cxnChg chg="mod">
          <ac:chgData name="Paolo Paganetti" userId="dcd282f25ae9c4f2" providerId="LiveId" clId="{C997E11D-29CD-4387-AD28-D8541B11CB53}" dt="2025-03-23T12:34:23.780" v="2999" actId="1038"/>
          <ac:cxnSpMkLst>
            <pc:docMk/>
            <pc:sldMk cId="4282942959" sldId="1611"/>
            <ac:cxnSpMk id="30" creationId="{840B2C7C-5203-C925-E6E3-93EA292198E3}"/>
          </ac:cxnSpMkLst>
        </pc:cxnChg>
        <pc:cxnChg chg="mod">
          <ac:chgData name="Paolo Paganetti" userId="dcd282f25ae9c4f2" providerId="LiveId" clId="{C997E11D-29CD-4387-AD28-D8541B11CB53}" dt="2025-03-23T12:34:00.108" v="2987" actId="1038"/>
          <ac:cxnSpMkLst>
            <pc:docMk/>
            <pc:sldMk cId="4282942959" sldId="1611"/>
            <ac:cxnSpMk id="31" creationId="{C578F8AB-4C78-8248-69ED-F85E2012868B}"/>
          </ac:cxnSpMkLst>
        </pc:cxnChg>
        <pc:cxnChg chg="mod">
          <ac:chgData name="Paolo Paganetti" userId="dcd282f25ae9c4f2" providerId="LiveId" clId="{C997E11D-29CD-4387-AD28-D8541B11CB53}" dt="2025-03-23T12:41:36.917" v="3144" actId="164"/>
          <ac:cxnSpMkLst>
            <pc:docMk/>
            <pc:sldMk cId="4282942959" sldId="1611"/>
            <ac:cxnSpMk id="34" creationId="{7670626F-282F-C9A4-2E6B-E2EDA97AD0D5}"/>
          </ac:cxnSpMkLst>
        </pc:cxnChg>
        <pc:cxnChg chg="mod">
          <ac:chgData name="Paolo Paganetti" userId="dcd282f25ae9c4f2" providerId="LiveId" clId="{C997E11D-29CD-4387-AD28-D8541B11CB53}" dt="2025-03-23T12:36:50.118" v="3041" actId="14100"/>
          <ac:cxnSpMkLst>
            <pc:docMk/>
            <pc:sldMk cId="4282942959" sldId="1611"/>
            <ac:cxnSpMk id="39" creationId="{03075D56-FAF0-C369-2C52-AF9DFCBCBD65}"/>
          </ac:cxnSpMkLst>
        </pc:cxnChg>
        <pc:cxnChg chg="del">
          <ac:chgData name="Paolo Paganetti" userId="dcd282f25ae9c4f2" providerId="LiveId" clId="{C997E11D-29CD-4387-AD28-D8541B11CB53}" dt="2025-03-23T12:36:28.980" v="3024" actId="478"/>
          <ac:cxnSpMkLst>
            <pc:docMk/>
            <pc:sldMk cId="4282942959" sldId="1611"/>
            <ac:cxnSpMk id="40" creationId="{547FC166-30A7-1E75-47D2-B59165A4AA9B}"/>
          </ac:cxnSpMkLst>
        </pc:cxnChg>
        <pc:cxnChg chg="mod ord">
          <ac:chgData name="Paolo Paganetti" userId="dcd282f25ae9c4f2" providerId="LiveId" clId="{C997E11D-29CD-4387-AD28-D8541B11CB53}" dt="2025-03-23T12:41:36.917" v="3144" actId="164"/>
          <ac:cxnSpMkLst>
            <pc:docMk/>
            <pc:sldMk cId="4282942959" sldId="1611"/>
            <ac:cxnSpMk id="42" creationId="{79E73104-AFA3-D45F-56BC-B8419E68A8A6}"/>
          </ac:cxnSpMkLst>
        </pc:cxnChg>
        <pc:cxnChg chg="add del mod">
          <ac:chgData name="Paolo Paganetti" userId="dcd282f25ae9c4f2" providerId="LiveId" clId="{C997E11D-29CD-4387-AD28-D8541B11CB53}" dt="2025-03-23T12:33:49.162" v="2975" actId="478"/>
          <ac:cxnSpMkLst>
            <pc:docMk/>
            <pc:sldMk cId="4282942959" sldId="1611"/>
            <ac:cxnSpMk id="46" creationId="{D130C27E-1402-23AE-B50D-1EF95DF564FF}"/>
          </ac:cxnSpMkLst>
        </pc:cxnChg>
        <pc:cxnChg chg="mod">
          <ac:chgData name="Paolo Paganetti" userId="dcd282f25ae9c4f2" providerId="LiveId" clId="{C997E11D-29CD-4387-AD28-D8541B11CB53}" dt="2025-03-23T12:41:40.875" v="3145" actId="164"/>
          <ac:cxnSpMkLst>
            <pc:docMk/>
            <pc:sldMk cId="4282942959" sldId="1611"/>
            <ac:cxnSpMk id="48" creationId="{C5CB7895-DCD2-1F58-32BB-D3B102D7A0F4}"/>
          </ac:cxnSpMkLst>
        </pc:cxnChg>
        <pc:cxnChg chg="mod ord">
          <ac:chgData name="Paolo Paganetti" userId="dcd282f25ae9c4f2" providerId="LiveId" clId="{C997E11D-29CD-4387-AD28-D8541B11CB53}" dt="2025-03-23T12:41:40.875" v="3145" actId="164"/>
          <ac:cxnSpMkLst>
            <pc:docMk/>
            <pc:sldMk cId="4282942959" sldId="1611"/>
            <ac:cxnSpMk id="49" creationId="{8618959D-3554-F7E3-7A96-22FFBEFD1473}"/>
          </ac:cxnSpMkLst>
        </pc:cxnChg>
        <pc:cxnChg chg="add del mod">
          <ac:chgData name="Paolo Paganetti" userId="dcd282f25ae9c4f2" providerId="LiveId" clId="{C997E11D-29CD-4387-AD28-D8541B11CB53}" dt="2025-03-23T12:34:08.310" v="2988" actId="478"/>
          <ac:cxnSpMkLst>
            <pc:docMk/>
            <pc:sldMk cId="4282942959" sldId="1611"/>
            <ac:cxnSpMk id="50" creationId="{E50E9F89-E51F-85E2-7E5D-F1A230351F2A}"/>
          </ac:cxnSpMkLst>
        </pc:cxnChg>
        <pc:cxnChg chg="add del mod">
          <ac:chgData name="Paolo Paganetti" userId="dcd282f25ae9c4f2" providerId="LiveId" clId="{C997E11D-29CD-4387-AD28-D8541B11CB53}" dt="2025-03-23T12:34:30.022" v="3000" actId="478"/>
          <ac:cxnSpMkLst>
            <pc:docMk/>
            <pc:sldMk cId="4282942959" sldId="1611"/>
            <ac:cxnSpMk id="52" creationId="{197C090C-F50A-E78D-3E45-8F186DB8C89F}"/>
          </ac:cxnSpMkLst>
        </pc:cxnChg>
        <pc:cxnChg chg="add mod">
          <ac:chgData name="Paolo Paganetti" userId="dcd282f25ae9c4f2" providerId="LiveId" clId="{C997E11D-29CD-4387-AD28-D8541B11CB53}" dt="2025-03-23T12:41:40.875" v="3145" actId="164"/>
          <ac:cxnSpMkLst>
            <pc:docMk/>
            <pc:sldMk cId="4282942959" sldId="1611"/>
            <ac:cxnSpMk id="63" creationId="{A43F03A1-3CCB-AA29-DFE0-F8D5458F2401}"/>
          </ac:cxnSpMkLst>
        </pc:cxnChg>
        <pc:cxnChg chg="add mod">
          <ac:chgData name="Paolo Paganetti" userId="dcd282f25ae9c4f2" providerId="LiveId" clId="{C997E11D-29CD-4387-AD28-D8541B11CB53}" dt="2025-03-19T10:36:18.272" v="1695" actId="571"/>
          <ac:cxnSpMkLst>
            <pc:docMk/>
            <pc:sldMk cId="4282942959" sldId="1611"/>
            <ac:cxnSpMk id="64" creationId="{299E2BDA-1B6E-CF65-7480-A38C940950D3}"/>
          </ac:cxnSpMkLst>
        </pc:cxnChg>
        <pc:cxnChg chg="add mod ord">
          <ac:chgData name="Paolo Paganetti" userId="dcd282f25ae9c4f2" providerId="LiveId" clId="{C997E11D-29CD-4387-AD28-D8541B11CB53}" dt="2025-03-23T12:41:40.875" v="3145" actId="164"/>
          <ac:cxnSpMkLst>
            <pc:docMk/>
            <pc:sldMk cId="4282942959" sldId="1611"/>
            <ac:cxnSpMk id="66" creationId="{89A1926B-0E34-DF89-A44E-F13C4EF91E3C}"/>
          </ac:cxnSpMkLst>
        </pc:cxnChg>
        <pc:cxnChg chg="add mod">
          <ac:chgData name="Paolo Paganetti" userId="dcd282f25ae9c4f2" providerId="LiveId" clId="{C997E11D-29CD-4387-AD28-D8541B11CB53}" dt="2025-03-23T12:41:36.917" v="3144" actId="164"/>
          <ac:cxnSpMkLst>
            <pc:docMk/>
            <pc:sldMk cId="4282942959" sldId="1611"/>
            <ac:cxnSpMk id="85" creationId="{E64D7408-E2C6-0C56-2FB1-FD0252AA44F4}"/>
          </ac:cxnSpMkLst>
        </pc:cxnChg>
      </pc:sldChg>
      <pc:sldChg chg="addSp delSp modSp mod">
        <pc:chgData name="Paolo Paganetti" userId="dcd282f25ae9c4f2" providerId="LiveId" clId="{C997E11D-29CD-4387-AD28-D8541B11CB53}" dt="2025-03-24T08:29:48.092" v="4407" actId="164"/>
        <pc:sldMkLst>
          <pc:docMk/>
          <pc:sldMk cId="1711125189" sldId="1612"/>
        </pc:sldMkLst>
        <pc:spChg chg="add mod ord">
          <ac:chgData name="Paolo Paganetti" userId="dcd282f25ae9c4f2" providerId="LiveId" clId="{C997E11D-29CD-4387-AD28-D8541B11CB53}" dt="2025-03-24T08:29:48.092" v="4407" actId="164"/>
          <ac:spMkLst>
            <pc:docMk/>
            <pc:sldMk cId="1711125189" sldId="1612"/>
            <ac:spMk id="2" creationId="{CA27696E-C7EC-E6AE-EB00-AD8A29624FAC}"/>
          </ac:spMkLst>
        </pc:spChg>
        <pc:spChg chg="add mod">
          <ac:chgData name="Paolo Paganetti" userId="dcd282f25ae9c4f2" providerId="LiveId" clId="{C997E11D-29CD-4387-AD28-D8541B11CB53}" dt="2025-03-24T08:29:48.092" v="4407" actId="164"/>
          <ac:spMkLst>
            <pc:docMk/>
            <pc:sldMk cId="1711125189" sldId="1612"/>
            <ac:spMk id="4" creationId="{A79D73D0-4DAD-0EE4-7FCC-BC2AD923BB5F}"/>
          </ac:spMkLst>
        </pc:spChg>
        <pc:spChg chg="mod">
          <ac:chgData name="Paolo Paganetti" userId="dcd282f25ae9c4f2" providerId="LiveId" clId="{C997E11D-29CD-4387-AD28-D8541B11CB53}" dt="2025-03-23T11:53:20.129" v="2374"/>
          <ac:spMkLst>
            <pc:docMk/>
            <pc:sldMk cId="1711125189" sldId="1612"/>
            <ac:spMk id="6" creationId="{08F34939-5EB0-0253-4DDB-423CFB2CD49E}"/>
          </ac:spMkLst>
        </pc:spChg>
        <pc:spChg chg="add mod">
          <ac:chgData name="Paolo Paganetti" userId="dcd282f25ae9c4f2" providerId="LiveId" clId="{C997E11D-29CD-4387-AD28-D8541B11CB53}" dt="2025-03-23T14:21:51.774" v="4307" actId="164"/>
          <ac:spMkLst>
            <pc:docMk/>
            <pc:sldMk cId="1711125189" sldId="1612"/>
            <ac:spMk id="7" creationId="{C78208B4-A2B0-7327-3407-C8F12DF6433F}"/>
          </ac:spMkLst>
        </pc:spChg>
        <pc:spChg chg="add mod">
          <ac:chgData name="Paolo Paganetti" userId="dcd282f25ae9c4f2" providerId="LiveId" clId="{C997E11D-29CD-4387-AD28-D8541B11CB53}" dt="2025-03-23T14:21:51.774" v="4307" actId="164"/>
          <ac:spMkLst>
            <pc:docMk/>
            <pc:sldMk cId="1711125189" sldId="1612"/>
            <ac:spMk id="8" creationId="{887D1698-7EB7-AE07-B738-6241FF008514}"/>
          </ac:spMkLst>
        </pc:spChg>
        <pc:spChg chg="add mod">
          <ac:chgData name="Paolo Paganetti" userId="dcd282f25ae9c4f2" providerId="LiveId" clId="{C997E11D-29CD-4387-AD28-D8541B11CB53}" dt="2025-03-19T10:44:37.111" v="1837" actId="1035"/>
          <ac:spMkLst>
            <pc:docMk/>
            <pc:sldMk cId="1711125189" sldId="1612"/>
            <ac:spMk id="9" creationId="{269D26D2-177B-00A5-E7D2-F26311BAB72B}"/>
          </ac:spMkLst>
        </pc:spChg>
        <pc:spChg chg="add mod">
          <ac:chgData name="Paolo Paganetti" userId="dcd282f25ae9c4f2" providerId="LiveId" clId="{C997E11D-29CD-4387-AD28-D8541B11CB53}" dt="2025-03-23T13:48:10.035" v="3745" actId="1037"/>
          <ac:spMkLst>
            <pc:docMk/>
            <pc:sldMk cId="1711125189" sldId="1612"/>
            <ac:spMk id="10" creationId="{4E0FD1A3-4443-A0E7-5DE8-F8176CB651BA}"/>
          </ac:spMkLst>
        </pc:spChg>
        <pc:spChg chg="add mod">
          <ac:chgData name="Paolo Paganetti" userId="dcd282f25ae9c4f2" providerId="LiveId" clId="{C997E11D-29CD-4387-AD28-D8541B11CB53}" dt="2025-03-23T14:13:10.396" v="3930" actId="1076"/>
          <ac:spMkLst>
            <pc:docMk/>
            <pc:sldMk cId="1711125189" sldId="1612"/>
            <ac:spMk id="11" creationId="{6BCE01C6-3093-CCDC-0BB1-E59238952B41}"/>
          </ac:spMkLst>
        </pc:spChg>
        <pc:spChg chg="add mod">
          <ac:chgData name="Paolo Paganetti" userId="dcd282f25ae9c4f2" providerId="LiveId" clId="{C997E11D-29CD-4387-AD28-D8541B11CB53}" dt="2025-03-23T13:48:10.035" v="3745" actId="1037"/>
          <ac:spMkLst>
            <pc:docMk/>
            <pc:sldMk cId="1711125189" sldId="1612"/>
            <ac:spMk id="12" creationId="{F4A751DB-F308-FAE8-A5E3-F5EFF5E46184}"/>
          </ac:spMkLst>
        </pc:spChg>
        <pc:spChg chg="mod">
          <ac:chgData name="Paolo Paganetti" userId="dcd282f25ae9c4f2" providerId="LiveId" clId="{C997E11D-29CD-4387-AD28-D8541B11CB53}" dt="2025-03-23T11:53:20.129" v="2374"/>
          <ac:spMkLst>
            <pc:docMk/>
            <pc:sldMk cId="1711125189" sldId="1612"/>
            <ac:spMk id="15" creationId="{8BFAA3C4-837E-E7D5-FC08-3510FDD75C56}"/>
          </ac:spMkLst>
        </pc:spChg>
        <pc:spChg chg="mod">
          <ac:chgData name="Paolo Paganetti" userId="dcd282f25ae9c4f2" providerId="LiveId" clId="{C997E11D-29CD-4387-AD28-D8541B11CB53}" dt="2025-03-23T11:53:20.129" v="2374"/>
          <ac:spMkLst>
            <pc:docMk/>
            <pc:sldMk cId="1711125189" sldId="1612"/>
            <ac:spMk id="16" creationId="{3020EC73-24C1-36D2-87A6-20A4532846FA}"/>
          </ac:spMkLst>
        </pc:spChg>
        <pc:spChg chg="add mod">
          <ac:chgData name="Paolo Paganetti" userId="dcd282f25ae9c4f2" providerId="LiveId" clId="{C997E11D-29CD-4387-AD28-D8541B11CB53}" dt="2025-03-23T13:48:10.035" v="3745" actId="1037"/>
          <ac:spMkLst>
            <pc:docMk/>
            <pc:sldMk cId="1711125189" sldId="1612"/>
            <ac:spMk id="17" creationId="{5CEC7235-BD2D-44A3-31B5-ED182C831A2C}"/>
          </ac:spMkLst>
        </pc:spChg>
        <pc:spChg chg="add mod">
          <ac:chgData name="Paolo Paganetti" userId="dcd282f25ae9c4f2" providerId="LiveId" clId="{C997E11D-29CD-4387-AD28-D8541B11CB53}" dt="2025-03-23T14:13:10.396" v="3930" actId="1076"/>
          <ac:spMkLst>
            <pc:docMk/>
            <pc:sldMk cId="1711125189" sldId="1612"/>
            <ac:spMk id="18" creationId="{2CCB7249-F7D2-5B29-4135-BAFCF246F0B3}"/>
          </ac:spMkLst>
        </pc:spChg>
        <pc:spChg chg="add mod">
          <ac:chgData name="Paolo Paganetti" userId="dcd282f25ae9c4f2" providerId="LiveId" clId="{C997E11D-29CD-4387-AD28-D8541B11CB53}" dt="2025-03-23T14:21:51.774" v="4307" actId="164"/>
          <ac:spMkLst>
            <pc:docMk/>
            <pc:sldMk cId="1711125189" sldId="1612"/>
            <ac:spMk id="21" creationId="{92B35C85-312A-E05E-E955-37E7204C690A}"/>
          </ac:spMkLst>
        </pc:spChg>
        <pc:spChg chg="add mod">
          <ac:chgData name="Paolo Paganetti" userId="dcd282f25ae9c4f2" providerId="LiveId" clId="{C997E11D-29CD-4387-AD28-D8541B11CB53}" dt="2025-03-23T13:49:28.576" v="3839" actId="1036"/>
          <ac:spMkLst>
            <pc:docMk/>
            <pc:sldMk cId="1711125189" sldId="1612"/>
            <ac:spMk id="23" creationId="{644CD90C-F91B-0A10-6C7E-409CED20DC30}"/>
          </ac:spMkLst>
        </pc:spChg>
        <pc:spChg chg="mod">
          <ac:chgData name="Paolo Paganetti" userId="dcd282f25ae9c4f2" providerId="LiveId" clId="{C997E11D-29CD-4387-AD28-D8541B11CB53}" dt="2025-03-23T11:53:20.129" v="2374"/>
          <ac:spMkLst>
            <pc:docMk/>
            <pc:sldMk cId="1711125189" sldId="1612"/>
            <ac:spMk id="24" creationId="{10E74A61-C538-2851-6420-7F3C6CADEA52}"/>
          </ac:spMkLst>
        </pc:spChg>
        <pc:spChg chg="add mod">
          <ac:chgData name="Paolo Paganetti" userId="dcd282f25ae9c4f2" providerId="LiveId" clId="{C997E11D-29CD-4387-AD28-D8541B11CB53}" dt="2025-03-23T14:21:51.774" v="4307" actId="164"/>
          <ac:spMkLst>
            <pc:docMk/>
            <pc:sldMk cId="1711125189" sldId="1612"/>
            <ac:spMk id="28" creationId="{B1416DD6-00A0-97B2-D71A-6744E8F7E31C}"/>
          </ac:spMkLst>
        </pc:spChg>
        <pc:spChg chg="add mod">
          <ac:chgData name="Paolo Paganetti" userId="dcd282f25ae9c4f2" providerId="LiveId" clId="{C997E11D-29CD-4387-AD28-D8541B11CB53}" dt="2025-03-23T14:21:51.774" v="4307" actId="164"/>
          <ac:spMkLst>
            <pc:docMk/>
            <pc:sldMk cId="1711125189" sldId="1612"/>
            <ac:spMk id="29" creationId="{495F659F-8C9C-F27A-B812-0EE5ADF030E1}"/>
          </ac:spMkLst>
        </pc:spChg>
        <pc:spChg chg="add del mod">
          <ac:chgData name="Paolo Paganetti" userId="dcd282f25ae9c4f2" providerId="LiveId" clId="{C997E11D-29CD-4387-AD28-D8541B11CB53}" dt="2025-03-23T13:49:12.654" v="3782" actId="478"/>
          <ac:spMkLst>
            <pc:docMk/>
            <pc:sldMk cId="1711125189" sldId="1612"/>
            <ac:spMk id="34" creationId="{EC4A4FF2-96F0-F11D-0585-7D420509665F}"/>
          </ac:spMkLst>
        </pc:spChg>
        <pc:spChg chg="add mod">
          <ac:chgData name="Paolo Paganetti" userId="dcd282f25ae9c4f2" providerId="LiveId" clId="{C997E11D-29CD-4387-AD28-D8541B11CB53}" dt="2025-03-23T14:21:51.774" v="4307" actId="164"/>
          <ac:spMkLst>
            <pc:docMk/>
            <pc:sldMk cId="1711125189" sldId="1612"/>
            <ac:spMk id="35" creationId="{17B44E4F-C52F-114A-6A89-246A86F195DC}"/>
          </ac:spMkLst>
        </pc:spChg>
        <pc:spChg chg="add mod">
          <ac:chgData name="Paolo Paganetti" userId="dcd282f25ae9c4f2" providerId="LiveId" clId="{C997E11D-29CD-4387-AD28-D8541B11CB53}" dt="2025-03-23T14:21:51.774" v="4307" actId="164"/>
          <ac:spMkLst>
            <pc:docMk/>
            <pc:sldMk cId="1711125189" sldId="1612"/>
            <ac:spMk id="40" creationId="{370A252C-1500-AC1F-C298-1277D30373ED}"/>
          </ac:spMkLst>
        </pc:spChg>
        <pc:spChg chg="add mod">
          <ac:chgData name="Paolo Paganetti" userId="dcd282f25ae9c4f2" providerId="LiveId" clId="{C997E11D-29CD-4387-AD28-D8541B11CB53}" dt="2025-03-23T14:20:13.098" v="4191" actId="164"/>
          <ac:spMkLst>
            <pc:docMk/>
            <pc:sldMk cId="1711125189" sldId="1612"/>
            <ac:spMk id="41" creationId="{380F6D27-6AF3-4109-5D62-8201782CFA73}"/>
          </ac:spMkLst>
        </pc:spChg>
        <pc:spChg chg="add mod">
          <ac:chgData name="Paolo Paganetti" userId="dcd282f25ae9c4f2" providerId="LiveId" clId="{C997E11D-29CD-4387-AD28-D8541B11CB53}" dt="2025-03-23T14:13:10.396" v="3930" actId="1076"/>
          <ac:spMkLst>
            <pc:docMk/>
            <pc:sldMk cId="1711125189" sldId="1612"/>
            <ac:spMk id="42" creationId="{44505B72-8B7A-4387-8831-A85F6BD85FA4}"/>
          </ac:spMkLst>
        </pc:spChg>
        <pc:spChg chg="add mod">
          <ac:chgData name="Paolo Paganetti" userId="dcd282f25ae9c4f2" providerId="LiveId" clId="{C997E11D-29CD-4387-AD28-D8541B11CB53}" dt="2025-03-23T13:49:04.659" v="3781" actId="1035"/>
          <ac:spMkLst>
            <pc:docMk/>
            <pc:sldMk cId="1711125189" sldId="1612"/>
            <ac:spMk id="43" creationId="{0CEAA7FB-015C-35B0-A664-B3A648C54C4D}"/>
          </ac:spMkLst>
        </pc:spChg>
        <pc:spChg chg="add mod">
          <ac:chgData name="Paolo Paganetti" userId="dcd282f25ae9c4f2" providerId="LiveId" clId="{C997E11D-29CD-4387-AD28-D8541B11CB53}" dt="2025-03-23T14:13:10.396" v="3930" actId="1076"/>
          <ac:spMkLst>
            <pc:docMk/>
            <pc:sldMk cId="1711125189" sldId="1612"/>
            <ac:spMk id="44" creationId="{382A8310-43C6-47D7-3E47-8EB320DD9326}"/>
          </ac:spMkLst>
        </pc:spChg>
        <pc:spChg chg="add mod">
          <ac:chgData name="Paolo Paganetti" userId="dcd282f25ae9c4f2" providerId="LiveId" clId="{C997E11D-29CD-4387-AD28-D8541B11CB53}" dt="2025-03-23T13:49:28.576" v="3839" actId="1036"/>
          <ac:spMkLst>
            <pc:docMk/>
            <pc:sldMk cId="1711125189" sldId="1612"/>
            <ac:spMk id="45" creationId="{C3D8B9D8-DDD4-F0A7-4F32-77AA6753D29D}"/>
          </ac:spMkLst>
        </pc:spChg>
        <pc:spChg chg="add mod">
          <ac:chgData name="Paolo Paganetti" userId="dcd282f25ae9c4f2" providerId="LiveId" clId="{C997E11D-29CD-4387-AD28-D8541B11CB53}" dt="2025-03-23T14:13:10.396" v="3930" actId="1076"/>
          <ac:spMkLst>
            <pc:docMk/>
            <pc:sldMk cId="1711125189" sldId="1612"/>
            <ac:spMk id="46" creationId="{7CE19B70-E8D4-FF1F-7B53-E2A98FC5DF84}"/>
          </ac:spMkLst>
        </pc:spChg>
        <pc:spChg chg="add mod">
          <ac:chgData name="Paolo Paganetti" userId="dcd282f25ae9c4f2" providerId="LiveId" clId="{C997E11D-29CD-4387-AD28-D8541B11CB53}" dt="2025-03-23T14:21:51.774" v="4307" actId="164"/>
          <ac:spMkLst>
            <pc:docMk/>
            <pc:sldMk cId="1711125189" sldId="1612"/>
            <ac:spMk id="47" creationId="{8F7FB21C-5798-E59C-B66F-18DE560735C7}"/>
          </ac:spMkLst>
        </pc:spChg>
        <pc:spChg chg="add mod">
          <ac:chgData name="Paolo Paganetti" userId="dcd282f25ae9c4f2" providerId="LiveId" clId="{C997E11D-29CD-4387-AD28-D8541B11CB53}" dt="2025-03-23T13:49:38.040" v="3849" actId="1038"/>
          <ac:spMkLst>
            <pc:docMk/>
            <pc:sldMk cId="1711125189" sldId="1612"/>
            <ac:spMk id="50" creationId="{A4B68811-B5C1-A395-F770-380CE848364F}"/>
          </ac:spMkLst>
        </pc:spChg>
        <pc:spChg chg="add mod">
          <ac:chgData name="Paolo Paganetti" userId="dcd282f25ae9c4f2" providerId="LiveId" clId="{C997E11D-29CD-4387-AD28-D8541B11CB53}" dt="2025-03-23T14:21:51.774" v="4307" actId="164"/>
          <ac:spMkLst>
            <pc:docMk/>
            <pc:sldMk cId="1711125189" sldId="1612"/>
            <ac:spMk id="51" creationId="{3D0B70AC-2C56-4F7A-FFCA-88154EB0EE0A}"/>
          </ac:spMkLst>
        </pc:spChg>
        <pc:spChg chg="mod">
          <ac:chgData name="Paolo Paganetti" userId="dcd282f25ae9c4f2" providerId="LiveId" clId="{C997E11D-29CD-4387-AD28-D8541B11CB53}" dt="2025-03-23T11:53:20.129" v="2374"/>
          <ac:spMkLst>
            <pc:docMk/>
            <pc:sldMk cId="1711125189" sldId="1612"/>
            <ac:spMk id="56" creationId="{5656B52E-75D4-D718-7773-EEDC7776F575}"/>
          </ac:spMkLst>
        </pc:spChg>
        <pc:spChg chg="mod">
          <ac:chgData name="Paolo Paganetti" userId="dcd282f25ae9c4f2" providerId="LiveId" clId="{C997E11D-29CD-4387-AD28-D8541B11CB53}" dt="2025-03-23T11:53:20.129" v="2374"/>
          <ac:spMkLst>
            <pc:docMk/>
            <pc:sldMk cId="1711125189" sldId="1612"/>
            <ac:spMk id="58" creationId="{4CD24E71-C312-767D-993A-492B211C5BC2}"/>
          </ac:spMkLst>
        </pc:spChg>
        <pc:spChg chg="mod">
          <ac:chgData name="Paolo Paganetti" userId="dcd282f25ae9c4f2" providerId="LiveId" clId="{C997E11D-29CD-4387-AD28-D8541B11CB53}" dt="2025-03-23T11:53:20.129" v="2374"/>
          <ac:spMkLst>
            <pc:docMk/>
            <pc:sldMk cId="1711125189" sldId="1612"/>
            <ac:spMk id="59" creationId="{9075DA55-807E-7770-EAD4-EB9E37858F45}"/>
          </ac:spMkLst>
        </pc:spChg>
        <pc:spChg chg="mod">
          <ac:chgData name="Paolo Paganetti" userId="dcd282f25ae9c4f2" providerId="LiveId" clId="{C997E11D-29CD-4387-AD28-D8541B11CB53}" dt="2025-03-23T11:53:20.129" v="2374"/>
          <ac:spMkLst>
            <pc:docMk/>
            <pc:sldMk cId="1711125189" sldId="1612"/>
            <ac:spMk id="61" creationId="{D0D0E03F-90E9-D120-9EEB-5C31AE376437}"/>
          </ac:spMkLst>
        </pc:spChg>
        <pc:spChg chg="mod">
          <ac:chgData name="Paolo Paganetti" userId="dcd282f25ae9c4f2" providerId="LiveId" clId="{C997E11D-29CD-4387-AD28-D8541B11CB53}" dt="2025-03-23T11:53:20.129" v="2374"/>
          <ac:spMkLst>
            <pc:docMk/>
            <pc:sldMk cId="1711125189" sldId="1612"/>
            <ac:spMk id="63" creationId="{5B07BBA5-A375-F0FC-5C1E-9D067BDF961C}"/>
          </ac:spMkLst>
        </pc:spChg>
        <pc:spChg chg="mod">
          <ac:chgData name="Paolo Paganetti" userId="dcd282f25ae9c4f2" providerId="LiveId" clId="{C997E11D-29CD-4387-AD28-D8541B11CB53}" dt="2025-03-23T11:53:20.129" v="2374"/>
          <ac:spMkLst>
            <pc:docMk/>
            <pc:sldMk cId="1711125189" sldId="1612"/>
            <ac:spMk id="66" creationId="{039357BC-AFFE-53FD-DBC3-EA143638F189}"/>
          </ac:spMkLst>
        </pc:spChg>
        <pc:spChg chg="add mod">
          <ac:chgData name="Paolo Paganetti" userId="dcd282f25ae9c4f2" providerId="LiveId" clId="{C997E11D-29CD-4387-AD28-D8541B11CB53}" dt="2025-03-23T14:20:13.098" v="4191" actId="164"/>
          <ac:spMkLst>
            <pc:docMk/>
            <pc:sldMk cId="1711125189" sldId="1612"/>
            <ac:spMk id="85" creationId="{AE700124-A8DA-1DA4-1733-64DFF2E0C1C7}"/>
          </ac:spMkLst>
        </pc:spChg>
        <pc:spChg chg="add mod">
          <ac:chgData name="Paolo Paganetti" userId="dcd282f25ae9c4f2" providerId="LiveId" clId="{C997E11D-29CD-4387-AD28-D8541B11CB53}" dt="2025-03-23T14:20:13.098" v="4191" actId="164"/>
          <ac:spMkLst>
            <pc:docMk/>
            <pc:sldMk cId="1711125189" sldId="1612"/>
            <ac:spMk id="86" creationId="{8AC9E202-8F2C-9127-508A-8DCF25147749}"/>
          </ac:spMkLst>
        </pc:spChg>
        <pc:spChg chg="add mod">
          <ac:chgData name="Paolo Paganetti" userId="dcd282f25ae9c4f2" providerId="LiveId" clId="{C997E11D-29CD-4387-AD28-D8541B11CB53}" dt="2025-03-23T14:20:13.098" v="4191" actId="164"/>
          <ac:spMkLst>
            <pc:docMk/>
            <pc:sldMk cId="1711125189" sldId="1612"/>
            <ac:spMk id="87" creationId="{CA8B79A3-F9A9-D867-6A3D-EBE2DB668AA2}"/>
          </ac:spMkLst>
        </pc:spChg>
        <pc:spChg chg="add mod">
          <ac:chgData name="Paolo Paganetti" userId="dcd282f25ae9c4f2" providerId="LiveId" clId="{C997E11D-29CD-4387-AD28-D8541B11CB53}" dt="2025-03-23T14:20:13.098" v="4191" actId="164"/>
          <ac:spMkLst>
            <pc:docMk/>
            <pc:sldMk cId="1711125189" sldId="1612"/>
            <ac:spMk id="88" creationId="{F9040862-5E28-9D38-8EC2-37AE6860CDF8}"/>
          </ac:spMkLst>
        </pc:spChg>
        <pc:spChg chg="add mod">
          <ac:chgData name="Paolo Paganetti" userId="dcd282f25ae9c4f2" providerId="LiveId" clId="{C997E11D-29CD-4387-AD28-D8541B11CB53}" dt="2025-03-23T14:20:13.098" v="4191" actId="164"/>
          <ac:spMkLst>
            <pc:docMk/>
            <pc:sldMk cId="1711125189" sldId="1612"/>
            <ac:spMk id="89" creationId="{143D4867-9C08-1BF5-5639-62C4F9F5D592}"/>
          </ac:spMkLst>
        </pc:spChg>
        <pc:spChg chg="add del mod">
          <ac:chgData name="Paolo Paganetti" userId="dcd282f25ae9c4f2" providerId="LiveId" clId="{C997E11D-29CD-4387-AD28-D8541B11CB53}" dt="2025-03-23T14:15:52.602" v="4106" actId="478"/>
          <ac:spMkLst>
            <pc:docMk/>
            <pc:sldMk cId="1711125189" sldId="1612"/>
            <ac:spMk id="90" creationId="{5AF0BA8C-EE56-9187-DE23-79076E87E157}"/>
          </ac:spMkLst>
        </pc:spChg>
        <pc:spChg chg="add mod">
          <ac:chgData name="Paolo Paganetti" userId="dcd282f25ae9c4f2" providerId="LiveId" clId="{C997E11D-29CD-4387-AD28-D8541B11CB53}" dt="2025-03-23T14:20:13.098" v="4191" actId="164"/>
          <ac:spMkLst>
            <pc:docMk/>
            <pc:sldMk cId="1711125189" sldId="1612"/>
            <ac:spMk id="91" creationId="{D9B07204-1B4B-CE50-1656-DF1C2BE0C1E3}"/>
          </ac:spMkLst>
        </pc:spChg>
        <pc:spChg chg="add mod">
          <ac:chgData name="Paolo Paganetti" userId="dcd282f25ae9c4f2" providerId="LiveId" clId="{C997E11D-29CD-4387-AD28-D8541B11CB53}" dt="2025-03-23T14:20:13.098" v="4191" actId="164"/>
          <ac:spMkLst>
            <pc:docMk/>
            <pc:sldMk cId="1711125189" sldId="1612"/>
            <ac:spMk id="92" creationId="{B8388B25-56F9-404E-98E9-DCC5F0F925F1}"/>
          </ac:spMkLst>
        </pc:spChg>
        <pc:spChg chg="add del mod">
          <ac:chgData name="Paolo Paganetti" userId="dcd282f25ae9c4f2" providerId="LiveId" clId="{C997E11D-29CD-4387-AD28-D8541B11CB53}" dt="2025-03-23T14:16:47.687" v="4158" actId="478"/>
          <ac:spMkLst>
            <pc:docMk/>
            <pc:sldMk cId="1711125189" sldId="1612"/>
            <ac:spMk id="93" creationId="{F2EFC8DC-6AD1-0DFD-D63C-DC54FFE0166D}"/>
          </ac:spMkLst>
        </pc:spChg>
        <pc:spChg chg="add mod">
          <ac:chgData name="Paolo Paganetti" userId="dcd282f25ae9c4f2" providerId="LiveId" clId="{C997E11D-29CD-4387-AD28-D8541B11CB53}" dt="2025-03-23T14:21:05.577" v="4265" actId="571"/>
          <ac:spMkLst>
            <pc:docMk/>
            <pc:sldMk cId="1711125189" sldId="1612"/>
            <ac:spMk id="98" creationId="{B83D6D96-8C50-689E-96B1-1FAF9EE1A00C}"/>
          </ac:spMkLst>
        </pc:spChg>
        <pc:spChg chg="add mod">
          <ac:chgData name="Paolo Paganetti" userId="dcd282f25ae9c4f2" providerId="LiveId" clId="{C997E11D-29CD-4387-AD28-D8541B11CB53}" dt="2025-03-23T14:21:13.858" v="4298" actId="1038"/>
          <ac:spMkLst>
            <pc:docMk/>
            <pc:sldMk cId="1711125189" sldId="1612"/>
            <ac:spMk id="99" creationId="{A63255D3-1A14-47BA-F5FB-899C7F4C4723}"/>
          </ac:spMkLst>
        </pc:spChg>
        <pc:spChg chg="add mod">
          <ac:chgData name="Paolo Paganetti" userId="dcd282f25ae9c4f2" providerId="LiveId" clId="{C997E11D-29CD-4387-AD28-D8541B11CB53}" dt="2025-03-23T14:21:22.902" v="4299" actId="571"/>
          <ac:spMkLst>
            <pc:docMk/>
            <pc:sldMk cId="1711125189" sldId="1612"/>
            <ac:spMk id="100" creationId="{B6C02841-9321-F87E-9BA6-898512473B72}"/>
          </ac:spMkLst>
        </pc:spChg>
        <pc:spChg chg="add mod">
          <ac:chgData name="Paolo Paganetti" userId="dcd282f25ae9c4f2" providerId="LiveId" clId="{C997E11D-29CD-4387-AD28-D8541B11CB53}" dt="2025-03-23T14:21:22.902" v="4299" actId="571"/>
          <ac:spMkLst>
            <pc:docMk/>
            <pc:sldMk cId="1711125189" sldId="1612"/>
            <ac:spMk id="101" creationId="{B31D3BEA-4C79-CF49-802F-391FEC066CDF}"/>
          </ac:spMkLst>
        </pc:spChg>
        <pc:spChg chg="add mod">
          <ac:chgData name="Paolo Paganetti" userId="dcd282f25ae9c4f2" providerId="LiveId" clId="{C997E11D-29CD-4387-AD28-D8541B11CB53}" dt="2025-03-23T14:21:51.774" v="4307" actId="164"/>
          <ac:spMkLst>
            <pc:docMk/>
            <pc:sldMk cId="1711125189" sldId="1612"/>
            <ac:spMk id="104" creationId="{A7EB0802-3932-2DB8-B01C-146CFC06AC61}"/>
          </ac:spMkLst>
        </pc:spChg>
        <pc:spChg chg="add mod">
          <ac:chgData name="Paolo Paganetti" userId="dcd282f25ae9c4f2" providerId="LiveId" clId="{C997E11D-29CD-4387-AD28-D8541B11CB53}" dt="2025-03-23T14:21:35.879" v="4304" actId="1038"/>
          <ac:spMkLst>
            <pc:docMk/>
            <pc:sldMk cId="1711125189" sldId="1612"/>
            <ac:spMk id="105" creationId="{F160E775-59C5-98F6-F3E7-A0BF566FA82F}"/>
          </ac:spMkLst>
        </pc:spChg>
        <pc:spChg chg="add del mod">
          <ac:chgData name="Paolo Paganetti" userId="dcd282f25ae9c4f2" providerId="LiveId" clId="{C997E11D-29CD-4387-AD28-D8541B11CB53}" dt="2025-03-23T14:21:39.263" v="4305" actId="478"/>
          <ac:spMkLst>
            <pc:docMk/>
            <pc:sldMk cId="1711125189" sldId="1612"/>
            <ac:spMk id="108" creationId="{A178F5CA-A7CC-7553-6341-9D69232A2413}"/>
          </ac:spMkLst>
        </pc:spChg>
        <pc:spChg chg="add del mod">
          <ac:chgData name="Paolo Paganetti" userId="dcd282f25ae9c4f2" providerId="LiveId" clId="{C997E11D-29CD-4387-AD28-D8541B11CB53}" dt="2025-03-23T14:21:39.263" v="4305" actId="478"/>
          <ac:spMkLst>
            <pc:docMk/>
            <pc:sldMk cId="1711125189" sldId="1612"/>
            <ac:spMk id="109" creationId="{F371E8DE-D931-F14C-2424-1415D003BE20}"/>
          </ac:spMkLst>
        </pc:spChg>
        <pc:grpChg chg="del mod">
          <ac:chgData name="Paolo Paganetti" userId="dcd282f25ae9c4f2" providerId="LiveId" clId="{C997E11D-29CD-4387-AD28-D8541B11CB53}" dt="2025-03-23T14:20:58.436" v="4264" actId="478"/>
          <ac:grpSpMkLst>
            <pc:docMk/>
            <pc:sldMk cId="1711125189" sldId="1612"/>
            <ac:grpSpMk id="2" creationId="{8A7FFBD6-1F92-1639-D6F9-66010557DFA6}"/>
          </ac:grpSpMkLst>
        </pc:grpChg>
        <pc:grpChg chg="add mod">
          <ac:chgData name="Paolo Paganetti" userId="dcd282f25ae9c4f2" providerId="LiveId" clId="{C997E11D-29CD-4387-AD28-D8541B11CB53}" dt="2025-03-24T08:29:48.092" v="4407" actId="164"/>
          <ac:grpSpMkLst>
            <pc:docMk/>
            <pc:sldMk cId="1711125189" sldId="1612"/>
            <ac:grpSpMk id="3" creationId="{69BE6233-093B-E176-4486-456894356A67}"/>
          </ac:grpSpMkLst>
        </pc:grpChg>
        <pc:grpChg chg="add mod">
          <ac:chgData name="Paolo Paganetti" userId="dcd282f25ae9c4f2" providerId="LiveId" clId="{C997E11D-29CD-4387-AD28-D8541B11CB53}" dt="2025-03-23T14:12:38.841" v="3926" actId="14100"/>
          <ac:grpSpMkLst>
            <pc:docMk/>
            <pc:sldMk cId="1711125189" sldId="1612"/>
            <ac:grpSpMk id="84" creationId="{D93B60E7-B3BE-A4CE-FC3F-4841C65A5BA5}"/>
          </ac:grpSpMkLst>
        </pc:grpChg>
        <pc:grpChg chg="add mod">
          <ac:chgData name="Paolo Paganetti" userId="dcd282f25ae9c4f2" providerId="LiveId" clId="{C997E11D-29CD-4387-AD28-D8541B11CB53}" dt="2025-03-23T14:19:42.168" v="4183" actId="14100"/>
          <ac:grpSpMkLst>
            <pc:docMk/>
            <pc:sldMk cId="1711125189" sldId="1612"/>
            <ac:grpSpMk id="94" creationId="{C37A9A3E-1AB6-9C8C-F4D5-FCB91ADE19A4}"/>
          </ac:grpSpMkLst>
        </pc:grpChg>
        <pc:grpChg chg="add mod">
          <ac:chgData name="Paolo Paganetti" userId="dcd282f25ae9c4f2" providerId="LiveId" clId="{C997E11D-29CD-4387-AD28-D8541B11CB53}" dt="2025-03-23T14:20:54.927" v="4263" actId="1076"/>
          <ac:grpSpMkLst>
            <pc:docMk/>
            <pc:sldMk cId="1711125189" sldId="1612"/>
            <ac:grpSpMk id="97" creationId="{55B9A262-B944-02D1-A52B-326BD7EAA45F}"/>
          </ac:grpSpMkLst>
        </pc:grpChg>
        <pc:grpChg chg="mod">
          <ac:chgData name="Paolo Paganetti" userId="dcd282f25ae9c4f2" providerId="LiveId" clId="{C997E11D-29CD-4387-AD28-D8541B11CB53}" dt="2025-03-24T08:29:48.092" v="4407" actId="164"/>
          <ac:grpSpMkLst>
            <pc:docMk/>
            <pc:sldMk cId="1711125189" sldId="1612"/>
            <ac:grpSpMk id="112" creationId="{1E7E50A2-B3AA-A021-7B87-799B83B8A133}"/>
          </ac:grpSpMkLst>
        </pc:grpChg>
        <pc:picChg chg="add del mod modCrop">
          <ac:chgData name="Paolo Paganetti" userId="dcd282f25ae9c4f2" providerId="LiveId" clId="{C997E11D-29CD-4387-AD28-D8541B11CB53}" dt="2025-03-23T13:47:14.028" v="3657" actId="478"/>
          <ac:picMkLst>
            <pc:docMk/>
            <pc:sldMk cId="1711125189" sldId="1612"/>
            <ac:picMk id="5" creationId="{2C307279-7DF1-5327-4A8F-CA781ACFF304}"/>
          </ac:picMkLst>
        </pc:picChg>
        <pc:picChg chg="del mod ord modCrop">
          <ac:chgData name="Paolo Paganetti" userId="dcd282f25ae9c4f2" providerId="LiveId" clId="{C997E11D-29CD-4387-AD28-D8541B11CB53}" dt="2025-03-23T13:47:14.028" v="3657" actId="478"/>
          <ac:picMkLst>
            <pc:docMk/>
            <pc:sldMk cId="1711125189" sldId="1612"/>
            <ac:picMk id="19" creationId="{00000000-0000-0000-0000-000000000000}"/>
          </ac:picMkLst>
        </pc:picChg>
        <pc:picChg chg="del mod ord modCrop">
          <ac:chgData name="Paolo Paganetti" userId="dcd282f25ae9c4f2" providerId="LiveId" clId="{C997E11D-29CD-4387-AD28-D8541B11CB53}" dt="2025-03-23T13:47:14.028" v="3657" actId="478"/>
          <ac:picMkLst>
            <pc:docMk/>
            <pc:sldMk cId="1711125189" sldId="1612"/>
            <ac:picMk id="25" creationId="{00000000-0000-0000-0000-000000000000}"/>
          </ac:picMkLst>
        </pc:picChg>
        <pc:picChg chg="mod modCrop">
          <ac:chgData name="Paolo Paganetti" userId="dcd282f25ae9c4f2" providerId="LiveId" clId="{C997E11D-29CD-4387-AD28-D8541B11CB53}" dt="2025-03-23T14:20:13.098" v="4191" actId="164"/>
          <ac:picMkLst>
            <pc:docMk/>
            <pc:sldMk cId="1711125189" sldId="1612"/>
            <ac:picMk id="27" creationId="{00000000-0000-0000-0000-000000000000}"/>
          </ac:picMkLst>
        </pc:picChg>
        <pc:picChg chg="mod modCrop">
          <ac:chgData name="Paolo Paganetti" userId="dcd282f25ae9c4f2" providerId="LiveId" clId="{C997E11D-29CD-4387-AD28-D8541B11CB53}" dt="2025-03-23T14:20:50.109" v="4262" actId="1076"/>
          <ac:picMkLst>
            <pc:docMk/>
            <pc:sldMk cId="1711125189" sldId="1612"/>
            <ac:picMk id="33" creationId="{00000000-0000-0000-0000-000000000000}"/>
          </ac:picMkLst>
        </pc:picChg>
        <pc:picChg chg="mod modCrop">
          <ac:chgData name="Paolo Paganetti" userId="dcd282f25ae9c4f2" providerId="LiveId" clId="{C997E11D-29CD-4387-AD28-D8541B11CB53}" dt="2025-03-23T14:08:44.796" v="3895" actId="18131"/>
          <ac:picMkLst>
            <pc:docMk/>
            <pc:sldMk cId="1711125189" sldId="1612"/>
            <ac:picMk id="57" creationId="{A76528BD-76DA-C0D9-D5FD-85A8721F05F2}"/>
          </ac:picMkLst>
        </pc:picChg>
        <pc:picChg chg="add mod ord modCrop">
          <ac:chgData name="Paolo Paganetti" userId="dcd282f25ae9c4f2" providerId="LiveId" clId="{C997E11D-29CD-4387-AD28-D8541B11CB53}" dt="2025-03-23T13:47:55.877" v="3731" actId="1037"/>
          <ac:picMkLst>
            <pc:docMk/>
            <pc:sldMk cId="1711125189" sldId="1612"/>
            <ac:picMk id="68" creationId="{558383CA-92D6-BF24-EE70-AB59B7BC756E}"/>
          </ac:picMkLst>
        </pc:picChg>
        <pc:picChg chg="add mod modCrop">
          <ac:chgData name="Paolo Paganetti" userId="dcd282f25ae9c4f2" providerId="LiveId" clId="{C997E11D-29CD-4387-AD28-D8541B11CB53}" dt="2025-03-23T13:47:28.492" v="3659" actId="1076"/>
          <ac:picMkLst>
            <pc:docMk/>
            <pc:sldMk cId="1711125189" sldId="1612"/>
            <ac:picMk id="70" creationId="{EA8233FF-7460-E6AD-884D-CFC53B22D8B0}"/>
          </ac:picMkLst>
        </pc:picChg>
        <pc:picChg chg="add del mod">
          <ac:chgData name="Paolo Paganetti" userId="dcd282f25ae9c4f2" providerId="LiveId" clId="{C997E11D-29CD-4387-AD28-D8541B11CB53}" dt="2025-03-23T13:38:26.817" v="3609" actId="478"/>
          <ac:picMkLst>
            <pc:docMk/>
            <pc:sldMk cId="1711125189" sldId="1612"/>
            <ac:picMk id="72" creationId="{8EFEE562-2F9A-94CA-7855-9A64D6B116C3}"/>
          </ac:picMkLst>
        </pc:picChg>
        <pc:picChg chg="add del mod">
          <ac:chgData name="Paolo Paganetti" userId="dcd282f25ae9c4f2" providerId="LiveId" clId="{C997E11D-29CD-4387-AD28-D8541B11CB53}" dt="2025-03-23T13:38:24.051" v="3608" actId="478"/>
          <ac:picMkLst>
            <pc:docMk/>
            <pc:sldMk cId="1711125189" sldId="1612"/>
            <ac:picMk id="74" creationId="{7E9D220A-4628-3B3C-3A36-A514C204B06B}"/>
          </ac:picMkLst>
        </pc:picChg>
        <pc:picChg chg="add mod modCrop">
          <ac:chgData name="Paolo Paganetti" userId="dcd282f25ae9c4f2" providerId="LiveId" clId="{C997E11D-29CD-4387-AD28-D8541B11CB53}" dt="2025-03-23T13:47:37.029" v="3667" actId="1037"/>
          <ac:picMkLst>
            <pc:docMk/>
            <pc:sldMk cId="1711125189" sldId="1612"/>
            <ac:picMk id="76" creationId="{42622A95-E4E9-1818-E1F4-5B432ACB1F92}"/>
          </ac:picMkLst>
        </pc:picChg>
        <pc:picChg chg="add mod">
          <ac:chgData name="Paolo Paganetti" userId="dcd282f25ae9c4f2" providerId="LiveId" clId="{C997E11D-29CD-4387-AD28-D8541B11CB53}" dt="2025-03-23T13:43:46.922" v="3634" actId="571"/>
          <ac:picMkLst>
            <pc:docMk/>
            <pc:sldMk cId="1711125189" sldId="1612"/>
            <ac:picMk id="77" creationId="{E1D956C3-CDDE-BC28-8347-796E3A627AE6}"/>
          </ac:picMkLst>
        </pc:picChg>
        <pc:picChg chg="add mod">
          <ac:chgData name="Paolo Paganetti" userId="dcd282f25ae9c4f2" providerId="LiveId" clId="{C997E11D-29CD-4387-AD28-D8541B11CB53}" dt="2025-03-23T13:43:46.922" v="3634" actId="571"/>
          <ac:picMkLst>
            <pc:docMk/>
            <pc:sldMk cId="1711125189" sldId="1612"/>
            <ac:picMk id="78" creationId="{32ABF7C0-DA87-B1A7-408E-CD74629F7A0D}"/>
          </ac:picMkLst>
        </pc:picChg>
        <pc:picChg chg="add mod">
          <ac:chgData name="Paolo Paganetti" userId="dcd282f25ae9c4f2" providerId="LiveId" clId="{C997E11D-29CD-4387-AD28-D8541B11CB53}" dt="2025-03-23T13:43:46.922" v="3634" actId="571"/>
          <ac:picMkLst>
            <pc:docMk/>
            <pc:sldMk cId="1711125189" sldId="1612"/>
            <ac:picMk id="79" creationId="{278F2845-B498-D332-CE36-2937B486521D}"/>
          </ac:picMkLst>
        </pc:picChg>
        <pc:picChg chg="add del mod">
          <ac:chgData name="Paolo Paganetti" userId="dcd282f25ae9c4f2" providerId="LiveId" clId="{C997E11D-29CD-4387-AD28-D8541B11CB53}" dt="2025-03-23T13:51:38.723" v="3873" actId="478"/>
          <ac:picMkLst>
            <pc:docMk/>
            <pc:sldMk cId="1711125189" sldId="1612"/>
            <ac:picMk id="81" creationId="{E9B71AF0-E372-C439-446D-F7954A34C043}"/>
          </ac:picMkLst>
        </pc:picChg>
        <pc:picChg chg="add del mod modCrop">
          <ac:chgData name="Paolo Paganetti" userId="dcd282f25ae9c4f2" providerId="LiveId" clId="{C997E11D-29CD-4387-AD28-D8541B11CB53}" dt="2025-03-23T14:10:13.792" v="3914" actId="478"/>
          <ac:picMkLst>
            <pc:docMk/>
            <pc:sldMk cId="1711125189" sldId="1612"/>
            <ac:picMk id="82" creationId="{C6D7B97B-8813-2A25-B34C-A5F282F9F9C7}"/>
          </ac:picMkLst>
        </pc:picChg>
        <pc:picChg chg="add del mod modCrop">
          <ac:chgData name="Paolo Paganetti" userId="dcd282f25ae9c4f2" providerId="LiveId" clId="{C997E11D-29CD-4387-AD28-D8541B11CB53}" dt="2025-03-23T14:10:57.409" v="3918" actId="478"/>
          <ac:picMkLst>
            <pc:docMk/>
            <pc:sldMk cId="1711125189" sldId="1612"/>
            <ac:picMk id="83" creationId="{9B3E30A6-0354-1578-0D8F-93A147CDC699}"/>
          </ac:picMkLst>
        </pc:picChg>
        <pc:cxnChg chg="add mod">
          <ac:chgData name="Paolo Paganetti" userId="dcd282f25ae9c4f2" providerId="LiveId" clId="{C997E11D-29CD-4387-AD28-D8541B11CB53}" dt="2025-03-23T13:49:48.183" v="3868" actId="1037"/>
          <ac:cxnSpMkLst>
            <pc:docMk/>
            <pc:sldMk cId="1711125189" sldId="1612"/>
            <ac:cxnSpMk id="31" creationId="{EBF53CCF-E3D3-0397-ACB0-50FFF8CB0194}"/>
          </ac:cxnSpMkLst>
        </pc:cxnChg>
        <pc:cxnChg chg="add mod">
          <ac:chgData name="Paolo Paganetti" userId="dcd282f25ae9c4f2" providerId="LiveId" clId="{C997E11D-29CD-4387-AD28-D8541B11CB53}" dt="2025-03-23T13:49:48.183" v="3868" actId="1037"/>
          <ac:cxnSpMkLst>
            <pc:docMk/>
            <pc:sldMk cId="1711125189" sldId="1612"/>
            <ac:cxnSpMk id="32" creationId="{3645B7D7-6E92-A678-23C5-6A6CC5EFB22A}"/>
          </ac:cxnSpMkLst>
        </pc:cxnChg>
        <pc:cxnChg chg="add mod ord">
          <ac:chgData name="Paolo Paganetti" userId="dcd282f25ae9c4f2" providerId="LiveId" clId="{C997E11D-29CD-4387-AD28-D8541B11CB53}" dt="2025-03-23T14:12:33.468" v="3925" actId="164"/>
          <ac:cxnSpMkLst>
            <pc:docMk/>
            <pc:sldMk cId="1711125189" sldId="1612"/>
            <ac:cxnSpMk id="36" creationId="{09A96ADF-94C9-62AB-B42E-AD235976F176}"/>
          </ac:cxnSpMkLst>
        </pc:cxnChg>
        <pc:cxnChg chg="add mod ord">
          <ac:chgData name="Paolo Paganetti" userId="dcd282f25ae9c4f2" providerId="LiveId" clId="{C997E11D-29CD-4387-AD28-D8541B11CB53}" dt="2025-03-23T14:12:33.468" v="3925" actId="164"/>
          <ac:cxnSpMkLst>
            <pc:docMk/>
            <pc:sldMk cId="1711125189" sldId="1612"/>
            <ac:cxnSpMk id="37" creationId="{B18B54EC-B1B0-131B-6DDB-167BC6FE9986}"/>
          </ac:cxnSpMkLst>
        </pc:cxnChg>
        <pc:cxnChg chg="add mod">
          <ac:chgData name="Paolo Paganetti" userId="dcd282f25ae9c4f2" providerId="LiveId" clId="{C997E11D-29CD-4387-AD28-D8541B11CB53}" dt="2025-03-19T10:57:33.414" v="2175" actId="1037"/>
          <ac:cxnSpMkLst>
            <pc:docMk/>
            <pc:sldMk cId="1711125189" sldId="1612"/>
            <ac:cxnSpMk id="38" creationId="{5DF69739-582D-FB4E-6C1B-EE9D4B6CC62E}"/>
          </ac:cxnSpMkLst>
        </pc:cxnChg>
        <pc:cxnChg chg="add mod">
          <ac:chgData name="Paolo Paganetti" userId="dcd282f25ae9c4f2" providerId="LiveId" clId="{C997E11D-29CD-4387-AD28-D8541B11CB53}" dt="2025-03-23T13:49:41.678" v="3853" actId="1037"/>
          <ac:cxnSpMkLst>
            <pc:docMk/>
            <pc:sldMk cId="1711125189" sldId="1612"/>
            <ac:cxnSpMk id="48" creationId="{3AC9D5F2-3C22-955D-CCE3-6ABA07B2216B}"/>
          </ac:cxnSpMkLst>
        </pc:cxnChg>
        <pc:cxnChg chg="add mod">
          <ac:chgData name="Paolo Paganetti" userId="dcd282f25ae9c4f2" providerId="LiveId" clId="{C997E11D-29CD-4387-AD28-D8541B11CB53}" dt="2025-03-23T13:49:41.678" v="3853" actId="1037"/>
          <ac:cxnSpMkLst>
            <pc:docMk/>
            <pc:sldMk cId="1711125189" sldId="1612"/>
            <ac:cxnSpMk id="49" creationId="{B175F993-F6CC-EF5B-8968-E058DB048C78}"/>
          </ac:cxnSpMkLst>
        </pc:cxnChg>
        <pc:cxnChg chg="add mod">
          <ac:chgData name="Paolo Paganetti" userId="dcd282f25ae9c4f2" providerId="LiveId" clId="{C997E11D-29CD-4387-AD28-D8541B11CB53}" dt="2025-03-23T13:49:38.040" v="3849" actId="1038"/>
          <ac:cxnSpMkLst>
            <pc:docMk/>
            <pc:sldMk cId="1711125189" sldId="1612"/>
            <ac:cxnSpMk id="52" creationId="{2F59A740-CB24-61F6-5276-C24F52929671}"/>
          </ac:cxnSpMkLst>
        </pc:cxnChg>
        <pc:cxnChg chg="add mod">
          <ac:chgData name="Paolo Paganetti" userId="dcd282f25ae9c4f2" providerId="LiveId" clId="{C997E11D-29CD-4387-AD28-D8541B11CB53}" dt="2025-03-23T13:49:38.040" v="3849" actId="1038"/>
          <ac:cxnSpMkLst>
            <pc:docMk/>
            <pc:sldMk cId="1711125189" sldId="1612"/>
            <ac:cxnSpMk id="53" creationId="{474A7A2B-6B03-A4C0-082D-DF1A34690DB7}"/>
          </ac:cxnSpMkLst>
        </pc:cxnChg>
        <pc:cxnChg chg="mod">
          <ac:chgData name="Paolo Paganetti" userId="dcd282f25ae9c4f2" providerId="LiveId" clId="{C997E11D-29CD-4387-AD28-D8541B11CB53}" dt="2025-03-23T14:19:31.073" v="4180" actId="571"/>
          <ac:cxnSpMkLst>
            <pc:docMk/>
            <pc:sldMk cId="1711125189" sldId="1612"/>
            <ac:cxnSpMk id="95" creationId="{F0342B03-D756-4086-FFA9-1F18042647CE}"/>
          </ac:cxnSpMkLst>
        </pc:cxnChg>
        <pc:cxnChg chg="mod">
          <ac:chgData name="Paolo Paganetti" userId="dcd282f25ae9c4f2" providerId="LiveId" clId="{C997E11D-29CD-4387-AD28-D8541B11CB53}" dt="2025-03-23T14:19:31.073" v="4180" actId="571"/>
          <ac:cxnSpMkLst>
            <pc:docMk/>
            <pc:sldMk cId="1711125189" sldId="1612"/>
            <ac:cxnSpMk id="96" creationId="{F216317D-BAA6-8E2B-4B30-5DE587F5417B}"/>
          </ac:cxnSpMkLst>
        </pc:cxnChg>
        <pc:cxnChg chg="add mod">
          <ac:chgData name="Paolo Paganetti" userId="dcd282f25ae9c4f2" providerId="LiveId" clId="{C997E11D-29CD-4387-AD28-D8541B11CB53}" dt="2025-03-23T14:21:22.902" v="4299" actId="571"/>
          <ac:cxnSpMkLst>
            <pc:docMk/>
            <pc:sldMk cId="1711125189" sldId="1612"/>
            <ac:cxnSpMk id="102" creationId="{EEE70DC2-C9BE-2584-A9F6-AE072DF39F6B}"/>
          </ac:cxnSpMkLst>
        </pc:cxnChg>
        <pc:cxnChg chg="add mod">
          <ac:chgData name="Paolo Paganetti" userId="dcd282f25ae9c4f2" providerId="LiveId" clId="{C997E11D-29CD-4387-AD28-D8541B11CB53}" dt="2025-03-23T14:21:22.902" v="4299" actId="571"/>
          <ac:cxnSpMkLst>
            <pc:docMk/>
            <pc:sldMk cId="1711125189" sldId="1612"/>
            <ac:cxnSpMk id="103" creationId="{505A3257-CF1E-D733-7988-54E5287929CB}"/>
          </ac:cxnSpMkLst>
        </pc:cxnChg>
        <pc:cxnChg chg="add mod">
          <ac:chgData name="Paolo Paganetti" userId="dcd282f25ae9c4f2" providerId="LiveId" clId="{C997E11D-29CD-4387-AD28-D8541B11CB53}" dt="2025-03-23T14:21:35.879" v="4304" actId="1038"/>
          <ac:cxnSpMkLst>
            <pc:docMk/>
            <pc:sldMk cId="1711125189" sldId="1612"/>
            <ac:cxnSpMk id="106" creationId="{23D1C2CB-A9B8-6271-B007-7810940E6DC9}"/>
          </ac:cxnSpMkLst>
        </pc:cxnChg>
        <pc:cxnChg chg="add mod">
          <ac:chgData name="Paolo Paganetti" userId="dcd282f25ae9c4f2" providerId="LiveId" clId="{C997E11D-29CD-4387-AD28-D8541B11CB53}" dt="2025-03-23T14:21:35.879" v="4304" actId="1038"/>
          <ac:cxnSpMkLst>
            <pc:docMk/>
            <pc:sldMk cId="1711125189" sldId="1612"/>
            <ac:cxnSpMk id="107" creationId="{6B21E2D2-DDF4-FB7E-7BB2-A7B3F1375DF1}"/>
          </ac:cxnSpMkLst>
        </pc:cxnChg>
        <pc:cxnChg chg="add del mod">
          <ac:chgData name="Paolo Paganetti" userId="dcd282f25ae9c4f2" providerId="LiveId" clId="{C997E11D-29CD-4387-AD28-D8541B11CB53}" dt="2025-03-23T14:21:39.263" v="4305" actId="478"/>
          <ac:cxnSpMkLst>
            <pc:docMk/>
            <pc:sldMk cId="1711125189" sldId="1612"/>
            <ac:cxnSpMk id="110" creationId="{CBBED626-86C3-A7CD-4782-3314DDD60D2E}"/>
          </ac:cxnSpMkLst>
        </pc:cxnChg>
        <pc:cxnChg chg="add del mod">
          <ac:chgData name="Paolo Paganetti" userId="dcd282f25ae9c4f2" providerId="LiveId" clId="{C997E11D-29CD-4387-AD28-D8541B11CB53}" dt="2025-03-23T14:21:39.263" v="4305" actId="478"/>
          <ac:cxnSpMkLst>
            <pc:docMk/>
            <pc:sldMk cId="1711125189" sldId="1612"/>
            <ac:cxnSpMk id="111" creationId="{EDC9FF58-E9C8-021B-BEDA-71647E97B1DB}"/>
          </ac:cxnSpMkLst>
        </pc:cxnChg>
      </pc:sldChg>
      <pc:sldChg chg="addSp delSp modSp add mod">
        <pc:chgData name="Paolo Paganetti" userId="dcd282f25ae9c4f2" providerId="LiveId" clId="{C997E11D-29CD-4387-AD28-D8541B11CB53}" dt="2025-03-24T08:27:34.973" v="4387" actId="164"/>
        <pc:sldMkLst>
          <pc:docMk/>
          <pc:sldMk cId="3754364032" sldId="1613"/>
        </pc:sldMkLst>
        <pc:spChg chg="add mod ord">
          <ac:chgData name="Paolo Paganetti" userId="dcd282f25ae9c4f2" providerId="LiveId" clId="{C997E11D-29CD-4387-AD28-D8541B11CB53}" dt="2025-03-24T08:27:21.531" v="4386" actId="167"/>
          <ac:spMkLst>
            <pc:docMk/>
            <pc:sldMk cId="3754364032" sldId="1613"/>
            <ac:spMk id="2" creationId="{0F2313C8-39AF-6960-C8AD-17334ED7FE42}"/>
          </ac:spMkLst>
        </pc:spChg>
        <pc:spChg chg="add del mod">
          <ac:chgData name="Paolo Paganetti" userId="dcd282f25ae9c4f2" providerId="LiveId" clId="{C997E11D-29CD-4387-AD28-D8541B11CB53}" dt="2025-03-24T08:25:54.548" v="4370" actId="478"/>
          <ac:spMkLst>
            <pc:docMk/>
            <pc:sldMk cId="3754364032" sldId="1613"/>
            <ac:spMk id="5" creationId="{BE03E629-4418-214B-3147-15A95CE25D85}"/>
          </ac:spMkLst>
        </pc:spChg>
        <pc:spChg chg="mod">
          <ac:chgData name="Paolo Paganetti" userId="dcd282f25ae9c4f2" providerId="LiveId" clId="{C997E11D-29CD-4387-AD28-D8541B11CB53}" dt="2025-03-23T11:45:56.757" v="2323"/>
          <ac:spMkLst>
            <pc:docMk/>
            <pc:sldMk cId="3754364032" sldId="1613"/>
            <ac:spMk id="10" creationId="{D0287C31-06D6-1DF3-91B9-A6EFD43DA5BE}"/>
          </ac:spMkLst>
        </pc:spChg>
        <pc:spChg chg="mod">
          <ac:chgData name="Paolo Paganetti" userId="dcd282f25ae9c4f2" providerId="LiveId" clId="{C997E11D-29CD-4387-AD28-D8541B11CB53}" dt="2025-03-23T11:45:56.757" v="2323"/>
          <ac:spMkLst>
            <pc:docMk/>
            <pc:sldMk cId="3754364032" sldId="1613"/>
            <ac:spMk id="11" creationId="{5FB2CA47-828D-80C9-25DC-92F44A60BCD6}"/>
          </ac:spMkLst>
        </pc:spChg>
        <pc:spChg chg="mod">
          <ac:chgData name="Paolo Paganetti" userId="dcd282f25ae9c4f2" providerId="LiveId" clId="{C997E11D-29CD-4387-AD28-D8541B11CB53}" dt="2025-03-24T08:26:43.985" v="4378" actId="571"/>
          <ac:spMkLst>
            <pc:docMk/>
            <pc:sldMk cId="3754364032" sldId="1613"/>
            <ac:spMk id="13" creationId="{7262DD48-FEFC-6035-913F-5D5B728E3867}"/>
          </ac:spMkLst>
        </pc:spChg>
        <pc:spChg chg="mod">
          <ac:chgData name="Paolo Paganetti" userId="dcd282f25ae9c4f2" providerId="LiveId" clId="{C997E11D-29CD-4387-AD28-D8541B11CB53}" dt="2025-03-24T08:26:43.985" v="4378" actId="571"/>
          <ac:spMkLst>
            <pc:docMk/>
            <pc:sldMk cId="3754364032" sldId="1613"/>
            <ac:spMk id="14" creationId="{BF7D2F36-F4D0-B795-D5A1-34D703413BAC}"/>
          </ac:spMkLst>
        </pc:spChg>
        <pc:spChg chg="mod">
          <ac:chgData name="Paolo Paganetti" userId="dcd282f25ae9c4f2" providerId="LiveId" clId="{C997E11D-29CD-4387-AD28-D8541B11CB53}" dt="2025-03-24T08:26:43.985" v="4378" actId="571"/>
          <ac:spMkLst>
            <pc:docMk/>
            <pc:sldMk cId="3754364032" sldId="1613"/>
            <ac:spMk id="15" creationId="{7657D9F4-D9F6-0B44-A3AD-6E8CB6FEB9B9}"/>
          </ac:spMkLst>
        </pc:spChg>
        <pc:spChg chg="mod">
          <ac:chgData name="Paolo Paganetti" userId="dcd282f25ae9c4f2" providerId="LiveId" clId="{C997E11D-29CD-4387-AD28-D8541B11CB53}" dt="2025-03-24T08:26:43.985" v="4378" actId="571"/>
          <ac:spMkLst>
            <pc:docMk/>
            <pc:sldMk cId="3754364032" sldId="1613"/>
            <ac:spMk id="18" creationId="{57628AA5-B057-E4DF-A87C-0BDE2EE0F889}"/>
          </ac:spMkLst>
        </pc:spChg>
        <pc:spChg chg="mod topLvl">
          <ac:chgData name="Paolo Paganetti" userId="dcd282f25ae9c4f2" providerId="LiveId" clId="{C997E11D-29CD-4387-AD28-D8541B11CB53}" dt="2025-03-24T08:27:34.973" v="4387" actId="164"/>
          <ac:spMkLst>
            <pc:docMk/>
            <pc:sldMk cId="3754364032" sldId="1613"/>
            <ac:spMk id="19" creationId="{E78A0CBD-8061-39CB-A957-E38207800084}"/>
          </ac:spMkLst>
        </pc:spChg>
        <pc:spChg chg="mod">
          <ac:chgData name="Paolo Paganetti" userId="dcd282f25ae9c4f2" providerId="LiveId" clId="{C997E11D-29CD-4387-AD28-D8541B11CB53}" dt="2025-03-24T08:27:00.433" v="4380" actId="571"/>
          <ac:spMkLst>
            <pc:docMk/>
            <pc:sldMk cId="3754364032" sldId="1613"/>
            <ac:spMk id="22" creationId="{F3CBA636-4E5A-6FA1-5CCD-E47692693D2A}"/>
          </ac:spMkLst>
        </pc:spChg>
        <pc:spChg chg="mod topLvl">
          <ac:chgData name="Paolo Paganetti" userId="dcd282f25ae9c4f2" providerId="LiveId" clId="{C997E11D-29CD-4387-AD28-D8541B11CB53}" dt="2025-03-24T08:21:31.011" v="4328" actId="164"/>
          <ac:spMkLst>
            <pc:docMk/>
            <pc:sldMk cId="3754364032" sldId="1613"/>
            <ac:spMk id="23" creationId="{94082EC9-E5FE-0F81-6B4D-B80888E7DAFC}"/>
          </ac:spMkLst>
        </pc:spChg>
        <pc:spChg chg="mod">
          <ac:chgData name="Paolo Paganetti" userId="dcd282f25ae9c4f2" providerId="LiveId" clId="{C997E11D-29CD-4387-AD28-D8541B11CB53}" dt="2025-03-24T08:27:00.433" v="4380" actId="571"/>
          <ac:spMkLst>
            <pc:docMk/>
            <pc:sldMk cId="3754364032" sldId="1613"/>
            <ac:spMk id="24" creationId="{9B3C0FB4-E20A-15E0-125E-35EC88DB0BDC}"/>
          </ac:spMkLst>
        </pc:spChg>
        <pc:spChg chg="mod topLvl">
          <ac:chgData name="Paolo Paganetti" userId="dcd282f25ae9c4f2" providerId="LiveId" clId="{C997E11D-29CD-4387-AD28-D8541B11CB53}" dt="2025-03-24T08:21:31.011" v="4328" actId="164"/>
          <ac:spMkLst>
            <pc:docMk/>
            <pc:sldMk cId="3754364032" sldId="1613"/>
            <ac:spMk id="25" creationId="{6A32C781-CF2D-5906-67B2-569E5B0CF82B}"/>
          </ac:spMkLst>
        </pc:spChg>
        <pc:spChg chg="mod">
          <ac:chgData name="Paolo Paganetti" userId="dcd282f25ae9c4f2" providerId="LiveId" clId="{C997E11D-29CD-4387-AD28-D8541B11CB53}" dt="2025-03-24T08:27:00.433" v="4380" actId="571"/>
          <ac:spMkLst>
            <pc:docMk/>
            <pc:sldMk cId="3754364032" sldId="1613"/>
            <ac:spMk id="26" creationId="{48127C44-2DFF-63A1-47AC-44F2AE75ED2B}"/>
          </ac:spMkLst>
        </pc:spChg>
        <pc:spChg chg="mod topLvl">
          <ac:chgData name="Paolo Paganetti" userId="dcd282f25ae9c4f2" providerId="LiveId" clId="{C997E11D-29CD-4387-AD28-D8541B11CB53}" dt="2025-03-24T08:27:34.973" v="4387" actId="164"/>
          <ac:spMkLst>
            <pc:docMk/>
            <pc:sldMk cId="3754364032" sldId="1613"/>
            <ac:spMk id="27" creationId="{C1E07B41-AD77-4860-8C15-64C4A6D8DC32}"/>
          </ac:spMkLst>
        </pc:spChg>
        <pc:spChg chg="mod topLvl">
          <ac:chgData name="Paolo Paganetti" userId="dcd282f25ae9c4f2" providerId="LiveId" clId="{C997E11D-29CD-4387-AD28-D8541B11CB53}" dt="2025-03-24T08:26:01.067" v="4371" actId="165"/>
          <ac:spMkLst>
            <pc:docMk/>
            <pc:sldMk cId="3754364032" sldId="1613"/>
            <ac:spMk id="28" creationId="{DB2B4EB2-D255-4B4E-3829-9128EAC18D9B}"/>
          </ac:spMkLst>
        </pc:spChg>
        <pc:spChg chg="mod topLvl">
          <ac:chgData name="Paolo Paganetti" userId="dcd282f25ae9c4f2" providerId="LiveId" clId="{C997E11D-29CD-4387-AD28-D8541B11CB53}" dt="2025-03-24T08:26:01.067" v="4371" actId="165"/>
          <ac:spMkLst>
            <pc:docMk/>
            <pc:sldMk cId="3754364032" sldId="1613"/>
            <ac:spMk id="29" creationId="{B825C897-DF5F-21AD-FBD5-674CCDF8AB34}"/>
          </ac:spMkLst>
        </pc:spChg>
        <pc:spChg chg="mod topLvl">
          <ac:chgData name="Paolo Paganetti" userId="dcd282f25ae9c4f2" providerId="LiveId" clId="{C997E11D-29CD-4387-AD28-D8541B11CB53}" dt="2025-03-23T14:06:08.177" v="3893" actId="1076"/>
          <ac:spMkLst>
            <pc:docMk/>
            <pc:sldMk cId="3754364032" sldId="1613"/>
            <ac:spMk id="31" creationId="{D169E6D4-D7A6-79F2-2863-5673767129AA}"/>
          </ac:spMkLst>
        </pc:spChg>
        <pc:spChg chg="mod topLvl">
          <ac:chgData name="Paolo Paganetti" userId="dcd282f25ae9c4f2" providerId="LiveId" clId="{C997E11D-29CD-4387-AD28-D8541B11CB53}" dt="2025-03-24T08:27:34.973" v="4387" actId="164"/>
          <ac:spMkLst>
            <pc:docMk/>
            <pc:sldMk cId="3754364032" sldId="1613"/>
            <ac:spMk id="32" creationId="{2FE3E261-F808-132B-7142-A6D8AEEEB93A}"/>
          </ac:spMkLst>
        </pc:spChg>
        <pc:spChg chg="mod topLvl">
          <ac:chgData name="Paolo Paganetti" userId="dcd282f25ae9c4f2" providerId="LiveId" clId="{C997E11D-29CD-4387-AD28-D8541B11CB53}" dt="2025-03-23T11:46:15.964" v="2326" actId="1076"/>
          <ac:spMkLst>
            <pc:docMk/>
            <pc:sldMk cId="3754364032" sldId="1613"/>
            <ac:spMk id="33" creationId="{D5E1D10B-72F7-0EBA-2F71-008A995CD2BA}"/>
          </ac:spMkLst>
        </pc:spChg>
        <pc:spChg chg="mod">
          <ac:chgData name="Paolo Paganetti" userId="dcd282f25ae9c4f2" providerId="LiveId" clId="{C997E11D-29CD-4387-AD28-D8541B11CB53}" dt="2025-03-24T08:27:00.433" v="4380" actId="571"/>
          <ac:spMkLst>
            <pc:docMk/>
            <pc:sldMk cId="3754364032" sldId="1613"/>
            <ac:spMk id="35" creationId="{B5C5D322-6450-C255-9827-7B1F5ACBB527}"/>
          </ac:spMkLst>
        </pc:spChg>
        <pc:spChg chg="mod">
          <ac:chgData name="Paolo Paganetti" userId="dcd282f25ae9c4f2" providerId="LiveId" clId="{C997E11D-29CD-4387-AD28-D8541B11CB53}" dt="2025-03-24T08:21:31.011" v="4328" actId="164"/>
          <ac:spMkLst>
            <pc:docMk/>
            <pc:sldMk cId="3754364032" sldId="1613"/>
            <ac:spMk id="40" creationId="{CA8FD352-A0FB-6C62-57C0-69E31CD9449F}"/>
          </ac:spMkLst>
        </pc:spChg>
        <pc:spChg chg="mod">
          <ac:chgData name="Paolo Paganetti" userId="dcd282f25ae9c4f2" providerId="LiveId" clId="{C997E11D-29CD-4387-AD28-D8541B11CB53}" dt="2025-03-24T08:21:49.401" v="4330" actId="1076"/>
          <ac:spMkLst>
            <pc:docMk/>
            <pc:sldMk cId="3754364032" sldId="1613"/>
            <ac:spMk id="41" creationId="{E4A8639E-7F61-4487-721D-EC82AB04FF01}"/>
          </ac:spMkLst>
        </pc:spChg>
        <pc:spChg chg="mod">
          <ac:chgData name="Paolo Paganetti" userId="dcd282f25ae9c4f2" providerId="LiveId" clId="{C997E11D-29CD-4387-AD28-D8541B11CB53}" dt="2025-03-24T08:21:31.011" v="4328" actId="164"/>
          <ac:spMkLst>
            <pc:docMk/>
            <pc:sldMk cId="3754364032" sldId="1613"/>
            <ac:spMk id="42" creationId="{454F19F0-4D86-829B-01CC-B3EA3F9DBC5B}"/>
          </ac:spMkLst>
        </pc:spChg>
        <pc:spChg chg="mod topLvl">
          <ac:chgData name="Paolo Paganetti" userId="dcd282f25ae9c4f2" providerId="LiveId" clId="{C997E11D-29CD-4387-AD28-D8541B11CB53}" dt="2025-03-24T08:26:01.067" v="4371" actId="165"/>
          <ac:spMkLst>
            <pc:docMk/>
            <pc:sldMk cId="3754364032" sldId="1613"/>
            <ac:spMk id="43" creationId="{8D51657C-210D-0488-8222-784955AB0E05}"/>
          </ac:spMkLst>
        </pc:spChg>
        <pc:spChg chg="add mod">
          <ac:chgData name="Paolo Paganetti" userId="dcd282f25ae9c4f2" providerId="LiveId" clId="{C997E11D-29CD-4387-AD28-D8541B11CB53}" dt="2025-03-23T11:46:15.964" v="2326" actId="1076"/>
          <ac:spMkLst>
            <pc:docMk/>
            <pc:sldMk cId="3754364032" sldId="1613"/>
            <ac:spMk id="48" creationId="{CC5A0E71-4626-E638-A887-4EE65659C14F}"/>
          </ac:spMkLst>
        </pc:spChg>
        <pc:spChg chg="mod">
          <ac:chgData name="Paolo Paganetti" userId="dcd282f25ae9c4f2" providerId="LiveId" clId="{C997E11D-29CD-4387-AD28-D8541B11CB53}" dt="2025-03-23T11:45:56.757" v="2323"/>
          <ac:spMkLst>
            <pc:docMk/>
            <pc:sldMk cId="3754364032" sldId="1613"/>
            <ac:spMk id="49" creationId="{4FDA0523-8095-B7B4-F412-0FA142D70125}"/>
          </ac:spMkLst>
        </pc:spChg>
        <pc:spChg chg="mod">
          <ac:chgData name="Paolo Paganetti" userId="dcd282f25ae9c4f2" providerId="LiveId" clId="{C997E11D-29CD-4387-AD28-D8541B11CB53}" dt="2025-03-23T11:45:56.757" v="2323"/>
          <ac:spMkLst>
            <pc:docMk/>
            <pc:sldMk cId="3754364032" sldId="1613"/>
            <ac:spMk id="50" creationId="{104CE84A-8763-F6D7-0DAE-FADAC6CD52F2}"/>
          </ac:spMkLst>
        </pc:spChg>
        <pc:spChg chg="mod">
          <ac:chgData name="Paolo Paganetti" userId="dcd282f25ae9c4f2" providerId="LiveId" clId="{C997E11D-29CD-4387-AD28-D8541B11CB53}" dt="2025-03-23T11:45:56.757" v="2323"/>
          <ac:spMkLst>
            <pc:docMk/>
            <pc:sldMk cId="3754364032" sldId="1613"/>
            <ac:spMk id="51" creationId="{CA752FEA-A369-2C97-595D-F214FDCC2EE9}"/>
          </ac:spMkLst>
        </pc:spChg>
        <pc:spChg chg="add mod">
          <ac:chgData name="Paolo Paganetti" userId="dcd282f25ae9c4f2" providerId="LiveId" clId="{C997E11D-29CD-4387-AD28-D8541B11CB53}" dt="2025-03-19T10:30:29.092" v="1476" actId="1076"/>
          <ac:spMkLst>
            <pc:docMk/>
            <pc:sldMk cId="3754364032" sldId="1613"/>
            <ac:spMk id="52" creationId="{74F97A0B-CB07-FE04-5D6D-9A64C468D388}"/>
          </ac:spMkLst>
        </pc:spChg>
        <pc:spChg chg="add mod topLvl">
          <ac:chgData name="Paolo Paganetti" userId="dcd282f25ae9c4f2" providerId="LiveId" clId="{C997E11D-29CD-4387-AD28-D8541B11CB53}" dt="2025-03-24T08:26:01.067" v="4371" actId="165"/>
          <ac:spMkLst>
            <pc:docMk/>
            <pc:sldMk cId="3754364032" sldId="1613"/>
            <ac:spMk id="53" creationId="{082EF365-FE59-A268-B356-5739D05AF6F5}"/>
          </ac:spMkLst>
        </pc:spChg>
        <pc:spChg chg="add mod">
          <ac:chgData name="Paolo Paganetti" userId="dcd282f25ae9c4f2" providerId="LiveId" clId="{C997E11D-29CD-4387-AD28-D8541B11CB53}" dt="2025-03-19T10:28:59.726" v="1451" actId="1076"/>
          <ac:spMkLst>
            <pc:docMk/>
            <pc:sldMk cId="3754364032" sldId="1613"/>
            <ac:spMk id="54" creationId="{BD4739BB-4F3C-0F66-555C-62F5D1350C8B}"/>
          </ac:spMkLst>
        </pc:spChg>
        <pc:spChg chg="add mod topLvl">
          <ac:chgData name="Paolo Paganetti" userId="dcd282f25ae9c4f2" providerId="LiveId" clId="{C997E11D-29CD-4387-AD28-D8541B11CB53}" dt="2025-03-24T08:27:34.973" v="4387" actId="164"/>
          <ac:spMkLst>
            <pc:docMk/>
            <pc:sldMk cId="3754364032" sldId="1613"/>
            <ac:spMk id="55" creationId="{AED121F1-7884-2B07-0CFE-19614F722902}"/>
          </ac:spMkLst>
        </pc:spChg>
        <pc:spChg chg="add mod topLvl">
          <ac:chgData name="Paolo Paganetti" userId="dcd282f25ae9c4f2" providerId="LiveId" clId="{C997E11D-29CD-4387-AD28-D8541B11CB53}" dt="2025-03-24T08:26:01.067" v="4371" actId="165"/>
          <ac:spMkLst>
            <pc:docMk/>
            <pc:sldMk cId="3754364032" sldId="1613"/>
            <ac:spMk id="56" creationId="{C29E1EE4-52E5-ED95-7375-08A14B377F47}"/>
          </ac:spMkLst>
        </pc:spChg>
        <pc:spChg chg="add mod">
          <ac:chgData name="Paolo Paganetti" userId="dcd282f25ae9c4f2" providerId="LiveId" clId="{C997E11D-29CD-4387-AD28-D8541B11CB53}" dt="2025-03-24T08:24:26.292" v="4350" actId="6549"/>
          <ac:spMkLst>
            <pc:docMk/>
            <pc:sldMk cId="3754364032" sldId="1613"/>
            <ac:spMk id="57" creationId="{589B1311-60F7-FCFF-B2F4-DE35958E6125}"/>
          </ac:spMkLst>
        </pc:spChg>
        <pc:spChg chg="add mod">
          <ac:chgData name="Paolo Paganetti" userId="dcd282f25ae9c4f2" providerId="LiveId" clId="{C997E11D-29CD-4387-AD28-D8541B11CB53}" dt="2025-03-23T11:46:15.964" v="2326" actId="1076"/>
          <ac:spMkLst>
            <pc:docMk/>
            <pc:sldMk cId="3754364032" sldId="1613"/>
            <ac:spMk id="58" creationId="{CCF30B8D-926C-A511-B727-BF65FB373E20}"/>
          </ac:spMkLst>
        </pc:spChg>
        <pc:spChg chg="add mod topLvl">
          <ac:chgData name="Paolo Paganetti" userId="dcd282f25ae9c4f2" providerId="LiveId" clId="{C997E11D-29CD-4387-AD28-D8541B11CB53}" dt="2025-03-24T08:27:34.973" v="4387" actId="164"/>
          <ac:spMkLst>
            <pc:docMk/>
            <pc:sldMk cId="3754364032" sldId="1613"/>
            <ac:spMk id="59" creationId="{D64B6838-F90B-A858-85F2-6DC239AAE180}"/>
          </ac:spMkLst>
        </pc:spChg>
        <pc:spChg chg="add mod">
          <ac:chgData name="Paolo Paganetti" userId="dcd282f25ae9c4f2" providerId="LiveId" clId="{C997E11D-29CD-4387-AD28-D8541B11CB53}" dt="2025-03-23T11:46:15.964" v="2326" actId="1076"/>
          <ac:spMkLst>
            <pc:docMk/>
            <pc:sldMk cId="3754364032" sldId="1613"/>
            <ac:spMk id="62" creationId="{D4682E85-5BF4-0652-614C-A90BE0C8390D}"/>
          </ac:spMkLst>
        </pc:spChg>
        <pc:spChg chg="add mod">
          <ac:chgData name="Paolo Paganetti" userId="dcd282f25ae9c4f2" providerId="LiveId" clId="{C997E11D-29CD-4387-AD28-D8541B11CB53}" dt="2025-03-23T14:05:41.248" v="3887" actId="164"/>
          <ac:spMkLst>
            <pc:docMk/>
            <pc:sldMk cId="3754364032" sldId="1613"/>
            <ac:spMk id="63" creationId="{70EAF17E-02FE-1A64-06FD-34221FC4BCBF}"/>
          </ac:spMkLst>
        </pc:spChg>
        <pc:spChg chg="add mod">
          <ac:chgData name="Paolo Paganetti" userId="dcd282f25ae9c4f2" providerId="LiveId" clId="{C997E11D-29CD-4387-AD28-D8541B11CB53}" dt="2025-03-19T10:53:17.384" v="2099" actId="571"/>
          <ac:spMkLst>
            <pc:docMk/>
            <pc:sldMk cId="3754364032" sldId="1613"/>
            <ac:spMk id="66" creationId="{878891CC-493F-4BEE-D8E4-420E64BBBCB5}"/>
          </ac:spMkLst>
        </pc:spChg>
        <pc:spChg chg="add mod topLvl">
          <ac:chgData name="Paolo Paganetti" userId="dcd282f25ae9c4f2" providerId="LiveId" clId="{C997E11D-29CD-4387-AD28-D8541B11CB53}" dt="2025-03-24T08:27:34.973" v="4387" actId="164"/>
          <ac:spMkLst>
            <pc:docMk/>
            <pc:sldMk cId="3754364032" sldId="1613"/>
            <ac:spMk id="67" creationId="{27C8AE99-5BAD-A0FA-93CB-89AD9AF66906}"/>
          </ac:spMkLst>
        </pc:spChg>
        <pc:spChg chg="mod">
          <ac:chgData name="Paolo Paganetti" userId="dcd282f25ae9c4f2" providerId="LiveId" clId="{C997E11D-29CD-4387-AD28-D8541B11CB53}" dt="2025-03-23T11:45:56.757" v="2323"/>
          <ac:spMkLst>
            <pc:docMk/>
            <pc:sldMk cId="3754364032" sldId="1613"/>
            <ac:spMk id="68" creationId="{7A85C155-A38A-CF56-7D61-49265D2782B4}"/>
          </ac:spMkLst>
        </pc:spChg>
        <pc:spChg chg="mod">
          <ac:chgData name="Paolo Paganetti" userId="dcd282f25ae9c4f2" providerId="LiveId" clId="{C997E11D-29CD-4387-AD28-D8541B11CB53}" dt="2025-03-23T11:45:56.757" v="2323"/>
          <ac:spMkLst>
            <pc:docMk/>
            <pc:sldMk cId="3754364032" sldId="1613"/>
            <ac:spMk id="72" creationId="{DD45F689-0D3D-CF96-8854-E05F053C0E33}"/>
          </ac:spMkLst>
        </pc:spChg>
        <pc:spChg chg="add mod ord topLvl">
          <ac:chgData name="Paolo Paganetti" userId="dcd282f25ae9c4f2" providerId="LiveId" clId="{C997E11D-29CD-4387-AD28-D8541B11CB53}" dt="2025-03-24T08:26:01.067" v="4371" actId="165"/>
          <ac:spMkLst>
            <pc:docMk/>
            <pc:sldMk cId="3754364032" sldId="1613"/>
            <ac:spMk id="87" creationId="{BEC01F70-5FE4-9E67-3401-ED0A53B0FE16}"/>
          </ac:spMkLst>
        </pc:spChg>
        <pc:spChg chg="add mod topLvl">
          <ac:chgData name="Paolo Paganetti" userId="dcd282f25ae9c4f2" providerId="LiveId" clId="{C997E11D-29CD-4387-AD28-D8541B11CB53}" dt="2025-03-23T12:19:08.486" v="2765" actId="1076"/>
          <ac:spMkLst>
            <pc:docMk/>
            <pc:sldMk cId="3754364032" sldId="1613"/>
            <ac:spMk id="88" creationId="{BCF116FF-01B3-DD1F-20A0-AA4E0E32A53E}"/>
          </ac:spMkLst>
        </pc:spChg>
        <pc:spChg chg="add mod topLvl">
          <ac:chgData name="Paolo Paganetti" userId="dcd282f25ae9c4f2" providerId="LiveId" clId="{C997E11D-29CD-4387-AD28-D8541B11CB53}" dt="2025-03-24T08:27:34.973" v="4387" actId="164"/>
          <ac:spMkLst>
            <pc:docMk/>
            <pc:sldMk cId="3754364032" sldId="1613"/>
            <ac:spMk id="89" creationId="{FC95BDBC-BDB2-FBD5-B281-AD1A49821511}"/>
          </ac:spMkLst>
        </pc:spChg>
        <pc:spChg chg="add mod topLvl">
          <ac:chgData name="Paolo Paganetti" userId="dcd282f25ae9c4f2" providerId="LiveId" clId="{C997E11D-29CD-4387-AD28-D8541B11CB53}" dt="2025-03-24T08:27:34.973" v="4387" actId="164"/>
          <ac:spMkLst>
            <pc:docMk/>
            <pc:sldMk cId="3754364032" sldId="1613"/>
            <ac:spMk id="90" creationId="{0BFD706F-F295-84A4-2B41-4CD54DF8AB47}"/>
          </ac:spMkLst>
        </pc:spChg>
        <pc:spChg chg="add mod topLvl">
          <ac:chgData name="Paolo Paganetti" userId="dcd282f25ae9c4f2" providerId="LiveId" clId="{C997E11D-29CD-4387-AD28-D8541B11CB53}" dt="2025-03-23T12:19:08.486" v="2765" actId="1076"/>
          <ac:spMkLst>
            <pc:docMk/>
            <pc:sldMk cId="3754364032" sldId="1613"/>
            <ac:spMk id="91" creationId="{238D2313-9F16-DF34-A4C3-EF0F028E5DFA}"/>
          </ac:spMkLst>
        </pc:spChg>
        <pc:spChg chg="add mod topLvl">
          <ac:chgData name="Paolo Paganetti" userId="dcd282f25ae9c4f2" providerId="LiveId" clId="{C997E11D-29CD-4387-AD28-D8541B11CB53}" dt="2025-03-24T08:26:01.067" v="4371" actId="165"/>
          <ac:spMkLst>
            <pc:docMk/>
            <pc:sldMk cId="3754364032" sldId="1613"/>
            <ac:spMk id="92" creationId="{6809BDC6-E766-F4E4-2102-7E99C318AAE0}"/>
          </ac:spMkLst>
        </pc:spChg>
        <pc:spChg chg="add mod topLvl">
          <ac:chgData name="Paolo Paganetti" userId="dcd282f25ae9c4f2" providerId="LiveId" clId="{C997E11D-29CD-4387-AD28-D8541B11CB53}" dt="2025-03-23T14:05:41.248" v="3887" actId="164"/>
          <ac:spMkLst>
            <pc:docMk/>
            <pc:sldMk cId="3754364032" sldId="1613"/>
            <ac:spMk id="93" creationId="{C03F073E-9F85-5512-D05B-32DD48E9A597}"/>
          </ac:spMkLst>
        </pc:spChg>
        <pc:spChg chg="add mod topLvl">
          <ac:chgData name="Paolo Paganetti" userId="dcd282f25ae9c4f2" providerId="LiveId" clId="{C997E11D-29CD-4387-AD28-D8541B11CB53}" dt="2025-03-23T12:19:08.486" v="2765" actId="1076"/>
          <ac:spMkLst>
            <pc:docMk/>
            <pc:sldMk cId="3754364032" sldId="1613"/>
            <ac:spMk id="94" creationId="{93263712-B343-E4D7-30CE-EA8AF245A34C}"/>
          </ac:spMkLst>
        </pc:spChg>
        <pc:spChg chg="add mod topLvl">
          <ac:chgData name="Paolo Paganetti" userId="dcd282f25ae9c4f2" providerId="LiveId" clId="{C997E11D-29CD-4387-AD28-D8541B11CB53}" dt="2025-03-23T14:05:41.248" v="3887" actId="164"/>
          <ac:spMkLst>
            <pc:docMk/>
            <pc:sldMk cId="3754364032" sldId="1613"/>
            <ac:spMk id="95" creationId="{FE04674A-D578-8CF5-6B88-464FE69C0BDE}"/>
          </ac:spMkLst>
        </pc:spChg>
        <pc:spChg chg="add mod topLvl">
          <ac:chgData name="Paolo Paganetti" userId="dcd282f25ae9c4f2" providerId="LiveId" clId="{C997E11D-29CD-4387-AD28-D8541B11CB53}" dt="2025-03-24T08:27:34.973" v="4387" actId="164"/>
          <ac:spMkLst>
            <pc:docMk/>
            <pc:sldMk cId="3754364032" sldId="1613"/>
            <ac:spMk id="97" creationId="{E15CC3FE-2300-C9F3-5AE3-13468A907A99}"/>
          </ac:spMkLst>
        </pc:spChg>
        <pc:spChg chg="add mod">
          <ac:chgData name="Paolo Paganetti" userId="dcd282f25ae9c4f2" providerId="LiveId" clId="{C997E11D-29CD-4387-AD28-D8541B11CB53}" dt="2025-03-23T14:05:41.248" v="3887" actId="164"/>
          <ac:spMkLst>
            <pc:docMk/>
            <pc:sldMk cId="3754364032" sldId="1613"/>
            <ac:spMk id="98" creationId="{4A4C23B0-2329-E401-7781-095E8A67BD01}"/>
          </ac:spMkLst>
        </pc:spChg>
        <pc:spChg chg="add mod topLvl">
          <ac:chgData name="Paolo Paganetti" userId="dcd282f25ae9c4f2" providerId="LiveId" clId="{C997E11D-29CD-4387-AD28-D8541B11CB53}" dt="2025-03-24T08:27:34.973" v="4387" actId="164"/>
          <ac:spMkLst>
            <pc:docMk/>
            <pc:sldMk cId="3754364032" sldId="1613"/>
            <ac:spMk id="99" creationId="{69A39BAD-AA51-C10B-2218-60ED4DD3B7FA}"/>
          </ac:spMkLst>
        </pc:spChg>
        <pc:spChg chg="add mod">
          <ac:chgData name="Paolo Paganetti" userId="dcd282f25ae9c4f2" providerId="LiveId" clId="{C997E11D-29CD-4387-AD28-D8541B11CB53}" dt="2025-03-24T08:25:19.695" v="4369" actId="20577"/>
          <ac:spMkLst>
            <pc:docMk/>
            <pc:sldMk cId="3754364032" sldId="1613"/>
            <ac:spMk id="102" creationId="{E4EA594B-0141-F01E-572E-49882E6664DA}"/>
          </ac:spMkLst>
        </pc:spChg>
        <pc:spChg chg="add mod">
          <ac:chgData name="Paolo Paganetti" userId="dcd282f25ae9c4f2" providerId="LiveId" clId="{C997E11D-29CD-4387-AD28-D8541B11CB53}" dt="2025-03-24T08:25:10.654" v="4357" actId="20577"/>
          <ac:spMkLst>
            <pc:docMk/>
            <pc:sldMk cId="3754364032" sldId="1613"/>
            <ac:spMk id="103" creationId="{E766B6E4-73AE-E09F-D361-18C2705BB645}"/>
          </ac:spMkLst>
        </pc:spChg>
        <pc:spChg chg="add del mod">
          <ac:chgData name="Paolo Paganetti" userId="dcd282f25ae9c4f2" providerId="LiveId" clId="{C997E11D-29CD-4387-AD28-D8541B11CB53}" dt="2025-03-23T12:25:00.153" v="2906" actId="478"/>
          <ac:spMkLst>
            <pc:docMk/>
            <pc:sldMk cId="3754364032" sldId="1613"/>
            <ac:spMk id="113" creationId="{BF559338-04D4-8744-5AA2-508AF10D626C}"/>
          </ac:spMkLst>
        </pc:spChg>
        <pc:spChg chg="add mod topLvl">
          <ac:chgData name="Paolo Paganetti" userId="dcd282f25ae9c4f2" providerId="LiveId" clId="{C997E11D-29CD-4387-AD28-D8541B11CB53}" dt="2025-03-24T08:26:16.174" v="4374" actId="164"/>
          <ac:spMkLst>
            <pc:docMk/>
            <pc:sldMk cId="3754364032" sldId="1613"/>
            <ac:spMk id="114" creationId="{C965DC35-0FFC-AA20-C419-099CAB703BBD}"/>
          </ac:spMkLst>
        </pc:spChg>
        <pc:spChg chg="add mod">
          <ac:chgData name="Paolo Paganetti" userId="dcd282f25ae9c4f2" providerId="LiveId" clId="{C997E11D-29CD-4387-AD28-D8541B11CB53}" dt="2025-03-24T08:26:08.535" v="4373" actId="164"/>
          <ac:spMkLst>
            <pc:docMk/>
            <pc:sldMk cId="3754364032" sldId="1613"/>
            <ac:spMk id="115" creationId="{1549EFCA-7392-63C8-DA35-3D86128366EF}"/>
          </ac:spMkLst>
        </pc:spChg>
        <pc:spChg chg="add mod topLvl">
          <ac:chgData name="Paolo Paganetti" userId="dcd282f25ae9c4f2" providerId="LiveId" clId="{C997E11D-29CD-4387-AD28-D8541B11CB53}" dt="2025-03-24T08:26:16.174" v="4374" actId="164"/>
          <ac:spMkLst>
            <pc:docMk/>
            <pc:sldMk cId="3754364032" sldId="1613"/>
            <ac:spMk id="116" creationId="{07683775-28D0-E738-BCA0-46FCF6BCEDC4}"/>
          </ac:spMkLst>
        </pc:spChg>
        <pc:spChg chg="add mod">
          <ac:chgData name="Paolo Paganetti" userId="dcd282f25ae9c4f2" providerId="LiveId" clId="{C997E11D-29CD-4387-AD28-D8541B11CB53}" dt="2025-03-24T08:26:16.174" v="4374" actId="164"/>
          <ac:spMkLst>
            <pc:docMk/>
            <pc:sldMk cId="3754364032" sldId="1613"/>
            <ac:spMk id="117" creationId="{EDBA5672-D18D-F731-5063-EEED09A9BE14}"/>
          </ac:spMkLst>
        </pc:spChg>
        <pc:spChg chg="add mod">
          <ac:chgData name="Paolo Paganetti" userId="dcd282f25ae9c4f2" providerId="LiveId" clId="{C997E11D-29CD-4387-AD28-D8541B11CB53}" dt="2025-03-23T12:26:12.608" v="2932" actId="571"/>
          <ac:spMkLst>
            <pc:docMk/>
            <pc:sldMk cId="3754364032" sldId="1613"/>
            <ac:spMk id="120" creationId="{AE53FD2A-3012-644A-A4C1-7F41399A1504}"/>
          </ac:spMkLst>
        </pc:spChg>
        <pc:spChg chg="add mod">
          <ac:chgData name="Paolo Paganetti" userId="dcd282f25ae9c4f2" providerId="LiveId" clId="{C997E11D-29CD-4387-AD28-D8541B11CB53}" dt="2025-03-23T12:26:12.608" v="2932" actId="571"/>
          <ac:spMkLst>
            <pc:docMk/>
            <pc:sldMk cId="3754364032" sldId="1613"/>
            <ac:spMk id="121" creationId="{11EA652F-2223-E6C1-6B7A-1ACA9A3EB5BB}"/>
          </ac:spMkLst>
        </pc:spChg>
        <pc:spChg chg="add mod topLvl">
          <ac:chgData name="Paolo Paganetti" userId="dcd282f25ae9c4f2" providerId="LiveId" clId="{C997E11D-29CD-4387-AD28-D8541B11CB53}" dt="2025-03-24T08:26:08.535" v="4373" actId="164"/>
          <ac:spMkLst>
            <pc:docMk/>
            <pc:sldMk cId="3754364032" sldId="1613"/>
            <ac:spMk id="124" creationId="{C8FAA2EE-7B1E-93CD-A3A3-494A6238463D}"/>
          </ac:spMkLst>
        </pc:spChg>
        <pc:spChg chg="add mod">
          <ac:chgData name="Paolo Paganetti" userId="dcd282f25ae9c4f2" providerId="LiveId" clId="{C997E11D-29CD-4387-AD28-D8541B11CB53}" dt="2025-03-24T08:26:08.535" v="4373" actId="164"/>
          <ac:spMkLst>
            <pc:docMk/>
            <pc:sldMk cId="3754364032" sldId="1613"/>
            <ac:spMk id="125" creationId="{631656AE-8DC1-237D-40C8-2B6AD10A23F8}"/>
          </ac:spMkLst>
        </pc:spChg>
        <pc:spChg chg="add mod">
          <ac:chgData name="Paolo Paganetti" userId="dcd282f25ae9c4f2" providerId="LiveId" clId="{C997E11D-29CD-4387-AD28-D8541B11CB53}" dt="2025-03-24T08:26:16.174" v="4374" actId="164"/>
          <ac:spMkLst>
            <pc:docMk/>
            <pc:sldMk cId="3754364032" sldId="1613"/>
            <ac:spMk id="128" creationId="{E6EE00BC-FB59-DD4E-795A-AA2AEC58BE31}"/>
          </ac:spMkLst>
        </pc:spChg>
        <pc:spChg chg="add mod">
          <ac:chgData name="Paolo Paganetti" userId="dcd282f25ae9c4f2" providerId="LiveId" clId="{C997E11D-29CD-4387-AD28-D8541B11CB53}" dt="2025-03-24T08:26:08.535" v="4373" actId="164"/>
          <ac:spMkLst>
            <pc:docMk/>
            <pc:sldMk cId="3754364032" sldId="1613"/>
            <ac:spMk id="129" creationId="{499D330C-28AF-1F54-2389-C8321695D44D}"/>
          </ac:spMkLst>
        </pc:spChg>
        <pc:grpChg chg="del mod">
          <ac:chgData name="Paolo Paganetti" userId="dcd282f25ae9c4f2" providerId="LiveId" clId="{C997E11D-29CD-4387-AD28-D8541B11CB53}" dt="2025-03-23T11:46:10.433" v="2325" actId="478"/>
          <ac:grpSpMkLst>
            <pc:docMk/>
            <pc:sldMk cId="3754364032" sldId="1613"/>
            <ac:grpSpMk id="3" creationId="{AA4AE278-3021-D05F-9A35-133AC32EB6A8}"/>
          </ac:grpSpMkLst>
        </pc:grpChg>
        <pc:grpChg chg="add del mod">
          <ac:chgData name="Paolo Paganetti" userId="dcd282f25ae9c4f2" providerId="LiveId" clId="{C997E11D-29CD-4387-AD28-D8541B11CB53}" dt="2025-03-24T08:27:17.935" v="4385" actId="478"/>
          <ac:grpSpMkLst>
            <pc:docMk/>
            <pc:sldMk cId="3754364032" sldId="1613"/>
            <ac:grpSpMk id="9" creationId="{ABC26B82-A35F-DA6F-A0AF-C3D0DD304E6E}"/>
          </ac:grpSpMkLst>
        </pc:grpChg>
        <pc:grpChg chg="add del mod">
          <ac:chgData name="Paolo Paganetti" userId="dcd282f25ae9c4f2" providerId="LiveId" clId="{C997E11D-29CD-4387-AD28-D8541B11CB53}" dt="2025-03-23T13:20:39.408" v="3590" actId="478"/>
          <ac:grpSpMkLst>
            <pc:docMk/>
            <pc:sldMk cId="3754364032" sldId="1613"/>
            <ac:grpSpMk id="9" creationId="{B2998DA8-2DE0-8128-FD18-BA8B86412D24}"/>
          </ac:grpSpMkLst>
        </pc:grpChg>
        <pc:grpChg chg="add del mod">
          <ac:chgData name="Paolo Paganetti" userId="dcd282f25ae9c4f2" providerId="LiveId" clId="{C997E11D-29CD-4387-AD28-D8541B11CB53}" dt="2025-03-24T08:27:14.983" v="4384" actId="478"/>
          <ac:grpSpMkLst>
            <pc:docMk/>
            <pc:sldMk cId="3754364032" sldId="1613"/>
            <ac:grpSpMk id="10" creationId="{27518807-6A22-7D1A-39F7-8B600B7BA32A}"/>
          </ac:grpSpMkLst>
        </pc:grpChg>
        <pc:grpChg chg="add mod ord">
          <ac:chgData name="Paolo Paganetti" userId="dcd282f25ae9c4f2" providerId="LiveId" clId="{C997E11D-29CD-4387-AD28-D8541B11CB53}" dt="2025-03-24T08:26:47.552" v="4379" actId="167"/>
          <ac:grpSpMkLst>
            <pc:docMk/>
            <pc:sldMk cId="3754364032" sldId="1613"/>
            <ac:grpSpMk id="11" creationId="{D3B3BDA8-D812-7BBE-AB54-2BF846686F6C}"/>
          </ac:grpSpMkLst>
        </pc:grpChg>
        <pc:grpChg chg="add del mod ord">
          <ac:chgData name="Paolo Paganetti" userId="dcd282f25ae9c4f2" providerId="LiveId" clId="{C997E11D-29CD-4387-AD28-D8541B11CB53}" dt="2025-03-24T08:27:12.299" v="4383" actId="478"/>
          <ac:grpSpMkLst>
            <pc:docMk/>
            <pc:sldMk cId="3754364032" sldId="1613"/>
            <ac:grpSpMk id="20" creationId="{832D4013-8851-7383-0098-19AB8A88C869}"/>
          </ac:grpSpMkLst>
        </pc:grpChg>
        <pc:grpChg chg="add del mod ord">
          <ac:chgData name="Paolo Paganetti" userId="dcd282f25ae9c4f2" providerId="LiveId" clId="{C997E11D-29CD-4387-AD28-D8541B11CB53}" dt="2025-03-23T12:14:28.751" v="2589" actId="165"/>
          <ac:grpSpMkLst>
            <pc:docMk/>
            <pc:sldMk cId="3754364032" sldId="1613"/>
            <ac:grpSpMk id="96" creationId="{69D8FB17-1AD0-33A4-CCF1-09008F8431A8}"/>
          </ac:grpSpMkLst>
        </pc:grpChg>
        <pc:grpChg chg="mod">
          <ac:chgData name="Paolo Paganetti" userId="dcd282f25ae9c4f2" providerId="LiveId" clId="{C997E11D-29CD-4387-AD28-D8541B11CB53}" dt="2025-03-24T08:22:09.026" v="4333" actId="14100"/>
          <ac:grpSpMkLst>
            <pc:docMk/>
            <pc:sldMk cId="3754364032" sldId="1613"/>
            <ac:grpSpMk id="134" creationId="{93F41D79-79CA-4C2E-3F77-08CEBD9D6F4B}"/>
          </ac:grpSpMkLst>
        </pc:grpChg>
        <pc:grpChg chg="add del mod">
          <ac:chgData name="Paolo Paganetti" userId="dcd282f25ae9c4f2" providerId="LiveId" clId="{C997E11D-29CD-4387-AD28-D8541B11CB53}" dt="2025-03-24T08:26:03.013" v="4372" actId="165"/>
          <ac:grpSpMkLst>
            <pc:docMk/>
            <pc:sldMk cId="3754364032" sldId="1613"/>
            <ac:grpSpMk id="135" creationId="{DCEB327B-CE7D-5AE3-AB92-63306077C4DA}"/>
          </ac:grpSpMkLst>
        </pc:grpChg>
        <pc:picChg chg="add mod">
          <ac:chgData name="Paolo Paganetti" userId="dcd282f25ae9c4f2" providerId="LiveId" clId="{C997E11D-29CD-4387-AD28-D8541B11CB53}" dt="2025-03-23T11:45:54.437" v="2322" actId="1076"/>
          <ac:picMkLst>
            <pc:docMk/>
            <pc:sldMk cId="3754364032" sldId="1613"/>
            <ac:picMk id="2" creationId="{23401A34-510A-CA80-18F6-9EE96EB752CC}"/>
          </ac:picMkLst>
        </pc:picChg>
        <pc:picChg chg="add del mod modCrop">
          <ac:chgData name="Paolo Paganetti" userId="dcd282f25ae9c4f2" providerId="LiveId" clId="{C997E11D-29CD-4387-AD28-D8541B11CB53}" dt="2025-03-23T12:08:49.544" v="2397" actId="478"/>
          <ac:picMkLst>
            <pc:docMk/>
            <pc:sldMk cId="3754364032" sldId="1613"/>
            <ac:picMk id="4" creationId="{6C6C223A-0CAF-5476-D4AE-6C4FB3CB316A}"/>
          </ac:picMkLst>
        </pc:picChg>
        <pc:picChg chg="add del mod modCrop">
          <ac:chgData name="Paolo Paganetti" userId="dcd282f25ae9c4f2" providerId="LiveId" clId="{C997E11D-29CD-4387-AD28-D8541B11CB53}" dt="2025-03-23T12:08:49.544" v="2397" actId="478"/>
          <ac:picMkLst>
            <pc:docMk/>
            <pc:sldMk cId="3754364032" sldId="1613"/>
            <ac:picMk id="5" creationId="{3E7F78D9-9693-F4D8-C1B5-4B2AC6B0AA79}"/>
          </ac:picMkLst>
        </pc:picChg>
        <pc:picChg chg="add mod modCrop">
          <ac:chgData name="Paolo Paganetti" userId="dcd282f25ae9c4f2" providerId="LiveId" clId="{C997E11D-29CD-4387-AD28-D8541B11CB53}" dt="2025-03-19T10:28:30.158" v="1446" actId="1076"/>
          <ac:picMkLst>
            <pc:docMk/>
            <pc:sldMk cId="3754364032" sldId="1613"/>
            <ac:picMk id="6" creationId="{1A80DAE1-BCB7-FFBA-EC82-0A8BAA75A87A}"/>
          </ac:picMkLst>
        </pc:picChg>
        <pc:picChg chg="add mod modCrop">
          <ac:chgData name="Paolo Paganetti" userId="dcd282f25ae9c4f2" providerId="LiveId" clId="{C997E11D-29CD-4387-AD28-D8541B11CB53}" dt="2025-03-23T12:27:30.443" v="2942" actId="1076"/>
          <ac:picMkLst>
            <pc:docMk/>
            <pc:sldMk cId="3754364032" sldId="1613"/>
            <ac:picMk id="7" creationId="{EAEE0763-ADA5-04E9-3833-6533E1DCA818}"/>
          </ac:picMkLst>
        </pc:picChg>
        <pc:picChg chg="add mod modCrop">
          <ac:chgData name="Paolo Paganetti" userId="dcd282f25ae9c4f2" providerId="LiveId" clId="{C997E11D-29CD-4387-AD28-D8541B11CB53}" dt="2025-03-23T14:05:29.328" v="3886" actId="732"/>
          <ac:picMkLst>
            <pc:docMk/>
            <pc:sldMk cId="3754364032" sldId="1613"/>
            <ac:picMk id="8" creationId="{B81878B3-EB87-B4C2-3D07-F60C7903684A}"/>
          </ac:picMkLst>
        </pc:picChg>
        <pc:picChg chg="mod">
          <ac:chgData name="Paolo Paganetti" userId="dcd282f25ae9c4f2" providerId="LiveId" clId="{C997E11D-29CD-4387-AD28-D8541B11CB53}" dt="2025-03-24T08:26:43.985" v="4378" actId="571"/>
          <ac:picMkLst>
            <pc:docMk/>
            <pc:sldMk cId="3754364032" sldId="1613"/>
            <ac:picMk id="12" creationId="{1B1FB0C8-F721-7CFE-95C8-7A9125EFD221}"/>
          </ac:picMkLst>
        </pc:picChg>
        <pc:picChg chg="mod">
          <ac:chgData name="Paolo Paganetti" userId="dcd282f25ae9c4f2" providerId="LiveId" clId="{C997E11D-29CD-4387-AD28-D8541B11CB53}" dt="2025-03-24T08:27:00.433" v="4380" actId="571"/>
          <ac:picMkLst>
            <pc:docMk/>
            <pc:sldMk cId="3754364032" sldId="1613"/>
            <ac:picMk id="21" creationId="{0C26A48F-6E7E-3F90-B5E0-A869B80A9634}"/>
          </ac:picMkLst>
        </pc:picChg>
        <pc:picChg chg="mod">
          <ac:chgData name="Paolo Paganetti" userId="dcd282f25ae9c4f2" providerId="LiveId" clId="{C997E11D-29CD-4387-AD28-D8541B11CB53}" dt="2025-03-23T11:45:56.757" v="2323"/>
          <ac:picMkLst>
            <pc:docMk/>
            <pc:sldMk cId="3754364032" sldId="1613"/>
            <ac:picMk id="21" creationId="{4C6A4D96-753F-24E0-6130-396B435730CB}"/>
          </ac:picMkLst>
        </pc:picChg>
        <pc:picChg chg="mod">
          <ac:chgData name="Paolo Paganetti" userId="dcd282f25ae9c4f2" providerId="LiveId" clId="{C997E11D-29CD-4387-AD28-D8541B11CB53}" dt="2025-03-23T11:45:56.757" v="2323"/>
          <ac:picMkLst>
            <pc:docMk/>
            <pc:sldMk cId="3754364032" sldId="1613"/>
            <ac:picMk id="44" creationId="{696263E5-CFF8-A2BD-08E1-8AA7571DB386}"/>
          </ac:picMkLst>
        </pc:picChg>
        <pc:picChg chg="mod">
          <ac:chgData name="Paolo Paganetti" userId="dcd282f25ae9c4f2" providerId="LiveId" clId="{C997E11D-29CD-4387-AD28-D8541B11CB53}" dt="2025-03-23T11:45:56.757" v="2323"/>
          <ac:picMkLst>
            <pc:docMk/>
            <pc:sldMk cId="3754364032" sldId="1613"/>
            <ac:picMk id="70" creationId="{E5A28AAA-BC99-E65F-A7D5-BA477C9064C6}"/>
          </ac:picMkLst>
        </pc:picChg>
        <pc:picChg chg="add del mod">
          <ac:chgData name="Paolo Paganetti" userId="dcd282f25ae9c4f2" providerId="LiveId" clId="{C997E11D-29CD-4387-AD28-D8541B11CB53}" dt="2025-03-23T11:49:38.992" v="2344" actId="478"/>
          <ac:picMkLst>
            <pc:docMk/>
            <pc:sldMk cId="3754364032" sldId="1613"/>
            <ac:picMk id="73" creationId="{5B29C39F-2AA5-354A-F1E1-491E69CD2EA3}"/>
          </ac:picMkLst>
        </pc:picChg>
        <pc:picChg chg="add del mod">
          <ac:chgData name="Paolo Paganetti" userId="dcd282f25ae9c4f2" providerId="LiveId" clId="{C997E11D-29CD-4387-AD28-D8541B11CB53}" dt="2025-03-23T11:55:19.197" v="2380" actId="478"/>
          <ac:picMkLst>
            <pc:docMk/>
            <pc:sldMk cId="3754364032" sldId="1613"/>
            <ac:picMk id="74" creationId="{EDCA8FEB-D53E-8579-6587-4F2801176454}"/>
          </ac:picMkLst>
        </pc:picChg>
        <pc:picChg chg="add del mod">
          <ac:chgData name="Paolo Paganetti" userId="dcd282f25ae9c4f2" providerId="LiveId" clId="{C997E11D-29CD-4387-AD28-D8541B11CB53}" dt="2025-03-23T11:49:38.992" v="2344" actId="478"/>
          <ac:picMkLst>
            <pc:docMk/>
            <pc:sldMk cId="3754364032" sldId="1613"/>
            <ac:picMk id="75" creationId="{8344F71F-2F12-7CBE-F492-5B91679AD8EE}"/>
          </ac:picMkLst>
        </pc:picChg>
        <pc:picChg chg="add del mod">
          <ac:chgData name="Paolo Paganetti" userId="dcd282f25ae9c4f2" providerId="LiveId" clId="{C997E11D-29CD-4387-AD28-D8541B11CB53}" dt="2025-03-23T11:49:38.992" v="2344" actId="478"/>
          <ac:picMkLst>
            <pc:docMk/>
            <pc:sldMk cId="3754364032" sldId="1613"/>
            <ac:picMk id="76" creationId="{A5A2AE5A-9EC0-0CCF-88C5-F56415E39874}"/>
          </ac:picMkLst>
        </pc:picChg>
        <pc:picChg chg="add del mod">
          <ac:chgData name="Paolo Paganetti" userId="dcd282f25ae9c4f2" providerId="LiveId" clId="{C997E11D-29CD-4387-AD28-D8541B11CB53}" dt="2025-03-23T11:55:19.197" v="2380" actId="478"/>
          <ac:picMkLst>
            <pc:docMk/>
            <pc:sldMk cId="3754364032" sldId="1613"/>
            <ac:picMk id="77" creationId="{E7A6596A-C3DD-148C-CD4E-CFABE571D419}"/>
          </ac:picMkLst>
        </pc:picChg>
        <pc:picChg chg="add del mod ord modCrop">
          <ac:chgData name="Paolo Paganetti" userId="dcd282f25ae9c4f2" providerId="LiveId" clId="{C997E11D-29CD-4387-AD28-D8541B11CB53}" dt="2025-03-24T08:26:16.174" v="4374" actId="164"/>
          <ac:picMkLst>
            <pc:docMk/>
            <pc:sldMk cId="3754364032" sldId="1613"/>
            <ac:picMk id="78" creationId="{F3A07F82-1FFE-306E-B56B-783212937C26}"/>
          </ac:picMkLst>
        </pc:picChg>
        <pc:picChg chg="add mod modCrop">
          <ac:chgData name="Paolo Paganetti" userId="dcd282f25ae9c4f2" providerId="LiveId" clId="{C997E11D-29CD-4387-AD28-D8541B11CB53}" dt="2025-03-23T12:19:08.486" v="2765" actId="1076"/>
          <ac:picMkLst>
            <pc:docMk/>
            <pc:sldMk cId="3754364032" sldId="1613"/>
            <ac:picMk id="79" creationId="{DF7007A4-9DFD-6947-FBE7-19B51F8F8E6F}"/>
          </ac:picMkLst>
        </pc:picChg>
        <pc:picChg chg="add del mod modCrop">
          <ac:chgData name="Paolo Paganetti" userId="dcd282f25ae9c4f2" providerId="LiveId" clId="{C997E11D-29CD-4387-AD28-D8541B11CB53}" dt="2025-03-23T12:23:24.553" v="2872" actId="478"/>
          <ac:picMkLst>
            <pc:docMk/>
            <pc:sldMk cId="3754364032" sldId="1613"/>
            <ac:picMk id="80" creationId="{F97B9AB0-6984-214E-D27B-7B223302C567}"/>
          </ac:picMkLst>
        </pc:picChg>
        <pc:picChg chg="add mod">
          <ac:chgData name="Paolo Paganetti" userId="dcd282f25ae9c4f2" providerId="LiveId" clId="{C997E11D-29CD-4387-AD28-D8541B11CB53}" dt="2025-03-23T12:07:43.850" v="2387"/>
          <ac:picMkLst>
            <pc:docMk/>
            <pc:sldMk cId="3754364032" sldId="1613"/>
            <ac:picMk id="81" creationId="{DF571278-F030-CE5E-A89C-D77EE98EBE8C}"/>
          </ac:picMkLst>
        </pc:picChg>
        <pc:picChg chg="add mod">
          <ac:chgData name="Paolo Paganetti" userId="dcd282f25ae9c4f2" providerId="LiveId" clId="{C997E11D-29CD-4387-AD28-D8541B11CB53}" dt="2025-03-23T12:07:43.850" v="2387"/>
          <ac:picMkLst>
            <pc:docMk/>
            <pc:sldMk cId="3754364032" sldId="1613"/>
            <ac:picMk id="82" creationId="{C6376FB2-429A-6640-E219-DC9AEAA707B2}"/>
          </ac:picMkLst>
        </pc:picChg>
        <pc:picChg chg="add mod">
          <ac:chgData name="Paolo Paganetti" userId="dcd282f25ae9c4f2" providerId="LiveId" clId="{C997E11D-29CD-4387-AD28-D8541B11CB53}" dt="2025-03-23T12:07:43.850" v="2387"/>
          <ac:picMkLst>
            <pc:docMk/>
            <pc:sldMk cId="3754364032" sldId="1613"/>
            <ac:picMk id="83" creationId="{8C2081CC-8E23-12A9-0E87-43F96D712D55}"/>
          </ac:picMkLst>
        </pc:picChg>
        <pc:picChg chg="add del mod">
          <ac:chgData name="Paolo Paganetti" userId="dcd282f25ae9c4f2" providerId="LiveId" clId="{C997E11D-29CD-4387-AD28-D8541B11CB53}" dt="2025-03-23T12:07:51.474" v="2390" actId="21"/>
          <ac:picMkLst>
            <pc:docMk/>
            <pc:sldMk cId="3754364032" sldId="1613"/>
            <ac:picMk id="84" creationId="{407C4FFF-BF5B-15B6-1141-CD2D7E557C35}"/>
          </ac:picMkLst>
        </pc:picChg>
        <pc:picChg chg="add del mod">
          <ac:chgData name="Paolo Paganetti" userId="dcd282f25ae9c4f2" providerId="LiveId" clId="{C997E11D-29CD-4387-AD28-D8541B11CB53}" dt="2025-03-23T12:07:51.474" v="2390" actId="21"/>
          <ac:picMkLst>
            <pc:docMk/>
            <pc:sldMk cId="3754364032" sldId="1613"/>
            <ac:picMk id="85" creationId="{334B5EF2-C3B8-9DDB-C42A-99E136B49122}"/>
          </ac:picMkLst>
        </pc:picChg>
        <pc:picChg chg="add del mod">
          <ac:chgData name="Paolo Paganetti" userId="dcd282f25ae9c4f2" providerId="LiveId" clId="{C997E11D-29CD-4387-AD28-D8541B11CB53}" dt="2025-03-23T12:07:51.474" v="2390" actId="21"/>
          <ac:picMkLst>
            <pc:docMk/>
            <pc:sldMk cId="3754364032" sldId="1613"/>
            <ac:picMk id="86" creationId="{E9566616-AB49-53BE-2BAB-2F2B5D207597}"/>
          </ac:picMkLst>
        </pc:picChg>
        <pc:picChg chg="add del mod">
          <ac:chgData name="Paolo Paganetti" userId="dcd282f25ae9c4f2" providerId="LiveId" clId="{C997E11D-29CD-4387-AD28-D8541B11CB53}" dt="2025-03-23T12:21:15.989" v="2821" actId="478"/>
          <ac:picMkLst>
            <pc:docMk/>
            <pc:sldMk cId="3754364032" sldId="1613"/>
            <ac:picMk id="104" creationId="{25D6B493-A2C8-CE47-5214-F94B077662ED}"/>
          </ac:picMkLst>
        </pc:picChg>
        <pc:picChg chg="add del mod">
          <ac:chgData name="Paolo Paganetti" userId="dcd282f25ae9c4f2" providerId="LiveId" clId="{C997E11D-29CD-4387-AD28-D8541B11CB53}" dt="2025-03-23T12:21:34.887" v="2829" actId="478"/>
          <ac:picMkLst>
            <pc:docMk/>
            <pc:sldMk cId="3754364032" sldId="1613"/>
            <ac:picMk id="105" creationId="{4B7F3E3D-09C2-CF9C-A05E-D5674D81AA8B}"/>
          </ac:picMkLst>
        </pc:picChg>
        <pc:picChg chg="add del mod">
          <ac:chgData name="Paolo Paganetti" userId="dcd282f25ae9c4f2" providerId="LiveId" clId="{C997E11D-29CD-4387-AD28-D8541B11CB53}" dt="2025-03-23T12:21:33.353" v="2828" actId="478"/>
          <ac:picMkLst>
            <pc:docMk/>
            <pc:sldMk cId="3754364032" sldId="1613"/>
            <ac:picMk id="106" creationId="{CBB33246-DDA5-BFA3-639F-A7552A5E9CE9}"/>
          </ac:picMkLst>
        </pc:picChg>
        <pc:picChg chg="add del mod">
          <ac:chgData name="Paolo Paganetti" userId="dcd282f25ae9c4f2" providerId="LiveId" clId="{C997E11D-29CD-4387-AD28-D8541B11CB53}" dt="2025-03-23T12:21:41.538" v="2831" actId="478"/>
          <ac:picMkLst>
            <pc:docMk/>
            <pc:sldMk cId="3754364032" sldId="1613"/>
            <ac:picMk id="107" creationId="{A832BC99-696F-4BB2-63EB-D4836FCF13DB}"/>
          </ac:picMkLst>
        </pc:picChg>
        <pc:picChg chg="add mod modCrop">
          <ac:chgData name="Paolo Paganetti" userId="dcd282f25ae9c4f2" providerId="LiveId" clId="{C997E11D-29CD-4387-AD28-D8541B11CB53}" dt="2025-03-24T08:26:08.535" v="4373" actId="164"/>
          <ac:picMkLst>
            <pc:docMk/>
            <pc:sldMk cId="3754364032" sldId="1613"/>
            <ac:picMk id="108" creationId="{4F84229C-A3E4-264F-0846-C83AFB099916}"/>
          </ac:picMkLst>
        </pc:picChg>
        <pc:picChg chg="add del mod">
          <ac:chgData name="Paolo Paganetti" userId="dcd282f25ae9c4f2" providerId="LiveId" clId="{C997E11D-29CD-4387-AD28-D8541B11CB53}" dt="2025-03-23T12:22:11.669" v="2838" actId="478"/>
          <ac:picMkLst>
            <pc:docMk/>
            <pc:sldMk cId="3754364032" sldId="1613"/>
            <ac:picMk id="109" creationId="{E189D149-898F-385D-E7AA-E983E3FF2C3B}"/>
          </ac:picMkLst>
        </pc:picChg>
        <pc:picChg chg="add mod">
          <ac:chgData name="Paolo Paganetti" userId="dcd282f25ae9c4f2" providerId="LiveId" clId="{C997E11D-29CD-4387-AD28-D8541B11CB53}" dt="2025-03-23T12:22:21.168" v="2855" actId="571"/>
          <ac:picMkLst>
            <pc:docMk/>
            <pc:sldMk cId="3754364032" sldId="1613"/>
            <ac:picMk id="110" creationId="{905472B3-CE77-E058-A174-B0755BC14438}"/>
          </ac:picMkLst>
        </pc:picChg>
        <pc:picChg chg="add mod">
          <ac:chgData name="Paolo Paganetti" userId="dcd282f25ae9c4f2" providerId="LiveId" clId="{C997E11D-29CD-4387-AD28-D8541B11CB53}" dt="2025-03-23T12:22:27.474" v="2859" actId="571"/>
          <ac:picMkLst>
            <pc:docMk/>
            <pc:sldMk cId="3754364032" sldId="1613"/>
            <ac:picMk id="111" creationId="{CD3BF13C-36AF-79F1-D6F0-D521355ECC15}"/>
          </ac:picMkLst>
        </pc:picChg>
        <pc:picChg chg="add mod">
          <ac:chgData name="Paolo Paganetti" userId="dcd282f25ae9c4f2" providerId="LiveId" clId="{C997E11D-29CD-4387-AD28-D8541B11CB53}" dt="2025-03-23T12:22:33.848" v="2862" actId="571"/>
          <ac:picMkLst>
            <pc:docMk/>
            <pc:sldMk cId="3754364032" sldId="1613"/>
            <ac:picMk id="112" creationId="{3F9A5334-7AFB-9A2A-35D6-15F5665494B1}"/>
          </ac:picMkLst>
        </pc:picChg>
        <pc:cxnChg chg="mod">
          <ac:chgData name="Paolo Paganetti" userId="dcd282f25ae9c4f2" providerId="LiveId" clId="{C997E11D-29CD-4387-AD28-D8541B11CB53}" dt="2025-03-24T08:26:43.985" v="4378" actId="571"/>
          <ac:cxnSpMkLst>
            <pc:docMk/>
            <pc:sldMk cId="3754364032" sldId="1613"/>
            <ac:cxnSpMk id="16" creationId="{40EAF4F2-CF1C-A295-79B6-C51F4ABF589C}"/>
          </ac:cxnSpMkLst>
        </pc:cxnChg>
        <pc:cxnChg chg="mod">
          <ac:chgData name="Paolo Paganetti" userId="dcd282f25ae9c4f2" providerId="LiveId" clId="{C997E11D-29CD-4387-AD28-D8541B11CB53}" dt="2025-03-24T08:26:43.985" v="4378" actId="571"/>
          <ac:cxnSpMkLst>
            <pc:docMk/>
            <pc:sldMk cId="3754364032" sldId="1613"/>
            <ac:cxnSpMk id="17" creationId="{8C0BF829-1F53-5062-06D6-9993E4236C0B}"/>
          </ac:cxnSpMkLst>
        </pc:cxnChg>
        <pc:cxnChg chg="mod">
          <ac:chgData name="Paolo Paganetti" userId="dcd282f25ae9c4f2" providerId="LiveId" clId="{C997E11D-29CD-4387-AD28-D8541B11CB53}" dt="2025-03-24T08:27:00.433" v="4380" actId="571"/>
          <ac:cxnSpMkLst>
            <pc:docMk/>
            <pc:sldMk cId="3754364032" sldId="1613"/>
            <ac:cxnSpMk id="30" creationId="{C8BD61FF-4AC4-FC7D-DECC-1F6E19B853B3}"/>
          </ac:cxnSpMkLst>
        </pc:cxnChg>
        <pc:cxnChg chg="mod">
          <ac:chgData name="Paolo Paganetti" userId="dcd282f25ae9c4f2" providerId="LiveId" clId="{C997E11D-29CD-4387-AD28-D8541B11CB53}" dt="2025-03-24T08:27:00.433" v="4380" actId="571"/>
          <ac:cxnSpMkLst>
            <pc:docMk/>
            <pc:sldMk cId="3754364032" sldId="1613"/>
            <ac:cxnSpMk id="34" creationId="{1F2E1880-F4FF-28CE-3517-018CF6A331AF}"/>
          </ac:cxnSpMkLst>
        </pc:cxnChg>
        <pc:cxnChg chg="mod">
          <ac:chgData name="Paolo Paganetti" userId="dcd282f25ae9c4f2" providerId="LiveId" clId="{C997E11D-29CD-4387-AD28-D8541B11CB53}" dt="2025-03-19T10:16:24.271" v="1277" actId="14100"/>
          <ac:cxnSpMkLst>
            <pc:docMk/>
            <pc:sldMk cId="3754364032" sldId="1613"/>
            <ac:cxnSpMk id="36" creationId="{817EC3B6-0E56-C656-93C8-74BF45B61EE1}"/>
          </ac:cxnSpMkLst>
        </pc:cxnChg>
        <pc:cxnChg chg="mod">
          <ac:chgData name="Paolo Paganetti" userId="dcd282f25ae9c4f2" providerId="LiveId" clId="{C997E11D-29CD-4387-AD28-D8541B11CB53}" dt="2025-03-19T10:16:38.564" v="1301" actId="1037"/>
          <ac:cxnSpMkLst>
            <pc:docMk/>
            <pc:sldMk cId="3754364032" sldId="1613"/>
            <ac:cxnSpMk id="37" creationId="{08698898-CDC5-6BC8-2C4F-73FF9221BB82}"/>
          </ac:cxnSpMkLst>
        </pc:cxnChg>
        <pc:cxnChg chg="mod topLvl">
          <ac:chgData name="Paolo Paganetti" userId="dcd282f25ae9c4f2" providerId="LiveId" clId="{C997E11D-29CD-4387-AD28-D8541B11CB53}" dt="2025-03-24T08:26:03.013" v="4372" actId="165"/>
          <ac:cxnSpMkLst>
            <pc:docMk/>
            <pc:sldMk cId="3754364032" sldId="1613"/>
            <ac:cxnSpMk id="45" creationId="{CC19713C-8143-8A9E-C47F-D26B09ACB81E}"/>
          </ac:cxnSpMkLst>
        </pc:cxnChg>
        <pc:cxnChg chg="del mod">
          <ac:chgData name="Paolo Paganetti" userId="dcd282f25ae9c4f2" providerId="LiveId" clId="{C997E11D-29CD-4387-AD28-D8541B11CB53}" dt="2025-03-23T12:27:51.442" v="2945" actId="478"/>
          <ac:cxnSpMkLst>
            <pc:docMk/>
            <pc:sldMk cId="3754364032" sldId="1613"/>
            <ac:cxnSpMk id="46" creationId="{8FB455C6-EA84-2F99-145B-B5F859BA36C5}"/>
          </ac:cxnSpMkLst>
        </pc:cxnChg>
        <pc:cxnChg chg="mod">
          <ac:chgData name="Paolo Paganetti" userId="dcd282f25ae9c4f2" providerId="LiveId" clId="{C997E11D-29CD-4387-AD28-D8541B11CB53}" dt="2025-03-19T10:24:03.918" v="1423" actId="14100"/>
          <ac:cxnSpMkLst>
            <pc:docMk/>
            <pc:sldMk cId="3754364032" sldId="1613"/>
            <ac:cxnSpMk id="47" creationId="{C1AE5DB4-444E-74CE-64B5-E20A2E804D61}"/>
          </ac:cxnSpMkLst>
        </pc:cxnChg>
        <pc:cxnChg chg="add mod">
          <ac:chgData name="Paolo Paganetti" userId="dcd282f25ae9c4f2" providerId="LiveId" clId="{C997E11D-29CD-4387-AD28-D8541B11CB53}" dt="2025-03-19T10:30:06.787" v="1472" actId="571"/>
          <ac:cxnSpMkLst>
            <pc:docMk/>
            <pc:sldMk cId="3754364032" sldId="1613"/>
            <ac:cxnSpMk id="60" creationId="{55FCFA0D-56D5-10B2-3105-65A13F2352AE}"/>
          </ac:cxnSpMkLst>
        </pc:cxnChg>
        <pc:cxnChg chg="add mod">
          <ac:chgData name="Paolo Paganetti" userId="dcd282f25ae9c4f2" providerId="LiveId" clId="{C997E11D-29CD-4387-AD28-D8541B11CB53}" dt="2025-03-19T10:30:06.787" v="1472" actId="571"/>
          <ac:cxnSpMkLst>
            <pc:docMk/>
            <pc:sldMk cId="3754364032" sldId="1613"/>
            <ac:cxnSpMk id="61" creationId="{96CF5374-B840-BA33-6E5C-F46D2C61BA0D}"/>
          </ac:cxnSpMkLst>
        </pc:cxnChg>
        <pc:cxnChg chg="add mod">
          <ac:chgData name="Paolo Paganetti" userId="dcd282f25ae9c4f2" providerId="LiveId" clId="{C997E11D-29CD-4387-AD28-D8541B11CB53}" dt="2025-03-19T10:30:11.699" v="1473" actId="571"/>
          <ac:cxnSpMkLst>
            <pc:docMk/>
            <pc:sldMk cId="3754364032" sldId="1613"/>
            <ac:cxnSpMk id="64" creationId="{5699411A-9844-166B-4297-9230B6735A2B}"/>
          </ac:cxnSpMkLst>
        </pc:cxnChg>
        <pc:cxnChg chg="add mod">
          <ac:chgData name="Paolo Paganetti" userId="dcd282f25ae9c4f2" providerId="LiveId" clId="{C997E11D-29CD-4387-AD28-D8541B11CB53}" dt="2025-03-19T10:30:11.699" v="1473" actId="571"/>
          <ac:cxnSpMkLst>
            <pc:docMk/>
            <pc:sldMk cId="3754364032" sldId="1613"/>
            <ac:cxnSpMk id="65" creationId="{E37D9E0D-98CF-BCCD-005F-A856FB359DC5}"/>
          </ac:cxnSpMkLst>
        </pc:cxnChg>
        <pc:cxnChg chg="add mod">
          <ac:chgData name="Paolo Paganetti" userId="dcd282f25ae9c4f2" providerId="LiveId" clId="{C997E11D-29CD-4387-AD28-D8541B11CB53}" dt="2025-03-23T12:19:27.414" v="2767" actId="571"/>
          <ac:cxnSpMkLst>
            <pc:docMk/>
            <pc:sldMk cId="3754364032" sldId="1613"/>
            <ac:cxnSpMk id="100" creationId="{22AE6469-2407-E00D-528F-384301D7499C}"/>
          </ac:cxnSpMkLst>
        </pc:cxnChg>
        <pc:cxnChg chg="add mod">
          <ac:chgData name="Paolo Paganetti" userId="dcd282f25ae9c4f2" providerId="LiveId" clId="{C997E11D-29CD-4387-AD28-D8541B11CB53}" dt="2025-03-23T12:19:27.414" v="2767" actId="571"/>
          <ac:cxnSpMkLst>
            <pc:docMk/>
            <pc:sldMk cId="3754364032" sldId="1613"/>
            <ac:cxnSpMk id="101" creationId="{DCEC958C-F09A-EEED-0964-4066D3D205AB}"/>
          </ac:cxnSpMkLst>
        </pc:cxnChg>
        <pc:cxnChg chg="add mod">
          <ac:chgData name="Paolo Paganetti" userId="dcd282f25ae9c4f2" providerId="LiveId" clId="{C997E11D-29CD-4387-AD28-D8541B11CB53}" dt="2025-03-24T08:26:16.174" v="4374" actId="164"/>
          <ac:cxnSpMkLst>
            <pc:docMk/>
            <pc:sldMk cId="3754364032" sldId="1613"/>
            <ac:cxnSpMk id="118" creationId="{E81B6C09-E4A7-C53D-C4DA-144AE21D6933}"/>
          </ac:cxnSpMkLst>
        </pc:cxnChg>
        <pc:cxnChg chg="add mod">
          <ac:chgData name="Paolo Paganetti" userId="dcd282f25ae9c4f2" providerId="LiveId" clId="{C997E11D-29CD-4387-AD28-D8541B11CB53}" dt="2025-03-24T08:26:16.174" v="4374" actId="164"/>
          <ac:cxnSpMkLst>
            <pc:docMk/>
            <pc:sldMk cId="3754364032" sldId="1613"/>
            <ac:cxnSpMk id="119" creationId="{0F505525-B3E4-F12B-0A65-9791A070BF78}"/>
          </ac:cxnSpMkLst>
        </pc:cxnChg>
        <pc:cxnChg chg="add mod">
          <ac:chgData name="Paolo Paganetti" userId="dcd282f25ae9c4f2" providerId="LiveId" clId="{C997E11D-29CD-4387-AD28-D8541B11CB53}" dt="2025-03-23T12:26:12.608" v="2932" actId="571"/>
          <ac:cxnSpMkLst>
            <pc:docMk/>
            <pc:sldMk cId="3754364032" sldId="1613"/>
            <ac:cxnSpMk id="122" creationId="{AB5E78B8-8C38-6C40-05ED-BECDFFEE900E}"/>
          </ac:cxnSpMkLst>
        </pc:cxnChg>
        <pc:cxnChg chg="add mod">
          <ac:chgData name="Paolo Paganetti" userId="dcd282f25ae9c4f2" providerId="LiveId" clId="{C997E11D-29CD-4387-AD28-D8541B11CB53}" dt="2025-03-23T12:26:12.608" v="2932" actId="571"/>
          <ac:cxnSpMkLst>
            <pc:docMk/>
            <pc:sldMk cId="3754364032" sldId="1613"/>
            <ac:cxnSpMk id="123" creationId="{353FF96E-2F85-1233-0B37-D21694905C3D}"/>
          </ac:cxnSpMkLst>
        </pc:cxnChg>
        <pc:cxnChg chg="add mod">
          <ac:chgData name="Paolo Paganetti" userId="dcd282f25ae9c4f2" providerId="LiveId" clId="{C997E11D-29CD-4387-AD28-D8541B11CB53}" dt="2025-03-24T08:26:08.535" v="4373" actId="164"/>
          <ac:cxnSpMkLst>
            <pc:docMk/>
            <pc:sldMk cId="3754364032" sldId="1613"/>
            <ac:cxnSpMk id="126" creationId="{91F25A22-943A-A9EE-54B9-46E8CF2F22D6}"/>
          </ac:cxnSpMkLst>
        </pc:cxnChg>
        <pc:cxnChg chg="add mod">
          <ac:chgData name="Paolo Paganetti" userId="dcd282f25ae9c4f2" providerId="LiveId" clId="{C997E11D-29CD-4387-AD28-D8541B11CB53}" dt="2025-03-24T08:26:08.535" v="4373" actId="164"/>
          <ac:cxnSpMkLst>
            <pc:docMk/>
            <pc:sldMk cId="3754364032" sldId="1613"/>
            <ac:cxnSpMk id="127" creationId="{BEB01DE3-F25C-8879-D22C-6F7C377A7EEF}"/>
          </ac:cxnSpMkLst>
        </pc:cxnChg>
        <pc:cxnChg chg="add mod topLvl">
          <ac:chgData name="Paolo Paganetti" userId="dcd282f25ae9c4f2" providerId="LiveId" clId="{C997E11D-29CD-4387-AD28-D8541B11CB53}" dt="2025-03-24T08:26:03.013" v="4372" actId="165"/>
          <ac:cxnSpMkLst>
            <pc:docMk/>
            <pc:sldMk cId="3754364032" sldId="1613"/>
            <ac:cxnSpMk id="133" creationId="{4EA08565-8C75-5370-0D66-B61C30EC2ACC}"/>
          </ac:cxnSpMkLst>
        </pc:cxnChg>
      </pc:sldChg>
      <pc:sldChg chg="addSp delSp modSp add mod">
        <pc:chgData name="Paolo Paganetti" userId="dcd282f25ae9c4f2" providerId="LiveId" clId="{C997E11D-29CD-4387-AD28-D8541B11CB53}" dt="2025-03-24T10:56:13.155" v="4510" actId="164"/>
        <pc:sldMkLst>
          <pc:docMk/>
          <pc:sldMk cId="268756059" sldId="1614"/>
        </pc:sldMkLst>
        <pc:spChg chg="mod">
          <ac:chgData name="Paolo Paganetti" userId="dcd282f25ae9c4f2" providerId="LiveId" clId="{C997E11D-29CD-4387-AD28-D8541B11CB53}" dt="2025-03-24T10:56:07.416" v="4509" actId="14100"/>
          <ac:spMkLst>
            <pc:docMk/>
            <pc:sldMk cId="268756059" sldId="1614"/>
            <ac:spMk id="2" creationId="{8EC5820E-1C87-E3FC-2700-36897150D3A3}"/>
          </ac:spMkLst>
        </pc:spChg>
        <pc:spChg chg="add mod">
          <ac:chgData name="Paolo Paganetti" userId="dcd282f25ae9c4f2" providerId="LiveId" clId="{C997E11D-29CD-4387-AD28-D8541B11CB53}" dt="2025-03-24T10:53:46.370" v="4483" actId="571"/>
          <ac:spMkLst>
            <pc:docMk/>
            <pc:sldMk cId="268756059" sldId="1614"/>
            <ac:spMk id="13" creationId="{317FE207-B5DD-FD2F-059D-364952F99405}"/>
          </ac:spMkLst>
        </pc:spChg>
        <pc:spChg chg="add mod">
          <ac:chgData name="Paolo Paganetti" userId="dcd282f25ae9c4f2" providerId="LiveId" clId="{C997E11D-29CD-4387-AD28-D8541B11CB53}" dt="2025-03-24T10:53:46.370" v="4483" actId="571"/>
          <ac:spMkLst>
            <pc:docMk/>
            <pc:sldMk cId="268756059" sldId="1614"/>
            <ac:spMk id="14" creationId="{75C7B303-5EF1-3D7F-F43A-0F4CF186E5A0}"/>
          </ac:spMkLst>
        </pc:spChg>
        <pc:spChg chg="add mod">
          <ac:chgData name="Paolo Paganetti" userId="dcd282f25ae9c4f2" providerId="LiveId" clId="{C997E11D-29CD-4387-AD28-D8541B11CB53}" dt="2025-03-24T10:53:45.955" v="4482" actId="571"/>
          <ac:spMkLst>
            <pc:docMk/>
            <pc:sldMk cId="268756059" sldId="1614"/>
            <ac:spMk id="17" creationId="{26F4DEDD-841D-40F4-3E44-18F3CB85035F}"/>
          </ac:spMkLst>
        </pc:spChg>
        <pc:spChg chg="add mod">
          <ac:chgData name="Paolo Paganetti" userId="dcd282f25ae9c4f2" providerId="LiveId" clId="{C997E11D-29CD-4387-AD28-D8541B11CB53}" dt="2025-03-24T10:53:45.955" v="4482" actId="571"/>
          <ac:spMkLst>
            <pc:docMk/>
            <pc:sldMk cId="268756059" sldId="1614"/>
            <ac:spMk id="18" creationId="{841ECE68-AE39-18F5-C70D-195A6090BE5E}"/>
          </ac:spMkLst>
        </pc:spChg>
        <pc:spChg chg="del">
          <ac:chgData name="Paolo Paganetti" userId="dcd282f25ae9c4f2" providerId="LiveId" clId="{C997E11D-29CD-4387-AD28-D8541B11CB53}" dt="2025-03-24T10:49:22.598" v="4417" actId="478"/>
          <ac:spMkLst>
            <pc:docMk/>
            <pc:sldMk cId="268756059" sldId="1614"/>
            <ac:spMk id="19" creationId="{FBCDFFB2-0293-032E-AED0-0525D4F7D2B4}"/>
          </ac:spMkLst>
        </pc:spChg>
        <pc:spChg chg="add del mod">
          <ac:chgData name="Paolo Paganetti" userId="dcd282f25ae9c4f2" providerId="LiveId" clId="{C997E11D-29CD-4387-AD28-D8541B11CB53}" dt="2025-03-24T10:54:35.888" v="4494" actId="478"/>
          <ac:spMkLst>
            <pc:docMk/>
            <pc:sldMk cId="268756059" sldId="1614"/>
            <ac:spMk id="22" creationId="{676FB305-5A4E-644C-2940-49C8686E70EB}"/>
          </ac:spMkLst>
        </pc:spChg>
        <pc:spChg chg="add mod">
          <ac:chgData name="Paolo Paganetti" userId="dcd282f25ae9c4f2" providerId="LiveId" clId="{C997E11D-29CD-4387-AD28-D8541B11CB53}" dt="2025-03-24T10:54:13.289" v="4489" actId="571"/>
          <ac:spMkLst>
            <pc:docMk/>
            <pc:sldMk cId="268756059" sldId="1614"/>
            <ac:spMk id="23" creationId="{89B841A5-42A0-B513-CE7A-B51AEF3DCD53}"/>
          </ac:spMkLst>
        </pc:spChg>
        <pc:spChg chg="add mod">
          <ac:chgData name="Paolo Paganetti" userId="dcd282f25ae9c4f2" providerId="LiveId" clId="{C997E11D-29CD-4387-AD28-D8541B11CB53}" dt="2025-03-24T10:54:27.720" v="4492" actId="1076"/>
          <ac:spMkLst>
            <pc:docMk/>
            <pc:sldMk cId="268756059" sldId="1614"/>
            <ac:spMk id="26" creationId="{8310B616-DCDF-E72F-25A0-705E387638DA}"/>
          </ac:spMkLst>
        </pc:spChg>
        <pc:spChg chg="add del mod">
          <ac:chgData name="Paolo Paganetti" userId="dcd282f25ae9c4f2" providerId="LiveId" clId="{C997E11D-29CD-4387-AD28-D8541B11CB53}" dt="2025-03-24T10:54:38.906" v="4495" actId="478"/>
          <ac:spMkLst>
            <pc:docMk/>
            <pc:sldMk cId="268756059" sldId="1614"/>
            <ac:spMk id="27" creationId="{482BAC63-0143-CF4D-7925-943696359DF4}"/>
          </ac:spMkLst>
        </pc:spChg>
        <pc:spChg chg="add mod">
          <ac:chgData name="Paolo Paganetti" userId="dcd282f25ae9c4f2" providerId="LiveId" clId="{C997E11D-29CD-4387-AD28-D8541B11CB53}" dt="2025-03-24T10:56:13.155" v="4510" actId="164"/>
          <ac:spMkLst>
            <pc:docMk/>
            <pc:sldMk cId="268756059" sldId="1614"/>
            <ac:spMk id="31" creationId="{38AA98A9-5500-226B-6312-83D31E101AF3}"/>
          </ac:spMkLst>
        </pc:spChg>
        <pc:spChg chg="add mod">
          <ac:chgData name="Paolo Paganetti" userId="dcd282f25ae9c4f2" providerId="LiveId" clId="{C997E11D-29CD-4387-AD28-D8541B11CB53}" dt="2025-03-24T10:55:15.521" v="4500" actId="571"/>
          <ac:spMkLst>
            <pc:docMk/>
            <pc:sldMk cId="268756059" sldId="1614"/>
            <ac:spMk id="32" creationId="{40341728-B712-F08C-7BD4-D3E6358A4D0C}"/>
          </ac:spMkLst>
        </pc:spChg>
        <pc:spChg chg="add mod">
          <ac:chgData name="Paolo Paganetti" userId="dcd282f25ae9c4f2" providerId="LiveId" clId="{C997E11D-29CD-4387-AD28-D8541B11CB53}" dt="2025-03-24T10:55:29.249" v="4502" actId="571"/>
          <ac:spMkLst>
            <pc:docMk/>
            <pc:sldMk cId="268756059" sldId="1614"/>
            <ac:spMk id="33" creationId="{8B2C3A02-8782-15DB-00E0-FEABA2F9BB26}"/>
          </ac:spMkLst>
        </pc:spChg>
        <pc:spChg chg="add mod">
          <ac:chgData name="Paolo Paganetti" userId="dcd282f25ae9c4f2" providerId="LiveId" clId="{C997E11D-29CD-4387-AD28-D8541B11CB53}" dt="2025-03-24T10:55:29.249" v="4502" actId="571"/>
          <ac:spMkLst>
            <pc:docMk/>
            <pc:sldMk cId="268756059" sldId="1614"/>
            <ac:spMk id="34" creationId="{848C58C4-A0E7-29FF-45F0-BEE1879E5E5D}"/>
          </ac:spMkLst>
        </pc:spChg>
        <pc:spChg chg="add mod">
          <ac:chgData name="Paolo Paganetti" userId="dcd282f25ae9c4f2" providerId="LiveId" clId="{C997E11D-29CD-4387-AD28-D8541B11CB53}" dt="2025-03-24T10:56:13.155" v="4510" actId="164"/>
          <ac:spMkLst>
            <pc:docMk/>
            <pc:sldMk cId="268756059" sldId="1614"/>
            <ac:spMk id="37" creationId="{30CB5201-37D0-7581-50FB-B83ABCAEDC78}"/>
          </ac:spMkLst>
        </pc:spChg>
        <pc:spChg chg="add mod">
          <ac:chgData name="Paolo Paganetti" userId="dcd282f25ae9c4f2" providerId="LiveId" clId="{C997E11D-29CD-4387-AD28-D8541B11CB53}" dt="2025-03-24T10:56:13.155" v="4510" actId="164"/>
          <ac:spMkLst>
            <pc:docMk/>
            <pc:sldMk cId="268756059" sldId="1614"/>
            <ac:spMk id="38" creationId="{93A9CC7B-F83D-ECEB-88DA-54890DFCB11A}"/>
          </ac:spMkLst>
        </pc:spChg>
        <pc:spChg chg="del mod topLvl">
          <ac:chgData name="Paolo Paganetti" userId="dcd282f25ae9c4f2" providerId="LiveId" clId="{C997E11D-29CD-4387-AD28-D8541B11CB53}" dt="2025-03-24T10:49:22.598" v="4417" actId="478"/>
          <ac:spMkLst>
            <pc:docMk/>
            <pc:sldMk cId="268756059" sldId="1614"/>
            <ac:spMk id="41" creationId="{618C21D6-4C00-6211-CED2-4E028B9DAA3D}"/>
          </ac:spMkLst>
        </pc:spChg>
        <pc:spChg chg="del mod topLvl">
          <ac:chgData name="Paolo Paganetti" userId="dcd282f25ae9c4f2" providerId="LiveId" clId="{C997E11D-29CD-4387-AD28-D8541B11CB53}" dt="2025-03-24T10:49:22.598" v="4417" actId="478"/>
          <ac:spMkLst>
            <pc:docMk/>
            <pc:sldMk cId="268756059" sldId="1614"/>
            <ac:spMk id="54" creationId="{11F61B75-E779-EB5A-EC6E-B4733ED2CDEF}"/>
          </ac:spMkLst>
        </pc:spChg>
        <pc:spChg chg="del mod topLvl">
          <ac:chgData name="Paolo Paganetti" userId="dcd282f25ae9c4f2" providerId="LiveId" clId="{C997E11D-29CD-4387-AD28-D8541B11CB53}" dt="2025-03-24T10:49:22.598" v="4417" actId="478"/>
          <ac:spMkLst>
            <pc:docMk/>
            <pc:sldMk cId="268756059" sldId="1614"/>
            <ac:spMk id="66" creationId="{60185B59-9FD1-9A4D-5E45-8730EB2C0389}"/>
          </ac:spMkLst>
        </pc:spChg>
        <pc:spChg chg="del">
          <ac:chgData name="Paolo Paganetti" userId="dcd282f25ae9c4f2" providerId="LiveId" clId="{C997E11D-29CD-4387-AD28-D8541B11CB53}" dt="2025-03-24T10:49:22.598" v="4417" actId="478"/>
          <ac:spMkLst>
            <pc:docMk/>
            <pc:sldMk cId="268756059" sldId="1614"/>
            <ac:spMk id="71" creationId="{2A1E9B39-F0C3-D7A0-E5DA-061922FF010B}"/>
          </ac:spMkLst>
        </pc:spChg>
        <pc:spChg chg="del mod topLvl">
          <ac:chgData name="Paolo Paganetti" userId="dcd282f25ae9c4f2" providerId="LiveId" clId="{C997E11D-29CD-4387-AD28-D8541B11CB53}" dt="2025-03-24T10:49:22.598" v="4417" actId="478"/>
          <ac:spMkLst>
            <pc:docMk/>
            <pc:sldMk cId="268756059" sldId="1614"/>
            <ac:spMk id="73" creationId="{67ECBE56-CF39-5F6E-22BA-ADF2CB8BAFB1}"/>
          </ac:spMkLst>
        </pc:spChg>
        <pc:spChg chg="del mod topLvl">
          <ac:chgData name="Paolo Paganetti" userId="dcd282f25ae9c4f2" providerId="LiveId" clId="{C997E11D-29CD-4387-AD28-D8541B11CB53}" dt="2025-03-24T10:49:22.598" v="4417" actId="478"/>
          <ac:spMkLst>
            <pc:docMk/>
            <pc:sldMk cId="268756059" sldId="1614"/>
            <ac:spMk id="75" creationId="{8E8510C3-6ECB-0808-0ED9-846A4F92248D}"/>
          </ac:spMkLst>
        </pc:spChg>
        <pc:spChg chg="del">
          <ac:chgData name="Paolo Paganetti" userId="dcd282f25ae9c4f2" providerId="LiveId" clId="{C997E11D-29CD-4387-AD28-D8541B11CB53}" dt="2025-03-24T10:49:22.598" v="4417" actId="478"/>
          <ac:spMkLst>
            <pc:docMk/>
            <pc:sldMk cId="268756059" sldId="1614"/>
            <ac:spMk id="82" creationId="{6EF778BE-9761-B002-EE75-E91F1C98BDD6}"/>
          </ac:spMkLst>
        </pc:spChg>
        <pc:spChg chg="del mod topLvl">
          <ac:chgData name="Paolo Paganetti" userId="dcd282f25ae9c4f2" providerId="LiveId" clId="{C997E11D-29CD-4387-AD28-D8541B11CB53}" dt="2025-03-24T10:49:22.598" v="4417" actId="478"/>
          <ac:spMkLst>
            <pc:docMk/>
            <pc:sldMk cId="268756059" sldId="1614"/>
            <ac:spMk id="99" creationId="{A9611DD1-CF49-60F0-509F-F61BE31632E8}"/>
          </ac:spMkLst>
        </pc:spChg>
        <pc:spChg chg="del mod topLvl">
          <ac:chgData name="Paolo Paganetti" userId="dcd282f25ae9c4f2" providerId="LiveId" clId="{C997E11D-29CD-4387-AD28-D8541B11CB53}" dt="2025-03-24T10:49:22.598" v="4417" actId="478"/>
          <ac:spMkLst>
            <pc:docMk/>
            <pc:sldMk cId="268756059" sldId="1614"/>
            <ac:spMk id="100" creationId="{DDF491AC-E380-5803-21FF-5B0B7B5BEE47}"/>
          </ac:spMkLst>
        </pc:spChg>
        <pc:spChg chg="mod">
          <ac:chgData name="Paolo Paganetti" userId="dcd282f25ae9c4f2" providerId="LiveId" clId="{C997E11D-29CD-4387-AD28-D8541B11CB53}" dt="2025-03-24T10:55:51.186" v="4505" actId="1076"/>
          <ac:spMkLst>
            <pc:docMk/>
            <pc:sldMk cId="268756059" sldId="1614"/>
            <ac:spMk id="114" creationId="{E2085215-BBD0-6F1E-A416-6CC14AC6BA7F}"/>
          </ac:spMkLst>
        </pc:spChg>
        <pc:spChg chg="mod">
          <ac:chgData name="Paolo Paganetti" userId="dcd282f25ae9c4f2" providerId="LiveId" clId="{C997E11D-29CD-4387-AD28-D8541B11CB53}" dt="2025-03-24T10:52:54.611" v="4472" actId="207"/>
          <ac:spMkLst>
            <pc:docMk/>
            <pc:sldMk cId="268756059" sldId="1614"/>
            <ac:spMk id="117" creationId="{1BD0F171-B765-EBA2-9916-F54C5F9234E3}"/>
          </ac:spMkLst>
        </pc:spChg>
        <pc:spChg chg="mod topLvl">
          <ac:chgData name="Paolo Paganetti" userId="dcd282f25ae9c4f2" providerId="LiveId" clId="{C997E11D-29CD-4387-AD28-D8541B11CB53}" dt="2025-03-24T10:56:13.155" v="4510" actId="164"/>
          <ac:spMkLst>
            <pc:docMk/>
            <pc:sldMk cId="268756059" sldId="1614"/>
            <ac:spMk id="118" creationId="{DE69D8F1-5DFC-A94D-0704-17EE03AD35B7}"/>
          </ac:spMkLst>
        </pc:spChg>
        <pc:spChg chg="mod">
          <ac:chgData name="Paolo Paganetti" userId="dcd282f25ae9c4f2" providerId="LiveId" clId="{C997E11D-29CD-4387-AD28-D8541B11CB53}" dt="2025-03-24T10:56:13.155" v="4510" actId="164"/>
          <ac:spMkLst>
            <pc:docMk/>
            <pc:sldMk cId="268756059" sldId="1614"/>
            <ac:spMk id="119" creationId="{571B809F-9F7B-7370-8550-C3E00CA8F5AD}"/>
          </ac:spMkLst>
        </pc:spChg>
        <pc:spChg chg="mod">
          <ac:chgData name="Paolo Paganetti" userId="dcd282f25ae9c4f2" providerId="LiveId" clId="{C997E11D-29CD-4387-AD28-D8541B11CB53}" dt="2025-03-24T10:56:13.155" v="4510" actId="164"/>
          <ac:spMkLst>
            <pc:docMk/>
            <pc:sldMk cId="268756059" sldId="1614"/>
            <ac:spMk id="120" creationId="{28204C09-36C9-E806-2652-3D56DC8C473B}"/>
          </ac:spMkLst>
        </pc:spChg>
        <pc:spChg chg="mod topLvl">
          <ac:chgData name="Paolo Paganetti" userId="dcd282f25ae9c4f2" providerId="LiveId" clId="{C997E11D-29CD-4387-AD28-D8541B11CB53}" dt="2025-03-24T10:56:13.155" v="4510" actId="164"/>
          <ac:spMkLst>
            <pc:docMk/>
            <pc:sldMk cId="268756059" sldId="1614"/>
            <ac:spMk id="121" creationId="{1CBDFD1B-B316-7799-34E8-2EFBBF4CF38C}"/>
          </ac:spMkLst>
        </pc:spChg>
        <pc:spChg chg="mod">
          <ac:chgData name="Paolo Paganetti" userId="dcd282f25ae9c4f2" providerId="LiveId" clId="{C997E11D-29CD-4387-AD28-D8541B11CB53}" dt="2025-03-24T10:52:30.594" v="4457" actId="1076"/>
          <ac:spMkLst>
            <pc:docMk/>
            <pc:sldMk cId="268756059" sldId="1614"/>
            <ac:spMk id="122" creationId="{14584946-19A1-B517-B98A-908E865290A2}"/>
          </ac:spMkLst>
        </pc:spChg>
        <pc:spChg chg="mod">
          <ac:chgData name="Paolo Paganetti" userId="dcd282f25ae9c4f2" providerId="LiveId" clId="{C997E11D-29CD-4387-AD28-D8541B11CB53}" dt="2025-03-24T10:52:30.594" v="4457" actId="1076"/>
          <ac:spMkLst>
            <pc:docMk/>
            <pc:sldMk cId="268756059" sldId="1614"/>
            <ac:spMk id="124" creationId="{7FE1ED2C-9A79-9688-7E02-9D7DDA85D524}"/>
          </ac:spMkLst>
        </pc:spChg>
        <pc:spChg chg="mod">
          <ac:chgData name="Paolo Paganetti" userId="dcd282f25ae9c4f2" providerId="LiveId" clId="{C997E11D-29CD-4387-AD28-D8541B11CB53}" dt="2025-03-24T10:56:13.155" v="4510" actId="164"/>
          <ac:spMkLst>
            <pc:docMk/>
            <pc:sldMk cId="268756059" sldId="1614"/>
            <ac:spMk id="125" creationId="{E3152C71-7FDA-D09E-0FDB-189E3BB1D6F0}"/>
          </ac:spMkLst>
        </pc:spChg>
        <pc:spChg chg="mod">
          <ac:chgData name="Paolo Paganetti" userId="dcd282f25ae9c4f2" providerId="LiveId" clId="{C997E11D-29CD-4387-AD28-D8541B11CB53}" dt="2025-03-24T10:55:24.320" v="4501" actId="1076"/>
          <ac:spMkLst>
            <pc:docMk/>
            <pc:sldMk cId="268756059" sldId="1614"/>
            <ac:spMk id="126" creationId="{3CB0C265-9912-AFAE-47A7-6D8BCA1BE367}"/>
          </ac:spMkLst>
        </pc:spChg>
        <pc:spChg chg="mod">
          <ac:chgData name="Paolo Paganetti" userId="dcd282f25ae9c4f2" providerId="LiveId" clId="{C997E11D-29CD-4387-AD28-D8541B11CB53}" dt="2025-03-24T10:56:13.155" v="4510" actId="164"/>
          <ac:spMkLst>
            <pc:docMk/>
            <pc:sldMk cId="268756059" sldId="1614"/>
            <ac:spMk id="127" creationId="{561B7977-D644-EBD8-0710-D2456C9D2991}"/>
          </ac:spMkLst>
        </pc:spChg>
        <pc:spChg chg="mod">
          <ac:chgData name="Paolo Paganetti" userId="dcd282f25ae9c4f2" providerId="LiveId" clId="{C997E11D-29CD-4387-AD28-D8541B11CB53}" dt="2025-03-24T10:52:30.594" v="4457" actId="1076"/>
          <ac:spMkLst>
            <pc:docMk/>
            <pc:sldMk cId="268756059" sldId="1614"/>
            <ac:spMk id="130" creationId="{4737961F-99CD-7479-85BB-E42125339ACC}"/>
          </ac:spMkLst>
        </pc:spChg>
        <pc:spChg chg="mod">
          <ac:chgData name="Paolo Paganetti" userId="dcd282f25ae9c4f2" providerId="LiveId" clId="{C997E11D-29CD-4387-AD28-D8541B11CB53}" dt="2025-03-24T10:52:30.594" v="4457" actId="1076"/>
          <ac:spMkLst>
            <pc:docMk/>
            <pc:sldMk cId="268756059" sldId="1614"/>
            <ac:spMk id="131" creationId="{F5CAF3D8-E2ED-5C53-BB31-FB8822553669}"/>
          </ac:spMkLst>
        </pc:spChg>
        <pc:spChg chg="mod topLvl">
          <ac:chgData name="Paolo Paganetti" userId="dcd282f25ae9c4f2" providerId="LiveId" clId="{C997E11D-29CD-4387-AD28-D8541B11CB53}" dt="2025-03-24T10:56:13.155" v="4510" actId="164"/>
          <ac:spMkLst>
            <pc:docMk/>
            <pc:sldMk cId="268756059" sldId="1614"/>
            <ac:spMk id="132" creationId="{37609028-30D7-0BD4-4003-9A5E838B27B1}"/>
          </ac:spMkLst>
        </pc:spChg>
        <pc:grpChg chg="add mod ord">
          <ac:chgData name="Paolo Paganetti" userId="dcd282f25ae9c4f2" providerId="LiveId" clId="{C997E11D-29CD-4387-AD28-D8541B11CB53}" dt="2025-03-24T10:54:55.243" v="4498" actId="166"/>
          <ac:grpSpMkLst>
            <pc:docMk/>
            <pc:sldMk cId="268756059" sldId="1614"/>
            <ac:grpSpMk id="30" creationId="{3A0BC728-DF76-3188-769C-45037B88E660}"/>
          </ac:grpSpMkLst>
        </pc:grpChg>
        <pc:picChg chg="add mod modCrop">
          <ac:chgData name="Paolo Paganetti" userId="dcd282f25ae9c4f2" providerId="LiveId" clId="{C997E11D-29CD-4387-AD28-D8541B11CB53}" dt="2025-03-24T10:54:27.720" v="4492" actId="1076"/>
          <ac:picMkLst>
            <pc:docMk/>
            <pc:sldMk cId="268756059" sldId="1614"/>
            <ac:picMk id="5" creationId="{D1AB23DF-0AC7-BF84-73F4-9A1A098D0752}"/>
          </ac:picMkLst>
        </pc:picChg>
        <pc:picChg chg="add del mod modCrop">
          <ac:chgData name="Paolo Paganetti" userId="dcd282f25ae9c4f2" providerId="LiveId" clId="{C997E11D-29CD-4387-AD28-D8541B11CB53}" dt="2025-03-24T10:53:59.426" v="4487" actId="1076"/>
          <ac:picMkLst>
            <pc:docMk/>
            <pc:sldMk cId="268756059" sldId="1614"/>
            <ac:picMk id="7" creationId="{565F856D-1D83-D0BB-73DE-51F20D17ECF4}"/>
          </ac:picMkLst>
        </pc:picChg>
        <pc:picChg chg="add mod modCrop">
          <ac:chgData name="Paolo Paganetti" userId="dcd282f25ae9c4f2" providerId="LiveId" clId="{C997E11D-29CD-4387-AD28-D8541B11CB53}" dt="2025-03-24T10:53:28.646" v="4479" actId="1076"/>
          <ac:picMkLst>
            <pc:docMk/>
            <pc:sldMk cId="268756059" sldId="1614"/>
            <ac:picMk id="12" creationId="{1C814ADD-0549-730B-96E8-B877E5CE5D05}"/>
          </ac:picMkLst>
        </pc:picChg>
        <pc:picChg chg="del mod">
          <ac:chgData name="Paolo Paganetti" userId="dcd282f25ae9c4f2" providerId="LiveId" clId="{C997E11D-29CD-4387-AD28-D8541B11CB53}" dt="2025-03-24T10:53:54.904" v="4486" actId="478"/>
          <ac:picMkLst>
            <pc:docMk/>
            <pc:sldMk cId="268756059" sldId="1614"/>
            <ac:picMk id="116" creationId="{DE0379B5-54E7-FB78-1D18-2C3DF7BC0F70}"/>
          </ac:picMkLst>
        </pc:picChg>
        <pc:cxnChg chg="add mod">
          <ac:chgData name="Paolo Paganetti" userId="dcd282f25ae9c4f2" providerId="LiveId" clId="{C997E11D-29CD-4387-AD28-D8541B11CB53}" dt="2025-03-24T10:53:46.370" v="4483" actId="571"/>
          <ac:cxnSpMkLst>
            <pc:docMk/>
            <pc:sldMk cId="268756059" sldId="1614"/>
            <ac:cxnSpMk id="15" creationId="{A7A40BAC-4384-49C6-30B2-287BCE006CB6}"/>
          </ac:cxnSpMkLst>
        </pc:cxnChg>
        <pc:cxnChg chg="add mod">
          <ac:chgData name="Paolo Paganetti" userId="dcd282f25ae9c4f2" providerId="LiveId" clId="{C997E11D-29CD-4387-AD28-D8541B11CB53}" dt="2025-03-24T10:53:46.370" v="4483" actId="571"/>
          <ac:cxnSpMkLst>
            <pc:docMk/>
            <pc:sldMk cId="268756059" sldId="1614"/>
            <ac:cxnSpMk id="16" creationId="{23C09198-C9BC-8F55-E3D0-C3129A52A8D2}"/>
          </ac:cxnSpMkLst>
        </pc:cxnChg>
        <pc:cxnChg chg="add mod">
          <ac:chgData name="Paolo Paganetti" userId="dcd282f25ae9c4f2" providerId="LiveId" clId="{C997E11D-29CD-4387-AD28-D8541B11CB53}" dt="2025-03-24T10:53:45.955" v="4482" actId="571"/>
          <ac:cxnSpMkLst>
            <pc:docMk/>
            <pc:sldMk cId="268756059" sldId="1614"/>
            <ac:cxnSpMk id="20" creationId="{5C232887-322D-6E5C-EC11-811E9FE024B4}"/>
          </ac:cxnSpMkLst>
        </pc:cxnChg>
        <pc:cxnChg chg="add mod">
          <ac:chgData name="Paolo Paganetti" userId="dcd282f25ae9c4f2" providerId="LiveId" clId="{C997E11D-29CD-4387-AD28-D8541B11CB53}" dt="2025-03-24T10:53:45.955" v="4482" actId="571"/>
          <ac:cxnSpMkLst>
            <pc:docMk/>
            <pc:sldMk cId="268756059" sldId="1614"/>
            <ac:cxnSpMk id="21" creationId="{71603BAF-F92C-9EBB-83D5-1FAC2694B6F3}"/>
          </ac:cxnSpMkLst>
        </pc:cxnChg>
        <pc:cxnChg chg="add mod">
          <ac:chgData name="Paolo Paganetti" userId="dcd282f25ae9c4f2" providerId="LiveId" clId="{C997E11D-29CD-4387-AD28-D8541B11CB53}" dt="2025-03-24T10:54:13.289" v="4489" actId="571"/>
          <ac:cxnSpMkLst>
            <pc:docMk/>
            <pc:sldMk cId="268756059" sldId="1614"/>
            <ac:cxnSpMk id="24" creationId="{F10A4F6B-CED7-DA41-14BF-0BE95918FF3D}"/>
          </ac:cxnSpMkLst>
        </pc:cxnChg>
        <pc:cxnChg chg="add del mod">
          <ac:chgData name="Paolo Paganetti" userId="dcd282f25ae9c4f2" providerId="LiveId" clId="{C997E11D-29CD-4387-AD28-D8541B11CB53}" dt="2025-03-24T10:54:35.888" v="4494" actId="478"/>
          <ac:cxnSpMkLst>
            <pc:docMk/>
            <pc:sldMk cId="268756059" sldId="1614"/>
            <ac:cxnSpMk id="25" creationId="{59450922-EC66-81BF-7E41-05D0AE1F4A9D}"/>
          </ac:cxnSpMkLst>
        </pc:cxnChg>
        <pc:cxnChg chg="add del mod">
          <ac:chgData name="Paolo Paganetti" userId="dcd282f25ae9c4f2" providerId="LiveId" clId="{C997E11D-29CD-4387-AD28-D8541B11CB53}" dt="2025-03-24T10:54:38.906" v="4495" actId="478"/>
          <ac:cxnSpMkLst>
            <pc:docMk/>
            <pc:sldMk cId="268756059" sldId="1614"/>
            <ac:cxnSpMk id="28" creationId="{545FEE50-778E-E7CC-1707-ABE07EA522FE}"/>
          </ac:cxnSpMkLst>
        </pc:cxnChg>
        <pc:cxnChg chg="add mod">
          <ac:chgData name="Paolo Paganetti" userId="dcd282f25ae9c4f2" providerId="LiveId" clId="{C997E11D-29CD-4387-AD28-D8541B11CB53}" dt="2025-03-24T10:54:27.720" v="4492" actId="1076"/>
          <ac:cxnSpMkLst>
            <pc:docMk/>
            <pc:sldMk cId="268756059" sldId="1614"/>
            <ac:cxnSpMk id="29" creationId="{6954CEE9-FCE9-C268-6B79-35221482D12D}"/>
          </ac:cxnSpMkLst>
        </pc:cxnChg>
        <pc:cxnChg chg="add mod">
          <ac:chgData name="Paolo Paganetti" userId="dcd282f25ae9c4f2" providerId="LiveId" clId="{C997E11D-29CD-4387-AD28-D8541B11CB53}" dt="2025-03-24T10:55:29.249" v="4502" actId="571"/>
          <ac:cxnSpMkLst>
            <pc:docMk/>
            <pc:sldMk cId="268756059" sldId="1614"/>
            <ac:cxnSpMk id="35" creationId="{42D869C1-4FA1-7225-CAA7-D7E2B9A7D7E9}"/>
          </ac:cxnSpMkLst>
        </pc:cxnChg>
        <pc:cxnChg chg="add mod">
          <ac:chgData name="Paolo Paganetti" userId="dcd282f25ae9c4f2" providerId="LiveId" clId="{C997E11D-29CD-4387-AD28-D8541B11CB53}" dt="2025-03-24T10:55:29.249" v="4502" actId="571"/>
          <ac:cxnSpMkLst>
            <pc:docMk/>
            <pc:sldMk cId="268756059" sldId="1614"/>
            <ac:cxnSpMk id="36" creationId="{CE2A1005-C8A8-D78B-1CBF-01092D5B66A4}"/>
          </ac:cxnSpMkLst>
        </pc:cxnChg>
        <pc:cxnChg chg="add mod">
          <ac:chgData name="Paolo Paganetti" userId="dcd282f25ae9c4f2" providerId="LiveId" clId="{C997E11D-29CD-4387-AD28-D8541B11CB53}" dt="2025-03-24T10:55:35.225" v="4503" actId="571"/>
          <ac:cxnSpMkLst>
            <pc:docMk/>
            <pc:sldMk cId="268756059" sldId="1614"/>
            <ac:cxnSpMk id="39" creationId="{0487D47E-0AE0-3E53-81B9-6FDF31D43C84}"/>
          </ac:cxnSpMkLst>
        </pc:cxnChg>
        <pc:cxnChg chg="add mod">
          <ac:chgData name="Paolo Paganetti" userId="dcd282f25ae9c4f2" providerId="LiveId" clId="{C997E11D-29CD-4387-AD28-D8541B11CB53}" dt="2025-03-24T10:55:35.225" v="4503" actId="571"/>
          <ac:cxnSpMkLst>
            <pc:docMk/>
            <pc:sldMk cId="268756059" sldId="1614"/>
            <ac:cxnSpMk id="40" creationId="{D83CC40D-375D-3BD5-CB2E-2CE1DC89C87D}"/>
          </ac:cxnSpMkLst>
        </pc:cxnChg>
        <pc:cxnChg chg="mod">
          <ac:chgData name="Paolo Paganetti" userId="dcd282f25ae9c4f2" providerId="LiveId" clId="{C997E11D-29CD-4387-AD28-D8541B11CB53}" dt="2025-03-24T10:55:24.320" v="4501" actId="1076"/>
          <ac:cxnSpMkLst>
            <pc:docMk/>
            <pc:sldMk cId="268756059" sldId="1614"/>
            <ac:cxnSpMk id="128" creationId="{9C930390-E047-8808-2A1A-929A99A5F4F9}"/>
          </ac:cxnSpMkLst>
        </pc:cxnChg>
        <pc:cxnChg chg="mod">
          <ac:chgData name="Paolo Paganetti" userId="dcd282f25ae9c4f2" providerId="LiveId" clId="{C997E11D-29CD-4387-AD28-D8541B11CB53}" dt="2025-03-24T10:55:24.320" v="4501" actId="1076"/>
          <ac:cxnSpMkLst>
            <pc:docMk/>
            <pc:sldMk cId="268756059" sldId="1614"/>
            <ac:cxnSpMk id="129" creationId="{E112B3BC-BF15-0682-44C2-4EC472330CA2}"/>
          </ac:cxnSpMkLst>
        </pc:cxnChg>
        <pc:cxnChg chg="mod">
          <ac:chgData name="Paolo Paganetti" userId="dcd282f25ae9c4f2" providerId="LiveId" clId="{C997E11D-29CD-4387-AD28-D8541B11CB53}" dt="2025-03-24T10:52:37.197" v="4470" actId="1037"/>
          <ac:cxnSpMkLst>
            <pc:docMk/>
            <pc:sldMk cId="268756059" sldId="1614"/>
            <ac:cxnSpMk id="133" creationId="{4189911E-CA7C-23E7-C05D-9EADEFD8D351}"/>
          </ac:cxnSpMkLst>
        </pc:cxnChg>
        <pc:cxnChg chg="mod">
          <ac:chgData name="Paolo Paganetti" userId="dcd282f25ae9c4f2" providerId="LiveId" clId="{C997E11D-29CD-4387-AD28-D8541B11CB53}" dt="2025-03-24T10:54:45.002" v="4496" actId="164"/>
          <ac:cxnSpMkLst>
            <pc:docMk/>
            <pc:sldMk cId="268756059" sldId="1614"/>
            <ac:cxnSpMk id="134" creationId="{698E3490-6BB6-4FAB-4FD0-584596F1CF84}"/>
          </ac:cxnSpMkLst>
        </pc:cxnChg>
        <pc:cxnChg chg="mod">
          <ac:chgData name="Paolo Paganetti" userId="dcd282f25ae9c4f2" providerId="LiveId" clId="{C997E11D-29CD-4387-AD28-D8541B11CB53}" dt="2025-03-24T10:54:45.002" v="4496" actId="164"/>
          <ac:cxnSpMkLst>
            <pc:docMk/>
            <pc:sldMk cId="268756059" sldId="1614"/>
            <ac:cxnSpMk id="135" creationId="{B3D5907A-AC7A-38B2-031C-FCB3EF907380}"/>
          </ac:cxnSpMkLst>
        </pc:cxnChg>
        <pc:cxnChg chg="mod">
          <ac:chgData name="Paolo Paganetti" userId="dcd282f25ae9c4f2" providerId="LiveId" clId="{C997E11D-29CD-4387-AD28-D8541B11CB53}" dt="2025-03-24T10:52:37.197" v="4470" actId="1037"/>
          <ac:cxnSpMkLst>
            <pc:docMk/>
            <pc:sldMk cId="268756059" sldId="1614"/>
            <ac:cxnSpMk id="136" creationId="{49915D19-7A48-E442-E2C4-D656E51CD1CE}"/>
          </ac:cxnSpMkLst>
        </pc:cxnChg>
      </pc:sldChg>
      <pc:sldChg chg="addSp delSp modSp add del mod ord">
        <pc:chgData name="Paolo Paganetti" userId="dcd282f25ae9c4f2" providerId="LiveId" clId="{C997E11D-29CD-4387-AD28-D8541B11CB53}" dt="2025-03-23T14:22:23.678" v="4309" actId="47"/>
        <pc:sldMkLst>
          <pc:docMk/>
          <pc:sldMk cId="286307492" sldId="1614"/>
        </pc:sldMkLst>
        <pc:spChg chg="add mod topLvl">
          <ac:chgData name="Paolo Paganetti" userId="dcd282f25ae9c4f2" providerId="LiveId" clId="{C997E11D-29CD-4387-AD28-D8541B11CB53}" dt="2025-03-23T11:44:43.185" v="2319" actId="164"/>
          <ac:spMkLst>
            <pc:docMk/>
            <pc:sldMk cId="286307492" sldId="1614"/>
            <ac:spMk id="58" creationId="{A42AABAB-F5A4-8AD8-5CE3-E94332E88BFA}"/>
          </ac:spMkLst>
        </pc:spChg>
        <pc:spChg chg="add mod topLvl">
          <ac:chgData name="Paolo Paganetti" userId="dcd282f25ae9c4f2" providerId="LiveId" clId="{C997E11D-29CD-4387-AD28-D8541B11CB53}" dt="2025-03-23T11:44:43.185" v="2319" actId="164"/>
          <ac:spMkLst>
            <pc:docMk/>
            <pc:sldMk cId="286307492" sldId="1614"/>
            <ac:spMk id="59" creationId="{AE2C5AE6-1598-0CC8-9A74-015B1414D1D6}"/>
          </ac:spMkLst>
        </pc:spChg>
        <pc:spChg chg="add mod topLvl">
          <ac:chgData name="Paolo Paganetti" userId="dcd282f25ae9c4f2" providerId="LiveId" clId="{C997E11D-29CD-4387-AD28-D8541B11CB53}" dt="2025-03-23T11:44:43.185" v="2319" actId="164"/>
          <ac:spMkLst>
            <pc:docMk/>
            <pc:sldMk cId="286307492" sldId="1614"/>
            <ac:spMk id="62" creationId="{E4A834A3-A014-C52C-9CB9-72E3ED89EC6F}"/>
          </ac:spMkLst>
        </pc:spChg>
        <pc:spChg chg="add mod topLvl">
          <ac:chgData name="Paolo Paganetti" userId="dcd282f25ae9c4f2" providerId="LiveId" clId="{C997E11D-29CD-4387-AD28-D8541B11CB53}" dt="2025-03-23T11:44:43.185" v="2319" actId="164"/>
          <ac:spMkLst>
            <pc:docMk/>
            <pc:sldMk cId="286307492" sldId="1614"/>
            <ac:spMk id="63" creationId="{0C411589-FB29-2B61-762C-068C36354F39}"/>
          </ac:spMkLst>
        </pc:spChg>
        <pc:spChg chg="add mod topLvl">
          <ac:chgData name="Paolo Paganetti" userId="dcd282f25ae9c4f2" providerId="LiveId" clId="{C997E11D-29CD-4387-AD28-D8541B11CB53}" dt="2025-03-23T11:44:43.185" v="2319" actId="164"/>
          <ac:spMkLst>
            <pc:docMk/>
            <pc:sldMk cId="286307492" sldId="1614"/>
            <ac:spMk id="64" creationId="{8373FD26-8A78-B6E2-B88F-E657AA6010AB}"/>
          </ac:spMkLst>
        </pc:spChg>
        <pc:spChg chg="add mod topLvl">
          <ac:chgData name="Paolo Paganetti" userId="dcd282f25ae9c4f2" providerId="LiveId" clId="{C997E11D-29CD-4387-AD28-D8541B11CB53}" dt="2025-03-23T11:44:43.185" v="2319" actId="164"/>
          <ac:spMkLst>
            <pc:docMk/>
            <pc:sldMk cId="286307492" sldId="1614"/>
            <ac:spMk id="65" creationId="{3D8115C1-7345-2281-EE8C-5E6C04DD0C5D}"/>
          </ac:spMkLst>
        </pc:spChg>
        <pc:spChg chg="add mod topLvl">
          <ac:chgData name="Paolo Paganetti" userId="dcd282f25ae9c4f2" providerId="LiveId" clId="{C997E11D-29CD-4387-AD28-D8541B11CB53}" dt="2025-03-23T11:44:43.185" v="2319" actId="164"/>
          <ac:spMkLst>
            <pc:docMk/>
            <pc:sldMk cId="286307492" sldId="1614"/>
            <ac:spMk id="66" creationId="{E377DD7C-D8B0-1B8E-D841-6CB0B0C57290}"/>
          </ac:spMkLst>
        </pc:spChg>
        <pc:spChg chg="mod topLvl">
          <ac:chgData name="Paolo Paganetti" userId="dcd282f25ae9c4f2" providerId="LiveId" clId="{C997E11D-29CD-4387-AD28-D8541B11CB53}" dt="2025-03-23T11:44:43.185" v="2319" actId="164"/>
          <ac:spMkLst>
            <pc:docMk/>
            <pc:sldMk cId="286307492" sldId="1614"/>
            <ac:spMk id="68" creationId="{4DAC7966-6C6C-CF06-E0E6-67EA521B609B}"/>
          </ac:spMkLst>
        </pc:spChg>
        <pc:spChg chg="add mod topLvl">
          <ac:chgData name="Paolo Paganetti" userId="dcd282f25ae9c4f2" providerId="LiveId" clId="{C997E11D-29CD-4387-AD28-D8541B11CB53}" dt="2025-03-23T11:44:43.185" v="2319" actId="164"/>
          <ac:spMkLst>
            <pc:docMk/>
            <pc:sldMk cId="286307492" sldId="1614"/>
            <ac:spMk id="73" creationId="{377DF664-6840-38AA-7707-E582DBDA9840}"/>
          </ac:spMkLst>
        </pc:spChg>
        <pc:spChg chg="add mod topLvl">
          <ac:chgData name="Paolo Paganetti" userId="dcd282f25ae9c4f2" providerId="LiveId" clId="{C997E11D-29CD-4387-AD28-D8541B11CB53}" dt="2025-03-23T11:44:43.185" v="2319" actId="164"/>
          <ac:spMkLst>
            <pc:docMk/>
            <pc:sldMk cId="286307492" sldId="1614"/>
            <ac:spMk id="74" creationId="{22386577-9F95-31B1-B2D2-DCA9DA596712}"/>
          </ac:spMkLst>
        </pc:spChg>
        <pc:grpChg chg="mod">
          <ac:chgData name="Paolo Paganetti" userId="dcd282f25ae9c4f2" providerId="LiveId" clId="{C997E11D-29CD-4387-AD28-D8541B11CB53}" dt="2025-03-23T11:42:23.403" v="2312" actId="1076"/>
          <ac:grpSpMkLst>
            <pc:docMk/>
            <pc:sldMk cId="286307492" sldId="1614"/>
            <ac:grpSpMk id="82" creationId="{CA231238-B8AF-E11B-B0BF-1867F3320A37}"/>
          </ac:grpSpMkLst>
        </pc:grpChg>
        <pc:picChg chg="add del mod">
          <ac:chgData name="Paolo Paganetti" userId="dcd282f25ae9c4f2" providerId="LiveId" clId="{C997E11D-29CD-4387-AD28-D8541B11CB53}" dt="2025-03-23T11:47:27.945" v="2332" actId="478"/>
          <ac:picMkLst>
            <pc:docMk/>
            <pc:sldMk cId="286307492" sldId="1614"/>
            <ac:picMk id="3" creationId="{B491D3FA-A341-61FD-B89C-FB389136D819}"/>
          </ac:picMkLst>
        </pc:picChg>
        <pc:picChg chg="add del mod">
          <ac:chgData name="Paolo Paganetti" userId="dcd282f25ae9c4f2" providerId="LiveId" clId="{C997E11D-29CD-4387-AD28-D8541B11CB53}" dt="2025-03-23T11:47:27.945" v="2332" actId="478"/>
          <ac:picMkLst>
            <pc:docMk/>
            <pc:sldMk cId="286307492" sldId="1614"/>
            <ac:picMk id="4" creationId="{C78F9E26-C757-6CF5-AE67-443E7ED26379}"/>
          </ac:picMkLst>
        </pc:picChg>
        <pc:picChg chg="add del mod">
          <ac:chgData name="Paolo Paganetti" userId="dcd282f25ae9c4f2" providerId="LiveId" clId="{C997E11D-29CD-4387-AD28-D8541B11CB53}" dt="2025-03-23T11:47:27.945" v="2332" actId="478"/>
          <ac:picMkLst>
            <pc:docMk/>
            <pc:sldMk cId="286307492" sldId="1614"/>
            <ac:picMk id="5" creationId="{9C2EFF55-130D-3AC5-2201-25BB0A73DB56}"/>
          </ac:picMkLst>
        </pc:picChg>
        <pc:picChg chg="add del mod">
          <ac:chgData name="Paolo Paganetti" userId="dcd282f25ae9c4f2" providerId="LiveId" clId="{C997E11D-29CD-4387-AD28-D8541B11CB53}" dt="2025-03-23T13:15:18.952" v="3588" actId="478"/>
          <ac:picMkLst>
            <pc:docMk/>
            <pc:sldMk cId="286307492" sldId="1614"/>
            <ac:picMk id="7" creationId="{7744AA9A-7931-A69A-86BE-349450880A1E}"/>
          </ac:picMkLst>
        </pc:picChg>
        <pc:cxnChg chg="add mod">
          <ac:chgData name="Paolo Paganetti" userId="dcd282f25ae9c4f2" providerId="LiveId" clId="{C997E11D-29CD-4387-AD28-D8541B11CB53}" dt="2025-03-23T11:42:44.306" v="2314" actId="208"/>
          <ac:cxnSpMkLst>
            <pc:docMk/>
            <pc:sldMk cId="286307492" sldId="1614"/>
            <ac:cxnSpMk id="76" creationId="{A41CB5F0-F055-ED0D-4EAF-0316FA8905E2}"/>
          </ac:cxnSpMkLst>
        </pc:cxnChg>
        <pc:cxnChg chg="add mod">
          <ac:chgData name="Paolo Paganetti" userId="dcd282f25ae9c4f2" providerId="LiveId" clId="{C997E11D-29CD-4387-AD28-D8541B11CB53}" dt="2025-03-23T11:42:51.466" v="2315" actId="208"/>
          <ac:cxnSpMkLst>
            <pc:docMk/>
            <pc:sldMk cId="286307492" sldId="1614"/>
            <ac:cxnSpMk id="79" creationId="{4489D93C-9552-30B0-D42C-D204D0254B9C}"/>
          </ac:cxnSpMkLst>
        </pc:cxnChg>
      </pc:sldChg>
      <pc:sldChg chg="del">
        <pc:chgData name="Paolo Paganetti" userId="dcd282f25ae9c4f2" providerId="LiveId" clId="{C997E11D-29CD-4387-AD28-D8541B11CB53}" dt="2025-03-19T08:50:13.164" v="13" actId="47"/>
        <pc:sldMkLst>
          <pc:docMk/>
          <pc:sldMk cId="3703832189" sldId="1615"/>
        </pc:sldMkLst>
      </pc:sldChg>
      <pc:sldChg chg="addSp delSp modSp new del mod">
        <pc:chgData name="Paolo Paganetti" userId="dcd282f25ae9c4f2" providerId="LiveId" clId="{C997E11D-29CD-4387-AD28-D8541B11CB53}" dt="2025-03-23T12:29:15.631" v="2949" actId="47"/>
        <pc:sldMkLst>
          <pc:docMk/>
          <pc:sldMk cId="3766322260" sldId="1615"/>
        </pc:sldMkLst>
        <pc:spChg chg="del">
          <ac:chgData name="Paolo Paganetti" userId="dcd282f25ae9c4f2" providerId="LiveId" clId="{C997E11D-29CD-4387-AD28-D8541B11CB53}" dt="2025-03-23T09:58:05.139" v="2188" actId="478"/>
          <ac:spMkLst>
            <pc:docMk/>
            <pc:sldMk cId="3766322260" sldId="1615"/>
            <ac:spMk id="2" creationId="{DBCC8F0E-C575-C382-C9F2-0AE62FD02DD4}"/>
          </ac:spMkLst>
        </pc:spChg>
        <pc:spChg chg="del">
          <ac:chgData name="Paolo Paganetti" userId="dcd282f25ae9c4f2" providerId="LiveId" clId="{C997E11D-29CD-4387-AD28-D8541B11CB53}" dt="2025-03-23T09:58:05.139" v="2188" actId="478"/>
          <ac:spMkLst>
            <pc:docMk/>
            <pc:sldMk cId="3766322260" sldId="1615"/>
            <ac:spMk id="3" creationId="{986E14C1-6C30-9175-D5B3-FEA7AA32E66D}"/>
          </ac:spMkLst>
        </pc:spChg>
        <pc:picChg chg="del mod">
          <ac:chgData name="Paolo Paganetti" userId="dcd282f25ae9c4f2" providerId="LiveId" clId="{C997E11D-29CD-4387-AD28-D8541B11CB53}" dt="2025-03-23T12:28:35.848" v="2948" actId="478"/>
          <ac:picMkLst>
            <pc:docMk/>
            <pc:sldMk cId="3766322260" sldId="1615"/>
            <ac:picMk id="5" creationId="{8F3EFA4E-BB0C-1123-6633-84FBD3A5BA02}"/>
          </ac:picMkLst>
        </pc:picChg>
        <pc:picChg chg="add del mod">
          <ac:chgData name="Paolo Paganetti" userId="dcd282f25ae9c4f2" providerId="LiveId" clId="{C997E11D-29CD-4387-AD28-D8541B11CB53}" dt="2025-03-23T12:28:35.848" v="2948" actId="478"/>
          <ac:picMkLst>
            <pc:docMk/>
            <pc:sldMk cId="3766322260" sldId="1615"/>
            <ac:picMk id="7" creationId="{40E566F6-3123-5D5D-ACF6-964F1925F493}"/>
          </ac:picMkLst>
        </pc:picChg>
        <pc:picChg chg="add del mod">
          <ac:chgData name="Paolo Paganetti" userId="dcd282f25ae9c4f2" providerId="LiveId" clId="{C997E11D-29CD-4387-AD28-D8541B11CB53}" dt="2025-03-23T11:55:26.921" v="2381" actId="478"/>
          <ac:picMkLst>
            <pc:docMk/>
            <pc:sldMk cId="3766322260" sldId="1615"/>
            <ac:picMk id="9" creationId="{FF639028-B56C-9868-B9F0-0243D0F05DF5}"/>
          </ac:picMkLst>
        </pc:picChg>
        <pc:picChg chg="add del mod">
          <ac:chgData name="Paolo Paganetti" userId="dcd282f25ae9c4f2" providerId="LiveId" clId="{C997E11D-29CD-4387-AD28-D8541B11CB53}" dt="2025-03-23T11:55:26.921" v="2381" actId="478"/>
          <ac:picMkLst>
            <pc:docMk/>
            <pc:sldMk cId="3766322260" sldId="1615"/>
            <ac:picMk id="11" creationId="{D20C9C1D-F3B2-BC62-D775-0856C0ADA60E}"/>
          </ac:picMkLst>
        </pc:picChg>
        <pc:picChg chg="add del mod">
          <ac:chgData name="Paolo Paganetti" userId="dcd282f25ae9c4f2" providerId="LiveId" clId="{C997E11D-29CD-4387-AD28-D8541B11CB53}" dt="2025-03-23T11:55:26.921" v="2381" actId="478"/>
          <ac:picMkLst>
            <pc:docMk/>
            <pc:sldMk cId="3766322260" sldId="1615"/>
            <ac:picMk id="13" creationId="{3823B455-ACAE-EE76-56E6-7A941B8E796C}"/>
          </ac:picMkLst>
        </pc:picChg>
        <pc:picChg chg="add del mod">
          <ac:chgData name="Paolo Paganetti" userId="dcd282f25ae9c4f2" providerId="LiveId" clId="{C997E11D-29CD-4387-AD28-D8541B11CB53}" dt="2025-03-23T11:48:13.050" v="2337" actId="478"/>
          <ac:picMkLst>
            <pc:docMk/>
            <pc:sldMk cId="3766322260" sldId="1615"/>
            <ac:picMk id="15" creationId="{042D7A83-A6B0-0386-B3A2-F7BD02F5F23E}"/>
          </ac:picMkLst>
        </pc:picChg>
        <pc:picChg chg="add del mod">
          <ac:chgData name="Paolo Paganetti" userId="dcd282f25ae9c4f2" providerId="LiveId" clId="{C997E11D-29CD-4387-AD28-D8541B11CB53}" dt="2025-03-23T11:55:26.921" v="2381" actId="478"/>
          <ac:picMkLst>
            <pc:docMk/>
            <pc:sldMk cId="3766322260" sldId="1615"/>
            <ac:picMk id="17" creationId="{A240D6BE-FCF2-177E-2A40-49E2FFE98F3A}"/>
          </ac:picMkLst>
        </pc:picChg>
        <pc:picChg chg="add del mod">
          <ac:chgData name="Paolo Paganetti" userId="dcd282f25ae9c4f2" providerId="LiveId" clId="{C997E11D-29CD-4387-AD28-D8541B11CB53}" dt="2025-03-23T11:55:26.921" v="2381" actId="478"/>
          <ac:picMkLst>
            <pc:docMk/>
            <pc:sldMk cId="3766322260" sldId="1615"/>
            <ac:picMk id="19" creationId="{6F44742B-A7CB-89C8-4C4E-D351745A8306}"/>
          </ac:picMkLst>
        </pc:picChg>
        <pc:picChg chg="add del mod">
          <ac:chgData name="Paolo Paganetti" userId="dcd282f25ae9c4f2" providerId="LiveId" clId="{C997E11D-29CD-4387-AD28-D8541B11CB53}" dt="2025-03-23T11:48:13.050" v="2337" actId="478"/>
          <ac:picMkLst>
            <pc:docMk/>
            <pc:sldMk cId="3766322260" sldId="1615"/>
            <ac:picMk id="21" creationId="{AD1C1B91-8366-A0C7-CD71-F9D811962F2D}"/>
          </ac:picMkLst>
        </pc:picChg>
        <pc:picChg chg="add del mod">
          <ac:chgData name="Paolo Paganetti" userId="dcd282f25ae9c4f2" providerId="LiveId" clId="{C997E11D-29CD-4387-AD28-D8541B11CB53}" dt="2025-03-23T11:48:13.050" v="2337" actId="478"/>
          <ac:picMkLst>
            <pc:docMk/>
            <pc:sldMk cId="3766322260" sldId="1615"/>
            <ac:picMk id="23" creationId="{ECF0EF9F-C4F6-BA6F-146B-EF55B8EC141B}"/>
          </ac:picMkLst>
        </pc:picChg>
        <pc:picChg chg="add del mod">
          <ac:chgData name="Paolo Paganetti" userId="dcd282f25ae9c4f2" providerId="LiveId" clId="{C997E11D-29CD-4387-AD28-D8541B11CB53}" dt="2025-03-23T12:28:35.848" v="2948" actId="478"/>
          <ac:picMkLst>
            <pc:docMk/>
            <pc:sldMk cId="3766322260" sldId="1615"/>
            <ac:picMk id="25" creationId="{5DE6E2A5-0E56-74F6-73F3-17CC29841E7C}"/>
          </ac:picMkLst>
        </pc:picChg>
      </pc:sldChg>
      <pc:sldChg chg="del">
        <pc:chgData name="Paolo Paganetti" userId="dcd282f25ae9c4f2" providerId="LiveId" clId="{C997E11D-29CD-4387-AD28-D8541B11CB53}" dt="2025-03-19T08:50:13.937" v="14" actId="47"/>
        <pc:sldMkLst>
          <pc:docMk/>
          <pc:sldMk cId="1800640478" sldId="1616"/>
        </pc:sldMkLst>
      </pc:sldChg>
      <pc:sldChg chg="addSp delSp modSp add del mod">
        <pc:chgData name="Paolo Paganetti" userId="dcd282f25ae9c4f2" providerId="LiveId" clId="{C997E11D-29CD-4387-AD28-D8541B11CB53}" dt="2025-03-23T14:22:21.980" v="4308" actId="47"/>
        <pc:sldMkLst>
          <pc:docMk/>
          <pc:sldMk cId="1892743693" sldId="1616"/>
        </pc:sldMkLst>
        <pc:picChg chg="add del mod">
          <ac:chgData name="Paolo Paganetti" userId="dcd282f25ae9c4f2" providerId="LiveId" clId="{C997E11D-29CD-4387-AD28-D8541B11CB53}" dt="2025-03-23T12:30:42.745" v="2954" actId="21"/>
          <ac:picMkLst>
            <pc:docMk/>
            <pc:sldMk cId="1892743693" sldId="1616"/>
            <ac:picMk id="3" creationId="{985889F2-9248-26C6-4042-B38D244CCF10}"/>
          </ac:picMkLst>
        </pc:picChg>
        <pc:picChg chg="add del mod">
          <ac:chgData name="Paolo Paganetti" userId="dcd282f25ae9c4f2" providerId="LiveId" clId="{C997E11D-29CD-4387-AD28-D8541B11CB53}" dt="2025-03-23T12:30:42.745" v="2954" actId="21"/>
          <ac:picMkLst>
            <pc:docMk/>
            <pc:sldMk cId="1892743693" sldId="1616"/>
            <ac:picMk id="5" creationId="{0CD442DC-7C3C-39B2-D5F9-085B2D8FE707}"/>
          </ac:picMkLst>
        </pc:picChg>
        <pc:picChg chg="add mod">
          <ac:chgData name="Paolo Paganetti" userId="dcd282f25ae9c4f2" providerId="LiveId" clId="{C997E11D-29CD-4387-AD28-D8541B11CB53}" dt="2025-03-23T13:05:03.991" v="3546" actId="1076"/>
          <ac:picMkLst>
            <pc:docMk/>
            <pc:sldMk cId="1892743693" sldId="1616"/>
            <ac:picMk id="7" creationId="{57B8A573-B6DA-9DA9-5B41-F3CB65D05ABE}"/>
          </ac:picMkLst>
        </pc:picChg>
        <pc:picChg chg="add mod">
          <ac:chgData name="Paolo Paganetti" userId="dcd282f25ae9c4f2" providerId="LiveId" clId="{C997E11D-29CD-4387-AD28-D8541B11CB53}" dt="2025-03-23T11:51:38.049" v="2363" actId="1076"/>
          <ac:picMkLst>
            <pc:docMk/>
            <pc:sldMk cId="1892743693" sldId="1616"/>
            <ac:picMk id="9" creationId="{C5D95D26-4F9E-E441-0240-FD1411695DB9}"/>
          </ac:picMkLst>
        </pc:picChg>
        <pc:picChg chg="add del mod">
          <ac:chgData name="Paolo Paganetti" userId="dcd282f25ae9c4f2" providerId="LiveId" clId="{C997E11D-29CD-4387-AD28-D8541B11CB53}" dt="2025-03-23T12:30:42.745" v="2954" actId="21"/>
          <ac:picMkLst>
            <pc:docMk/>
            <pc:sldMk cId="1892743693" sldId="1616"/>
            <ac:picMk id="11" creationId="{6B665F3D-5697-2864-CB1D-3F40B6A239EB}"/>
          </ac:picMkLst>
        </pc:picChg>
        <pc:picChg chg="add mod">
          <ac:chgData name="Paolo Paganetti" userId="dcd282f25ae9c4f2" providerId="LiveId" clId="{C997E11D-29CD-4387-AD28-D8541B11CB53}" dt="2025-03-23T11:51:20.976" v="2358" actId="1076"/>
          <ac:picMkLst>
            <pc:docMk/>
            <pc:sldMk cId="1892743693" sldId="1616"/>
            <ac:picMk id="13" creationId="{1891732E-BD4A-6E15-3397-F6FF907A7618}"/>
          </ac:picMkLst>
        </pc:picChg>
        <pc:picChg chg="mod">
          <ac:chgData name="Paolo Paganetti" userId="dcd282f25ae9c4f2" providerId="LiveId" clId="{C997E11D-29CD-4387-AD28-D8541B11CB53}" dt="2025-03-23T11:52:15.526" v="2371" actId="1076"/>
          <ac:picMkLst>
            <pc:docMk/>
            <pc:sldMk cId="1892743693" sldId="1616"/>
            <ac:picMk id="15" creationId="{4A520C03-9F8B-0998-B18F-41EF01FA65F7}"/>
          </ac:picMkLst>
        </pc:picChg>
        <pc:picChg chg="add mod">
          <ac:chgData name="Paolo Paganetti" userId="dcd282f25ae9c4f2" providerId="LiveId" clId="{C997E11D-29CD-4387-AD28-D8541B11CB53}" dt="2025-03-23T11:51:04" v="2353" actId="1076"/>
          <ac:picMkLst>
            <pc:docMk/>
            <pc:sldMk cId="1892743693" sldId="1616"/>
            <ac:picMk id="17" creationId="{9008FA46-007F-8BB0-74E3-348DAE503173}"/>
          </ac:picMkLst>
        </pc:picChg>
        <pc:picChg chg="add mod ord">
          <ac:chgData name="Paolo Paganetti" userId="dcd282f25ae9c4f2" providerId="LiveId" clId="{C997E11D-29CD-4387-AD28-D8541B11CB53}" dt="2025-03-23T13:05:00.984" v="3545" actId="1076"/>
          <ac:picMkLst>
            <pc:docMk/>
            <pc:sldMk cId="1892743693" sldId="1616"/>
            <ac:picMk id="19" creationId="{E6D8B147-09C5-3C27-F703-BBB652A8DE18}"/>
          </ac:picMkLst>
        </pc:picChg>
        <pc:picChg chg="add mod">
          <ac:chgData name="Paolo Paganetti" userId="dcd282f25ae9c4f2" providerId="LiveId" clId="{C997E11D-29CD-4387-AD28-D8541B11CB53}" dt="2025-03-23T11:51:08.281" v="2355" actId="1076"/>
          <ac:picMkLst>
            <pc:docMk/>
            <pc:sldMk cId="1892743693" sldId="1616"/>
            <ac:picMk id="21" creationId="{E303711B-7443-0936-CF60-68B8F74763A1}"/>
          </ac:picMkLst>
        </pc:picChg>
        <pc:picChg chg="add mod">
          <ac:chgData name="Paolo Paganetti" userId="dcd282f25ae9c4f2" providerId="LiveId" clId="{C997E11D-29CD-4387-AD28-D8541B11CB53}" dt="2025-03-23T13:04:52.472" v="3544" actId="1076"/>
          <ac:picMkLst>
            <pc:docMk/>
            <pc:sldMk cId="1892743693" sldId="1616"/>
            <ac:picMk id="23" creationId="{3B7F757F-95A1-44C0-53B3-AD7355F5157A}"/>
          </ac:picMkLst>
        </pc:picChg>
        <pc:picChg chg="add del mod">
          <ac:chgData name="Paolo Paganetti" userId="dcd282f25ae9c4f2" providerId="LiveId" clId="{C997E11D-29CD-4387-AD28-D8541B11CB53}" dt="2025-03-23T12:30:26.456" v="2953" actId="478"/>
          <ac:picMkLst>
            <pc:docMk/>
            <pc:sldMk cId="1892743693" sldId="1616"/>
            <ac:picMk id="24" creationId="{B0B17779-1E50-D12B-9FB1-5F85AB75767F}"/>
          </ac:picMkLst>
        </pc:picChg>
        <pc:picChg chg="add del mod">
          <ac:chgData name="Paolo Paganetti" userId="dcd282f25ae9c4f2" providerId="LiveId" clId="{C997E11D-29CD-4387-AD28-D8541B11CB53}" dt="2025-03-23T13:06:36.451" v="3549" actId="478"/>
          <ac:picMkLst>
            <pc:docMk/>
            <pc:sldMk cId="1892743693" sldId="1616"/>
            <ac:picMk id="25" creationId="{76987677-717D-8580-6AE4-CF646A45333E}"/>
          </ac:picMkLst>
        </pc:picChg>
      </pc:sldChg>
      <pc:sldChg chg="delSp add del mod">
        <pc:chgData name="Paolo Paganetti" userId="dcd282f25ae9c4f2" providerId="LiveId" clId="{C997E11D-29CD-4387-AD28-D8541B11CB53}" dt="2025-03-23T14:22:25.418" v="4310" actId="47"/>
        <pc:sldMkLst>
          <pc:docMk/>
          <pc:sldMk cId="3846530163" sldId="1617"/>
        </pc:sldMkLst>
        <pc:picChg chg="del">
          <ac:chgData name="Paolo Paganetti" userId="dcd282f25ae9c4f2" providerId="LiveId" clId="{C997E11D-29CD-4387-AD28-D8541B11CB53}" dt="2025-03-23T13:04:29.565" v="3540" actId="21"/>
          <ac:picMkLst>
            <pc:docMk/>
            <pc:sldMk cId="3846530163" sldId="1617"/>
            <ac:picMk id="15" creationId="{042D7A83-A6B0-0386-B3A2-F7BD02F5F23E}"/>
          </ac:picMkLst>
        </pc:picChg>
        <pc:picChg chg="del">
          <ac:chgData name="Paolo Paganetti" userId="dcd282f25ae9c4f2" providerId="LiveId" clId="{C997E11D-29CD-4387-AD28-D8541B11CB53}" dt="2025-03-23T13:04:29.565" v="3540" actId="21"/>
          <ac:picMkLst>
            <pc:docMk/>
            <pc:sldMk cId="3846530163" sldId="1617"/>
            <ac:picMk id="21" creationId="{AD1C1B91-8366-A0C7-CD71-F9D811962F2D}"/>
          </ac:picMkLst>
        </pc:picChg>
        <pc:picChg chg="del">
          <ac:chgData name="Paolo Paganetti" userId="dcd282f25ae9c4f2" providerId="LiveId" clId="{C997E11D-29CD-4387-AD28-D8541B11CB53}" dt="2025-03-23T13:04:29.565" v="3540" actId="21"/>
          <ac:picMkLst>
            <pc:docMk/>
            <pc:sldMk cId="3846530163" sldId="1617"/>
            <ac:picMk id="23" creationId="{ECF0EF9F-C4F6-BA6F-146B-EF55B8EC141B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FDF978-D19F-4A5A-8679-2E0618E9280D}" type="datetimeFigureOut">
              <a:rPr lang="en-US" smtClean="0"/>
              <a:t>3/24/25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496D66-D293-40EB-89C6-C0CE420BBB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1949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C496D66-D293-40EB-89C6-C0CE420BBBF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8675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EC51782-45D3-EB0B-F52B-836457596AC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>
            <a:extLst>
              <a:ext uri="{FF2B5EF4-FFF2-40B4-BE49-F238E27FC236}">
                <a16:creationId xmlns:a16="http://schemas.microsoft.com/office/drawing/2014/main" id="{87111363-7120-A08C-0B17-CF5D270603CD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>
            <a:extLst>
              <a:ext uri="{FF2B5EF4-FFF2-40B4-BE49-F238E27FC236}">
                <a16:creationId xmlns:a16="http://schemas.microsoft.com/office/drawing/2014/main" id="{5DA38BC5-7C18-8503-2CC4-287C3E74752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C1B12AD-785B-5397-ACB4-373901B20B7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C496D66-D293-40EB-89C6-C0CE420BBBF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30904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D9BD1F1-4484-F1C8-9E9F-ACC242165B6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>
            <a:extLst>
              <a:ext uri="{FF2B5EF4-FFF2-40B4-BE49-F238E27FC236}">
                <a16:creationId xmlns:a16="http://schemas.microsoft.com/office/drawing/2014/main" id="{E4CED198-4ABD-DDEB-CC65-A017181ABC5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>
            <a:extLst>
              <a:ext uri="{FF2B5EF4-FFF2-40B4-BE49-F238E27FC236}">
                <a16:creationId xmlns:a16="http://schemas.microsoft.com/office/drawing/2014/main" id="{D6A2899E-AC04-CBEC-A0CD-2B9B8C048BE8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8D29A0A-3373-3C0B-05B9-A6B0101EFBC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C496D66-D293-40EB-89C6-C0CE420BBBF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39574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C496D66-D293-40EB-89C6-C0CE420BBBF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5638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it-CH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  <a:endParaRPr lang="it-CH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50E19-37E9-40A8-A781-FC337CC9E37A}" type="datetimeFigureOut">
              <a:rPr lang="it-CH" smtClean="0"/>
              <a:t>24.03.25</a:t>
            </a:fld>
            <a:endParaRPr lang="it-CH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CH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62C2-09A1-4DFD-A333-CC8A0E06C6D7}" type="slidenum">
              <a:rPr lang="it-CH" smtClean="0"/>
              <a:t>‹#›</a:t>
            </a:fld>
            <a:endParaRPr lang="it-CH"/>
          </a:p>
        </p:txBody>
      </p:sp>
    </p:spTree>
    <p:extLst>
      <p:ext uri="{BB962C8B-B14F-4D97-AF65-F5344CB8AC3E}">
        <p14:creationId xmlns:p14="http://schemas.microsoft.com/office/powerpoint/2010/main" val="16571300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it-CH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it-CH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50E19-37E9-40A8-A781-FC337CC9E37A}" type="datetimeFigureOut">
              <a:rPr lang="it-CH" smtClean="0"/>
              <a:t>24.03.25</a:t>
            </a:fld>
            <a:endParaRPr lang="it-CH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CH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62C2-09A1-4DFD-A333-CC8A0E06C6D7}" type="slidenum">
              <a:rPr lang="it-CH" smtClean="0"/>
              <a:t>‹#›</a:t>
            </a:fld>
            <a:endParaRPr lang="it-CH"/>
          </a:p>
        </p:txBody>
      </p:sp>
    </p:spTree>
    <p:extLst>
      <p:ext uri="{BB962C8B-B14F-4D97-AF65-F5344CB8AC3E}">
        <p14:creationId xmlns:p14="http://schemas.microsoft.com/office/powerpoint/2010/main" val="1191377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it-CH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it-CH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50E19-37E9-40A8-A781-FC337CC9E37A}" type="datetimeFigureOut">
              <a:rPr lang="it-CH" smtClean="0"/>
              <a:t>24.03.25</a:t>
            </a:fld>
            <a:endParaRPr lang="it-CH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CH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62C2-09A1-4DFD-A333-CC8A0E06C6D7}" type="slidenum">
              <a:rPr lang="it-CH" smtClean="0"/>
              <a:t>‹#›</a:t>
            </a:fld>
            <a:endParaRPr lang="it-CH"/>
          </a:p>
        </p:txBody>
      </p:sp>
    </p:spTree>
    <p:extLst>
      <p:ext uri="{BB962C8B-B14F-4D97-AF65-F5344CB8AC3E}">
        <p14:creationId xmlns:p14="http://schemas.microsoft.com/office/powerpoint/2010/main" val="408354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it-CH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it-CH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50E19-37E9-40A8-A781-FC337CC9E37A}" type="datetimeFigureOut">
              <a:rPr lang="it-CH" smtClean="0"/>
              <a:t>24.03.25</a:t>
            </a:fld>
            <a:endParaRPr lang="it-CH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CH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62C2-09A1-4DFD-A333-CC8A0E06C6D7}" type="slidenum">
              <a:rPr lang="it-CH" smtClean="0"/>
              <a:t>‹#›</a:t>
            </a:fld>
            <a:endParaRPr lang="it-CH"/>
          </a:p>
        </p:txBody>
      </p:sp>
    </p:spTree>
    <p:extLst>
      <p:ext uri="{BB962C8B-B14F-4D97-AF65-F5344CB8AC3E}">
        <p14:creationId xmlns:p14="http://schemas.microsoft.com/office/powerpoint/2010/main" val="3900767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  <a:endParaRPr lang="it-CH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50E19-37E9-40A8-A781-FC337CC9E37A}" type="datetimeFigureOut">
              <a:rPr lang="it-CH" smtClean="0"/>
              <a:t>24.03.25</a:t>
            </a:fld>
            <a:endParaRPr lang="it-CH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CH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62C2-09A1-4DFD-A333-CC8A0E06C6D7}" type="slidenum">
              <a:rPr lang="it-CH" smtClean="0"/>
              <a:t>‹#›</a:t>
            </a:fld>
            <a:endParaRPr lang="it-CH"/>
          </a:p>
        </p:txBody>
      </p:sp>
    </p:spTree>
    <p:extLst>
      <p:ext uri="{BB962C8B-B14F-4D97-AF65-F5344CB8AC3E}">
        <p14:creationId xmlns:p14="http://schemas.microsoft.com/office/powerpoint/2010/main" val="53898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it-CH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it-CH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it-CH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50E19-37E9-40A8-A781-FC337CC9E37A}" type="datetimeFigureOut">
              <a:rPr lang="it-CH" smtClean="0"/>
              <a:t>24.03.25</a:t>
            </a:fld>
            <a:endParaRPr lang="it-CH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CH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62C2-09A1-4DFD-A333-CC8A0E06C6D7}" type="slidenum">
              <a:rPr lang="it-CH" smtClean="0"/>
              <a:t>‹#›</a:t>
            </a:fld>
            <a:endParaRPr lang="it-CH"/>
          </a:p>
        </p:txBody>
      </p:sp>
    </p:spTree>
    <p:extLst>
      <p:ext uri="{BB962C8B-B14F-4D97-AF65-F5344CB8AC3E}">
        <p14:creationId xmlns:p14="http://schemas.microsoft.com/office/powerpoint/2010/main" val="537479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  <a:endParaRPr lang="it-CH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it-CH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it-CH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50E19-37E9-40A8-A781-FC337CC9E37A}" type="datetimeFigureOut">
              <a:rPr lang="it-CH" smtClean="0"/>
              <a:t>24.03.25</a:t>
            </a:fld>
            <a:endParaRPr lang="it-CH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CH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62C2-09A1-4DFD-A333-CC8A0E06C6D7}" type="slidenum">
              <a:rPr lang="it-CH" smtClean="0"/>
              <a:t>‹#›</a:t>
            </a:fld>
            <a:endParaRPr lang="it-CH"/>
          </a:p>
        </p:txBody>
      </p:sp>
    </p:spTree>
    <p:extLst>
      <p:ext uri="{BB962C8B-B14F-4D97-AF65-F5344CB8AC3E}">
        <p14:creationId xmlns:p14="http://schemas.microsoft.com/office/powerpoint/2010/main" val="26011976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it-CH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50E19-37E9-40A8-A781-FC337CC9E37A}" type="datetimeFigureOut">
              <a:rPr lang="it-CH" smtClean="0"/>
              <a:t>24.03.25</a:t>
            </a:fld>
            <a:endParaRPr lang="it-CH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CH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62C2-09A1-4DFD-A333-CC8A0E06C6D7}" type="slidenum">
              <a:rPr lang="it-CH" smtClean="0"/>
              <a:t>‹#›</a:t>
            </a:fld>
            <a:endParaRPr lang="it-CH"/>
          </a:p>
        </p:txBody>
      </p:sp>
    </p:spTree>
    <p:extLst>
      <p:ext uri="{BB962C8B-B14F-4D97-AF65-F5344CB8AC3E}">
        <p14:creationId xmlns:p14="http://schemas.microsoft.com/office/powerpoint/2010/main" val="2175159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50E19-37E9-40A8-A781-FC337CC9E37A}" type="datetimeFigureOut">
              <a:rPr lang="it-CH" smtClean="0"/>
              <a:t>24.03.25</a:t>
            </a:fld>
            <a:endParaRPr lang="it-CH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CH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62C2-09A1-4DFD-A333-CC8A0E06C6D7}" type="slidenum">
              <a:rPr lang="it-CH" smtClean="0"/>
              <a:t>‹#›</a:t>
            </a:fld>
            <a:endParaRPr lang="it-CH"/>
          </a:p>
        </p:txBody>
      </p:sp>
    </p:spTree>
    <p:extLst>
      <p:ext uri="{BB962C8B-B14F-4D97-AF65-F5344CB8AC3E}">
        <p14:creationId xmlns:p14="http://schemas.microsoft.com/office/powerpoint/2010/main" val="4053725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it-CH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it-CH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50E19-37E9-40A8-A781-FC337CC9E37A}" type="datetimeFigureOut">
              <a:rPr lang="it-CH" smtClean="0"/>
              <a:t>24.03.25</a:t>
            </a:fld>
            <a:endParaRPr lang="it-CH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CH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62C2-09A1-4DFD-A333-CC8A0E06C6D7}" type="slidenum">
              <a:rPr lang="it-CH" smtClean="0"/>
              <a:t>‹#›</a:t>
            </a:fld>
            <a:endParaRPr lang="it-CH"/>
          </a:p>
        </p:txBody>
      </p:sp>
    </p:spTree>
    <p:extLst>
      <p:ext uri="{BB962C8B-B14F-4D97-AF65-F5344CB8AC3E}">
        <p14:creationId xmlns:p14="http://schemas.microsoft.com/office/powerpoint/2010/main" val="3257238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it-CH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CH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50E19-37E9-40A8-A781-FC337CC9E37A}" type="datetimeFigureOut">
              <a:rPr lang="it-CH" smtClean="0"/>
              <a:t>24.03.25</a:t>
            </a:fld>
            <a:endParaRPr lang="it-CH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CH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62C2-09A1-4DFD-A333-CC8A0E06C6D7}" type="slidenum">
              <a:rPr lang="it-CH" smtClean="0"/>
              <a:t>‹#›</a:t>
            </a:fld>
            <a:endParaRPr lang="it-CH"/>
          </a:p>
        </p:txBody>
      </p:sp>
    </p:spTree>
    <p:extLst>
      <p:ext uri="{BB962C8B-B14F-4D97-AF65-F5344CB8AC3E}">
        <p14:creationId xmlns:p14="http://schemas.microsoft.com/office/powerpoint/2010/main" val="6669641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it-CH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it-CH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50E19-37E9-40A8-A781-FC337CC9E37A}" type="datetimeFigureOut">
              <a:rPr lang="it-CH" smtClean="0"/>
              <a:t>24.03.25</a:t>
            </a:fld>
            <a:endParaRPr lang="it-CH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CH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1762C2-09A1-4DFD-A333-CC8A0E06C6D7}" type="slidenum">
              <a:rPr lang="it-CH" smtClean="0"/>
              <a:t>‹#›</a:t>
            </a:fld>
            <a:endParaRPr lang="it-CH"/>
          </a:p>
        </p:txBody>
      </p:sp>
    </p:spTree>
    <p:extLst>
      <p:ext uri="{BB962C8B-B14F-4D97-AF65-F5344CB8AC3E}">
        <p14:creationId xmlns:p14="http://schemas.microsoft.com/office/powerpoint/2010/main" val="1711741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C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>
            <a:extLst>
              <a:ext uri="{FF2B5EF4-FFF2-40B4-BE49-F238E27FC236}">
                <a16:creationId xmlns:a16="http://schemas.microsoft.com/office/drawing/2014/main" id="{A8A62E67-031B-94F8-C1FD-6F652E620364}"/>
              </a:ext>
            </a:extLst>
          </p:cNvPr>
          <p:cNvGrpSpPr/>
          <p:nvPr/>
        </p:nvGrpSpPr>
        <p:grpSpPr>
          <a:xfrm>
            <a:off x="511337" y="1399918"/>
            <a:ext cx="8408827" cy="3603583"/>
            <a:chOff x="-702321" y="1521838"/>
            <a:chExt cx="8408827" cy="3603583"/>
          </a:xfrm>
        </p:grpSpPr>
        <p:sp>
          <p:nvSpPr>
            <p:cNvPr id="2" name="Rettangolo 1">
              <a:extLst>
                <a:ext uri="{FF2B5EF4-FFF2-40B4-BE49-F238E27FC236}">
                  <a16:creationId xmlns:a16="http://schemas.microsoft.com/office/drawing/2014/main" id="{EDD94D72-ACF3-F0CC-79B9-BD4407B177ED}"/>
                </a:ext>
              </a:extLst>
            </p:cNvPr>
            <p:cNvSpPr/>
            <p:nvPr/>
          </p:nvSpPr>
          <p:spPr>
            <a:xfrm>
              <a:off x="-659456" y="1521838"/>
              <a:ext cx="8296081" cy="36035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CH"/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D1E241AE-349F-FCCE-34DF-04DA796A9DAF}"/>
                </a:ext>
              </a:extLst>
            </p:cNvPr>
            <p:cNvSpPr txBox="1"/>
            <p:nvPr/>
          </p:nvSpPr>
          <p:spPr>
            <a:xfrm>
              <a:off x="-669591" y="1521838"/>
              <a:ext cx="98706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600" b="1" dirty="0"/>
                <a:t>Figure 3A</a:t>
              </a:r>
              <a:endParaRPr lang="en-US" sz="1600" b="1" dirty="0"/>
            </a:p>
          </p:txBody>
        </p:sp>
        <p:sp>
          <p:nvSpPr>
            <p:cNvPr id="67" name="CasellaDiTesto 40">
              <a:extLst>
                <a:ext uri="{FF2B5EF4-FFF2-40B4-BE49-F238E27FC236}">
                  <a16:creationId xmlns:a16="http://schemas.microsoft.com/office/drawing/2014/main" id="{8968D980-42A3-9809-79A8-D75EFC395954}"/>
                </a:ext>
              </a:extLst>
            </p:cNvPr>
            <p:cNvSpPr txBox="1"/>
            <p:nvPr/>
          </p:nvSpPr>
          <p:spPr>
            <a:xfrm>
              <a:off x="1827165" y="3745950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solidFill>
                    <a:srgbClr val="FF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actin</a:t>
              </a:r>
            </a:p>
          </p:txBody>
        </p:sp>
        <p:sp>
          <p:nvSpPr>
            <p:cNvPr id="68" name="CasellaDiTesto 39">
              <a:extLst>
                <a:ext uri="{FF2B5EF4-FFF2-40B4-BE49-F238E27FC236}">
                  <a16:creationId xmlns:a16="http://schemas.microsoft.com/office/drawing/2014/main" id="{CC26C7B0-8B49-9F72-2ED8-CD115AB8B63D}"/>
                </a:ext>
              </a:extLst>
            </p:cNvPr>
            <p:cNvSpPr txBox="1"/>
            <p:nvPr/>
          </p:nvSpPr>
          <p:spPr>
            <a:xfrm>
              <a:off x="1863920" y="3155804"/>
              <a:ext cx="3802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solidFill>
                    <a:srgbClr val="FF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au</a:t>
              </a:r>
            </a:p>
          </p:txBody>
        </p:sp>
        <p:sp>
          <p:nvSpPr>
            <p:cNvPr id="70" name="CasellaDiTesto 42">
              <a:extLst>
                <a:ext uri="{FF2B5EF4-FFF2-40B4-BE49-F238E27FC236}">
                  <a16:creationId xmlns:a16="http://schemas.microsoft.com/office/drawing/2014/main" id="{E66CC3FC-8628-3DE5-075B-7249192F557C}"/>
                </a:ext>
              </a:extLst>
            </p:cNvPr>
            <p:cNvSpPr txBox="1"/>
            <p:nvPr/>
          </p:nvSpPr>
          <p:spPr>
            <a:xfrm>
              <a:off x="-438331" y="190525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 err="1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a</a:t>
              </a:r>
              <a:endParaRPr lang="en-US" sz="8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1" name="CasellaDiTesto 46">
              <a:extLst>
                <a:ext uri="{FF2B5EF4-FFF2-40B4-BE49-F238E27FC236}">
                  <a16:creationId xmlns:a16="http://schemas.microsoft.com/office/drawing/2014/main" id="{9154DC47-5E82-7483-D749-0731EE027024}"/>
                </a:ext>
              </a:extLst>
            </p:cNvPr>
            <p:cNvSpPr txBox="1"/>
            <p:nvPr/>
          </p:nvSpPr>
          <p:spPr>
            <a:xfrm>
              <a:off x="-651025" y="2926232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95 -</a:t>
              </a:r>
            </a:p>
          </p:txBody>
        </p:sp>
        <p:sp>
          <p:nvSpPr>
            <p:cNvPr id="72" name="CasellaDiTesto 47">
              <a:extLst>
                <a:ext uri="{FF2B5EF4-FFF2-40B4-BE49-F238E27FC236}">
                  <a16:creationId xmlns:a16="http://schemas.microsoft.com/office/drawing/2014/main" id="{A18E10A0-0442-55B8-5610-9A9B61813B1F}"/>
                </a:ext>
              </a:extLst>
            </p:cNvPr>
            <p:cNvSpPr txBox="1"/>
            <p:nvPr/>
          </p:nvSpPr>
          <p:spPr>
            <a:xfrm>
              <a:off x="-651025" y="3203611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70 -</a:t>
              </a:r>
            </a:p>
          </p:txBody>
        </p:sp>
        <p:sp>
          <p:nvSpPr>
            <p:cNvPr id="73" name="CasellaDiTesto 48">
              <a:extLst>
                <a:ext uri="{FF2B5EF4-FFF2-40B4-BE49-F238E27FC236}">
                  <a16:creationId xmlns:a16="http://schemas.microsoft.com/office/drawing/2014/main" id="{D6D3FE1C-B34E-2DD2-7460-BC79D99A85F4}"/>
                </a:ext>
              </a:extLst>
            </p:cNvPr>
            <p:cNvSpPr txBox="1"/>
            <p:nvPr/>
          </p:nvSpPr>
          <p:spPr>
            <a:xfrm>
              <a:off x="-651025" y="3483155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5 -</a:t>
              </a:r>
            </a:p>
          </p:txBody>
        </p:sp>
        <p:sp>
          <p:nvSpPr>
            <p:cNvPr id="74" name="CasellaDiTesto 49">
              <a:extLst>
                <a:ext uri="{FF2B5EF4-FFF2-40B4-BE49-F238E27FC236}">
                  <a16:creationId xmlns:a16="http://schemas.microsoft.com/office/drawing/2014/main" id="{FCB569C5-8ABC-9E80-B8B3-2C026D48AB21}"/>
                </a:ext>
              </a:extLst>
            </p:cNvPr>
            <p:cNvSpPr txBox="1"/>
            <p:nvPr/>
          </p:nvSpPr>
          <p:spPr>
            <a:xfrm>
              <a:off x="-702321" y="2665928"/>
              <a:ext cx="3930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30 -</a:t>
              </a:r>
            </a:p>
          </p:txBody>
        </p:sp>
        <p:sp>
          <p:nvSpPr>
            <p:cNvPr id="75" name="CasellaDiTesto 51">
              <a:extLst>
                <a:ext uri="{FF2B5EF4-FFF2-40B4-BE49-F238E27FC236}">
                  <a16:creationId xmlns:a16="http://schemas.microsoft.com/office/drawing/2014/main" id="{8606E20F-E8A6-E18A-0BCE-41FB95899E39}"/>
                </a:ext>
              </a:extLst>
            </p:cNvPr>
            <p:cNvSpPr txBox="1"/>
            <p:nvPr/>
          </p:nvSpPr>
          <p:spPr>
            <a:xfrm>
              <a:off x="-702321" y="2391582"/>
              <a:ext cx="3930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50 -</a:t>
              </a:r>
            </a:p>
          </p:txBody>
        </p:sp>
        <p:sp>
          <p:nvSpPr>
            <p:cNvPr id="76" name="CasellaDiTesto 31">
              <a:extLst>
                <a:ext uri="{FF2B5EF4-FFF2-40B4-BE49-F238E27FC236}">
                  <a16:creationId xmlns:a16="http://schemas.microsoft.com/office/drawing/2014/main" id="{80B20AD5-0447-C223-5D5A-DEEB72D9F025}"/>
                </a:ext>
              </a:extLst>
            </p:cNvPr>
            <p:cNvSpPr txBox="1"/>
            <p:nvPr/>
          </p:nvSpPr>
          <p:spPr>
            <a:xfrm>
              <a:off x="-166532" y="4848422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trl</a:t>
              </a:r>
            </a:p>
          </p:txBody>
        </p:sp>
        <p:sp>
          <p:nvSpPr>
            <p:cNvPr id="77" name="CasellaDiTesto 32">
              <a:extLst>
                <a:ext uri="{FF2B5EF4-FFF2-40B4-BE49-F238E27FC236}">
                  <a16:creationId xmlns:a16="http://schemas.microsoft.com/office/drawing/2014/main" id="{EDF15A6C-ABA4-AB43-D6F5-AE9E71CD098B}"/>
                </a:ext>
              </a:extLst>
            </p:cNvPr>
            <p:cNvSpPr txBox="1"/>
            <p:nvPr/>
          </p:nvSpPr>
          <p:spPr>
            <a:xfrm>
              <a:off x="758345" y="4848422"/>
              <a:ext cx="8046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</a:t>
              </a:r>
            </a:p>
          </p:txBody>
        </p:sp>
        <p:cxnSp>
          <p:nvCxnSpPr>
            <p:cNvPr id="78" name="Connettore diritto 36">
              <a:extLst>
                <a:ext uri="{FF2B5EF4-FFF2-40B4-BE49-F238E27FC236}">
                  <a16:creationId xmlns:a16="http://schemas.microsoft.com/office/drawing/2014/main" id="{276FD3D9-6BA3-FD9B-04AB-818137F93E8B}"/>
                </a:ext>
              </a:extLst>
            </p:cNvPr>
            <p:cNvCxnSpPr>
              <a:cxnSpLocks/>
            </p:cNvCxnSpPr>
            <p:nvPr/>
          </p:nvCxnSpPr>
          <p:spPr>
            <a:xfrm>
              <a:off x="-166532" y="4871984"/>
              <a:ext cx="82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ttore diritto 37">
              <a:extLst>
                <a:ext uri="{FF2B5EF4-FFF2-40B4-BE49-F238E27FC236}">
                  <a16:creationId xmlns:a16="http://schemas.microsoft.com/office/drawing/2014/main" id="{5E54BD99-C7AD-CA65-EB37-7971EEBB7EDD}"/>
                </a:ext>
              </a:extLst>
            </p:cNvPr>
            <p:cNvCxnSpPr>
              <a:cxnSpLocks/>
            </p:cNvCxnSpPr>
            <p:nvPr/>
          </p:nvCxnSpPr>
          <p:spPr>
            <a:xfrm>
              <a:off x="758345" y="4871984"/>
              <a:ext cx="82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CasellaDiTesto 48">
              <a:extLst>
                <a:ext uri="{FF2B5EF4-FFF2-40B4-BE49-F238E27FC236}">
                  <a16:creationId xmlns:a16="http://schemas.microsoft.com/office/drawing/2014/main" id="{A02F3DCB-02BC-A844-57A6-3CDB230F0246}"/>
                </a:ext>
              </a:extLst>
            </p:cNvPr>
            <p:cNvSpPr txBox="1"/>
            <p:nvPr/>
          </p:nvSpPr>
          <p:spPr>
            <a:xfrm>
              <a:off x="-651025" y="4197198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4 -</a:t>
              </a:r>
            </a:p>
          </p:txBody>
        </p:sp>
        <p:sp>
          <p:nvSpPr>
            <p:cNvPr id="81" name="CasellaDiTesto 48">
              <a:extLst>
                <a:ext uri="{FF2B5EF4-FFF2-40B4-BE49-F238E27FC236}">
                  <a16:creationId xmlns:a16="http://schemas.microsoft.com/office/drawing/2014/main" id="{372D46AC-99B7-B8B7-1E68-E9F1CB10DB89}"/>
                </a:ext>
              </a:extLst>
            </p:cNvPr>
            <p:cNvSpPr txBox="1"/>
            <p:nvPr/>
          </p:nvSpPr>
          <p:spPr>
            <a:xfrm>
              <a:off x="-651026" y="3826234"/>
              <a:ext cx="3417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43 -</a:t>
              </a:r>
            </a:p>
          </p:txBody>
        </p:sp>
        <p:sp>
          <p:nvSpPr>
            <p:cNvPr id="82" name="CasellaDiTesto 48">
              <a:extLst>
                <a:ext uri="{FF2B5EF4-FFF2-40B4-BE49-F238E27FC236}">
                  <a16:creationId xmlns:a16="http://schemas.microsoft.com/office/drawing/2014/main" id="{8AED5054-BEC9-5B87-4B1A-9329A0F46617}"/>
                </a:ext>
              </a:extLst>
            </p:cNvPr>
            <p:cNvSpPr txBox="1"/>
            <p:nvPr/>
          </p:nvSpPr>
          <p:spPr>
            <a:xfrm>
              <a:off x="-651026" y="4507483"/>
              <a:ext cx="3417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6 -</a:t>
              </a:r>
            </a:p>
          </p:txBody>
        </p:sp>
        <p:cxnSp>
          <p:nvCxnSpPr>
            <p:cNvPr id="83" name="Connettore diritto 37">
              <a:extLst>
                <a:ext uri="{FF2B5EF4-FFF2-40B4-BE49-F238E27FC236}">
                  <a16:creationId xmlns:a16="http://schemas.microsoft.com/office/drawing/2014/main" id="{EF0403AF-07DD-DE18-585D-E407BFF6D6A3}"/>
                </a:ext>
              </a:extLst>
            </p:cNvPr>
            <p:cNvCxnSpPr>
              <a:cxnSpLocks/>
            </p:cNvCxnSpPr>
            <p:nvPr/>
          </p:nvCxnSpPr>
          <p:spPr>
            <a:xfrm>
              <a:off x="1909167" y="2773650"/>
              <a:ext cx="0" cy="987318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" name="Immagine 8" descr="Immagine che contiene schizzo, testo, bianco e nero&#10;&#10;Il contenuto generato dall'IA potrebbe non essere corretto.">
              <a:extLst>
                <a:ext uri="{FF2B5EF4-FFF2-40B4-BE49-F238E27FC236}">
                  <a16:creationId xmlns:a16="http://schemas.microsoft.com/office/drawing/2014/main" id="{8675D2AA-A012-DBC5-8E0B-9DCB1D38C13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198600" y="2099541"/>
              <a:ext cx="2260469" cy="2734805"/>
            </a:xfrm>
            <a:prstGeom prst="rect">
              <a:avLst/>
            </a:prstGeom>
          </p:spPr>
        </p:pic>
        <p:pic>
          <p:nvPicPr>
            <p:cNvPr id="10" name="Immagine 9" descr="Immagine che contiene oscurità, Policromia, Neon, rosso&#10;&#10;Il contenuto generato dall'IA potrebbe non essere corretto.">
              <a:extLst>
                <a:ext uri="{FF2B5EF4-FFF2-40B4-BE49-F238E27FC236}">
                  <a16:creationId xmlns:a16="http://schemas.microsoft.com/office/drawing/2014/main" id="{3FA18C46-B7CE-B503-E8D5-9B1407F5025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-367262" y="2099543"/>
              <a:ext cx="2243138" cy="2734805"/>
            </a:xfrm>
            <a:prstGeom prst="rect">
              <a:avLst/>
            </a:prstGeom>
          </p:spPr>
        </p:pic>
        <p:pic>
          <p:nvPicPr>
            <p:cNvPr id="11" name="Immagine 10" descr="Immagine che contiene schizzo, bianco e nero, bianco, monocromatico&#10;&#10;Il contenuto generato dall'IA potrebbe non essere corretto.">
              <a:extLst>
                <a:ext uri="{FF2B5EF4-FFF2-40B4-BE49-F238E27FC236}">
                  <a16:creationId xmlns:a16="http://schemas.microsoft.com/office/drawing/2014/main" id="{D2E1E3C1-05E7-1D3F-35DD-8DCFB812D61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487037" y="2099543"/>
              <a:ext cx="2280112" cy="2734803"/>
            </a:xfrm>
            <a:prstGeom prst="rect">
              <a:avLst/>
            </a:prstGeom>
          </p:spPr>
        </p:pic>
        <p:sp>
          <p:nvSpPr>
            <p:cNvPr id="19" name="CasellaDiTesto 32">
              <a:extLst>
                <a:ext uri="{FF2B5EF4-FFF2-40B4-BE49-F238E27FC236}">
                  <a16:creationId xmlns:a16="http://schemas.microsoft.com/office/drawing/2014/main" id="{D04B4750-277D-2970-5857-27105C0E3559}"/>
                </a:ext>
              </a:extLst>
            </p:cNvPr>
            <p:cNvSpPr txBox="1"/>
            <p:nvPr/>
          </p:nvSpPr>
          <p:spPr>
            <a:xfrm>
              <a:off x="-176058" y="1832917"/>
              <a:ext cx="17244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C-32</a:t>
              </a:r>
            </a:p>
          </p:txBody>
        </p:sp>
        <p:cxnSp>
          <p:nvCxnSpPr>
            <p:cNvPr id="84" name="Connettore diritto 37">
              <a:extLst>
                <a:ext uri="{FF2B5EF4-FFF2-40B4-BE49-F238E27FC236}">
                  <a16:creationId xmlns:a16="http://schemas.microsoft.com/office/drawing/2014/main" id="{F61C8070-5A04-07B8-2BA7-B866A23F4DB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344803" y="3790369"/>
              <a:ext cx="2586742" cy="3702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nettore diritto 37">
              <a:extLst>
                <a:ext uri="{FF2B5EF4-FFF2-40B4-BE49-F238E27FC236}">
                  <a16:creationId xmlns:a16="http://schemas.microsoft.com/office/drawing/2014/main" id="{7959BA16-C40F-FECD-F528-BB9B67B733F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344803" y="4409939"/>
              <a:ext cx="2586742" cy="3702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CasellaDiTesto 40">
              <a:extLst>
                <a:ext uri="{FF2B5EF4-FFF2-40B4-BE49-F238E27FC236}">
                  <a16:creationId xmlns:a16="http://schemas.microsoft.com/office/drawing/2014/main" id="{5B4B7F1A-11F0-D833-E8CF-45BA0E5C5C71}"/>
                </a:ext>
              </a:extLst>
            </p:cNvPr>
            <p:cNvSpPr txBox="1"/>
            <p:nvPr/>
          </p:nvSpPr>
          <p:spPr>
            <a:xfrm rot="16200000">
              <a:off x="4651438" y="3998182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solidFill>
                    <a:srgbClr val="FF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actin</a:t>
              </a:r>
            </a:p>
          </p:txBody>
        </p:sp>
        <p:cxnSp>
          <p:nvCxnSpPr>
            <p:cNvPr id="53" name="Connettore diritto 37">
              <a:extLst>
                <a:ext uri="{FF2B5EF4-FFF2-40B4-BE49-F238E27FC236}">
                  <a16:creationId xmlns:a16="http://schemas.microsoft.com/office/drawing/2014/main" id="{A344D3EF-5E15-5607-76BC-46D09DEDE875}"/>
                </a:ext>
              </a:extLst>
            </p:cNvPr>
            <p:cNvCxnSpPr>
              <a:cxnSpLocks/>
            </p:cNvCxnSpPr>
            <p:nvPr/>
          </p:nvCxnSpPr>
          <p:spPr>
            <a:xfrm>
              <a:off x="4800493" y="3875435"/>
              <a:ext cx="0" cy="46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CasellaDiTesto 40">
              <a:extLst>
                <a:ext uri="{FF2B5EF4-FFF2-40B4-BE49-F238E27FC236}">
                  <a16:creationId xmlns:a16="http://schemas.microsoft.com/office/drawing/2014/main" id="{2F4349C9-2207-C994-DD85-548831DBB989}"/>
                </a:ext>
              </a:extLst>
            </p:cNvPr>
            <p:cNvSpPr txBox="1"/>
            <p:nvPr/>
          </p:nvSpPr>
          <p:spPr>
            <a:xfrm rot="16200000">
              <a:off x="4683499" y="2806812"/>
              <a:ext cx="3754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solidFill>
                    <a:srgbClr val="FF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au</a:t>
              </a:r>
            </a:p>
          </p:txBody>
        </p:sp>
        <p:cxnSp>
          <p:nvCxnSpPr>
            <p:cNvPr id="55" name="Connettore diritto 37">
              <a:extLst>
                <a:ext uri="{FF2B5EF4-FFF2-40B4-BE49-F238E27FC236}">
                  <a16:creationId xmlns:a16="http://schemas.microsoft.com/office/drawing/2014/main" id="{11E2C5E7-1D50-3266-2E21-799CEFEEDBB1}"/>
                </a:ext>
              </a:extLst>
            </p:cNvPr>
            <p:cNvCxnSpPr>
              <a:cxnSpLocks/>
            </p:cNvCxnSpPr>
            <p:nvPr/>
          </p:nvCxnSpPr>
          <p:spPr>
            <a:xfrm>
              <a:off x="4800494" y="2155922"/>
              <a:ext cx="0" cy="154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CasellaDiTesto 40">
              <a:extLst>
                <a:ext uri="{FF2B5EF4-FFF2-40B4-BE49-F238E27FC236}">
                  <a16:creationId xmlns:a16="http://schemas.microsoft.com/office/drawing/2014/main" id="{83E3261D-AAE8-0AE8-FA6E-BBF7951C2328}"/>
                </a:ext>
              </a:extLst>
            </p:cNvPr>
            <p:cNvSpPr txBox="1"/>
            <p:nvPr/>
          </p:nvSpPr>
          <p:spPr>
            <a:xfrm>
              <a:off x="1810651" y="4079057"/>
              <a:ext cx="5629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solidFill>
                    <a:srgbClr val="00B05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GAPDH</a:t>
              </a:r>
            </a:p>
          </p:txBody>
        </p:sp>
        <p:sp>
          <p:nvSpPr>
            <p:cNvPr id="59" name="CasellaDiTesto 31">
              <a:extLst>
                <a:ext uri="{FF2B5EF4-FFF2-40B4-BE49-F238E27FC236}">
                  <a16:creationId xmlns:a16="http://schemas.microsoft.com/office/drawing/2014/main" id="{FA33C44B-2EDA-DCBD-FBF1-1A3D076533CF}"/>
                </a:ext>
              </a:extLst>
            </p:cNvPr>
            <p:cNvSpPr txBox="1"/>
            <p:nvPr/>
          </p:nvSpPr>
          <p:spPr>
            <a:xfrm>
              <a:off x="2726639" y="4848422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trl</a:t>
              </a:r>
            </a:p>
          </p:txBody>
        </p:sp>
        <p:sp>
          <p:nvSpPr>
            <p:cNvPr id="61" name="CasellaDiTesto 32">
              <a:extLst>
                <a:ext uri="{FF2B5EF4-FFF2-40B4-BE49-F238E27FC236}">
                  <a16:creationId xmlns:a16="http://schemas.microsoft.com/office/drawing/2014/main" id="{F29EEB07-9607-C24C-37DD-8EA4C5C66191}"/>
                </a:ext>
              </a:extLst>
            </p:cNvPr>
            <p:cNvSpPr txBox="1"/>
            <p:nvPr/>
          </p:nvSpPr>
          <p:spPr>
            <a:xfrm>
              <a:off x="3651516" y="4848422"/>
              <a:ext cx="8046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</a:t>
              </a:r>
            </a:p>
          </p:txBody>
        </p:sp>
        <p:cxnSp>
          <p:nvCxnSpPr>
            <p:cNvPr id="62" name="Connettore diritto 36">
              <a:extLst>
                <a:ext uri="{FF2B5EF4-FFF2-40B4-BE49-F238E27FC236}">
                  <a16:creationId xmlns:a16="http://schemas.microsoft.com/office/drawing/2014/main" id="{347E8E8C-D923-AC13-3EF6-41FBB11E3B3E}"/>
                </a:ext>
              </a:extLst>
            </p:cNvPr>
            <p:cNvCxnSpPr>
              <a:cxnSpLocks/>
            </p:cNvCxnSpPr>
            <p:nvPr/>
          </p:nvCxnSpPr>
          <p:spPr>
            <a:xfrm>
              <a:off x="2726639" y="4871984"/>
              <a:ext cx="82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nettore diritto 37">
              <a:extLst>
                <a:ext uri="{FF2B5EF4-FFF2-40B4-BE49-F238E27FC236}">
                  <a16:creationId xmlns:a16="http://schemas.microsoft.com/office/drawing/2014/main" id="{515353E9-5754-A73E-5666-2BEE7118C1BC}"/>
                </a:ext>
              </a:extLst>
            </p:cNvPr>
            <p:cNvCxnSpPr>
              <a:cxnSpLocks/>
            </p:cNvCxnSpPr>
            <p:nvPr/>
          </p:nvCxnSpPr>
          <p:spPr>
            <a:xfrm>
              <a:off x="3651516" y="4871984"/>
              <a:ext cx="82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CasellaDiTesto 32">
              <a:extLst>
                <a:ext uri="{FF2B5EF4-FFF2-40B4-BE49-F238E27FC236}">
                  <a16:creationId xmlns:a16="http://schemas.microsoft.com/office/drawing/2014/main" id="{C5A9ED45-9675-D216-9112-06E7B0833084}"/>
                </a:ext>
              </a:extLst>
            </p:cNvPr>
            <p:cNvSpPr txBox="1"/>
            <p:nvPr/>
          </p:nvSpPr>
          <p:spPr>
            <a:xfrm>
              <a:off x="2717113" y="1832917"/>
              <a:ext cx="17244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C-32</a:t>
              </a:r>
            </a:p>
          </p:txBody>
        </p:sp>
        <p:sp>
          <p:nvSpPr>
            <p:cNvPr id="66" name="CasellaDiTesto 31">
              <a:extLst>
                <a:ext uri="{FF2B5EF4-FFF2-40B4-BE49-F238E27FC236}">
                  <a16:creationId xmlns:a16="http://schemas.microsoft.com/office/drawing/2014/main" id="{6084F3A6-6BBE-354E-B414-06B256B4B900}"/>
                </a:ext>
              </a:extLst>
            </p:cNvPr>
            <p:cNvSpPr txBox="1"/>
            <p:nvPr/>
          </p:nvSpPr>
          <p:spPr>
            <a:xfrm>
              <a:off x="5432527" y="4848422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trl</a:t>
              </a:r>
            </a:p>
          </p:txBody>
        </p:sp>
        <p:sp>
          <p:nvSpPr>
            <p:cNvPr id="96" name="CasellaDiTesto 32">
              <a:extLst>
                <a:ext uri="{FF2B5EF4-FFF2-40B4-BE49-F238E27FC236}">
                  <a16:creationId xmlns:a16="http://schemas.microsoft.com/office/drawing/2014/main" id="{EE616B4A-9325-EE7D-2677-34DA52C20B23}"/>
                </a:ext>
              </a:extLst>
            </p:cNvPr>
            <p:cNvSpPr txBox="1"/>
            <p:nvPr/>
          </p:nvSpPr>
          <p:spPr>
            <a:xfrm>
              <a:off x="6357404" y="4848422"/>
              <a:ext cx="8046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</a:t>
              </a:r>
            </a:p>
          </p:txBody>
        </p:sp>
        <p:cxnSp>
          <p:nvCxnSpPr>
            <p:cNvPr id="97" name="Connettore diritto 36">
              <a:extLst>
                <a:ext uri="{FF2B5EF4-FFF2-40B4-BE49-F238E27FC236}">
                  <a16:creationId xmlns:a16="http://schemas.microsoft.com/office/drawing/2014/main" id="{DA77BA12-653A-7967-C637-C9D605A7DE7D}"/>
                </a:ext>
              </a:extLst>
            </p:cNvPr>
            <p:cNvCxnSpPr>
              <a:cxnSpLocks/>
            </p:cNvCxnSpPr>
            <p:nvPr/>
          </p:nvCxnSpPr>
          <p:spPr>
            <a:xfrm>
              <a:off x="5432527" y="4871984"/>
              <a:ext cx="82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Connettore diritto 37">
              <a:extLst>
                <a:ext uri="{FF2B5EF4-FFF2-40B4-BE49-F238E27FC236}">
                  <a16:creationId xmlns:a16="http://schemas.microsoft.com/office/drawing/2014/main" id="{C5FB8F3A-6CC4-2B0B-6F8D-E16527D87B0C}"/>
                </a:ext>
              </a:extLst>
            </p:cNvPr>
            <p:cNvCxnSpPr>
              <a:cxnSpLocks/>
            </p:cNvCxnSpPr>
            <p:nvPr/>
          </p:nvCxnSpPr>
          <p:spPr>
            <a:xfrm>
              <a:off x="6357404" y="4871984"/>
              <a:ext cx="82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CasellaDiTesto 32">
              <a:extLst>
                <a:ext uri="{FF2B5EF4-FFF2-40B4-BE49-F238E27FC236}">
                  <a16:creationId xmlns:a16="http://schemas.microsoft.com/office/drawing/2014/main" id="{4A34471C-5CC3-48FE-6686-56A5F191DBAE}"/>
                </a:ext>
              </a:extLst>
            </p:cNvPr>
            <p:cNvSpPr txBox="1"/>
            <p:nvPr/>
          </p:nvSpPr>
          <p:spPr>
            <a:xfrm>
              <a:off x="5423001" y="1832917"/>
              <a:ext cx="17244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C-32</a:t>
              </a:r>
            </a:p>
          </p:txBody>
        </p:sp>
        <p:cxnSp>
          <p:nvCxnSpPr>
            <p:cNvPr id="90" name="Connettore diritto 37">
              <a:extLst>
                <a:ext uri="{FF2B5EF4-FFF2-40B4-BE49-F238E27FC236}">
                  <a16:creationId xmlns:a16="http://schemas.microsoft.com/office/drawing/2014/main" id="{C420D90A-9CB6-429B-7EAC-AA200405317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119764" y="3909672"/>
              <a:ext cx="2586742" cy="3702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Connettore diritto 37">
              <a:extLst>
                <a:ext uri="{FF2B5EF4-FFF2-40B4-BE49-F238E27FC236}">
                  <a16:creationId xmlns:a16="http://schemas.microsoft.com/office/drawing/2014/main" id="{37970CD3-1F1A-BDB6-A9AB-E06F96DCEC6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119764" y="4424188"/>
              <a:ext cx="2586742" cy="3702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CasellaDiTesto 40">
              <a:extLst>
                <a:ext uri="{FF2B5EF4-FFF2-40B4-BE49-F238E27FC236}">
                  <a16:creationId xmlns:a16="http://schemas.microsoft.com/office/drawing/2014/main" id="{225972A6-66E3-B84E-AD0F-7EBEE02478F6}"/>
                </a:ext>
              </a:extLst>
            </p:cNvPr>
            <p:cNvSpPr txBox="1"/>
            <p:nvPr/>
          </p:nvSpPr>
          <p:spPr>
            <a:xfrm rot="16200000">
              <a:off x="7276432" y="4066762"/>
              <a:ext cx="5629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solidFill>
                    <a:srgbClr val="00B05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GAPDH</a:t>
              </a:r>
            </a:p>
          </p:txBody>
        </p:sp>
        <p:cxnSp>
          <p:nvCxnSpPr>
            <p:cNvPr id="101" name="Connettore diritto 37">
              <a:extLst>
                <a:ext uri="{FF2B5EF4-FFF2-40B4-BE49-F238E27FC236}">
                  <a16:creationId xmlns:a16="http://schemas.microsoft.com/office/drawing/2014/main" id="{CFD490EF-FA2C-BEBD-07BF-9F797E570D14}"/>
                </a:ext>
              </a:extLst>
            </p:cNvPr>
            <p:cNvCxnSpPr>
              <a:cxnSpLocks/>
            </p:cNvCxnSpPr>
            <p:nvPr/>
          </p:nvCxnSpPr>
          <p:spPr>
            <a:xfrm>
              <a:off x="7487201" y="3944015"/>
              <a:ext cx="0" cy="46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169777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E1D7524-122A-1543-3656-5B8A5938D2A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uppo 41">
            <a:extLst>
              <a:ext uri="{FF2B5EF4-FFF2-40B4-BE49-F238E27FC236}">
                <a16:creationId xmlns:a16="http://schemas.microsoft.com/office/drawing/2014/main" id="{D6977E17-DC19-2AE4-A17D-5CD9B6699E4A}"/>
              </a:ext>
            </a:extLst>
          </p:cNvPr>
          <p:cNvGrpSpPr/>
          <p:nvPr/>
        </p:nvGrpSpPr>
        <p:grpSpPr>
          <a:xfrm>
            <a:off x="376889" y="1281673"/>
            <a:ext cx="8593438" cy="3434649"/>
            <a:chOff x="376889" y="1281673"/>
            <a:chExt cx="8593438" cy="3434649"/>
          </a:xfrm>
        </p:grpSpPr>
        <p:sp>
          <p:nvSpPr>
            <p:cNvPr id="2" name="Rettangolo 1">
              <a:extLst>
                <a:ext uri="{FF2B5EF4-FFF2-40B4-BE49-F238E27FC236}">
                  <a16:creationId xmlns:a16="http://schemas.microsoft.com/office/drawing/2014/main" id="{8EC5820E-1C87-E3FC-2700-36897150D3A3}"/>
                </a:ext>
              </a:extLst>
            </p:cNvPr>
            <p:cNvSpPr/>
            <p:nvPr/>
          </p:nvSpPr>
          <p:spPr>
            <a:xfrm>
              <a:off x="428185" y="1329216"/>
              <a:ext cx="8468166" cy="338710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CH"/>
            </a:p>
          </p:txBody>
        </p:sp>
        <p:sp>
          <p:nvSpPr>
            <p:cNvPr id="114" name="ZoneTexte 40">
              <a:extLst>
                <a:ext uri="{FF2B5EF4-FFF2-40B4-BE49-F238E27FC236}">
                  <a16:creationId xmlns:a16="http://schemas.microsoft.com/office/drawing/2014/main" id="{E2085215-BBD0-6F1E-A416-6CC14AC6BA7F}"/>
                </a:ext>
              </a:extLst>
            </p:cNvPr>
            <p:cNvSpPr txBox="1"/>
            <p:nvPr/>
          </p:nvSpPr>
          <p:spPr>
            <a:xfrm>
              <a:off x="395925" y="1281673"/>
              <a:ext cx="9774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600" b="1" dirty="0"/>
                <a:t>Figure 3B</a:t>
              </a:r>
              <a:endParaRPr lang="en-US" sz="1600" b="1" dirty="0"/>
            </a:p>
          </p:txBody>
        </p:sp>
        <p:sp>
          <p:nvSpPr>
            <p:cNvPr id="117" name="CasellaDiTesto 40">
              <a:extLst>
                <a:ext uri="{FF2B5EF4-FFF2-40B4-BE49-F238E27FC236}">
                  <a16:creationId xmlns:a16="http://schemas.microsoft.com/office/drawing/2014/main" id="{1BD0F171-B765-EBA2-9916-F54C5F9234E3}"/>
                </a:ext>
              </a:extLst>
            </p:cNvPr>
            <p:cNvSpPr txBox="1"/>
            <p:nvPr/>
          </p:nvSpPr>
          <p:spPr>
            <a:xfrm>
              <a:off x="2916399" y="3362609"/>
              <a:ext cx="5629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solidFill>
                    <a:srgbClr val="00B05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GAPDH</a:t>
              </a:r>
            </a:p>
          </p:txBody>
        </p:sp>
        <p:sp>
          <p:nvSpPr>
            <p:cNvPr id="118" name="CasellaDiTesto 39">
              <a:extLst>
                <a:ext uri="{FF2B5EF4-FFF2-40B4-BE49-F238E27FC236}">
                  <a16:creationId xmlns:a16="http://schemas.microsoft.com/office/drawing/2014/main" id="{DE69D8F1-5DFC-A94D-0704-17EE03AD35B7}"/>
                </a:ext>
              </a:extLst>
            </p:cNvPr>
            <p:cNvSpPr txBox="1"/>
            <p:nvPr/>
          </p:nvSpPr>
          <p:spPr>
            <a:xfrm>
              <a:off x="2916399" y="2451323"/>
              <a:ext cx="3802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solidFill>
                    <a:srgbClr val="FF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au</a:t>
              </a:r>
            </a:p>
          </p:txBody>
        </p:sp>
        <p:sp>
          <p:nvSpPr>
            <p:cNvPr id="119" name="CasellaDiTesto 32">
              <a:extLst>
                <a:ext uri="{FF2B5EF4-FFF2-40B4-BE49-F238E27FC236}">
                  <a16:creationId xmlns:a16="http://schemas.microsoft.com/office/drawing/2014/main" id="{571B809F-9F7B-7370-8550-C3E00CA8F5AD}"/>
                </a:ext>
              </a:extLst>
            </p:cNvPr>
            <p:cNvSpPr txBox="1"/>
            <p:nvPr/>
          </p:nvSpPr>
          <p:spPr>
            <a:xfrm>
              <a:off x="1006533" y="1549087"/>
              <a:ext cx="18336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C-71</a:t>
              </a:r>
            </a:p>
          </p:txBody>
        </p:sp>
        <p:sp>
          <p:nvSpPr>
            <p:cNvPr id="120" name="CasellaDiTesto 42">
              <a:extLst>
                <a:ext uri="{FF2B5EF4-FFF2-40B4-BE49-F238E27FC236}">
                  <a16:creationId xmlns:a16="http://schemas.microsoft.com/office/drawing/2014/main" id="{28204C09-36C9-E806-2652-3D56DC8C473B}"/>
                </a:ext>
              </a:extLst>
            </p:cNvPr>
            <p:cNvSpPr txBox="1"/>
            <p:nvPr/>
          </p:nvSpPr>
          <p:spPr>
            <a:xfrm>
              <a:off x="665818" y="1606747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 err="1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a</a:t>
              </a:r>
              <a:endParaRPr lang="en-US" sz="8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1" name="CasellaDiTesto 46">
              <a:extLst>
                <a:ext uri="{FF2B5EF4-FFF2-40B4-BE49-F238E27FC236}">
                  <a16:creationId xmlns:a16="http://schemas.microsoft.com/office/drawing/2014/main" id="{1CBDFD1B-B316-7799-34E8-2EFBBF4CF38C}"/>
                </a:ext>
              </a:extLst>
            </p:cNvPr>
            <p:cNvSpPr txBox="1"/>
            <p:nvPr/>
          </p:nvSpPr>
          <p:spPr>
            <a:xfrm>
              <a:off x="428185" y="2311009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95 -</a:t>
              </a:r>
            </a:p>
          </p:txBody>
        </p:sp>
        <p:sp>
          <p:nvSpPr>
            <p:cNvPr id="122" name="CasellaDiTesto 47">
              <a:extLst>
                <a:ext uri="{FF2B5EF4-FFF2-40B4-BE49-F238E27FC236}">
                  <a16:creationId xmlns:a16="http://schemas.microsoft.com/office/drawing/2014/main" id="{14584946-19A1-B517-B98A-908E865290A2}"/>
                </a:ext>
              </a:extLst>
            </p:cNvPr>
            <p:cNvSpPr txBox="1"/>
            <p:nvPr/>
          </p:nvSpPr>
          <p:spPr>
            <a:xfrm>
              <a:off x="428185" y="2571762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70 -</a:t>
              </a:r>
            </a:p>
          </p:txBody>
        </p:sp>
        <p:sp>
          <p:nvSpPr>
            <p:cNvPr id="123" name="CasellaDiTesto 48">
              <a:extLst>
                <a:ext uri="{FF2B5EF4-FFF2-40B4-BE49-F238E27FC236}">
                  <a16:creationId xmlns:a16="http://schemas.microsoft.com/office/drawing/2014/main" id="{D104F6D8-59D6-A5AB-894D-1C11DA3BD79E}"/>
                </a:ext>
              </a:extLst>
            </p:cNvPr>
            <p:cNvSpPr txBox="1"/>
            <p:nvPr/>
          </p:nvSpPr>
          <p:spPr>
            <a:xfrm>
              <a:off x="428185" y="2862390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5 -</a:t>
              </a:r>
            </a:p>
          </p:txBody>
        </p:sp>
        <p:sp>
          <p:nvSpPr>
            <p:cNvPr id="124" name="CasellaDiTesto 49">
              <a:extLst>
                <a:ext uri="{FF2B5EF4-FFF2-40B4-BE49-F238E27FC236}">
                  <a16:creationId xmlns:a16="http://schemas.microsoft.com/office/drawing/2014/main" id="{7FE1ED2C-9A79-9688-7E02-9D7DDA85D524}"/>
                </a:ext>
              </a:extLst>
            </p:cNvPr>
            <p:cNvSpPr txBox="1"/>
            <p:nvPr/>
          </p:nvSpPr>
          <p:spPr>
            <a:xfrm>
              <a:off x="376889" y="2070102"/>
              <a:ext cx="3930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30 -</a:t>
              </a:r>
            </a:p>
          </p:txBody>
        </p:sp>
        <p:sp>
          <p:nvSpPr>
            <p:cNvPr id="125" name="CasellaDiTesto 51">
              <a:extLst>
                <a:ext uri="{FF2B5EF4-FFF2-40B4-BE49-F238E27FC236}">
                  <a16:creationId xmlns:a16="http://schemas.microsoft.com/office/drawing/2014/main" id="{E3152C71-7FDA-D09E-0FDB-189E3BB1D6F0}"/>
                </a:ext>
              </a:extLst>
            </p:cNvPr>
            <p:cNvSpPr txBox="1"/>
            <p:nvPr/>
          </p:nvSpPr>
          <p:spPr>
            <a:xfrm>
              <a:off x="376889" y="1829008"/>
              <a:ext cx="3930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50 -</a:t>
              </a:r>
            </a:p>
          </p:txBody>
        </p:sp>
        <p:sp>
          <p:nvSpPr>
            <p:cNvPr id="126" name="CasellaDiTesto 31">
              <a:extLst>
                <a:ext uri="{FF2B5EF4-FFF2-40B4-BE49-F238E27FC236}">
                  <a16:creationId xmlns:a16="http://schemas.microsoft.com/office/drawing/2014/main" id="{3CB0C265-9912-AFAE-47A7-6D8BCA1BE367}"/>
                </a:ext>
              </a:extLst>
            </p:cNvPr>
            <p:cNvSpPr txBox="1"/>
            <p:nvPr/>
          </p:nvSpPr>
          <p:spPr>
            <a:xfrm>
              <a:off x="1063692" y="4439322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trl</a:t>
              </a:r>
            </a:p>
          </p:txBody>
        </p:sp>
        <p:sp>
          <p:nvSpPr>
            <p:cNvPr id="127" name="CasellaDiTesto 32">
              <a:extLst>
                <a:ext uri="{FF2B5EF4-FFF2-40B4-BE49-F238E27FC236}">
                  <a16:creationId xmlns:a16="http://schemas.microsoft.com/office/drawing/2014/main" id="{561B7977-D644-EBD8-0710-D2456C9D2991}"/>
                </a:ext>
              </a:extLst>
            </p:cNvPr>
            <p:cNvSpPr txBox="1"/>
            <p:nvPr/>
          </p:nvSpPr>
          <p:spPr>
            <a:xfrm>
              <a:off x="1988569" y="4439322"/>
              <a:ext cx="8046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</a:t>
              </a:r>
            </a:p>
          </p:txBody>
        </p:sp>
        <p:cxnSp>
          <p:nvCxnSpPr>
            <p:cNvPr id="128" name="Connettore diritto 36">
              <a:extLst>
                <a:ext uri="{FF2B5EF4-FFF2-40B4-BE49-F238E27FC236}">
                  <a16:creationId xmlns:a16="http://schemas.microsoft.com/office/drawing/2014/main" id="{9C930390-E047-8808-2A1A-929A99A5F4F9}"/>
                </a:ext>
              </a:extLst>
            </p:cNvPr>
            <p:cNvCxnSpPr>
              <a:cxnSpLocks/>
            </p:cNvCxnSpPr>
            <p:nvPr/>
          </p:nvCxnSpPr>
          <p:spPr>
            <a:xfrm>
              <a:off x="1063692" y="4462884"/>
              <a:ext cx="82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Connettore diritto 37">
              <a:extLst>
                <a:ext uri="{FF2B5EF4-FFF2-40B4-BE49-F238E27FC236}">
                  <a16:creationId xmlns:a16="http://schemas.microsoft.com/office/drawing/2014/main" id="{E112B3BC-BF15-0682-44C2-4EC472330CA2}"/>
                </a:ext>
              </a:extLst>
            </p:cNvPr>
            <p:cNvCxnSpPr>
              <a:cxnSpLocks/>
            </p:cNvCxnSpPr>
            <p:nvPr/>
          </p:nvCxnSpPr>
          <p:spPr>
            <a:xfrm>
              <a:off x="1988569" y="4462884"/>
              <a:ext cx="82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CasellaDiTesto 48">
              <a:extLst>
                <a:ext uri="{FF2B5EF4-FFF2-40B4-BE49-F238E27FC236}">
                  <a16:creationId xmlns:a16="http://schemas.microsoft.com/office/drawing/2014/main" id="{4737961F-99CD-7479-85BB-E42125339ACC}"/>
                </a:ext>
              </a:extLst>
            </p:cNvPr>
            <p:cNvSpPr txBox="1"/>
            <p:nvPr/>
          </p:nvSpPr>
          <p:spPr>
            <a:xfrm>
              <a:off x="428185" y="3543181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4 -</a:t>
              </a:r>
            </a:p>
          </p:txBody>
        </p:sp>
        <p:sp>
          <p:nvSpPr>
            <p:cNvPr id="131" name="CasellaDiTesto 48">
              <a:extLst>
                <a:ext uri="{FF2B5EF4-FFF2-40B4-BE49-F238E27FC236}">
                  <a16:creationId xmlns:a16="http://schemas.microsoft.com/office/drawing/2014/main" id="{F5CAF3D8-E2ED-5C53-BB31-FB8822553669}"/>
                </a:ext>
              </a:extLst>
            </p:cNvPr>
            <p:cNvSpPr txBox="1"/>
            <p:nvPr/>
          </p:nvSpPr>
          <p:spPr>
            <a:xfrm>
              <a:off x="428184" y="3177759"/>
              <a:ext cx="3417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43 -</a:t>
              </a:r>
            </a:p>
          </p:txBody>
        </p:sp>
        <p:sp>
          <p:nvSpPr>
            <p:cNvPr id="132" name="CasellaDiTesto 48">
              <a:extLst>
                <a:ext uri="{FF2B5EF4-FFF2-40B4-BE49-F238E27FC236}">
                  <a16:creationId xmlns:a16="http://schemas.microsoft.com/office/drawing/2014/main" id="{37609028-30D7-0BD4-4003-9A5E838B27B1}"/>
                </a:ext>
              </a:extLst>
            </p:cNvPr>
            <p:cNvSpPr txBox="1"/>
            <p:nvPr/>
          </p:nvSpPr>
          <p:spPr>
            <a:xfrm>
              <a:off x="428184" y="3919970"/>
              <a:ext cx="3417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6 -</a:t>
              </a:r>
            </a:p>
          </p:txBody>
        </p:sp>
        <p:cxnSp>
          <p:nvCxnSpPr>
            <p:cNvPr id="133" name="Connettore diritto 37">
              <a:extLst>
                <a:ext uri="{FF2B5EF4-FFF2-40B4-BE49-F238E27FC236}">
                  <a16:creationId xmlns:a16="http://schemas.microsoft.com/office/drawing/2014/main" id="{4189911E-CA7C-23E7-C05D-9EADEFD8D351}"/>
                </a:ext>
              </a:extLst>
            </p:cNvPr>
            <p:cNvCxnSpPr>
              <a:cxnSpLocks/>
            </p:cNvCxnSpPr>
            <p:nvPr/>
          </p:nvCxnSpPr>
          <p:spPr>
            <a:xfrm>
              <a:off x="2942596" y="1936730"/>
              <a:ext cx="0" cy="127540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Connettore diritto 37">
              <a:extLst>
                <a:ext uri="{FF2B5EF4-FFF2-40B4-BE49-F238E27FC236}">
                  <a16:creationId xmlns:a16="http://schemas.microsoft.com/office/drawing/2014/main" id="{49915D19-7A48-E442-E2C4-D656E51CD1CE}"/>
                </a:ext>
              </a:extLst>
            </p:cNvPr>
            <p:cNvCxnSpPr>
              <a:cxnSpLocks/>
            </p:cNvCxnSpPr>
            <p:nvPr/>
          </p:nvCxnSpPr>
          <p:spPr>
            <a:xfrm>
              <a:off x="2942596" y="3282267"/>
              <a:ext cx="0" cy="46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" name="Immagine 4" descr="Immagine che contiene bianco e nero, bianco, Fotografia monocromatica, monocromatico&#10;&#10;Il contenuto generato dall'IA potrebbe non essere corretto.">
              <a:extLst>
                <a:ext uri="{FF2B5EF4-FFF2-40B4-BE49-F238E27FC236}">
                  <a16:creationId xmlns:a16="http://schemas.microsoft.com/office/drawing/2014/main" id="{D1AB23DF-0AC7-BF84-73F4-9A1A098D075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200977" y="1791025"/>
              <a:ext cx="2186507" cy="2615806"/>
            </a:xfrm>
            <a:prstGeom prst="rect">
              <a:avLst/>
            </a:prstGeom>
          </p:spPr>
        </p:pic>
        <p:pic>
          <p:nvPicPr>
            <p:cNvPr id="7" name="Immagine 6" descr="Immagine che contiene testo, design&#10;&#10;Il contenuto generato dall'IA potrebbe non essere corretto.">
              <a:extLst>
                <a:ext uri="{FF2B5EF4-FFF2-40B4-BE49-F238E27FC236}">
                  <a16:creationId xmlns:a16="http://schemas.microsoft.com/office/drawing/2014/main" id="{565F856D-1D83-D0BB-73DE-51F20D17ECF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450804" y="1791025"/>
              <a:ext cx="2186507" cy="2615806"/>
            </a:xfrm>
            <a:prstGeom prst="rect">
              <a:avLst/>
            </a:prstGeom>
          </p:spPr>
        </p:pic>
        <p:pic>
          <p:nvPicPr>
            <p:cNvPr id="12" name="Immagine 11" descr="Immagine che contiene Policromia, oscurità, rosso, Ambra&#10;&#10;Il contenuto generato dall'IA potrebbe non essere corretto.">
              <a:extLst>
                <a:ext uri="{FF2B5EF4-FFF2-40B4-BE49-F238E27FC236}">
                  <a16:creationId xmlns:a16="http://schemas.microsoft.com/office/drawing/2014/main" id="{1C814ADD-0549-730B-96E8-B877E5CE5D0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00631" y="1791025"/>
              <a:ext cx="2186507" cy="2615806"/>
            </a:xfrm>
            <a:prstGeom prst="rect">
              <a:avLst/>
            </a:prstGeom>
          </p:spPr>
        </p:pic>
        <p:sp>
          <p:nvSpPr>
            <p:cNvPr id="23" name="CasellaDiTesto 39">
              <a:extLst>
                <a:ext uri="{FF2B5EF4-FFF2-40B4-BE49-F238E27FC236}">
                  <a16:creationId xmlns:a16="http://schemas.microsoft.com/office/drawing/2014/main" id="{89B841A5-42A0-B513-CE7A-B51AEF3DCD53}"/>
                </a:ext>
              </a:extLst>
            </p:cNvPr>
            <p:cNvSpPr txBox="1"/>
            <p:nvPr/>
          </p:nvSpPr>
          <p:spPr>
            <a:xfrm>
              <a:off x="5664977" y="2451323"/>
              <a:ext cx="3802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solidFill>
                    <a:srgbClr val="FF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au</a:t>
              </a:r>
            </a:p>
          </p:txBody>
        </p:sp>
        <p:cxnSp>
          <p:nvCxnSpPr>
            <p:cNvPr id="24" name="Connettore diritto 37">
              <a:extLst>
                <a:ext uri="{FF2B5EF4-FFF2-40B4-BE49-F238E27FC236}">
                  <a16:creationId xmlns:a16="http://schemas.microsoft.com/office/drawing/2014/main" id="{F10A4F6B-CED7-DA41-14BF-0BE95918FF3D}"/>
                </a:ext>
              </a:extLst>
            </p:cNvPr>
            <p:cNvCxnSpPr>
              <a:cxnSpLocks/>
            </p:cNvCxnSpPr>
            <p:nvPr/>
          </p:nvCxnSpPr>
          <p:spPr>
            <a:xfrm>
              <a:off x="5691174" y="1936730"/>
              <a:ext cx="0" cy="127540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CasellaDiTesto 40">
              <a:extLst>
                <a:ext uri="{FF2B5EF4-FFF2-40B4-BE49-F238E27FC236}">
                  <a16:creationId xmlns:a16="http://schemas.microsoft.com/office/drawing/2014/main" id="{8310B616-DCDF-E72F-25A0-705E387638DA}"/>
                </a:ext>
              </a:extLst>
            </p:cNvPr>
            <p:cNvSpPr txBox="1"/>
            <p:nvPr/>
          </p:nvSpPr>
          <p:spPr>
            <a:xfrm>
              <a:off x="8407352" y="3362609"/>
              <a:ext cx="5629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solidFill>
                    <a:srgbClr val="00B05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GAPDH</a:t>
              </a:r>
            </a:p>
          </p:txBody>
        </p:sp>
        <p:cxnSp>
          <p:nvCxnSpPr>
            <p:cNvPr id="29" name="Connettore diritto 37">
              <a:extLst>
                <a:ext uri="{FF2B5EF4-FFF2-40B4-BE49-F238E27FC236}">
                  <a16:creationId xmlns:a16="http://schemas.microsoft.com/office/drawing/2014/main" id="{6954CEE9-FCE9-C268-6B79-35221482D12D}"/>
                </a:ext>
              </a:extLst>
            </p:cNvPr>
            <p:cNvCxnSpPr>
              <a:cxnSpLocks/>
            </p:cNvCxnSpPr>
            <p:nvPr/>
          </p:nvCxnSpPr>
          <p:spPr>
            <a:xfrm>
              <a:off x="8433549" y="3282267"/>
              <a:ext cx="0" cy="46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0" name="Gruppo 29">
              <a:extLst>
                <a:ext uri="{FF2B5EF4-FFF2-40B4-BE49-F238E27FC236}">
                  <a16:creationId xmlns:a16="http://schemas.microsoft.com/office/drawing/2014/main" id="{3A0BC728-DF76-3188-769C-45037B88E660}"/>
                </a:ext>
              </a:extLst>
            </p:cNvPr>
            <p:cNvGrpSpPr/>
            <p:nvPr/>
          </p:nvGrpSpPr>
          <p:grpSpPr>
            <a:xfrm>
              <a:off x="465983" y="3238050"/>
              <a:ext cx="8039835" cy="556768"/>
              <a:chOff x="465984" y="3238050"/>
              <a:chExt cx="2586742" cy="556768"/>
            </a:xfrm>
          </p:grpSpPr>
          <p:cxnSp>
            <p:nvCxnSpPr>
              <p:cNvPr id="134" name="Connettore diritto 37">
                <a:extLst>
                  <a:ext uri="{FF2B5EF4-FFF2-40B4-BE49-F238E27FC236}">
                    <a16:creationId xmlns:a16="http://schemas.microsoft.com/office/drawing/2014/main" id="{698E3490-6BB6-4FAB-4FD0-584596F1CF8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65984" y="3238050"/>
                <a:ext cx="2586742" cy="3702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Connettore diritto 37">
                <a:extLst>
                  <a:ext uri="{FF2B5EF4-FFF2-40B4-BE49-F238E27FC236}">
                    <a16:creationId xmlns:a16="http://schemas.microsoft.com/office/drawing/2014/main" id="{B3D5907A-AC7A-38B2-031C-FCB3EF90738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65984" y="3791116"/>
                <a:ext cx="2586742" cy="3702"/>
              </a:xfrm>
              <a:prstGeom prst="line">
                <a:avLst/>
              </a:prstGeom>
              <a:ln w="9525">
                <a:solidFill>
                  <a:schemeClr val="bg1">
                    <a:lumMod val="6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" name="CasellaDiTesto 32">
              <a:extLst>
                <a:ext uri="{FF2B5EF4-FFF2-40B4-BE49-F238E27FC236}">
                  <a16:creationId xmlns:a16="http://schemas.microsoft.com/office/drawing/2014/main" id="{38AA98A9-5500-226B-6312-83D31E101AF3}"/>
                </a:ext>
              </a:extLst>
            </p:cNvPr>
            <p:cNvSpPr txBox="1"/>
            <p:nvPr/>
          </p:nvSpPr>
          <p:spPr>
            <a:xfrm>
              <a:off x="3803648" y="1549087"/>
              <a:ext cx="18336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C-71</a:t>
              </a:r>
            </a:p>
          </p:txBody>
        </p:sp>
        <p:sp>
          <p:nvSpPr>
            <p:cNvPr id="32" name="CasellaDiTesto 32">
              <a:extLst>
                <a:ext uri="{FF2B5EF4-FFF2-40B4-BE49-F238E27FC236}">
                  <a16:creationId xmlns:a16="http://schemas.microsoft.com/office/drawing/2014/main" id="{40341728-B712-F08C-7BD4-D3E6358A4D0C}"/>
                </a:ext>
              </a:extLst>
            </p:cNvPr>
            <p:cNvSpPr txBox="1"/>
            <p:nvPr/>
          </p:nvSpPr>
          <p:spPr>
            <a:xfrm>
              <a:off x="6518273" y="1549087"/>
              <a:ext cx="18336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C-71</a:t>
              </a:r>
            </a:p>
          </p:txBody>
        </p:sp>
        <p:sp>
          <p:nvSpPr>
            <p:cNvPr id="33" name="CasellaDiTesto 31">
              <a:extLst>
                <a:ext uri="{FF2B5EF4-FFF2-40B4-BE49-F238E27FC236}">
                  <a16:creationId xmlns:a16="http://schemas.microsoft.com/office/drawing/2014/main" id="{8B2C3A02-8782-15DB-00E0-FEABA2F9BB26}"/>
                </a:ext>
              </a:extLst>
            </p:cNvPr>
            <p:cNvSpPr txBox="1"/>
            <p:nvPr/>
          </p:nvSpPr>
          <p:spPr>
            <a:xfrm>
              <a:off x="3849755" y="4439322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trl</a:t>
              </a:r>
            </a:p>
          </p:txBody>
        </p:sp>
        <p:sp>
          <p:nvSpPr>
            <p:cNvPr id="34" name="CasellaDiTesto 32">
              <a:extLst>
                <a:ext uri="{FF2B5EF4-FFF2-40B4-BE49-F238E27FC236}">
                  <a16:creationId xmlns:a16="http://schemas.microsoft.com/office/drawing/2014/main" id="{848C58C4-A0E7-29FF-45F0-BEE1879E5E5D}"/>
                </a:ext>
              </a:extLst>
            </p:cNvPr>
            <p:cNvSpPr txBox="1"/>
            <p:nvPr/>
          </p:nvSpPr>
          <p:spPr>
            <a:xfrm>
              <a:off x="4774632" y="4439322"/>
              <a:ext cx="8046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</a:t>
              </a:r>
            </a:p>
          </p:txBody>
        </p:sp>
        <p:cxnSp>
          <p:nvCxnSpPr>
            <p:cNvPr id="35" name="Connettore diritto 36">
              <a:extLst>
                <a:ext uri="{FF2B5EF4-FFF2-40B4-BE49-F238E27FC236}">
                  <a16:creationId xmlns:a16="http://schemas.microsoft.com/office/drawing/2014/main" id="{42D869C1-4FA1-7225-CAA7-D7E2B9A7D7E9}"/>
                </a:ext>
              </a:extLst>
            </p:cNvPr>
            <p:cNvCxnSpPr>
              <a:cxnSpLocks/>
            </p:cNvCxnSpPr>
            <p:nvPr/>
          </p:nvCxnSpPr>
          <p:spPr>
            <a:xfrm>
              <a:off x="3849755" y="4462884"/>
              <a:ext cx="82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ttore diritto 37">
              <a:extLst>
                <a:ext uri="{FF2B5EF4-FFF2-40B4-BE49-F238E27FC236}">
                  <a16:creationId xmlns:a16="http://schemas.microsoft.com/office/drawing/2014/main" id="{CE2A1005-C8A8-D78B-1CBF-01092D5B66A4}"/>
                </a:ext>
              </a:extLst>
            </p:cNvPr>
            <p:cNvCxnSpPr>
              <a:cxnSpLocks/>
            </p:cNvCxnSpPr>
            <p:nvPr/>
          </p:nvCxnSpPr>
          <p:spPr>
            <a:xfrm>
              <a:off x="4774632" y="4462884"/>
              <a:ext cx="82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CasellaDiTesto 31">
              <a:extLst>
                <a:ext uri="{FF2B5EF4-FFF2-40B4-BE49-F238E27FC236}">
                  <a16:creationId xmlns:a16="http://schemas.microsoft.com/office/drawing/2014/main" id="{30CB5201-37D0-7581-50FB-B83ABCAEDC78}"/>
                </a:ext>
              </a:extLst>
            </p:cNvPr>
            <p:cNvSpPr txBox="1"/>
            <p:nvPr/>
          </p:nvSpPr>
          <p:spPr>
            <a:xfrm>
              <a:off x="6578668" y="4439322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trl</a:t>
              </a:r>
            </a:p>
          </p:txBody>
        </p:sp>
        <p:sp>
          <p:nvSpPr>
            <p:cNvPr id="38" name="CasellaDiTesto 32">
              <a:extLst>
                <a:ext uri="{FF2B5EF4-FFF2-40B4-BE49-F238E27FC236}">
                  <a16:creationId xmlns:a16="http://schemas.microsoft.com/office/drawing/2014/main" id="{93A9CC7B-F83D-ECEB-88DA-54890DFCB11A}"/>
                </a:ext>
              </a:extLst>
            </p:cNvPr>
            <p:cNvSpPr txBox="1"/>
            <p:nvPr/>
          </p:nvSpPr>
          <p:spPr>
            <a:xfrm>
              <a:off x="7503545" y="4439322"/>
              <a:ext cx="8046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</a:t>
              </a:r>
            </a:p>
          </p:txBody>
        </p:sp>
        <p:cxnSp>
          <p:nvCxnSpPr>
            <p:cNvPr id="39" name="Connettore diritto 36">
              <a:extLst>
                <a:ext uri="{FF2B5EF4-FFF2-40B4-BE49-F238E27FC236}">
                  <a16:creationId xmlns:a16="http://schemas.microsoft.com/office/drawing/2014/main" id="{0487D47E-0AE0-3E53-81B9-6FDF31D43C84}"/>
                </a:ext>
              </a:extLst>
            </p:cNvPr>
            <p:cNvCxnSpPr>
              <a:cxnSpLocks/>
            </p:cNvCxnSpPr>
            <p:nvPr/>
          </p:nvCxnSpPr>
          <p:spPr>
            <a:xfrm>
              <a:off x="6578668" y="4462884"/>
              <a:ext cx="82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nettore diritto 37">
              <a:extLst>
                <a:ext uri="{FF2B5EF4-FFF2-40B4-BE49-F238E27FC236}">
                  <a16:creationId xmlns:a16="http://schemas.microsoft.com/office/drawing/2014/main" id="{D83CC40D-375D-3BD5-CB2E-2CE1DC89C87D}"/>
                </a:ext>
              </a:extLst>
            </p:cNvPr>
            <p:cNvCxnSpPr>
              <a:cxnSpLocks/>
            </p:cNvCxnSpPr>
            <p:nvPr/>
          </p:nvCxnSpPr>
          <p:spPr>
            <a:xfrm>
              <a:off x="7503545" y="4462884"/>
              <a:ext cx="82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687560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D14DA2B-2EE3-29B6-4037-76B929177EF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uppo 37">
            <a:extLst>
              <a:ext uri="{FF2B5EF4-FFF2-40B4-BE49-F238E27FC236}">
                <a16:creationId xmlns:a16="http://schemas.microsoft.com/office/drawing/2014/main" id="{BEB6FB7C-E7D0-7380-40E0-02D60F59DD11}"/>
              </a:ext>
            </a:extLst>
          </p:cNvPr>
          <p:cNvGrpSpPr/>
          <p:nvPr/>
        </p:nvGrpSpPr>
        <p:grpSpPr>
          <a:xfrm>
            <a:off x="744331" y="308135"/>
            <a:ext cx="7241314" cy="6254975"/>
            <a:chOff x="744331" y="308135"/>
            <a:chExt cx="7241314" cy="6254975"/>
          </a:xfrm>
        </p:grpSpPr>
        <p:sp>
          <p:nvSpPr>
            <p:cNvPr id="2" name="Rettangolo 1">
              <a:extLst>
                <a:ext uri="{FF2B5EF4-FFF2-40B4-BE49-F238E27FC236}">
                  <a16:creationId xmlns:a16="http://schemas.microsoft.com/office/drawing/2014/main" id="{0F2313C8-39AF-6960-C8AD-17334ED7FE42}"/>
                </a:ext>
              </a:extLst>
            </p:cNvPr>
            <p:cNvSpPr/>
            <p:nvPr/>
          </p:nvSpPr>
          <p:spPr>
            <a:xfrm>
              <a:off x="744331" y="376844"/>
              <a:ext cx="7241313" cy="61292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CH"/>
            </a:p>
          </p:txBody>
        </p:sp>
        <p:grpSp>
          <p:nvGrpSpPr>
            <p:cNvPr id="20" name="Gruppo 19">
              <a:extLst>
                <a:ext uri="{FF2B5EF4-FFF2-40B4-BE49-F238E27FC236}">
                  <a16:creationId xmlns:a16="http://schemas.microsoft.com/office/drawing/2014/main" id="{832D4013-8851-7383-0098-19AB8A88C869}"/>
                </a:ext>
              </a:extLst>
            </p:cNvPr>
            <p:cNvGrpSpPr/>
            <p:nvPr/>
          </p:nvGrpSpPr>
          <p:grpSpPr>
            <a:xfrm>
              <a:off x="3811249" y="3659734"/>
              <a:ext cx="2001978" cy="2903376"/>
              <a:chOff x="5983667" y="3659734"/>
              <a:chExt cx="2001978" cy="2903376"/>
            </a:xfrm>
          </p:grpSpPr>
          <p:pic>
            <p:nvPicPr>
              <p:cNvPr id="21" name="Immagine 20" descr="Immagine che contiene nero, clarinetto&#10;&#10;Il contenuto generato dall'IA potrebbe non essere corretto.">
                <a:extLst>
                  <a:ext uri="{FF2B5EF4-FFF2-40B4-BE49-F238E27FC236}">
                    <a16:creationId xmlns:a16="http://schemas.microsoft.com/office/drawing/2014/main" id="{0C26A48F-6E7E-3F90-B5E0-A869B80A963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6061657" y="3914776"/>
                <a:ext cx="1677685" cy="2352420"/>
              </a:xfrm>
              <a:prstGeom prst="rect">
                <a:avLst/>
              </a:prstGeom>
            </p:spPr>
          </p:pic>
          <p:sp>
            <p:nvSpPr>
              <p:cNvPr id="22" name="CasellaDiTesto 32">
                <a:extLst>
                  <a:ext uri="{FF2B5EF4-FFF2-40B4-BE49-F238E27FC236}">
                    <a16:creationId xmlns:a16="http://schemas.microsoft.com/office/drawing/2014/main" id="{F3CBA636-4E5A-6FA1-5CCD-E47692693D2A}"/>
                  </a:ext>
                </a:extLst>
              </p:cNvPr>
              <p:cNvSpPr txBox="1"/>
              <p:nvPr/>
            </p:nvSpPr>
            <p:spPr>
              <a:xfrm rot="16200000">
                <a:off x="7489821" y="5034462"/>
                <a:ext cx="7146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rgbClr val="FF0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actin</a:t>
                </a:r>
              </a:p>
            </p:txBody>
          </p:sp>
          <p:sp>
            <p:nvSpPr>
              <p:cNvPr id="24" name="CasellaDiTesto 23">
                <a:extLst>
                  <a:ext uri="{FF2B5EF4-FFF2-40B4-BE49-F238E27FC236}">
                    <a16:creationId xmlns:a16="http://schemas.microsoft.com/office/drawing/2014/main" id="{9B3C0FB4-E20A-15E0-125E-35EC88DB0BDC}"/>
                  </a:ext>
                </a:extLst>
              </p:cNvPr>
              <p:cNvSpPr txBox="1"/>
              <p:nvPr/>
            </p:nvSpPr>
            <p:spPr>
              <a:xfrm>
                <a:off x="6170136" y="6286111"/>
                <a:ext cx="72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ctrl</a:t>
                </a:r>
              </a:p>
            </p:txBody>
          </p:sp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48127C44-2DFF-63A1-47AC-44F2AE75ED2B}"/>
                  </a:ext>
                </a:extLst>
              </p:cNvPr>
              <p:cNvSpPr txBox="1"/>
              <p:nvPr/>
            </p:nvSpPr>
            <p:spPr>
              <a:xfrm>
                <a:off x="6988645" y="6286111"/>
                <a:ext cx="72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KD</a:t>
                </a:r>
              </a:p>
            </p:txBody>
          </p:sp>
          <p:cxnSp>
            <p:nvCxnSpPr>
              <p:cNvPr id="30" name="Connettore diritto 36">
                <a:extLst>
                  <a:ext uri="{FF2B5EF4-FFF2-40B4-BE49-F238E27FC236}">
                    <a16:creationId xmlns:a16="http://schemas.microsoft.com/office/drawing/2014/main" id="{C8BD61FF-4AC4-FC7D-DECC-1F6E19B853B3}"/>
                  </a:ext>
                </a:extLst>
              </p:cNvPr>
              <p:cNvCxnSpPr/>
              <p:nvPr/>
            </p:nvCxnSpPr>
            <p:spPr>
              <a:xfrm>
                <a:off x="6170136" y="6309673"/>
                <a:ext cx="72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ttore diritto 37">
                <a:extLst>
                  <a:ext uri="{FF2B5EF4-FFF2-40B4-BE49-F238E27FC236}">
                    <a16:creationId xmlns:a16="http://schemas.microsoft.com/office/drawing/2014/main" id="{1F2E1880-F4FF-28CE-3517-018CF6A331AF}"/>
                  </a:ext>
                </a:extLst>
              </p:cNvPr>
              <p:cNvCxnSpPr/>
              <p:nvPr/>
            </p:nvCxnSpPr>
            <p:spPr>
              <a:xfrm>
                <a:off x="6988644" y="6309673"/>
                <a:ext cx="72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CasellaDiTesto 32">
                <a:extLst>
                  <a:ext uri="{FF2B5EF4-FFF2-40B4-BE49-F238E27FC236}">
                    <a16:creationId xmlns:a16="http://schemas.microsoft.com/office/drawing/2014/main" id="{B5C5D322-6450-C255-9827-7B1F5ACBB527}"/>
                  </a:ext>
                </a:extLst>
              </p:cNvPr>
              <p:cNvSpPr txBox="1"/>
              <p:nvPr/>
            </p:nvSpPr>
            <p:spPr>
              <a:xfrm>
                <a:off x="5983667" y="3659734"/>
                <a:ext cx="18336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TC-32</a:t>
                </a:r>
              </a:p>
            </p:txBody>
          </p:sp>
        </p:grpSp>
        <p:grpSp>
          <p:nvGrpSpPr>
            <p:cNvPr id="11" name="Gruppo 10">
              <a:extLst>
                <a:ext uri="{FF2B5EF4-FFF2-40B4-BE49-F238E27FC236}">
                  <a16:creationId xmlns:a16="http://schemas.microsoft.com/office/drawing/2014/main" id="{D3B3BDA8-D812-7BBE-AB54-2BF846686F6C}"/>
                </a:ext>
              </a:extLst>
            </p:cNvPr>
            <p:cNvGrpSpPr/>
            <p:nvPr/>
          </p:nvGrpSpPr>
          <p:grpSpPr>
            <a:xfrm>
              <a:off x="5983665" y="3659734"/>
              <a:ext cx="1958656" cy="2903376"/>
              <a:chOff x="3854571" y="3659734"/>
              <a:chExt cx="1958656" cy="2903376"/>
            </a:xfrm>
          </p:grpSpPr>
          <p:pic>
            <p:nvPicPr>
              <p:cNvPr id="12" name="Immagine 11" descr="Immagine che contiene nero, schizzo, bianco e nero, monocromatico&#10;&#10;Il contenuto generato dall'IA potrebbe non essere corretto.">
                <a:extLst>
                  <a:ext uri="{FF2B5EF4-FFF2-40B4-BE49-F238E27FC236}">
                    <a16:creationId xmlns:a16="http://schemas.microsoft.com/office/drawing/2014/main" id="{1B1FB0C8-F721-7CFE-95C8-7A9125EFD22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164" t="7822" r="13077" b="11394"/>
              <a:stretch/>
            </p:blipFill>
            <p:spPr>
              <a:xfrm>
                <a:off x="3932560" y="3914776"/>
                <a:ext cx="1677686" cy="2352421"/>
              </a:xfrm>
              <a:prstGeom prst="rect">
                <a:avLst/>
              </a:prstGeom>
            </p:spPr>
          </p:pic>
          <p:sp>
            <p:nvSpPr>
              <p:cNvPr id="13" name="CasellaDiTesto 32">
                <a:extLst>
                  <a:ext uri="{FF2B5EF4-FFF2-40B4-BE49-F238E27FC236}">
                    <a16:creationId xmlns:a16="http://schemas.microsoft.com/office/drawing/2014/main" id="{7262DD48-FEFC-6035-913F-5D5B728E3867}"/>
                  </a:ext>
                </a:extLst>
              </p:cNvPr>
              <p:cNvSpPr txBox="1"/>
              <p:nvPr/>
            </p:nvSpPr>
            <p:spPr>
              <a:xfrm rot="16200000">
                <a:off x="5305087" y="5266717"/>
                <a:ext cx="7392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rgbClr val="00B05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vimentin</a:t>
                </a: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BF7D2F36-F4D0-B795-D5A1-34D703413BAC}"/>
                  </a:ext>
                </a:extLst>
              </p:cNvPr>
              <p:cNvSpPr txBox="1"/>
              <p:nvPr/>
            </p:nvSpPr>
            <p:spPr>
              <a:xfrm>
                <a:off x="4029551" y="6286111"/>
                <a:ext cx="72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ctrl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7657D9F4-D9F6-0B44-A3AD-6E8CB6FEB9B9}"/>
                  </a:ext>
                </a:extLst>
              </p:cNvPr>
              <p:cNvSpPr txBox="1"/>
              <p:nvPr/>
            </p:nvSpPr>
            <p:spPr>
              <a:xfrm>
                <a:off x="4848060" y="6286111"/>
                <a:ext cx="72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KD</a:t>
                </a:r>
              </a:p>
            </p:txBody>
          </p:sp>
          <p:cxnSp>
            <p:nvCxnSpPr>
              <p:cNvPr id="16" name="Connettore diritto 36">
                <a:extLst>
                  <a:ext uri="{FF2B5EF4-FFF2-40B4-BE49-F238E27FC236}">
                    <a16:creationId xmlns:a16="http://schemas.microsoft.com/office/drawing/2014/main" id="{40EAF4F2-CF1C-A295-79B6-C51F4ABF589C}"/>
                  </a:ext>
                </a:extLst>
              </p:cNvPr>
              <p:cNvCxnSpPr/>
              <p:nvPr/>
            </p:nvCxnSpPr>
            <p:spPr>
              <a:xfrm>
                <a:off x="4029551" y="6309673"/>
                <a:ext cx="72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nettore diritto 37">
                <a:extLst>
                  <a:ext uri="{FF2B5EF4-FFF2-40B4-BE49-F238E27FC236}">
                    <a16:creationId xmlns:a16="http://schemas.microsoft.com/office/drawing/2014/main" id="{8C0BF829-1F53-5062-06D6-9993E4236C0B}"/>
                  </a:ext>
                </a:extLst>
              </p:cNvPr>
              <p:cNvCxnSpPr/>
              <p:nvPr/>
            </p:nvCxnSpPr>
            <p:spPr>
              <a:xfrm>
                <a:off x="4848059" y="6309673"/>
                <a:ext cx="72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CasellaDiTesto 32">
                <a:extLst>
                  <a:ext uri="{FF2B5EF4-FFF2-40B4-BE49-F238E27FC236}">
                    <a16:creationId xmlns:a16="http://schemas.microsoft.com/office/drawing/2014/main" id="{57628AA5-B057-E4DF-A87C-0BDE2EE0F889}"/>
                  </a:ext>
                </a:extLst>
              </p:cNvPr>
              <p:cNvSpPr txBox="1"/>
              <p:nvPr/>
            </p:nvSpPr>
            <p:spPr>
              <a:xfrm>
                <a:off x="3854571" y="3659734"/>
                <a:ext cx="183366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TC-32</a:t>
                </a:r>
              </a:p>
            </p:txBody>
          </p:sp>
        </p:grp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E4A8639E-7F61-4487-721D-EC82AB04FF01}"/>
                </a:ext>
              </a:extLst>
            </p:cNvPr>
            <p:cNvSpPr txBox="1"/>
            <p:nvPr/>
          </p:nvSpPr>
          <p:spPr>
            <a:xfrm>
              <a:off x="768226" y="308135"/>
              <a:ext cx="98706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600" b="1" dirty="0"/>
                <a:t>Figure 4A</a:t>
              </a:r>
              <a:endParaRPr lang="en-US" sz="1600" b="1" dirty="0"/>
            </a:p>
          </p:txBody>
        </p:sp>
        <p:sp>
          <p:nvSpPr>
            <p:cNvPr id="23" name="CasellaDiTesto 42">
              <a:extLst>
                <a:ext uri="{FF2B5EF4-FFF2-40B4-BE49-F238E27FC236}">
                  <a16:creationId xmlns:a16="http://schemas.microsoft.com/office/drawing/2014/main" id="{94082EC9-E5FE-0F81-6B4D-B80888E7DAFC}"/>
                </a:ext>
              </a:extLst>
            </p:cNvPr>
            <p:cNvSpPr txBox="1"/>
            <p:nvPr/>
          </p:nvSpPr>
          <p:spPr>
            <a:xfrm>
              <a:off x="1069048" y="666098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 err="1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a</a:t>
              </a:r>
              <a:endParaRPr lang="en-US" sz="8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5" name="CasellaDiTesto 46">
              <a:extLst>
                <a:ext uri="{FF2B5EF4-FFF2-40B4-BE49-F238E27FC236}">
                  <a16:creationId xmlns:a16="http://schemas.microsoft.com/office/drawing/2014/main" id="{6A32C781-CF2D-5906-67B2-569E5B0CF82B}"/>
                </a:ext>
              </a:extLst>
            </p:cNvPr>
            <p:cNvSpPr txBox="1"/>
            <p:nvPr/>
          </p:nvSpPr>
          <p:spPr>
            <a:xfrm>
              <a:off x="817125" y="1441800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95 -</a:t>
              </a:r>
            </a:p>
          </p:txBody>
        </p:sp>
        <p:sp>
          <p:nvSpPr>
            <p:cNvPr id="27" name="CasellaDiTesto 47">
              <a:extLst>
                <a:ext uri="{FF2B5EF4-FFF2-40B4-BE49-F238E27FC236}">
                  <a16:creationId xmlns:a16="http://schemas.microsoft.com/office/drawing/2014/main" id="{C1E07B41-AD77-4860-8C15-64C4A6D8DC32}"/>
                </a:ext>
              </a:extLst>
            </p:cNvPr>
            <p:cNvSpPr txBox="1"/>
            <p:nvPr/>
          </p:nvSpPr>
          <p:spPr>
            <a:xfrm>
              <a:off x="817125" y="1688263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70 -</a:t>
              </a:r>
            </a:p>
          </p:txBody>
        </p:sp>
        <p:sp>
          <p:nvSpPr>
            <p:cNvPr id="28" name="CasellaDiTesto 48">
              <a:extLst>
                <a:ext uri="{FF2B5EF4-FFF2-40B4-BE49-F238E27FC236}">
                  <a16:creationId xmlns:a16="http://schemas.microsoft.com/office/drawing/2014/main" id="{DB2B4EB2-D255-4B4E-3829-9128EAC18D9B}"/>
                </a:ext>
              </a:extLst>
            </p:cNvPr>
            <p:cNvSpPr txBox="1"/>
            <p:nvPr/>
          </p:nvSpPr>
          <p:spPr>
            <a:xfrm>
              <a:off x="817125" y="1931265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5 -</a:t>
              </a:r>
            </a:p>
          </p:txBody>
        </p:sp>
        <p:sp>
          <p:nvSpPr>
            <p:cNvPr id="29" name="CasellaDiTesto 49">
              <a:extLst>
                <a:ext uri="{FF2B5EF4-FFF2-40B4-BE49-F238E27FC236}">
                  <a16:creationId xmlns:a16="http://schemas.microsoft.com/office/drawing/2014/main" id="{B825C897-DF5F-21AD-FBD5-674CCDF8AB34}"/>
                </a:ext>
              </a:extLst>
            </p:cNvPr>
            <p:cNvSpPr txBox="1"/>
            <p:nvPr/>
          </p:nvSpPr>
          <p:spPr>
            <a:xfrm>
              <a:off x="765829" y="1225024"/>
              <a:ext cx="3930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30 -</a:t>
              </a:r>
            </a:p>
          </p:txBody>
        </p:sp>
        <p:sp>
          <p:nvSpPr>
            <p:cNvPr id="31" name="CasellaDiTesto 51">
              <a:extLst>
                <a:ext uri="{FF2B5EF4-FFF2-40B4-BE49-F238E27FC236}">
                  <a16:creationId xmlns:a16="http://schemas.microsoft.com/office/drawing/2014/main" id="{D169E6D4-D7A6-79F2-2863-5673767129AA}"/>
                </a:ext>
              </a:extLst>
            </p:cNvPr>
            <p:cNvSpPr txBox="1"/>
            <p:nvPr/>
          </p:nvSpPr>
          <p:spPr>
            <a:xfrm>
              <a:off x="760145" y="992466"/>
              <a:ext cx="3930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50 -</a:t>
              </a:r>
            </a:p>
          </p:txBody>
        </p:sp>
        <p:sp>
          <p:nvSpPr>
            <p:cNvPr id="40" name="CasellaDiTesto 48">
              <a:extLst>
                <a:ext uri="{FF2B5EF4-FFF2-40B4-BE49-F238E27FC236}">
                  <a16:creationId xmlns:a16="http://schemas.microsoft.com/office/drawing/2014/main" id="{CA8FD352-A0FB-6C62-57C0-69E31CD9449F}"/>
                </a:ext>
              </a:extLst>
            </p:cNvPr>
            <p:cNvSpPr txBox="1"/>
            <p:nvPr/>
          </p:nvSpPr>
          <p:spPr>
            <a:xfrm>
              <a:off x="817125" y="2507282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4 -</a:t>
              </a:r>
            </a:p>
          </p:txBody>
        </p:sp>
        <p:sp>
          <p:nvSpPr>
            <p:cNvPr id="42" name="CasellaDiTesto 48">
              <a:extLst>
                <a:ext uri="{FF2B5EF4-FFF2-40B4-BE49-F238E27FC236}">
                  <a16:creationId xmlns:a16="http://schemas.microsoft.com/office/drawing/2014/main" id="{454F19F0-4D86-829B-01CC-B3EA3F9DBC5B}"/>
                </a:ext>
              </a:extLst>
            </p:cNvPr>
            <p:cNvSpPr txBox="1"/>
            <p:nvPr/>
          </p:nvSpPr>
          <p:spPr>
            <a:xfrm>
              <a:off x="817124" y="2208535"/>
              <a:ext cx="3417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43 -</a:t>
              </a:r>
            </a:p>
          </p:txBody>
        </p:sp>
        <p:sp>
          <p:nvSpPr>
            <p:cNvPr id="43" name="CasellaDiTesto 48">
              <a:extLst>
                <a:ext uri="{FF2B5EF4-FFF2-40B4-BE49-F238E27FC236}">
                  <a16:creationId xmlns:a16="http://schemas.microsoft.com/office/drawing/2014/main" id="{8D51657C-210D-0488-8222-784955AB0E05}"/>
                </a:ext>
              </a:extLst>
            </p:cNvPr>
            <p:cNvSpPr txBox="1"/>
            <p:nvPr/>
          </p:nvSpPr>
          <p:spPr>
            <a:xfrm>
              <a:off x="817124" y="2831683"/>
              <a:ext cx="3417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6 -</a:t>
              </a:r>
            </a:p>
          </p:txBody>
        </p:sp>
        <p:pic>
          <p:nvPicPr>
            <p:cNvPr id="6" name="Image 9">
              <a:extLst>
                <a:ext uri="{FF2B5EF4-FFF2-40B4-BE49-F238E27FC236}">
                  <a16:creationId xmlns:a16="http://schemas.microsoft.com/office/drawing/2014/main" id="{1A80DAE1-BCB7-FFBA-EC82-0A8BAA75A87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728067" y="881542"/>
              <a:ext cx="1882179" cy="2352420"/>
            </a:xfrm>
            <a:prstGeom prst="rect">
              <a:avLst/>
            </a:prstGeom>
          </p:spPr>
        </p:pic>
        <p:pic>
          <p:nvPicPr>
            <p:cNvPr id="7" name="Image 11">
              <a:extLst>
                <a:ext uri="{FF2B5EF4-FFF2-40B4-BE49-F238E27FC236}">
                  <a16:creationId xmlns:a16="http://schemas.microsoft.com/office/drawing/2014/main" id="{EAEE0763-ADA5-04E9-3833-6533E1DCA8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823469" y="881542"/>
              <a:ext cx="1918282" cy="2352420"/>
            </a:xfrm>
            <a:prstGeom prst="rect">
              <a:avLst/>
            </a:prstGeom>
          </p:spPr>
        </p:pic>
        <p:pic>
          <p:nvPicPr>
            <p:cNvPr id="8" name="Image 20">
              <a:extLst>
                <a:ext uri="{FF2B5EF4-FFF2-40B4-BE49-F238E27FC236}">
                  <a16:creationId xmlns:a16="http://schemas.microsoft.com/office/drawing/2014/main" id="{B81878B3-EB87-B4C2-3D07-F60C790368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089547" y="881542"/>
              <a:ext cx="1995648" cy="2352420"/>
            </a:xfrm>
            <a:prstGeom prst="rect">
              <a:avLst/>
            </a:prstGeom>
          </p:spPr>
        </p:pic>
        <p:sp>
          <p:nvSpPr>
            <p:cNvPr id="19" name="CasellaDiTesto 40">
              <a:extLst>
                <a:ext uri="{FF2B5EF4-FFF2-40B4-BE49-F238E27FC236}">
                  <a16:creationId xmlns:a16="http://schemas.microsoft.com/office/drawing/2014/main" id="{E78A0CBD-8061-39CB-A957-E38207800084}"/>
                </a:ext>
              </a:extLst>
            </p:cNvPr>
            <p:cNvSpPr txBox="1"/>
            <p:nvPr/>
          </p:nvSpPr>
          <p:spPr>
            <a:xfrm>
              <a:off x="3062772" y="2383643"/>
              <a:ext cx="944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CH" sz="1000" dirty="0">
                  <a:solidFill>
                    <a:srgbClr val="00B050"/>
                  </a:solidFill>
                </a:rPr>
                <a:t>GAPDH</a:t>
              </a: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2FE3E261-F808-132B-7142-A6D8AEEEB93A}"/>
                </a:ext>
              </a:extLst>
            </p:cNvPr>
            <p:cNvSpPr txBox="1"/>
            <p:nvPr/>
          </p:nvSpPr>
          <p:spPr>
            <a:xfrm>
              <a:off x="1355707" y="3255201"/>
              <a:ext cx="72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trl</a:t>
              </a: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D5E1D10B-72F7-0EBA-2F71-008A995CD2BA}"/>
                </a:ext>
              </a:extLst>
            </p:cNvPr>
            <p:cNvSpPr txBox="1"/>
            <p:nvPr/>
          </p:nvSpPr>
          <p:spPr>
            <a:xfrm>
              <a:off x="2174216" y="3255201"/>
              <a:ext cx="72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</a:t>
              </a:r>
            </a:p>
          </p:txBody>
        </p:sp>
        <p:cxnSp>
          <p:nvCxnSpPr>
            <p:cNvPr id="36" name="Connettore diritto 36">
              <a:extLst>
                <a:ext uri="{FF2B5EF4-FFF2-40B4-BE49-F238E27FC236}">
                  <a16:creationId xmlns:a16="http://schemas.microsoft.com/office/drawing/2014/main" id="{817EC3B6-0E56-C656-93C8-74BF45B61EE1}"/>
                </a:ext>
              </a:extLst>
            </p:cNvPr>
            <p:cNvCxnSpPr/>
            <p:nvPr/>
          </p:nvCxnSpPr>
          <p:spPr>
            <a:xfrm>
              <a:off x="1355707" y="3278763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nettore diritto 37">
              <a:extLst>
                <a:ext uri="{FF2B5EF4-FFF2-40B4-BE49-F238E27FC236}">
                  <a16:creationId xmlns:a16="http://schemas.microsoft.com/office/drawing/2014/main" id="{08698898-CDC5-6BC8-2C4F-73FF9221BB82}"/>
                </a:ext>
              </a:extLst>
            </p:cNvPr>
            <p:cNvCxnSpPr/>
            <p:nvPr/>
          </p:nvCxnSpPr>
          <p:spPr>
            <a:xfrm>
              <a:off x="2174215" y="3278763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ttore diritto 37">
              <a:extLst>
                <a:ext uri="{FF2B5EF4-FFF2-40B4-BE49-F238E27FC236}">
                  <a16:creationId xmlns:a16="http://schemas.microsoft.com/office/drawing/2014/main" id="{C1AE5DB4-444E-74CE-64B5-E20A2E804D61}"/>
                </a:ext>
              </a:extLst>
            </p:cNvPr>
            <p:cNvCxnSpPr>
              <a:cxnSpLocks/>
            </p:cNvCxnSpPr>
            <p:nvPr/>
          </p:nvCxnSpPr>
          <p:spPr>
            <a:xfrm>
              <a:off x="3108019" y="1253638"/>
              <a:ext cx="0" cy="396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CasellaDiTesto 32">
              <a:extLst>
                <a:ext uri="{FF2B5EF4-FFF2-40B4-BE49-F238E27FC236}">
                  <a16:creationId xmlns:a16="http://schemas.microsoft.com/office/drawing/2014/main" id="{CC5A0E71-4626-E638-A887-4EE65659C14F}"/>
                </a:ext>
              </a:extLst>
            </p:cNvPr>
            <p:cNvSpPr txBox="1"/>
            <p:nvPr/>
          </p:nvSpPr>
          <p:spPr>
            <a:xfrm>
              <a:off x="1212944" y="620384"/>
              <a:ext cx="18336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C-32</a:t>
              </a:r>
            </a:p>
          </p:txBody>
        </p:sp>
        <p:sp>
          <p:nvSpPr>
            <p:cNvPr id="52" name="CasellaDiTesto 40">
              <a:extLst>
                <a:ext uri="{FF2B5EF4-FFF2-40B4-BE49-F238E27FC236}">
                  <a16:creationId xmlns:a16="http://schemas.microsoft.com/office/drawing/2014/main" id="{74F97A0B-CB07-FE04-5D6D-9A64C468D388}"/>
                </a:ext>
              </a:extLst>
            </p:cNvPr>
            <p:cNvSpPr txBox="1"/>
            <p:nvPr/>
          </p:nvSpPr>
          <p:spPr>
            <a:xfrm>
              <a:off x="3062772" y="1318637"/>
              <a:ext cx="944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CH" sz="1000" dirty="0">
                  <a:solidFill>
                    <a:srgbClr val="FF0000"/>
                  </a:solidFill>
                </a:rPr>
                <a:t>P-FAK/</a:t>
              </a:r>
              <a:r>
                <a:rPr lang="it-CH" sz="1000" dirty="0">
                  <a:solidFill>
                    <a:srgbClr val="00B050"/>
                  </a:solidFill>
                </a:rPr>
                <a:t>FAK</a:t>
              </a:r>
            </a:p>
          </p:txBody>
        </p:sp>
        <p:sp>
          <p:nvSpPr>
            <p:cNvPr id="53" name="CasellaDiTesto 40">
              <a:extLst>
                <a:ext uri="{FF2B5EF4-FFF2-40B4-BE49-F238E27FC236}">
                  <a16:creationId xmlns:a16="http://schemas.microsoft.com/office/drawing/2014/main" id="{082EF365-FE59-A268-B356-5739D05AF6F5}"/>
                </a:ext>
              </a:extLst>
            </p:cNvPr>
            <p:cNvSpPr txBox="1"/>
            <p:nvPr/>
          </p:nvSpPr>
          <p:spPr>
            <a:xfrm>
              <a:off x="3062772" y="2170672"/>
              <a:ext cx="944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CH" sz="1000" dirty="0" err="1">
                  <a:solidFill>
                    <a:srgbClr val="FF0000"/>
                  </a:solidFill>
                </a:rPr>
                <a:t>actin</a:t>
              </a:r>
              <a:endParaRPr lang="it-CH" sz="1000" dirty="0">
                <a:solidFill>
                  <a:srgbClr val="00B050"/>
                </a:solidFill>
              </a:endParaRPr>
            </a:p>
          </p:txBody>
        </p:sp>
        <p:sp>
          <p:nvSpPr>
            <p:cNvPr id="54" name="CasellaDiTesto 32">
              <a:extLst>
                <a:ext uri="{FF2B5EF4-FFF2-40B4-BE49-F238E27FC236}">
                  <a16:creationId xmlns:a16="http://schemas.microsoft.com/office/drawing/2014/main" id="{BD4739BB-4F3C-0F66-555C-62F5D1350C8B}"/>
                </a:ext>
              </a:extLst>
            </p:cNvPr>
            <p:cNvSpPr txBox="1"/>
            <p:nvPr/>
          </p:nvSpPr>
          <p:spPr>
            <a:xfrm rot="16200000">
              <a:off x="5349235" y="1301968"/>
              <a:ext cx="7146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FF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-FAK</a:t>
              </a:r>
            </a:p>
          </p:txBody>
        </p:sp>
        <p:sp>
          <p:nvSpPr>
            <p:cNvPr id="55" name="CasellaDiTesto 32">
              <a:extLst>
                <a:ext uri="{FF2B5EF4-FFF2-40B4-BE49-F238E27FC236}">
                  <a16:creationId xmlns:a16="http://schemas.microsoft.com/office/drawing/2014/main" id="{AED121F1-7884-2B07-0CFE-19614F722902}"/>
                </a:ext>
              </a:extLst>
            </p:cNvPr>
            <p:cNvSpPr txBox="1"/>
            <p:nvPr/>
          </p:nvSpPr>
          <p:spPr>
            <a:xfrm rot="16200000">
              <a:off x="7489820" y="1301968"/>
              <a:ext cx="7146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B05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FAK</a:t>
              </a:r>
            </a:p>
          </p:txBody>
        </p:sp>
        <p:sp>
          <p:nvSpPr>
            <p:cNvPr id="56" name="CasellaDiTesto 32">
              <a:extLst>
                <a:ext uri="{FF2B5EF4-FFF2-40B4-BE49-F238E27FC236}">
                  <a16:creationId xmlns:a16="http://schemas.microsoft.com/office/drawing/2014/main" id="{C29E1EE4-52E5-ED95-7375-08A14B377F47}"/>
                </a:ext>
              </a:extLst>
            </p:cNvPr>
            <p:cNvSpPr txBox="1"/>
            <p:nvPr/>
          </p:nvSpPr>
          <p:spPr>
            <a:xfrm rot="16200000">
              <a:off x="7489821" y="2389497"/>
              <a:ext cx="7146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B05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GAPDH</a:t>
              </a:r>
            </a:p>
          </p:txBody>
        </p:sp>
        <p:sp>
          <p:nvSpPr>
            <p:cNvPr id="57" name="CasellaDiTesto 32">
              <a:extLst>
                <a:ext uri="{FF2B5EF4-FFF2-40B4-BE49-F238E27FC236}">
                  <a16:creationId xmlns:a16="http://schemas.microsoft.com/office/drawing/2014/main" id="{589B1311-60F7-FCFF-B2F4-DE35958E6125}"/>
                </a:ext>
              </a:extLst>
            </p:cNvPr>
            <p:cNvSpPr txBox="1"/>
            <p:nvPr/>
          </p:nvSpPr>
          <p:spPr>
            <a:xfrm rot="16200000">
              <a:off x="5305086" y="2162406"/>
              <a:ext cx="7392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rgbClr val="FF0000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actin</a:t>
              </a:r>
            </a:p>
          </p:txBody>
        </p:sp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id="{CCF30B8D-926C-A511-B727-BF65FB373E20}"/>
                </a:ext>
              </a:extLst>
            </p:cNvPr>
            <p:cNvSpPr txBox="1"/>
            <p:nvPr/>
          </p:nvSpPr>
          <p:spPr>
            <a:xfrm>
              <a:off x="3956544" y="3255201"/>
              <a:ext cx="72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trl</a:t>
              </a:r>
            </a:p>
          </p:txBody>
        </p:sp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id="{D64B6838-F90B-A858-85F2-6DC239AAE180}"/>
                </a:ext>
              </a:extLst>
            </p:cNvPr>
            <p:cNvSpPr txBox="1"/>
            <p:nvPr/>
          </p:nvSpPr>
          <p:spPr>
            <a:xfrm>
              <a:off x="4775053" y="3255201"/>
              <a:ext cx="72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</a:t>
              </a:r>
            </a:p>
          </p:txBody>
        </p:sp>
        <p:cxnSp>
          <p:nvCxnSpPr>
            <p:cNvPr id="60" name="Connettore diritto 36">
              <a:extLst>
                <a:ext uri="{FF2B5EF4-FFF2-40B4-BE49-F238E27FC236}">
                  <a16:creationId xmlns:a16="http://schemas.microsoft.com/office/drawing/2014/main" id="{55FCFA0D-56D5-10B2-3105-65A13F2352AE}"/>
                </a:ext>
              </a:extLst>
            </p:cNvPr>
            <p:cNvCxnSpPr/>
            <p:nvPr/>
          </p:nvCxnSpPr>
          <p:spPr>
            <a:xfrm>
              <a:off x="3956544" y="3278763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ttore diritto 37">
              <a:extLst>
                <a:ext uri="{FF2B5EF4-FFF2-40B4-BE49-F238E27FC236}">
                  <a16:creationId xmlns:a16="http://schemas.microsoft.com/office/drawing/2014/main" id="{96CF5374-B840-BA33-6E5C-F46D2C61BA0D}"/>
                </a:ext>
              </a:extLst>
            </p:cNvPr>
            <p:cNvCxnSpPr/>
            <p:nvPr/>
          </p:nvCxnSpPr>
          <p:spPr>
            <a:xfrm>
              <a:off x="4775052" y="3278763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CasellaDiTesto 61">
              <a:extLst>
                <a:ext uri="{FF2B5EF4-FFF2-40B4-BE49-F238E27FC236}">
                  <a16:creationId xmlns:a16="http://schemas.microsoft.com/office/drawing/2014/main" id="{D4682E85-5BF4-0652-614C-A90BE0C8390D}"/>
                </a:ext>
              </a:extLst>
            </p:cNvPr>
            <p:cNvSpPr txBox="1"/>
            <p:nvPr/>
          </p:nvSpPr>
          <p:spPr>
            <a:xfrm>
              <a:off x="6170136" y="3255201"/>
              <a:ext cx="72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trl</a:t>
              </a:r>
            </a:p>
          </p:txBody>
        </p: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id="{70EAF17E-02FE-1A64-06FD-34221FC4BCBF}"/>
                </a:ext>
              </a:extLst>
            </p:cNvPr>
            <p:cNvSpPr txBox="1"/>
            <p:nvPr/>
          </p:nvSpPr>
          <p:spPr>
            <a:xfrm>
              <a:off x="6988645" y="3255201"/>
              <a:ext cx="72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</a:t>
              </a:r>
            </a:p>
          </p:txBody>
        </p:sp>
        <p:cxnSp>
          <p:nvCxnSpPr>
            <p:cNvPr id="64" name="Connettore diritto 36">
              <a:extLst>
                <a:ext uri="{FF2B5EF4-FFF2-40B4-BE49-F238E27FC236}">
                  <a16:creationId xmlns:a16="http://schemas.microsoft.com/office/drawing/2014/main" id="{5699411A-9844-166B-4297-9230B6735A2B}"/>
                </a:ext>
              </a:extLst>
            </p:cNvPr>
            <p:cNvCxnSpPr/>
            <p:nvPr/>
          </p:nvCxnSpPr>
          <p:spPr>
            <a:xfrm>
              <a:off x="6170136" y="3278763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nettore diritto 37">
              <a:extLst>
                <a:ext uri="{FF2B5EF4-FFF2-40B4-BE49-F238E27FC236}">
                  <a16:creationId xmlns:a16="http://schemas.microsoft.com/office/drawing/2014/main" id="{E37D9E0D-98CF-BCCD-005F-A856FB359DC5}"/>
                </a:ext>
              </a:extLst>
            </p:cNvPr>
            <p:cNvCxnSpPr/>
            <p:nvPr/>
          </p:nvCxnSpPr>
          <p:spPr>
            <a:xfrm>
              <a:off x="6988644" y="3278763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CasellaDiTesto 32">
              <a:extLst>
                <a:ext uri="{FF2B5EF4-FFF2-40B4-BE49-F238E27FC236}">
                  <a16:creationId xmlns:a16="http://schemas.microsoft.com/office/drawing/2014/main" id="{878891CC-493F-4BEE-D8E4-420E64BBBCB5}"/>
                </a:ext>
              </a:extLst>
            </p:cNvPr>
            <p:cNvSpPr txBox="1"/>
            <p:nvPr/>
          </p:nvSpPr>
          <p:spPr>
            <a:xfrm>
              <a:off x="3858220" y="620384"/>
              <a:ext cx="18336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C-32</a:t>
              </a:r>
            </a:p>
          </p:txBody>
        </p:sp>
        <p:sp>
          <p:nvSpPr>
            <p:cNvPr id="67" name="CasellaDiTesto 32">
              <a:extLst>
                <a:ext uri="{FF2B5EF4-FFF2-40B4-BE49-F238E27FC236}">
                  <a16:creationId xmlns:a16="http://schemas.microsoft.com/office/drawing/2014/main" id="{27C8AE99-5BAD-A0FA-93CB-89AD9AF66906}"/>
                </a:ext>
              </a:extLst>
            </p:cNvPr>
            <p:cNvSpPr txBox="1"/>
            <p:nvPr/>
          </p:nvSpPr>
          <p:spPr>
            <a:xfrm>
              <a:off x="5918330" y="620384"/>
              <a:ext cx="18336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C-32</a:t>
              </a:r>
            </a:p>
          </p:txBody>
        </p:sp>
        <p:pic>
          <p:nvPicPr>
            <p:cNvPr id="79" name="Immagine 78" descr="Immagine che contiene oscurità, luce&#10;&#10;Il contenuto generato dall'IA potrebbe non essere corretto.">
              <a:extLst>
                <a:ext uri="{FF2B5EF4-FFF2-40B4-BE49-F238E27FC236}">
                  <a16:creationId xmlns:a16="http://schemas.microsoft.com/office/drawing/2014/main" id="{DF7007A4-9DFD-6947-FBE7-19B51F8F8E6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128125" y="3914777"/>
              <a:ext cx="1957070" cy="2352420"/>
            </a:xfrm>
            <a:prstGeom prst="rect">
              <a:avLst/>
            </a:prstGeom>
          </p:spPr>
        </p:pic>
        <p:sp>
          <p:nvSpPr>
            <p:cNvPr id="87" name="CasellaDiTesto 42">
              <a:extLst>
                <a:ext uri="{FF2B5EF4-FFF2-40B4-BE49-F238E27FC236}">
                  <a16:creationId xmlns:a16="http://schemas.microsoft.com/office/drawing/2014/main" id="{BEC01F70-5FE4-9E67-3401-ED0A53B0FE16}"/>
                </a:ext>
              </a:extLst>
            </p:cNvPr>
            <p:cNvSpPr txBox="1"/>
            <p:nvPr/>
          </p:nvSpPr>
          <p:spPr>
            <a:xfrm>
              <a:off x="1068819" y="3716837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 err="1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a</a:t>
              </a:r>
              <a:endParaRPr lang="en-US" sz="8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8" name="CasellaDiTesto 46">
              <a:extLst>
                <a:ext uri="{FF2B5EF4-FFF2-40B4-BE49-F238E27FC236}">
                  <a16:creationId xmlns:a16="http://schemas.microsoft.com/office/drawing/2014/main" id="{BCF116FF-01B3-DD1F-20A0-AA4E0E32A53E}"/>
                </a:ext>
              </a:extLst>
            </p:cNvPr>
            <p:cNvSpPr txBox="1"/>
            <p:nvPr/>
          </p:nvSpPr>
          <p:spPr>
            <a:xfrm>
              <a:off x="855720" y="4512477"/>
              <a:ext cx="341760" cy="2265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95 -</a:t>
              </a:r>
            </a:p>
          </p:txBody>
        </p:sp>
        <p:sp>
          <p:nvSpPr>
            <p:cNvPr id="89" name="CasellaDiTesto 47">
              <a:extLst>
                <a:ext uri="{FF2B5EF4-FFF2-40B4-BE49-F238E27FC236}">
                  <a16:creationId xmlns:a16="http://schemas.microsoft.com/office/drawing/2014/main" id="{FC95BDBC-BDB2-FBD5-B281-AD1A49821511}"/>
                </a:ext>
              </a:extLst>
            </p:cNvPr>
            <p:cNvSpPr txBox="1"/>
            <p:nvPr/>
          </p:nvSpPr>
          <p:spPr>
            <a:xfrm>
              <a:off x="855720" y="4787553"/>
              <a:ext cx="341760" cy="2265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70 -</a:t>
              </a:r>
            </a:p>
          </p:txBody>
        </p:sp>
        <p:sp>
          <p:nvSpPr>
            <p:cNvPr id="90" name="CasellaDiTesto 48">
              <a:extLst>
                <a:ext uri="{FF2B5EF4-FFF2-40B4-BE49-F238E27FC236}">
                  <a16:creationId xmlns:a16="http://schemas.microsoft.com/office/drawing/2014/main" id="{0BFD706F-F295-84A4-2B41-4CD54DF8AB47}"/>
                </a:ext>
              </a:extLst>
            </p:cNvPr>
            <p:cNvSpPr txBox="1"/>
            <p:nvPr/>
          </p:nvSpPr>
          <p:spPr>
            <a:xfrm>
              <a:off x="855720" y="5020880"/>
              <a:ext cx="341760" cy="2265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55 -</a:t>
              </a:r>
            </a:p>
          </p:txBody>
        </p:sp>
        <p:sp>
          <p:nvSpPr>
            <p:cNvPr id="91" name="CasellaDiTesto 49">
              <a:extLst>
                <a:ext uri="{FF2B5EF4-FFF2-40B4-BE49-F238E27FC236}">
                  <a16:creationId xmlns:a16="http://schemas.microsoft.com/office/drawing/2014/main" id="{238D2313-9F16-DF34-A4C3-EF0F028E5DFA}"/>
                </a:ext>
              </a:extLst>
            </p:cNvPr>
            <p:cNvSpPr txBox="1"/>
            <p:nvPr/>
          </p:nvSpPr>
          <p:spPr>
            <a:xfrm>
              <a:off x="804424" y="4268626"/>
              <a:ext cx="393056" cy="2265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130 -</a:t>
              </a:r>
            </a:p>
          </p:txBody>
        </p:sp>
        <p:sp>
          <p:nvSpPr>
            <p:cNvPr id="92" name="CasellaDiTesto 51">
              <a:extLst>
                <a:ext uri="{FF2B5EF4-FFF2-40B4-BE49-F238E27FC236}">
                  <a16:creationId xmlns:a16="http://schemas.microsoft.com/office/drawing/2014/main" id="{6809BDC6-E766-F4E4-2102-7E99C318AAE0}"/>
                </a:ext>
              </a:extLst>
            </p:cNvPr>
            <p:cNvSpPr txBox="1"/>
            <p:nvPr/>
          </p:nvSpPr>
          <p:spPr>
            <a:xfrm>
              <a:off x="804424" y="4022468"/>
              <a:ext cx="393056" cy="2265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50 -</a:t>
              </a:r>
            </a:p>
          </p:txBody>
        </p:sp>
        <p:sp>
          <p:nvSpPr>
            <p:cNvPr id="93" name="CasellaDiTesto 48">
              <a:extLst>
                <a:ext uri="{FF2B5EF4-FFF2-40B4-BE49-F238E27FC236}">
                  <a16:creationId xmlns:a16="http://schemas.microsoft.com/office/drawing/2014/main" id="{C03F073E-9F85-5512-D05B-32DD48E9A597}"/>
                </a:ext>
              </a:extLst>
            </p:cNvPr>
            <p:cNvSpPr txBox="1"/>
            <p:nvPr/>
          </p:nvSpPr>
          <p:spPr>
            <a:xfrm>
              <a:off x="855720" y="5702868"/>
              <a:ext cx="341760" cy="2265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34 -</a:t>
              </a:r>
            </a:p>
          </p:txBody>
        </p:sp>
        <p:sp>
          <p:nvSpPr>
            <p:cNvPr id="94" name="CasellaDiTesto 48">
              <a:extLst>
                <a:ext uri="{FF2B5EF4-FFF2-40B4-BE49-F238E27FC236}">
                  <a16:creationId xmlns:a16="http://schemas.microsoft.com/office/drawing/2014/main" id="{93263712-B343-E4D7-30CE-EA8AF245A34C}"/>
                </a:ext>
              </a:extLst>
            </p:cNvPr>
            <p:cNvSpPr txBox="1"/>
            <p:nvPr/>
          </p:nvSpPr>
          <p:spPr>
            <a:xfrm>
              <a:off x="855719" y="5344226"/>
              <a:ext cx="341761" cy="2265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43 -</a:t>
              </a:r>
            </a:p>
          </p:txBody>
        </p:sp>
        <p:sp>
          <p:nvSpPr>
            <p:cNvPr id="95" name="CasellaDiTesto 48">
              <a:extLst>
                <a:ext uri="{FF2B5EF4-FFF2-40B4-BE49-F238E27FC236}">
                  <a16:creationId xmlns:a16="http://schemas.microsoft.com/office/drawing/2014/main" id="{FE04674A-D578-8CF5-6B88-464FE69C0BDE}"/>
                </a:ext>
              </a:extLst>
            </p:cNvPr>
            <p:cNvSpPr txBox="1"/>
            <p:nvPr/>
          </p:nvSpPr>
          <p:spPr>
            <a:xfrm>
              <a:off x="855719" y="6007509"/>
              <a:ext cx="341761" cy="2265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6 -</a:t>
              </a:r>
            </a:p>
          </p:txBody>
        </p:sp>
        <p:sp>
          <p:nvSpPr>
            <p:cNvPr id="97" name="CasellaDiTesto 32">
              <a:extLst>
                <a:ext uri="{FF2B5EF4-FFF2-40B4-BE49-F238E27FC236}">
                  <a16:creationId xmlns:a16="http://schemas.microsoft.com/office/drawing/2014/main" id="{E15CC3FE-2300-C9F3-5AE3-13468A907A99}"/>
                </a:ext>
              </a:extLst>
            </p:cNvPr>
            <p:cNvSpPr txBox="1"/>
            <p:nvPr/>
          </p:nvSpPr>
          <p:spPr>
            <a:xfrm>
              <a:off x="1212944" y="3659734"/>
              <a:ext cx="18336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C-32</a:t>
              </a:r>
            </a:p>
          </p:txBody>
        </p:sp>
        <p:sp>
          <p:nvSpPr>
            <p:cNvPr id="98" name="CasellaDiTesto 97">
              <a:extLst>
                <a:ext uri="{FF2B5EF4-FFF2-40B4-BE49-F238E27FC236}">
                  <a16:creationId xmlns:a16="http://schemas.microsoft.com/office/drawing/2014/main" id="{4A4C23B0-2329-E401-7781-095E8A67BD01}"/>
                </a:ext>
              </a:extLst>
            </p:cNvPr>
            <p:cNvSpPr txBox="1"/>
            <p:nvPr/>
          </p:nvSpPr>
          <p:spPr>
            <a:xfrm>
              <a:off x="1355707" y="6286111"/>
              <a:ext cx="72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ctrl</a:t>
              </a:r>
            </a:p>
          </p:txBody>
        </p:sp>
        <p:sp>
          <p:nvSpPr>
            <p:cNvPr id="99" name="CasellaDiTesto 98">
              <a:extLst>
                <a:ext uri="{FF2B5EF4-FFF2-40B4-BE49-F238E27FC236}">
                  <a16:creationId xmlns:a16="http://schemas.microsoft.com/office/drawing/2014/main" id="{69A39BAD-AA51-C10B-2218-60ED4DD3B7FA}"/>
                </a:ext>
              </a:extLst>
            </p:cNvPr>
            <p:cNvSpPr txBox="1"/>
            <p:nvPr/>
          </p:nvSpPr>
          <p:spPr>
            <a:xfrm>
              <a:off x="2174216" y="6286111"/>
              <a:ext cx="72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KD</a:t>
              </a:r>
            </a:p>
          </p:txBody>
        </p:sp>
        <p:cxnSp>
          <p:nvCxnSpPr>
            <p:cNvPr id="100" name="Connettore diritto 36">
              <a:extLst>
                <a:ext uri="{FF2B5EF4-FFF2-40B4-BE49-F238E27FC236}">
                  <a16:creationId xmlns:a16="http://schemas.microsoft.com/office/drawing/2014/main" id="{22AE6469-2407-E00D-528F-384301D7499C}"/>
                </a:ext>
              </a:extLst>
            </p:cNvPr>
            <p:cNvCxnSpPr/>
            <p:nvPr/>
          </p:nvCxnSpPr>
          <p:spPr>
            <a:xfrm>
              <a:off x="1355707" y="6309673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Connettore diritto 37">
              <a:extLst>
                <a:ext uri="{FF2B5EF4-FFF2-40B4-BE49-F238E27FC236}">
                  <a16:creationId xmlns:a16="http://schemas.microsoft.com/office/drawing/2014/main" id="{DCEC958C-F09A-EEED-0964-4066D3D205AB}"/>
                </a:ext>
              </a:extLst>
            </p:cNvPr>
            <p:cNvCxnSpPr/>
            <p:nvPr/>
          </p:nvCxnSpPr>
          <p:spPr>
            <a:xfrm>
              <a:off x="2174215" y="6309673"/>
              <a:ext cx="72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CasellaDiTesto 40">
              <a:extLst>
                <a:ext uri="{FF2B5EF4-FFF2-40B4-BE49-F238E27FC236}">
                  <a16:creationId xmlns:a16="http://schemas.microsoft.com/office/drawing/2014/main" id="{E4EA594B-0141-F01E-572E-49882E6664DA}"/>
                </a:ext>
              </a:extLst>
            </p:cNvPr>
            <p:cNvSpPr txBox="1"/>
            <p:nvPr/>
          </p:nvSpPr>
          <p:spPr>
            <a:xfrm>
              <a:off x="3062772" y="5024342"/>
              <a:ext cx="944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CH" sz="1000" dirty="0" err="1">
                  <a:solidFill>
                    <a:srgbClr val="00B050"/>
                  </a:solidFill>
                </a:rPr>
                <a:t>vimentin</a:t>
              </a:r>
              <a:endParaRPr lang="it-CH" sz="1000" dirty="0">
                <a:solidFill>
                  <a:srgbClr val="00B050"/>
                </a:solidFill>
              </a:endParaRPr>
            </a:p>
          </p:txBody>
        </p:sp>
        <p:sp>
          <p:nvSpPr>
            <p:cNvPr id="103" name="CasellaDiTesto 40">
              <a:extLst>
                <a:ext uri="{FF2B5EF4-FFF2-40B4-BE49-F238E27FC236}">
                  <a16:creationId xmlns:a16="http://schemas.microsoft.com/office/drawing/2014/main" id="{E766B6E4-73AE-E09F-D361-18C2705BB645}"/>
                </a:ext>
              </a:extLst>
            </p:cNvPr>
            <p:cNvSpPr txBox="1"/>
            <p:nvPr/>
          </p:nvSpPr>
          <p:spPr>
            <a:xfrm>
              <a:off x="3062772" y="5293142"/>
              <a:ext cx="944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CH" sz="1000" dirty="0" err="1">
                  <a:solidFill>
                    <a:srgbClr val="FF0000"/>
                  </a:solidFill>
                </a:rPr>
                <a:t>actin</a:t>
              </a:r>
              <a:endParaRPr lang="it-CH" sz="1000" dirty="0">
                <a:solidFill>
                  <a:srgbClr val="00B050"/>
                </a:solidFill>
              </a:endParaRPr>
            </a:p>
          </p:txBody>
        </p:sp>
        <p:cxnSp>
          <p:nvCxnSpPr>
            <p:cNvPr id="45" name="Connettore diritto 37">
              <a:extLst>
                <a:ext uri="{FF2B5EF4-FFF2-40B4-BE49-F238E27FC236}">
                  <a16:creationId xmlns:a16="http://schemas.microsoft.com/office/drawing/2014/main" id="{CC19713C-8143-8A9E-C47F-D26B09ACB81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40600" y="1222778"/>
              <a:ext cx="6856141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Connettore diritto 37">
              <a:extLst>
                <a:ext uri="{FF2B5EF4-FFF2-40B4-BE49-F238E27FC236}">
                  <a16:creationId xmlns:a16="http://schemas.microsoft.com/office/drawing/2014/main" id="{4EA08565-8C75-5370-0D66-B61C30EC2AC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61189" y="1657244"/>
              <a:ext cx="6856141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543640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o 5">
            <a:extLst>
              <a:ext uri="{FF2B5EF4-FFF2-40B4-BE49-F238E27FC236}">
                <a16:creationId xmlns:a16="http://schemas.microsoft.com/office/drawing/2014/main" id="{0655331B-8831-F855-9381-F3EE0FD8E112}"/>
              </a:ext>
            </a:extLst>
          </p:cNvPr>
          <p:cNvGrpSpPr/>
          <p:nvPr/>
        </p:nvGrpSpPr>
        <p:grpSpPr>
          <a:xfrm>
            <a:off x="84700" y="1220798"/>
            <a:ext cx="9002089" cy="4159329"/>
            <a:chOff x="84700" y="1220798"/>
            <a:chExt cx="9002089" cy="4159329"/>
          </a:xfrm>
        </p:grpSpPr>
        <p:sp>
          <p:nvSpPr>
            <p:cNvPr id="2" name="Rettangolo 1">
              <a:extLst>
                <a:ext uri="{FF2B5EF4-FFF2-40B4-BE49-F238E27FC236}">
                  <a16:creationId xmlns:a16="http://schemas.microsoft.com/office/drawing/2014/main" id="{0E35D1A9-2DF5-429E-90B7-441E57DBFE9F}"/>
                </a:ext>
              </a:extLst>
            </p:cNvPr>
            <p:cNvSpPr/>
            <p:nvPr/>
          </p:nvSpPr>
          <p:spPr>
            <a:xfrm>
              <a:off x="135994" y="1297151"/>
              <a:ext cx="8923305" cy="406055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CH"/>
            </a:p>
          </p:txBody>
        </p:sp>
        <p:sp>
          <p:nvSpPr>
            <p:cNvPr id="4" name="ZoneTexte 40">
              <a:extLst>
                <a:ext uri="{FF2B5EF4-FFF2-40B4-BE49-F238E27FC236}">
                  <a16:creationId xmlns:a16="http://schemas.microsoft.com/office/drawing/2014/main" id="{C6061853-291C-0387-F8C8-2014544DDB83}"/>
                </a:ext>
              </a:extLst>
            </p:cNvPr>
            <p:cNvSpPr txBox="1"/>
            <p:nvPr/>
          </p:nvSpPr>
          <p:spPr>
            <a:xfrm>
              <a:off x="118658" y="1220798"/>
              <a:ext cx="233538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600" b="1" dirty="0" err="1"/>
                <a:t>Supplementary</a:t>
              </a:r>
              <a:r>
                <a:rPr lang="fr-CH" sz="1600" b="1" dirty="0"/>
                <a:t> Figure 1A</a:t>
              </a:r>
              <a:endParaRPr lang="en-US" sz="1600" b="1" dirty="0"/>
            </a:p>
          </p:txBody>
        </p:sp>
        <p:grpSp>
          <p:nvGrpSpPr>
            <p:cNvPr id="89" name="Gruppo 88">
              <a:extLst>
                <a:ext uri="{FF2B5EF4-FFF2-40B4-BE49-F238E27FC236}">
                  <a16:creationId xmlns:a16="http://schemas.microsoft.com/office/drawing/2014/main" id="{F2B05A2B-E531-E2C5-6790-88D956ABC69D}"/>
                </a:ext>
              </a:extLst>
            </p:cNvPr>
            <p:cNvGrpSpPr/>
            <p:nvPr/>
          </p:nvGrpSpPr>
          <p:grpSpPr>
            <a:xfrm>
              <a:off x="84700" y="1500297"/>
              <a:ext cx="9002089" cy="3879830"/>
              <a:chOff x="84700" y="1500297"/>
              <a:chExt cx="9002089" cy="3879830"/>
            </a:xfrm>
          </p:grpSpPr>
          <p:grpSp>
            <p:nvGrpSpPr>
              <p:cNvPr id="86" name="Gruppo 85">
                <a:extLst>
                  <a:ext uri="{FF2B5EF4-FFF2-40B4-BE49-F238E27FC236}">
                    <a16:creationId xmlns:a16="http://schemas.microsoft.com/office/drawing/2014/main" id="{DDEA45CF-6C03-2545-701E-0DF2A8ABD692}"/>
                  </a:ext>
                </a:extLst>
              </p:cNvPr>
              <p:cNvGrpSpPr/>
              <p:nvPr/>
            </p:nvGrpSpPr>
            <p:grpSpPr>
              <a:xfrm>
                <a:off x="84700" y="1500297"/>
                <a:ext cx="3344255" cy="3879830"/>
                <a:chOff x="-2024236" y="1500297"/>
                <a:chExt cx="3344255" cy="3879830"/>
              </a:xfrm>
            </p:grpSpPr>
            <p:sp>
              <p:nvSpPr>
                <p:cNvPr id="9" name="CasellaDiTesto 39">
                  <a:extLst>
                    <a:ext uri="{FF2B5EF4-FFF2-40B4-BE49-F238E27FC236}">
                      <a16:creationId xmlns:a16="http://schemas.microsoft.com/office/drawing/2014/main" id="{40A22D7D-E755-7F91-2970-05ACA534013D}"/>
                    </a:ext>
                  </a:extLst>
                </p:cNvPr>
                <p:cNvSpPr txBox="1"/>
                <p:nvPr/>
              </p:nvSpPr>
              <p:spPr>
                <a:xfrm>
                  <a:off x="830914" y="2776834"/>
                  <a:ext cx="38023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Tau</a:t>
                  </a:r>
                </a:p>
              </p:txBody>
            </p:sp>
            <p:sp>
              <p:nvSpPr>
                <p:cNvPr id="16" name="CasellaDiTesto 42">
                  <a:extLst>
                    <a:ext uri="{FF2B5EF4-FFF2-40B4-BE49-F238E27FC236}">
                      <a16:creationId xmlns:a16="http://schemas.microsoft.com/office/drawing/2014/main" id="{BEFC125E-7CE3-8813-16C2-A8D1DDB82C99}"/>
                    </a:ext>
                  </a:extLst>
                </p:cNvPr>
                <p:cNvSpPr txBox="1"/>
                <p:nvPr/>
              </p:nvSpPr>
              <p:spPr>
                <a:xfrm>
                  <a:off x="-1718416" y="1567189"/>
                  <a:ext cx="3433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 err="1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kDa</a:t>
                  </a:r>
                  <a:endParaRPr lang="en-US" sz="800" dirty="0">
                    <a:solidFill>
                      <a:prstClr val="black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cxnSp>
              <p:nvCxnSpPr>
                <p:cNvPr id="39" name="Connettore diritto 37">
                  <a:extLst>
                    <a:ext uri="{FF2B5EF4-FFF2-40B4-BE49-F238E27FC236}">
                      <a16:creationId xmlns:a16="http://schemas.microsoft.com/office/drawing/2014/main" id="{03075D56-FAF0-C369-2C52-AF9DFCBCBD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85952" y="1901825"/>
                  <a:ext cx="0" cy="1872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" name="CasellaDiTesto 40">
                  <a:extLst>
                    <a:ext uri="{FF2B5EF4-FFF2-40B4-BE49-F238E27FC236}">
                      <a16:creationId xmlns:a16="http://schemas.microsoft.com/office/drawing/2014/main" id="{D901F1B0-EFEF-3E54-AF79-A6CE2363EB83}"/>
                    </a:ext>
                  </a:extLst>
                </p:cNvPr>
                <p:cNvSpPr txBox="1"/>
                <p:nvPr/>
              </p:nvSpPr>
              <p:spPr>
                <a:xfrm>
                  <a:off x="757044" y="3725172"/>
                  <a:ext cx="56297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solidFill>
                        <a:srgbClr val="00B05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GAPDH</a:t>
                  </a:r>
                </a:p>
              </p:txBody>
            </p:sp>
            <p:pic>
              <p:nvPicPr>
                <p:cNvPr id="3" name="Immagine 2">
                  <a:extLst>
                    <a:ext uri="{FF2B5EF4-FFF2-40B4-BE49-F238E27FC236}">
                      <a16:creationId xmlns:a16="http://schemas.microsoft.com/office/drawing/2014/main" id="{985889F2-9248-26C6-4042-B38D244CCF1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-1702889" y="1777349"/>
                  <a:ext cx="2535998" cy="3274545"/>
                </a:xfrm>
                <a:prstGeom prst="rect">
                  <a:avLst/>
                </a:prstGeom>
              </p:spPr>
            </p:pic>
            <p:sp>
              <p:nvSpPr>
                <p:cNvPr id="10" name="CasellaDiTesto 32">
                  <a:extLst>
                    <a:ext uri="{FF2B5EF4-FFF2-40B4-BE49-F238E27FC236}">
                      <a16:creationId xmlns:a16="http://schemas.microsoft.com/office/drawing/2014/main" id="{B5C7A86F-6310-A7E6-3CE1-264192A141E7}"/>
                    </a:ext>
                  </a:extLst>
                </p:cNvPr>
                <p:cNvSpPr txBox="1"/>
                <p:nvPr/>
              </p:nvSpPr>
              <p:spPr>
                <a:xfrm>
                  <a:off x="-1432559" y="1500297"/>
                  <a:ext cx="195834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TC-32</a:t>
                  </a:r>
                </a:p>
              </p:txBody>
            </p:sp>
            <p:sp>
              <p:nvSpPr>
                <p:cNvPr id="12" name="CasellaDiTesto 42">
                  <a:extLst>
                    <a:ext uri="{FF2B5EF4-FFF2-40B4-BE49-F238E27FC236}">
                      <a16:creationId xmlns:a16="http://schemas.microsoft.com/office/drawing/2014/main" id="{B6A08515-F524-05F0-15E0-FD4D5C7797D2}"/>
                    </a:ext>
                  </a:extLst>
                </p:cNvPr>
                <p:cNvSpPr txBox="1"/>
                <p:nvPr/>
              </p:nvSpPr>
              <p:spPr>
                <a:xfrm>
                  <a:off x="-1712621" y="1730909"/>
                  <a:ext cx="3433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 err="1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kDa</a:t>
                  </a:r>
                  <a:endParaRPr lang="en-US" sz="800" dirty="0">
                    <a:solidFill>
                      <a:prstClr val="black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4" name="CasellaDiTesto 46">
                  <a:extLst>
                    <a:ext uri="{FF2B5EF4-FFF2-40B4-BE49-F238E27FC236}">
                      <a16:creationId xmlns:a16="http://schemas.microsoft.com/office/drawing/2014/main" id="{DA891110-7C7E-A644-6B4B-DAA3E0E11D24}"/>
                    </a:ext>
                  </a:extLst>
                </p:cNvPr>
                <p:cNvSpPr txBox="1"/>
                <p:nvPr/>
              </p:nvSpPr>
              <p:spPr>
                <a:xfrm>
                  <a:off x="-1972940" y="2561390"/>
                  <a:ext cx="34176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95 -</a:t>
                  </a:r>
                </a:p>
              </p:txBody>
            </p:sp>
            <p:sp>
              <p:nvSpPr>
                <p:cNvPr id="15" name="CasellaDiTesto 47">
                  <a:extLst>
                    <a:ext uri="{FF2B5EF4-FFF2-40B4-BE49-F238E27FC236}">
                      <a16:creationId xmlns:a16="http://schemas.microsoft.com/office/drawing/2014/main" id="{53029F72-D711-D4B4-5E87-4D7E3AA403C5}"/>
                    </a:ext>
                  </a:extLst>
                </p:cNvPr>
                <p:cNvSpPr txBox="1"/>
                <p:nvPr/>
              </p:nvSpPr>
              <p:spPr>
                <a:xfrm>
                  <a:off x="-1972940" y="2848288"/>
                  <a:ext cx="34176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70 -</a:t>
                  </a:r>
                </a:p>
              </p:txBody>
            </p:sp>
            <p:sp>
              <p:nvSpPr>
                <p:cNvPr id="18" name="CasellaDiTesto 48">
                  <a:extLst>
                    <a:ext uri="{FF2B5EF4-FFF2-40B4-BE49-F238E27FC236}">
                      <a16:creationId xmlns:a16="http://schemas.microsoft.com/office/drawing/2014/main" id="{1E907F25-3A7D-0FB8-B124-1BFD105C229A}"/>
                    </a:ext>
                  </a:extLst>
                </p:cNvPr>
                <p:cNvSpPr txBox="1"/>
                <p:nvPr/>
              </p:nvSpPr>
              <p:spPr>
                <a:xfrm>
                  <a:off x="-1972940" y="3161172"/>
                  <a:ext cx="34176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55 -</a:t>
                  </a:r>
                </a:p>
              </p:txBody>
            </p:sp>
            <p:sp>
              <p:nvSpPr>
                <p:cNvPr id="20" name="CasellaDiTesto 49">
                  <a:extLst>
                    <a:ext uri="{FF2B5EF4-FFF2-40B4-BE49-F238E27FC236}">
                      <a16:creationId xmlns:a16="http://schemas.microsoft.com/office/drawing/2014/main" id="{2FB12205-A63C-14CD-CE15-874197C048B0}"/>
                    </a:ext>
                  </a:extLst>
                </p:cNvPr>
                <p:cNvSpPr txBox="1"/>
                <p:nvPr/>
              </p:nvSpPr>
              <p:spPr>
                <a:xfrm>
                  <a:off x="-2024236" y="2282031"/>
                  <a:ext cx="39305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30 -</a:t>
                  </a:r>
                </a:p>
              </p:txBody>
            </p:sp>
            <p:sp>
              <p:nvSpPr>
                <p:cNvPr id="21" name="CasellaDiTesto 51">
                  <a:extLst>
                    <a:ext uri="{FF2B5EF4-FFF2-40B4-BE49-F238E27FC236}">
                      <a16:creationId xmlns:a16="http://schemas.microsoft.com/office/drawing/2014/main" id="{DB583B02-65F0-81DB-38CA-BBC20E2972B2}"/>
                    </a:ext>
                  </a:extLst>
                </p:cNvPr>
                <p:cNvSpPr txBox="1"/>
                <p:nvPr/>
              </p:nvSpPr>
              <p:spPr>
                <a:xfrm>
                  <a:off x="-2024236" y="1993608"/>
                  <a:ext cx="39305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250 -</a:t>
                  </a:r>
                </a:p>
              </p:txBody>
            </p:sp>
            <p:sp>
              <p:nvSpPr>
                <p:cNvPr id="28" name="CasellaDiTesto 31">
                  <a:extLst>
                    <a:ext uri="{FF2B5EF4-FFF2-40B4-BE49-F238E27FC236}">
                      <a16:creationId xmlns:a16="http://schemas.microsoft.com/office/drawing/2014/main" id="{3AF0E19A-EF0D-3076-7D31-E95DEA1006E2}"/>
                    </a:ext>
                  </a:extLst>
                </p:cNvPr>
                <p:cNvSpPr txBox="1"/>
                <p:nvPr/>
              </p:nvSpPr>
              <p:spPr>
                <a:xfrm>
                  <a:off x="-1327342" y="5103128"/>
                  <a:ext cx="8280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ctrl</a:t>
                  </a:r>
                </a:p>
              </p:txBody>
            </p:sp>
            <p:sp>
              <p:nvSpPr>
                <p:cNvPr id="29" name="CasellaDiTesto 32">
                  <a:extLst>
                    <a:ext uri="{FF2B5EF4-FFF2-40B4-BE49-F238E27FC236}">
                      <a16:creationId xmlns:a16="http://schemas.microsoft.com/office/drawing/2014/main" id="{B1BBCC83-FB09-B69C-4F6A-1439CD43CCAB}"/>
                    </a:ext>
                  </a:extLst>
                </p:cNvPr>
                <p:cNvSpPr txBox="1"/>
                <p:nvPr/>
              </p:nvSpPr>
              <p:spPr>
                <a:xfrm>
                  <a:off x="-357698" y="5103128"/>
                  <a:ext cx="80461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mock</a:t>
                  </a:r>
                </a:p>
              </p:txBody>
            </p:sp>
            <p:cxnSp>
              <p:nvCxnSpPr>
                <p:cNvPr id="30" name="Connettore diritto 36">
                  <a:extLst>
                    <a:ext uri="{FF2B5EF4-FFF2-40B4-BE49-F238E27FC236}">
                      <a16:creationId xmlns:a16="http://schemas.microsoft.com/office/drawing/2014/main" id="{840B2C7C-5203-C925-E6E3-93EA292198E3}"/>
                    </a:ext>
                  </a:extLst>
                </p:cNvPr>
                <p:cNvCxnSpPr/>
                <p:nvPr/>
              </p:nvCxnSpPr>
              <p:spPr>
                <a:xfrm>
                  <a:off x="-1327342" y="5126690"/>
                  <a:ext cx="82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Connettore diritto 37">
                  <a:extLst>
                    <a:ext uri="{FF2B5EF4-FFF2-40B4-BE49-F238E27FC236}">
                      <a16:creationId xmlns:a16="http://schemas.microsoft.com/office/drawing/2014/main" id="{C578F8AB-4C78-8248-69ED-F85E2012868B}"/>
                    </a:ext>
                  </a:extLst>
                </p:cNvPr>
                <p:cNvCxnSpPr/>
                <p:nvPr/>
              </p:nvCxnSpPr>
              <p:spPr>
                <a:xfrm>
                  <a:off x="-357698" y="5126690"/>
                  <a:ext cx="82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" name="CasellaDiTesto 48">
                  <a:extLst>
                    <a:ext uri="{FF2B5EF4-FFF2-40B4-BE49-F238E27FC236}">
                      <a16:creationId xmlns:a16="http://schemas.microsoft.com/office/drawing/2014/main" id="{6CCDFCED-2CAD-A7B5-9F49-FAE5B1A9DB51}"/>
                    </a:ext>
                  </a:extLst>
                </p:cNvPr>
                <p:cNvSpPr txBox="1"/>
                <p:nvPr/>
              </p:nvSpPr>
              <p:spPr>
                <a:xfrm>
                  <a:off x="-1972940" y="3927603"/>
                  <a:ext cx="34176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34 -</a:t>
                  </a:r>
                </a:p>
              </p:txBody>
            </p:sp>
            <p:sp>
              <p:nvSpPr>
                <p:cNvPr id="33" name="CasellaDiTesto 48">
                  <a:extLst>
                    <a:ext uri="{FF2B5EF4-FFF2-40B4-BE49-F238E27FC236}">
                      <a16:creationId xmlns:a16="http://schemas.microsoft.com/office/drawing/2014/main" id="{E17ED80E-E32C-E7C0-EFB3-EAECF0674C2D}"/>
                    </a:ext>
                  </a:extLst>
                </p:cNvPr>
                <p:cNvSpPr txBox="1"/>
                <p:nvPr/>
              </p:nvSpPr>
              <p:spPr>
                <a:xfrm>
                  <a:off x="-1972941" y="3532824"/>
                  <a:ext cx="34176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43 -</a:t>
                  </a:r>
                </a:p>
              </p:txBody>
            </p:sp>
            <p:sp>
              <p:nvSpPr>
                <p:cNvPr id="36" name="CasellaDiTesto 48">
                  <a:extLst>
                    <a:ext uri="{FF2B5EF4-FFF2-40B4-BE49-F238E27FC236}">
                      <a16:creationId xmlns:a16="http://schemas.microsoft.com/office/drawing/2014/main" id="{E3E4D384-0886-FDEE-04BE-936B95AE0681}"/>
                    </a:ext>
                  </a:extLst>
                </p:cNvPr>
                <p:cNvSpPr txBox="1"/>
                <p:nvPr/>
              </p:nvSpPr>
              <p:spPr>
                <a:xfrm>
                  <a:off x="-1972941" y="4337903"/>
                  <a:ext cx="34176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26 -</a:t>
                  </a:r>
                </a:p>
              </p:txBody>
            </p:sp>
            <p:cxnSp>
              <p:nvCxnSpPr>
                <p:cNvPr id="41" name="Connettore diritto 37">
                  <a:extLst>
                    <a:ext uri="{FF2B5EF4-FFF2-40B4-BE49-F238E27FC236}">
                      <a16:creationId xmlns:a16="http://schemas.microsoft.com/office/drawing/2014/main" id="{950C1B20-C080-72F9-947D-282037E7D26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-1855740" y="4383239"/>
                  <a:ext cx="2749658" cy="0"/>
                </a:xfrm>
                <a:prstGeom prst="line">
                  <a:avLst/>
                </a:prstGeom>
                <a:ln w="9525">
                  <a:solidFill>
                    <a:schemeClr val="bg1">
                      <a:lumMod val="75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3" name="CasellaDiTesto 48">
                  <a:extLst>
                    <a:ext uri="{FF2B5EF4-FFF2-40B4-BE49-F238E27FC236}">
                      <a16:creationId xmlns:a16="http://schemas.microsoft.com/office/drawing/2014/main" id="{10677203-306D-47DE-7E66-AC22761342B5}"/>
                    </a:ext>
                  </a:extLst>
                </p:cNvPr>
                <p:cNvSpPr txBox="1"/>
                <p:nvPr/>
              </p:nvSpPr>
              <p:spPr>
                <a:xfrm>
                  <a:off x="-1972941" y="4908382"/>
                  <a:ext cx="34176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800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5 -</a:t>
                  </a:r>
                </a:p>
              </p:txBody>
            </p:sp>
          </p:grpSp>
          <p:grpSp>
            <p:nvGrpSpPr>
              <p:cNvPr id="88" name="Gruppo 87">
                <a:extLst>
                  <a:ext uri="{FF2B5EF4-FFF2-40B4-BE49-F238E27FC236}">
                    <a16:creationId xmlns:a16="http://schemas.microsoft.com/office/drawing/2014/main" id="{F33066A5-C1F4-B291-A09D-E39FD4A10C34}"/>
                  </a:ext>
                </a:extLst>
              </p:cNvPr>
              <p:cNvGrpSpPr/>
              <p:nvPr/>
            </p:nvGrpSpPr>
            <p:grpSpPr>
              <a:xfrm>
                <a:off x="6170359" y="1500297"/>
                <a:ext cx="2916430" cy="3879830"/>
                <a:chOff x="4797117" y="1500297"/>
                <a:chExt cx="2916430" cy="3879830"/>
              </a:xfrm>
            </p:grpSpPr>
            <p:sp>
              <p:nvSpPr>
                <p:cNvPr id="44" name="CasellaDiTesto 32">
                  <a:extLst>
                    <a:ext uri="{FF2B5EF4-FFF2-40B4-BE49-F238E27FC236}">
                      <a16:creationId xmlns:a16="http://schemas.microsoft.com/office/drawing/2014/main" id="{9FA0BCA5-1D4F-2F5B-2367-E29478EC21D1}"/>
                    </a:ext>
                  </a:extLst>
                </p:cNvPr>
                <p:cNvSpPr txBox="1"/>
                <p:nvPr/>
              </p:nvSpPr>
              <p:spPr>
                <a:xfrm>
                  <a:off x="5130543" y="1500297"/>
                  <a:ext cx="205193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TC-32</a:t>
                  </a:r>
                </a:p>
              </p:txBody>
            </p:sp>
            <p:cxnSp>
              <p:nvCxnSpPr>
                <p:cNvPr id="48" name="Connettore diritto 37">
                  <a:extLst>
                    <a:ext uri="{FF2B5EF4-FFF2-40B4-BE49-F238E27FC236}">
                      <a16:creationId xmlns:a16="http://schemas.microsoft.com/office/drawing/2014/main" id="{C5CB7895-DCD2-1F58-32BB-D3B102D7A0F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488369" y="3644830"/>
                  <a:ext cx="0" cy="468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1" name="CasellaDiTesto 31">
                  <a:extLst>
                    <a:ext uri="{FF2B5EF4-FFF2-40B4-BE49-F238E27FC236}">
                      <a16:creationId xmlns:a16="http://schemas.microsoft.com/office/drawing/2014/main" id="{66C893E4-1BF5-72C8-42D5-C106E5C17804}"/>
                    </a:ext>
                  </a:extLst>
                </p:cNvPr>
                <p:cNvSpPr txBox="1"/>
                <p:nvPr/>
              </p:nvSpPr>
              <p:spPr>
                <a:xfrm>
                  <a:off x="5282870" y="5103128"/>
                  <a:ext cx="8280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ctrl</a:t>
                  </a:r>
                </a:p>
              </p:txBody>
            </p:sp>
            <p:sp>
              <p:nvSpPr>
                <p:cNvPr id="62" name="CasellaDiTesto 32">
                  <a:extLst>
                    <a:ext uri="{FF2B5EF4-FFF2-40B4-BE49-F238E27FC236}">
                      <a16:creationId xmlns:a16="http://schemas.microsoft.com/office/drawing/2014/main" id="{4200A200-5022-662B-3EB1-E7539B4FCC8F}"/>
                    </a:ext>
                  </a:extLst>
                </p:cNvPr>
                <p:cNvSpPr txBox="1"/>
                <p:nvPr/>
              </p:nvSpPr>
              <p:spPr>
                <a:xfrm>
                  <a:off x="6241084" y="5103128"/>
                  <a:ext cx="80461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mock</a:t>
                  </a:r>
                </a:p>
              </p:txBody>
            </p:sp>
            <p:cxnSp>
              <p:nvCxnSpPr>
                <p:cNvPr id="63" name="Connettore diritto 36">
                  <a:extLst>
                    <a:ext uri="{FF2B5EF4-FFF2-40B4-BE49-F238E27FC236}">
                      <a16:creationId xmlns:a16="http://schemas.microsoft.com/office/drawing/2014/main" id="{A43F03A1-3CCB-AA29-DFE0-F8D5458F2401}"/>
                    </a:ext>
                  </a:extLst>
                </p:cNvPr>
                <p:cNvCxnSpPr/>
                <p:nvPr/>
              </p:nvCxnSpPr>
              <p:spPr>
                <a:xfrm>
                  <a:off x="5282870" y="5126690"/>
                  <a:ext cx="82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Connettore diritto 37">
                  <a:extLst>
                    <a:ext uri="{FF2B5EF4-FFF2-40B4-BE49-F238E27FC236}">
                      <a16:creationId xmlns:a16="http://schemas.microsoft.com/office/drawing/2014/main" id="{299E2BDA-1B6E-CF65-7480-A38C940950D3}"/>
                    </a:ext>
                  </a:extLst>
                </p:cNvPr>
                <p:cNvCxnSpPr/>
                <p:nvPr/>
              </p:nvCxnSpPr>
              <p:spPr>
                <a:xfrm>
                  <a:off x="6241084" y="5126690"/>
                  <a:ext cx="82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1" name="Immagine 10">
                  <a:extLst>
                    <a:ext uri="{FF2B5EF4-FFF2-40B4-BE49-F238E27FC236}">
                      <a16:creationId xmlns:a16="http://schemas.microsoft.com/office/drawing/2014/main" id="{6B665F3D-5697-2864-CB1D-3F40B6A239E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4910845" y="1777349"/>
                  <a:ext cx="2536000" cy="3274545"/>
                </a:xfrm>
                <a:prstGeom prst="rect">
                  <a:avLst/>
                </a:prstGeom>
              </p:spPr>
            </p:pic>
            <p:cxnSp>
              <p:nvCxnSpPr>
                <p:cNvPr id="49" name="Connettore diritto 37">
                  <a:extLst>
                    <a:ext uri="{FF2B5EF4-FFF2-40B4-BE49-F238E27FC236}">
                      <a16:creationId xmlns:a16="http://schemas.microsoft.com/office/drawing/2014/main" id="{8618959D-3554-F7E3-7A96-22FFBEFD147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4811880" y="3545820"/>
                  <a:ext cx="2772000" cy="3702"/>
                </a:xfrm>
                <a:prstGeom prst="line">
                  <a:avLst/>
                </a:prstGeom>
                <a:ln w="9525">
                  <a:solidFill>
                    <a:schemeClr val="bg1">
                      <a:lumMod val="65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Connettore diritto 37">
                  <a:extLst>
                    <a:ext uri="{FF2B5EF4-FFF2-40B4-BE49-F238E27FC236}">
                      <a16:creationId xmlns:a16="http://schemas.microsoft.com/office/drawing/2014/main" id="{89A1926B-0E34-DF89-A44E-F13C4EF91E3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4797117" y="4199006"/>
                  <a:ext cx="2772000" cy="3702"/>
                </a:xfrm>
                <a:prstGeom prst="line">
                  <a:avLst/>
                </a:prstGeom>
                <a:ln w="9525">
                  <a:solidFill>
                    <a:schemeClr val="bg1">
                      <a:lumMod val="65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4" name="CasellaDiTesto 40">
                  <a:extLst>
                    <a:ext uri="{FF2B5EF4-FFF2-40B4-BE49-F238E27FC236}">
                      <a16:creationId xmlns:a16="http://schemas.microsoft.com/office/drawing/2014/main" id="{F024E611-ADA9-B610-06F2-F779BC9A9981}"/>
                    </a:ext>
                  </a:extLst>
                </p:cNvPr>
                <p:cNvSpPr txBox="1"/>
                <p:nvPr/>
              </p:nvSpPr>
              <p:spPr>
                <a:xfrm rot="16200000">
                  <a:off x="7308949" y="3751320"/>
                  <a:ext cx="56297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solidFill>
                        <a:srgbClr val="00B05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GAPDH</a:t>
                  </a:r>
                </a:p>
              </p:txBody>
            </p:sp>
          </p:grpSp>
          <p:grpSp>
            <p:nvGrpSpPr>
              <p:cNvPr id="87" name="Gruppo 86">
                <a:extLst>
                  <a:ext uri="{FF2B5EF4-FFF2-40B4-BE49-F238E27FC236}">
                    <a16:creationId xmlns:a16="http://schemas.microsoft.com/office/drawing/2014/main" id="{87D71D90-6AF2-F232-3CFF-946367689851}"/>
                  </a:ext>
                </a:extLst>
              </p:cNvPr>
              <p:cNvGrpSpPr/>
              <p:nvPr/>
            </p:nvGrpSpPr>
            <p:grpSpPr>
              <a:xfrm>
                <a:off x="3320083" y="1500297"/>
                <a:ext cx="2933912" cy="3879830"/>
                <a:chOff x="1558834" y="1500297"/>
                <a:chExt cx="2933912" cy="3879830"/>
              </a:xfrm>
            </p:grpSpPr>
            <p:sp>
              <p:nvSpPr>
                <p:cNvPr id="13" name="CasellaDiTesto 32">
                  <a:extLst>
                    <a:ext uri="{FF2B5EF4-FFF2-40B4-BE49-F238E27FC236}">
                      <a16:creationId xmlns:a16="http://schemas.microsoft.com/office/drawing/2014/main" id="{46BEDBA9-FF66-0027-036A-161DDA909EE7}"/>
                    </a:ext>
                  </a:extLst>
                </p:cNvPr>
                <p:cNvSpPr txBox="1"/>
                <p:nvPr/>
              </p:nvSpPr>
              <p:spPr>
                <a:xfrm>
                  <a:off x="1914716" y="1500297"/>
                  <a:ext cx="205193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TC-32</a:t>
                  </a:r>
                </a:p>
              </p:txBody>
            </p:sp>
            <p:sp>
              <p:nvSpPr>
                <p:cNvPr id="25" name="CasellaDiTesto 31">
                  <a:extLst>
                    <a:ext uri="{FF2B5EF4-FFF2-40B4-BE49-F238E27FC236}">
                      <a16:creationId xmlns:a16="http://schemas.microsoft.com/office/drawing/2014/main" id="{CB22425F-5615-1D78-001E-D87D1C4E3363}"/>
                    </a:ext>
                  </a:extLst>
                </p:cNvPr>
                <p:cNvSpPr txBox="1"/>
                <p:nvPr/>
              </p:nvSpPr>
              <p:spPr>
                <a:xfrm>
                  <a:off x="2030082" y="5103128"/>
                  <a:ext cx="8280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ctrl</a:t>
                  </a:r>
                </a:p>
              </p:txBody>
            </p:sp>
            <p:sp>
              <p:nvSpPr>
                <p:cNvPr id="26" name="CasellaDiTesto 32">
                  <a:extLst>
                    <a:ext uri="{FF2B5EF4-FFF2-40B4-BE49-F238E27FC236}">
                      <a16:creationId xmlns:a16="http://schemas.microsoft.com/office/drawing/2014/main" id="{7D368ACC-00C3-FB53-9321-65F4DCFE90AF}"/>
                    </a:ext>
                  </a:extLst>
                </p:cNvPr>
                <p:cNvSpPr txBox="1"/>
                <p:nvPr/>
              </p:nvSpPr>
              <p:spPr>
                <a:xfrm>
                  <a:off x="2988296" y="5103128"/>
                  <a:ext cx="80461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solidFill>
                        <a:prstClr val="black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mock</a:t>
                  </a:r>
                </a:p>
              </p:txBody>
            </p:sp>
            <p:cxnSp>
              <p:nvCxnSpPr>
                <p:cNvPr id="27" name="Connettore diritto 36">
                  <a:extLst>
                    <a:ext uri="{FF2B5EF4-FFF2-40B4-BE49-F238E27FC236}">
                      <a16:creationId xmlns:a16="http://schemas.microsoft.com/office/drawing/2014/main" id="{9A92D741-4E60-AB2B-07CC-811E0FCD51AC}"/>
                    </a:ext>
                  </a:extLst>
                </p:cNvPr>
                <p:cNvCxnSpPr/>
                <p:nvPr/>
              </p:nvCxnSpPr>
              <p:spPr>
                <a:xfrm>
                  <a:off x="2030082" y="5126690"/>
                  <a:ext cx="82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Connettore diritto 37">
                  <a:extLst>
                    <a:ext uri="{FF2B5EF4-FFF2-40B4-BE49-F238E27FC236}">
                      <a16:creationId xmlns:a16="http://schemas.microsoft.com/office/drawing/2014/main" id="{7670626F-282F-C9A4-2E6B-E2EDA97AD0D5}"/>
                    </a:ext>
                  </a:extLst>
                </p:cNvPr>
                <p:cNvCxnSpPr/>
                <p:nvPr/>
              </p:nvCxnSpPr>
              <p:spPr>
                <a:xfrm>
                  <a:off x="2988296" y="5126690"/>
                  <a:ext cx="828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5" name="Immagine 4">
                  <a:extLst>
                    <a:ext uri="{FF2B5EF4-FFF2-40B4-BE49-F238E27FC236}">
                      <a16:creationId xmlns:a16="http://schemas.microsoft.com/office/drawing/2014/main" id="{0CD442DC-7C3C-39B2-D5F9-085B2D8FE7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>
                  <a:off x="1659452" y="1777349"/>
                  <a:ext cx="2535998" cy="3274545"/>
                </a:xfrm>
                <a:prstGeom prst="rect">
                  <a:avLst/>
                </a:prstGeom>
              </p:spPr>
            </p:pic>
            <p:cxnSp>
              <p:nvCxnSpPr>
                <p:cNvPr id="42" name="Connettore diritto 37">
                  <a:extLst>
                    <a:ext uri="{FF2B5EF4-FFF2-40B4-BE49-F238E27FC236}">
                      <a16:creationId xmlns:a16="http://schemas.microsoft.com/office/drawing/2014/main" id="{79E73104-AFA3-D45F-56BC-B8419E68A8A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558834" y="4383239"/>
                  <a:ext cx="2749658" cy="0"/>
                </a:xfrm>
                <a:prstGeom prst="line">
                  <a:avLst/>
                </a:prstGeom>
                <a:ln w="9525">
                  <a:solidFill>
                    <a:schemeClr val="bg1">
                      <a:lumMod val="65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3" name="CasellaDiTesto 39">
                  <a:extLst>
                    <a:ext uri="{FF2B5EF4-FFF2-40B4-BE49-F238E27FC236}">
                      <a16:creationId xmlns:a16="http://schemas.microsoft.com/office/drawing/2014/main" id="{0DE7DA38-A53B-5289-3FA5-9D74200844C7}"/>
                    </a:ext>
                  </a:extLst>
                </p:cNvPr>
                <p:cNvSpPr txBox="1"/>
                <p:nvPr/>
              </p:nvSpPr>
              <p:spPr>
                <a:xfrm rot="16200000">
                  <a:off x="4179519" y="2963921"/>
                  <a:ext cx="38023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solidFill>
                        <a:srgbClr val="FF000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Tau</a:t>
                  </a:r>
                </a:p>
              </p:txBody>
            </p:sp>
            <p:cxnSp>
              <p:nvCxnSpPr>
                <p:cNvPr id="85" name="Connettore diritto 37">
                  <a:extLst>
                    <a:ext uri="{FF2B5EF4-FFF2-40B4-BE49-F238E27FC236}">
                      <a16:creationId xmlns:a16="http://schemas.microsoft.com/office/drawing/2014/main" id="{E64D7408-E2C6-0C56-2FB1-FD0252AA44F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46525" y="1863032"/>
                  <a:ext cx="0" cy="2448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42829429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545DB1B-C2A4-D241-A4ED-4B2237A3F2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59233"/>
            <a:ext cx="9144000" cy="2577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730403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r">
          <a:defRPr sz="1000" dirty="0" smtClean="0">
            <a:latin typeface="Calibri" panose="020F0502020204030204" pitchFamily="34" charset="0"/>
            <a:ea typeface="Calibri" panose="020F0502020204030204" pitchFamily="34" charset="0"/>
            <a:cs typeface="Calibri" panose="020F0502020204030204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73</Words>
  <Application>Microsoft Macintosh PowerPoint</Application>
  <PresentationFormat>On-screen Show (4:3)</PresentationFormat>
  <Paragraphs>125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EOC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20190117- Test different shRNA MAPT gene</dc:title>
  <dc:creator>Magrin Claudia</dc:creator>
  <cp:lastModifiedBy>Florencia Cidre-Aranaz</cp:lastModifiedBy>
  <cp:revision>266</cp:revision>
  <dcterms:created xsi:type="dcterms:W3CDTF">2019-01-23T11:12:05Z</dcterms:created>
  <dcterms:modified xsi:type="dcterms:W3CDTF">2025-03-24T12:56:37Z</dcterms:modified>
</cp:coreProperties>
</file>